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D16C6C8-1B3A-4906-ABC2-5BA2B76A7AFE}"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685800" y="198108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1C73438-B3AB-4A8F-B62F-425AFA52141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DE1D057-9A7F-413F-BE2E-6931F9085D22}"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685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313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594144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685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313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594144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7EBBA86-FD11-4856-A87A-9B911EC2DC4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685800" y="198108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EDCE2C5-7D31-4570-B484-CDD48EEB89B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1EE9A87-C95F-4604-8673-504A49CAC3F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26EEB09-9CBE-4EBA-BA75-C5229536C9A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16ED1E6-1E8A-4415-A26C-12B1404372A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858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C11F9DA-294F-47DD-8FCC-81B3C785749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78774F9-3031-4D11-9194-4C5E458EA4F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D664493-DBF1-4D38-AF66-796F7E1F00F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AF07177-AC12-46AB-885B-8097353BBEB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685800" y="1981080"/>
            <a:ext cx="7772400" cy="4114800"/>
          </a:xfrm>
          <a:prstGeom prst="rect">
            <a:avLst/>
          </a:prstGeom>
          <a:noFill/>
          <a:ln w="0">
            <a:noFill/>
          </a:ln>
        </p:spPr>
        <p:txBody>
          <a:bodyPr lIns="90000" rIns="90000" tIns="46800" bIns="46800" anchor="t">
            <a:normAutofit fontScale="99000"/>
          </a:bodyPr>
          <a:p>
            <a:pPr marL="339480" indent="-3394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35480" indent="-28296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3148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58400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3652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3652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3652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685800" y="6248520"/>
            <a:ext cx="1905120" cy="45720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8520"/>
            <a:ext cx="2895840" cy="45720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3080" y="6248520"/>
            <a:ext cx="190512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DE49FF2-551E-4247-B698-73A16713A871}"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rot="16200000">
            <a:off x="2468880" y="3528000"/>
            <a:ext cx="35280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 Cells</a:t>
            </a:r>
            <a:endParaRPr b="0" lang="en-US" sz="900" spc="-1" strike="noStrike">
              <a:solidFill>
                <a:srgbClr val="000000"/>
              </a:solidFill>
              <a:latin typeface="Arial"/>
            </a:endParaRPr>
          </a:p>
        </p:txBody>
      </p:sp>
      <p:sp>
        <p:nvSpPr>
          <p:cNvPr id="42" name=""/>
          <p:cNvSpPr/>
          <p:nvPr/>
        </p:nvSpPr>
        <p:spPr>
          <a:xfrm>
            <a:off x="1618560" y="4395960"/>
            <a:ext cx="31932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FL2-H</a:t>
            </a:r>
            <a:endParaRPr b="0" lang="en-US" sz="900" spc="-1" strike="noStrike">
              <a:solidFill>
                <a:srgbClr val="000000"/>
              </a:solidFill>
              <a:latin typeface="Arial"/>
            </a:endParaRPr>
          </a:p>
        </p:txBody>
      </p:sp>
      <p:sp>
        <p:nvSpPr>
          <p:cNvPr id="43" name=""/>
          <p:cNvSpPr/>
          <p:nvPr/>
        </p:nvSpPr>
        <p:spPr>
          <a:xfrm rot="16200000">
            <a:off x="654480" y="3528000"/>
            <a:ext cx="35280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 Cells</a:t>
            </a:r>
            <a:endParaRPr b="0" lang="en-US" sz="900" spc="-1" strike="noStrike">
              <a:solidFill>
                <a:srgbClr val="000000"/>
              </a:solidFill>
              <a:latin typeface="Arial"/>
            </a:endParaRPr>
          </a:p>
        </p:txBody>
      </p:sp>
      <p:sp>
        <p:nvSpPr>
          <p:cNvPr id="44" name=""/>
          <p:cNvSpPr/>
          <p:nvPr/>
        </p:nvSpPr>
        <p:spPr>
          <a:xfrm>
            <a:off x="3432960" y="4395960"/>
            <a:ext cx="31932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FL2-H</a:t>
            </a:r>
            <a:endParaRPr b="0" lang="en-US" sz="900" spc="-1" strike="noStrike">
              <a:solidFill>
                <a:srgbClr val="000000"/>
              </a:solidFill>
              <a:latin typeface="Arial"/>
            </a:endParaRPr>
          </a:p>
        </p:txBody>
      </p:sp>
      <p:sp>
        <p:nvSpPr>
          <p:cNvPr id="45" name=""/>
          <p:cNvSpPr/>
          <p:nvPr/>
        </p:nvSpPr>
        <p:spPr>
          <a:xfrm rot="16200000">
            <a:off x="2468880" y="1987200"/>
            <a:ext cx="35280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 Cells</a:t>
            </a:r>
            <a:endParaRPr b="0" lang="en-US" sz="900" spc="-1" strike="noStrike">
              <a:solidFill>
                <a:srgbClr val="000000"/>
              </a:solidFill>
              <a:latin typeface="Arial"/>
            </a:endParaRPr>
          </a:p>
        </p:txBody>
      </p:sp>
      <p:sp>
        <p:nvSpPr>
          <p:cNvPr id="46" name=""/>
          <p:cNvSpPr/>
          <p:nvPr/>
        </p:nvSpPr>
        <p:spPr>
          <a:xfrm>
            <a:off x="2887560" y="1371600"/>
            <a:ext cx="1444680" cy="1252440"/>
          </a:xfrm>
          <a:prstGeom prst="rect">
            <a:avLst/>
          </a:prstGeom>
          <a:solidFill>
            <a:srgbClr val="ffffff"/>
          </a:solidFill>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47" name=""/>
          <p:cNvSpPr/>
          <p:nvPr/>
        </p:nvSpPr>
        <p:spPr>
          <a:xfrm>
            <a:off x="2887560" y="2619360"/>
            <a:ext cx="144000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48" name=""/>
          <p:cNvSpPr/>
          <p:nvPr/>
        </p:nvSpPr>
        <p:spPr>
          <a:xfrm>
            <a:off x="2887560" y="2624040"/>
            <a:ext cx="0" cy="28800"/>
          </a:xfrm>
          <a:prstGeom prst="line">
            <a:avLst/>
          </a:prstGeom>
          <a:ln w="12600">
            <a:solidFill>
              <a:srgbClr val="000000"/>
            </a:solidFill>
            <a:miter/>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49" name=""/>
          <p:cNvSpPr/>
          <p:nvPr/>
        </p:nvSpPr>
        <p:spPr>
          <a:xfrm>
            <a:off x="2994120" y="26240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50" name=""/>
          <p:cNvSpPr/>
          <p:nvPr/>
        </p:nvSpPr>
        <p:spPr>
          <a:xfrm>
            <a:off x="3054240" y="262404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51" name=""/>
          <p:cNvSpPr/>
          <p:nvPr/>
        </p:nvSpPr>
        <p:spPr>
          <a:xfrm>
            <a:off x="3100320" y="26240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52" name=""/>
          <p:cNvSpPr/>
          <p:nvPr/>
        </p:nvSpPr>
        <p:spPr>
          <a:xfrm>
            <a:off x="3138480" y="2624040"/>
            <a:ext cx="144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53" name=""/>
          <p:cNvSpPr/>
          <p:nvPr/>
        </p:nvSpPr>
        <p:spPr>
          <a:xfrm>
            <a:off x="3166920" y="26240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54" name=""/>
          <p:cNvSpPr/>
          <p:nvPr/>
        </p:nvSpPr>
        <p:spPr>
          <a:xfrm>
            <a:off x="3189240" y="26240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55" name=""/>
          <p:cNvSpPr/>
          <p:nvPr/>
        </p:nvSpPr>
        <p:spPr>
          <a:xfrm>
            <a:off x="3211560" y="26240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56" name=""/>
          <p:cNvSpPr/>
          <p:nvPr/>
        </p:nvSpPr>
        <p:spPr>
          <a:xfrm>
            <a:off x="3227400" y="262404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57" name=""/>
          <p:cNvSpPr/>
          <p:nvPr/>
        </p:nvSpPr>
        <p:spPr>
          <a:xfrm>
            <a:off x="3244680" y="2624040"/>
            <a:ext cx="0" cy="28800"/>
          </a:xfrm>
          <a:prstGeom prst="line">
            <a:avLst/>
          </a:prstGeom>
          <a:ln w="12600">
            <a:solidFill>
              <a:srgbClr val="000000"/>
            </a:solidFill>
            <a:miter/>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58" name=""/>
          <p:cNvSpPr/>
          <p:nvPr/>
        </p:nvSpPr>
        <p:spPr>
          <a:xfrm>
            <a:off x="3355920" y="262404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59" name=""/>
          <p:cNvSpPr/>
          <p:nvPr/>
        </p:nvSpPr>
        <p:spPr>
          <a:xfrm>
            <a:off x="3417840" y="26240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60" name=""/>
          <p:cNvSpPr/>
          <p:nvPr/>
        </p:nvSpPr>
        <p:spPr>
          <a:xfrm>
            <a:off x="3462480" y="26240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61" name=""/>
          <p:cNvSpPr/>
          <p:nvPr/>
        </p:nvSpPr>
        <p:spPr>
          <a:xfrm>
            <a:off x="3495600" y="2624040"/>
            <a:ext cx="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62" name=""/>
          <p:cNvSpPr/>
          <p:nvPr/>
        </p:nvSpPr>
        <p:spPr>
          <a:xfrm>
            <a:off x="3529080" y="262404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63" name=""/>
          <p:cNvSpPr/>
          <p:nvPr/>
        </p:nvSpPr>
        <p:spPr>
          <a:xfrm>
            <a:off x="3551400" y="262404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64" name=""/>
          <p:cNvSpPr/>
          <p:nvPr/>
        </p:nvSpPr>
        <p:spPr>
          <a:xfrm>
            <a:off x="3573360" y="262404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65" name=""/>
          <p:cNvSpPr/>
          <p:nvPr/>
        </p:nvSpPr>
        <p:spPr>
          <a:xfrm>
            <a:off x="3591000" y="26240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66" name=""/>
          <p:cNvSpPr/>
          <p:nvPr/>
        </p:nvSpPr>
        <p:spPr>
          <a:xfrm>
            <a:off x="3606840" y="2624040"/>
            <a:ext cx="1440" cy="28800"/>
          </a:xfrm>
          <a:prstGeom prst="line">
            <a:avLst/>
          </a:prstGeom>
          <a:ln w="12600">
            <a:solidFill>
              <a:srgbClr val="000000"/>
            </a:solidFill>
            <a:miter/>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67" name=""/>
          <p:cNvSpPr/>
          <p:nvPr/>
        </p:nvSpPr>
        <p:spPr>
          <a:xfrm>
            <a:off x="3713040" y="26240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68" name=""/>
          <p:cNvSpPr/>
          <p:nvPr/>
        </p:nvSpPr>
        <p:spPr>
          <a:xfrm>
            <a:off x="3780000" y="262404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69" name=""/>
          <p:cNvSpPr/>
          <p:nvPr/>
        </p:nvSpPr>
        <p:spPr>
          <a:xfrm>
            <a:off x="3824280" y="262404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70" name=""/>
          <p:cNvSpPr/>
          <p:nvPr/>
        </p:nvSpPr>
        <p:spPr>
          <a:xfrm>
            <a:off x="3857760" y="2624040"/>
            <a:ext cx="144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71" name=""/>
          <p:cNvSpPr/>
          <p:nvPr/>
        </p:nvSpPr>
        <p:spPr>
          <a:xfrm>
            <a:off x="3886200" y="26240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72" name=""/>
          <p:cNvSpPr/>
          <p:nvPr/>
        </p:nvSpPr>
        <p:spPr>
          <a:xfrm>
            <a:off x="3914640" y="26240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73" name=""/>
          <p:cNvSpPr/>
          <p:nvPr/>
        </p:nvSpPr>
        <p:spPr>
          <a:xfrm>
            <a:off x="3930480" y="262404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74" name=""/>
          <p:cNvSpPr/>
          <p:nvPr/>
        </p:nvSpPr>
        <p:spPr>
          <a:xfrm>
            <a:off x="3952800" y="262404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75" name=""/>
          <p:cNvSpPr/>
          <p:nvPr/>
        </p:nvSpPr>
        <p:spPr>
          <a:xfrm>
            <a:off x="3970440" y="2624040"/>
            <a:ext cx="0" cy="28800"/>
          </a:xfrm>
          <a:prstGeom prst="line">
            <a:avLst/>
          </a:prstGeom>
          <a:ln w="12600">
            <a:solidFill>
              <a:srgbClr val="000000"/>
            </a:solidFill>
            <a:miter/>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76" name=""/>
          <p:cNvSpPr/>
          <p:nvPr/>
        </p:nvSpPr>
        <p:spPr>
          <a:xfrm>
            <a:off x="4075200" y="262404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77" name=""/>
          <p:cNvSpPr/>
          <p:nvPr/>
        </p:nvSpPr>
        <p:spPr>
          <a:xfrm>
            <a:off x="4143240" y="26240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78" name=""/>
          <p:cNvSpPr/>
          <p:nvPr/>
        </p:nvSpPr>
        <p:spPr>
          <a:xfrm>
            <a:off x="4187880" y="26240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79" name=""/>
          <p:cNvSpPr/>
          <p:nvPr/>
        </p:nvSpPr>
        <p:spPr>
          <a:xfrm>
            <a:off x="4221000" y="2624040"/>
            <a:ext cx="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80" name=""/>
          <p:cNvSpPr/>
          <p:nvPr/>
        </p:nvSpPr>
        <p:spPr>
          <a:xfrm>
            <a:off x="4248000" y="262404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81" name=""/>
          <p:cNvSpPr/>
          <p:nvPr/>
        </p:nvSpPr>
        <p:spPr>
          <a:xfrm>
            <a:off x="4270320" y="262404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82" name=""/>
          <p:cNvSpPr/>
          <p:nvPr/>
        </p:nvSpPr>
        <p:spPr>
          <a:xfrm>
            <a:off x="4292640" y="262404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83" name=""/>
          <p:cNvSpPr/>
          <p:nvPr/>
        </p:nvSpPr>
        <p:spPr>
          <a:xfrm>
            <a:off x="4309920" y="26240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84" name=""/>
          <p:cNvSpPr/>
          <p:nvPr/>
        </p:nvSpPr>
        <p:spPr>
          <a:xfrm>
            <a:off x="4327560" y="2624040"/>
            <a:ext cx="0" cy="28800"/>
          </a:xfrm>
          <a:prstGeom prst="line">
            <a:avLst/>
          </a:prstGeom>
          <a:ln w="12600">
            <a:solidFill>
              <a:srgbClr val="000000"/>
            </a:solidFill>
            <a:miter/>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85" name=""/>
          <p:cNvSpPr/>
          <p:nvPr/>
        </p:nvSpPr>
        <p:spPr>
          <a:xfrm flipV="1">
            <a:off x="2887560" y="1371600"/>
            <a:ext cx="0" cy="12477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86" name=""/>
          <p:cNvSpPr/>
          <p:nvPr/>
        </p:nvSpPr>
        <p:spPr>
          <a:xfrm>
            <a:off x="2768040" y="2589120"/>
            <a:ext cx="648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0</a:t>
            </a:r>
            <a:endParaRPr b="0" lang="en-US" sz="900" spc="-1" strike="noStrike">
              <a:solidFill>
                <a:srgbClr val="000000"/>
              </a:solidFill>
              <a:latin typeface="Arial"/>
            </a:endParaRPr>
          </a:p>
        </p:txBody>
      </p:sp>
      <p:sp>
        <p:nvSpPr>
          <p:cNvPr id="87" name=""/>
          <p:cNvSpPr/>
          <p:nvPr/>
        </p:nvSpPr>
        <p:spPr>
          <a:xfrm>
            <a:off x="2724840" y="23526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50</a:t>
            </a:r>
            <a:endParaRPr b="0" lang="en-US" sz="900" spc="-1" strike="noStrike">
              <a:solidFill>
                <a:srgbClr val="000000"/>
              </a:solidFill>
              <a:latin typeface="Arial"/>
            </a:endParaRPr>
          </a:p>
        </p:txBody>
      </p:sp>
      <p:sp>
        <p:nvSpPr>
          <p:cNvPr id="88" name=""/>
          <p:cNvSpPr/>
          <p:nvPr/>
        </p:nvSpPr>
        <p:spPr>
          <a:xfrm>
            <a:off x="2689920" y="211464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0</a:t>
            </a:r>
            <a:endParaRPr b="0" lang="en-US" sz="900" spc="-1" strike="noStrike">
              <a:solidFill>
                <a:srgbClr val="000000"/>
              </a:solidFill>
              <a:latin typeface="Arial"/>
            </a:endParaRPr>
          </a:p>
        </p:txBody>
      </p:sp>
      <p:sp>
        <p:nvSpPr>
          <p:cNvPr id="89" name=""/>
          <p:cNvSpPr/>
          <p:nvPr/>
        </p:nvSpPr>
        <p:spPr>
          <a:xfrm>
            <a:off x="2689920" y="187164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50</a:t>
            </a:r>
            <a:endParaRPr b="0" lang="en-US" sz="900" spc="-1" strike="noStrike">
              <a:solidFill>
                <a:srgbClr val="000000"/>
              </a:solidFill>
              <a:latin typeface="Arial"/>
            </a:endParaRPr>
          </a:p>
        </p:txBody>
      </p:sp>
      <p:sp>
        <p:nvSpPr>
          <p:cNvPr id="90" name=""/>
          <p:cNvSpPr/>
          <p:nvPr/>
        </p:nvSpPr>
        <p:spPr>
          <a:xfrm>
            <a:off x="2689920" y="163044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200</a:t>
            </a:r>
            <a:endParaRPr b="0" lang="en-US" sz="900" spc="-1" strike="noStrike">
              <a:solidFill>
                <a:srgbClr val="000000"/>
              </a:solidFill>
              <a:latin typeface="Arial"/>
            </a:endParaRPr>
          </a:p>
        </p:txBody>
      </p:sp>
      <p:sp>
        <p:nvSpPr>
          <p:cNvPr id="91" name=""/>
          <p:cNvSpPr/>
          <p:nvPr/>
        </p:nvSpPr>
        <p:spPr>
          <a:xfrm>
            <a:off x="2689920" y="138924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250</a:t>
            </a:r>
            <a:endParaRPr b="0" lang="en-US" sz="900" spc="-1" strike="noStrike">
              <a:solidFill>
                <a:srgbClr val="000000"/>
              </a:solidFill>
              <a:latin typeface="Arial"/>
            </a:endParaRPr>
          </a:p>
        </p:txBody>
      </p:sp>
      <p:sp>
        <p:nvSpPr>
          <p:cNvPr id="92" name=""/>
          <p:cNvSpPr/>
          <p:nvPr/>
        </p:nvSpPr>
        <p:spPr>
          <a:xfrm flipH="1">
            <a:off x="2854440" y="2619360"/>
            <a:ext cx="331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93" name=""/>
          <p:cNvSpPr/>
          <p:nvPr/>
        </p:nvSpPr>
        <p:spPr>
          <a:xfrm flipH="1">
            <a:off x="2876040" y="2575080"/>
            <a:ext cx="111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94" name=""/>
          <p:cNvSpPr/>
          <p:nvPr/>
        </p:nvSpPr>
        <p:spPr>
          <a:xfrm flipH="1">
            <a:off x="2876040" y="252720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95" name=""/>
          <p:cNvSpPr/>
          <p:nvPr/>
        </p:nvSpPr>
        <p:spPr>
          <a:xfrm flipH="1">
            <a:off x="2876040" y="2478240"/>
            <a:ext cx="111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96" name=""/>
          <p:cNvSpPr/>
          <p:nvPr/>
        </p:nvSpPr>
        <p:spPr>
          <a:xfrm flipH="1">
            <a:off x="2876040" y="243036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97" name=""/>
          <p:cNvSpPr/>
          <p:nvPr/>
        </p:nvSpPr>
        <p:spPr>
          <a:xfrm flipH="1">
            <a:off x="2854440" y="2381400"/>
            <a:ext cx="3312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98" name=""/>
          <p:cNvSpPr/>
          <p:nvPr/>
        </p:nvSpPr>
        <p:spPr>
          <a:xfrm flipH="1">
            <a:off x="2876040" y="233352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99" name=""/>
          <p:cNvSpPr/>
          <p:nvPr/>
        </p:nvSpPr>
        <p:spPr>
          <a:xfrm flipH="1">
            <a:off x="2876040" y="2284560"/>
            <a:ext cx="111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100" name=""/>
          <p:cNvSpPr/>
          <p:nvPr/>
        </p:nvSpPr>
        <p:spPr>
          <a:xfrm flipH="1">
            <a:off x="2876040" y="223668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01" name=""/>
          <p:cNvSpPr/>
          <p:nvPr/>
        </p:nvSpPr>
        <p:spPr>
          <a:xfrm flipH="1">
            <a:off x="2876040" y="2187720"/>
            <a:ext cx="111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102" name=""/>
          <p:cNvSpPr/>
          <p:nvPr/>
        </p:nvSpPr>
        <p:spPr>
          <a:xfrm flipH="1">
            <a:off x="2854440" y="2139840"/>
            <a:ext cx="331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03" name=""/>
          <p:cNvSpPr/>
          <p:nvPr/>
        </p:nvSpPr>
        <p:spPr>
          <a:xfrm flipH="1">
            <a:off x="2876040" y="209232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04" name=""/>
          <p:cNvSpPr/>
          <p:nvPr/>
        </p:nvSpPr>
        <p:spPr>
          <a:xfrm flipH="1">
            <a:off x="2876040" y="204300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05" name=""/>
          <p:cNvSpPr/>
          <p:nvPr/>
        </p:nvSpPr>
        <p:spPr>
          <a:xfrm flipH="1">
            <a:off x="2876040" y="199548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06" name=""/>
          <p:cNvSpPr/>
          <p:nvPr/>
        </p:nvSpPr>
        <p:spPr>
          <a:xfrm flipH="1">
            <a:off x="2876040" y="1946160"/>
            <a:ext cx="111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107" name=""/>
          <p:cNvSpPr/>
          <p:nvPr/>
        </p:nvSpPr>
        <p:spPr>
          <a:xfrm flipH="1">
            <a:off x="2854440" y="1898640"/>
            <a:ext cx="331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08" name=""/>
          <p:cNvSpPr/>
          <p:nvPr/>
        </p:nvSpPr>
        <p:spPr>
          <a:xfrm flipH="1">
            <a:off x="2876040" y="1849320"/>
            <a:ext cx="111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109" name=""/>
          <p:cNvSpPr/>
          <p:nvPr/>
        </p:nvSpPr>
        <p:spPr>
          <a:xfrm flipH="1">
            <a:off x="2876040" y="180180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10" name=""/>
          <p:cNvSpPr/>
          <p:nvPr/>
        </p:nvSpPr>
        <p:spPr>
          <a:xfrm flipH="1">
            <a:off x="2876040" y="1752480"/>
            <a:ext cx="111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111" name=""/>
          <p:cNvSpPr/>
          <p:nvPr/>
        </p:nvSpPr>
        <p:spPr>
          <a:xfrm flipH="1">
            <a:off x="2876040" y="170496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12" name=""/>
          <p:cNvSpPr/>
          <p:nvPr/>
        </p:nvSpPr>
        <p:spPr>
          <a:xfrm flipH="1">
            <a:off x="2854440" y="1655640"/>
            <a:ext cx="3312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113" name=""/>
          <p:cNvSpPr/>
          <p:nvPr/>
        </p:nvSpPr>
        <p:spPr>
          <a:xfrm flipH="1">
            <a:off x="2876040" y="160812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14" name=""/>
          <p:cNvSpPr/>
          <p:nvPr/>
        </p:nvSpPr>
        <p:spPr>
          <a:xfrm flipH="1">
            <a:off x="2876040" y="1558800"/>
            <a:ext cx="111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115" name=""/>
          <p:cNvSpPr/>
          <p:nvPr/>
        </p:nvSpPr>
        <p:spPr>
          <a:xfrm flipH="1">
            <a:off x="2876040" y="151128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16" name=""/>
          <p:cNvSpPr/>
          <p:nvPr/>
        </p:nvSpPr>
        <p:spPr>
          <a:xfrm flipH="1">
            <a:off x="2876040" y="1461960"/>
            <a:ext cx="111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117" name=""/>
          <p:cNvSpPr/>
          <p:nvPr/>
        </p:nvSpPr>
        <p:spPr>
          <a:xfrm flipH="1">
            <a:off x="2854440" y="1414440"/>
            <a:ext cx="331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18" name=""/>
          <p:cNvSpPr/>
          <p:nvPr/>
        </p:nvSpPr>
        <p:spPr>
          <a:xfrm>
            <a:off x="2898720" y="1440000"/>
            <a:ext cx="1417680" cy="1172880"/>
          </a:xfrm>
          <a:custGeom>
            <a:avLst/>
            <a:gdLst/>
            <a:ahLst/>
            <a:rect l="l" t="t" r="r" b="b"/>
            <a:pathLst>
              <a:path w="2032" h="1944">
                <a:moveTo>
                  <a:pt x="0" y="1944"/>
                </a:moveTo>
                <a:lnTo>
                  <a:pt x="0" y="1912"/>
                </a:lnTo>
                <a:lnTo>
                  <a:pt x="0" y="1944"/>
                </a:lnTo>
                <a:lnTo>
                  <a:pt x="8" y="1944"/>
                </a:lnTo>
                <a:lnTo>
                  <a:pt x="16" y="1944"/>
                </a:lnTo>
                <a:lnTo>
                  <a:pt x="24" y="1944"/>
                </a:lnTo>
                <a:lnTo>
                  <a:pt x="32" y="1936"/>
                </a:lnTo>
                <a:lnTo>
                  <a:pt x="40" y="1920"/>
                </a:lnTo>
                <a:lnTo>
                  <a:pt x="48" y="1912"/>
                </a:lnTo>
                <a:lnTo>
                  <a:pt x="56" y="1896"/>
                </a:lnTo>
                <a:lnTo>
                  <a:pt x="64" y="1912"/>
                </a:lnTo>
                <a:lnTo>
                  <a:pt x="72" y="1880"/>
                </a:lnTo>
                <a:lnTo>
                  <a:pt x="80" y="1832"/>
                </a:lnTo>
                <a:lnTo>
                  <a:pt x="88" y="1896"/>
                </a:lnTo>
                <a:lnTo>
                  <a:pt x="96" y="1800"/>
                </a:lnTo>
                <a:lnTo>
                  <a:pt x="104" y="1840"/>
                </a:lnTo>
                <a:lnTo>
                  <a:pt x="112" y="1728"/>
                </a:lnTo>
                <a:lnTo>
                  <a:pt x="120" y="1648"/>
                </a:lnTo>
                <a:lnTo>
                  <a:pt x="128" y="1712"/>
                </a:lnTo>
                <a:lnTo>
                  <a:pt x="136" y="1672"/>
                </a:lnTo>
                <a:lnTo>
                  <a:pt x="144" y="1632"/>
                </a:lnTo>
                <a:lnTo>
                  <a:pt x="152" y="1576"/>
                </a:lnTo>
                <a:lnTo>
                  <a:pt x="160" y="1432"/>
                </a:lnTo>
                <a:lnTo>
                  <a:pt x="168" y="1512"/>
                </a:lnTo>
                <a:lnTo>
                  <a:pt x="176" y="1504"/>
                </a:lnTo>
                <a:lnTo>
                  <a:pt x="184" y="1448"/>
                </a:lnTo>
                <a:lnTo>
                  <a:pt x="192" y="1416"/>
                </a:lnTo>
                <a:lnTo>
                  <a:pt x="200" y="1376"/>
                </a:lnTo>
                <a:lnTo>
                  <a:pt x="208" y="1384"/>
                </a:lnTo>
                <a:lnTo>
                  <a:pt x="216" y="1240"/>
                </a:lnTo>
                <a:lnTo>
                  <a:pt x="224" y="1304"/>
                </a:lnTo>
                <a:lnTo>
                  <a:pt x="232" y="1296"/>
                </a:lnTo>
                <a:lnTo>
                  <a:pt x="240" y="1400"/>
                </a:lnTo>
                <a:lnTo>
                  <a:pt x="248" y="1312"/>
                </a:lnTo>
                <a:lnTo>
                  <a:pt x="256" y="1344"/>
                </a:lnTo>
                <a:lnTo>
                  <a:pt x="264" y="1240"/>
                </a:lnTo>
                <a:lnTo>
                  <a:pt x="272" y="1352"/>
                </a:lnTo>
                <a:lnTo>
                  <a:pt x="280" y="1264"/>
                </a:lnTo>
                <a:lnTo>
                  <a:pt x="288" y="1328"/>
                </a:lnTo>
                <a:lnTo>
                  <a:pt x="296" y="1392"/>
                </a:lnTo>
                <a:lnTo>
                  <a:pt x="304" y="1264"/>
                </a:lnTo>
                <a:lnTo>
                  <a:pt x="312" y="1152"/>
                </a:lnTo>
                <a:lnTo>
                  <a:pt x="320" y="1240"/>
                </a:lnTo>
                <a:lnTo>
                  <a:pt x="328" y="1072"/>
                </a:lnTo>
                <a:lnTo>
                  <a:pt x="336" y="1224"/>
                </a:lnTo>
                <a:lnTo>
                  <a:pt x="344" y="1344"/>
                </a:lnTo>
                <a:lnTo>
                  <a:pt x="352" y="1152"/>
                </a:lnTo>
                <a:lnTo>
                  <a:pt x="360" y="1120"/>
                </a:lnTo>
                <a:lnTo>
                  <a:pt x="368" y="1128"/>
                </a:lnTo>
                <a:lnTo>
                  <a:pt x="376" y="912"/>
                </a:lnTo>
                <a:lnTo>
                  <a:pt x="384" y="1024"/>
                </a:lnTo>
                <a:lnTo>
                  <a:pt x="392" y="896"/>
                </a:lnTo>
                <a:lnTo>
                  <a:pt x="400" y="896"/>
                </a:lnTo>
                <a:lnTo>
                  <a:pt x="408" y="832"/>
                </a:lnTo>
                <a:lnTo>
                  <a:pt x="416" y="776"/>
                </a:lnTo>
                <a:lnTo>
                  <a:pt x="424" y="728"/>
                </a:lnTo>
                <a:lnTo>
                  <a:pt x="432" y="536"/>
                </a:lnTo>
                <a:lnTo>
                  <a:pt x="440" y="416"/>
                </a:lnTo>
                <a:lnTo>
                  <a:pt x="448" y="440"/>
                </a:lnTo>
                <a:lnTo>
                  <a:pt x="456" y="392"/>
                </a:lnTo>
                <a:lnTo>
                  <a:pt x="464" y="464"/>
                </a:lnTo>
                <a:lnTo>
                  <a:pt x="472" y="272"/>
                </a:lnTo>
                <a:lnTo>
                  <a:pt x="480" y="0"/>
                </a:lnTo>
                <a:lnTo>
                  <a:pt x="488" y="208"/>
                </a:lnTo>
                <a:lnTo>
                  <a:pt x="496" y="296"/>
                </a:lnTo>
                <a:lnTo>
                  <a:pt x="504" y="192"/>
                </a:lnTo>
                <a:lnTo>
                  <a:pt x="512" y="408"/>
                </a:lnTo>
                <a:lnTo>
                  <a:pt x="520" y="120"/>
                </a:lnTo>
                <a:lnTo>
                  <a:pt x="528" y="120"/>
                </a:lnTo>
                <a:lnTo>
                  <a:pt x="536" y="224"/>
                </a:lnTo>
                <a:lnTo>
                  <a:pt x="544" y="88"/>
                </a:lnTo>
                <a:lnTo>
                  <a:pt x="552" y="344"/>
                </a:lnTo>
                <a:lnTo>
                  <a:pt x="560" y="528"/>
                </a:lnTo>
                <a:lnTo>
                  <a:pt x="568" y="368"/>
                </a:lnTo>
                <a:lnTo>
                  <a:pt x="576" y="552"/>
                </a:lnTo>
                <a:lnTo>
                  <a:pt x="584" y="528"/>
                </a:lnTo>
                <a:lnTo>
                  <a:pt x="592" y="448"/>
                </a:lnTo>
                <a:lnTo>
                  <a:pt x="600" y="584"/>
                </a:lnTo>
                <a:lnTo>
                  <a:pt x="608" y="568"/>
                </a:lnTo>
                <a:lnTo>
                  <a:pt x="616" y="856"/>
                </a:lnTo>
                <a:lnTo>
                  <a:pt x="624" y="752"/>
                </a:lnTo>
                <a:lnTo>
                  <a:pt x="632" y="936"/>
                </a:lnTo>
                <a:lnTo>
                  <a:pt x="640" y="984"/>
                </a:lnTo>
                <a:lnTo>
                  <a:pt x="648" y="1016"/>
                </a:lnTo>
                <a:lnTo>
                  <a:pt x="656" y="1088"/>
                </a:lnTo>
                <a:lnTo>
                  <a:pt x="664" y="1064"/>
                </a:lnTo>
                <a:lnTo>
                  <a:pt x="672" y="1168"/>
                </a:lnTo>
                <a:lnTo>
                  <a:pt x="680" y="1360"/>
                </a:lnTo>
                <a:lnTo>
                  <a:pt x="688" y="1408"/>
                </a:lnTo>
                <a:lnTo>
                  <a:pt x="696" y="1424"/>
                </a:lnTo>
                <a:lnTo>
                  <a:pt x="704" y="1416"/>
                </a:lnTo>
                <a:lnTo>
                  <a:pt x="712" y="1472"/>
                </a:lnTo>
                <a:lnTo>
                  <a:pt x="720" y="1544"/>
                </a:lnTo>
                <a:lnTo>
                  <a:pt x="728" y="1560"/>
                </a:lnTo>
                <a:lnTo>
                  <a:pt x="736" y="1568"/>
                </a:lnTo>
                <a:lnTo>
                  <a:pt x="744" y="1624"/>
                </a:lnTo>
                <a:lnTo>
                  <a:pt x="752" y="1712"/>
                </a:lnTo>
                <a:lnTo>
                  <a:pt x="760" y="1776"/>
                </a:lnTo>
                <a:lnTo>
                  <a:pt x="768" y="1744"/>
                </a:lnTo>
                <a:lnTo>
                  <a:pt x="776" y="1664"/>
                </a:lnTo>
                <a:lnTo>
                  <a:pt x="784" y="1720"/>
                </a:lnTo>
                <a:lnTo>
                  <a:pt x="792" y="1720"/>
                </a:lnTo>
                <a:lnTo>
                  <a:pt x="800" y="1824"/>
                </a:lnTo>
                <a:lnTo>
                  <a:pt x="808" y="1864"/>
                </a:lnTo>
                <a:lnTo>
                  <a:pt x="816" y="1840"/>
                </a:lnTo>
                <a:lnTo>
                  <a:pt x="824" y="1808"/>
                </a:lnTo>
                <a:lnTo>
                  <a:pt x="832" y="1880"/>
                </a:lnTo>
                <a:lnTo>
                  <a:pt x="840" y="1824"/>
                </a:lnTo>
                <a:lnTo>
                  <a:pt x="848" y="1864"/>
                </a:lnTo>
                <a:lnTo>
                  <a:pt x="856" y="1888"/>
                </a:lnTo>
                <a:lnTo>
                  <a:pt x="864" y="1936"/>
                </a:lnTo>
                <a:lnTo>
                  <a:pt x="872" y="1936"/>
                </a:lnTo>
                <a:lnTo>
                  <a:pt x="880" y="1944"/>
                </a:lnTo>
                <a:lnTo>
                  <a:pt x="888" y="1928"/>
                </a:lnTo>
                <a:lnTo>
                  <a:pt x="896" y="1944"/>
                </a:lnTo>
                <a:lnTo>
                  <a:pt x="904" y="1944"/>
                </a:lnTo>
                <a:lnTo>
                  <a:pt x="912" y="1944"/>
                </a:lnTo>
                <a:lnTo>
                  <a:pt x="920" y="1936"/>
                </a:lnTo>
                <a:lnTo>
                  <a:pt x="928" y="1944"/>
                </a:lnTo>
                <a:lnTo>
                  <a:pt x="936" y="1944"/>
                </a:lnTo>
                <a:lnTo>
                  <a:pt x="944" y="1944"/>
                </a:lnTo>
                <a:lnTo>
                  <a:pt x="952" y="1944"/>
                </a:lnTo>
                <a:lnTo>
                  <a:pt x="960" y="1944"/>
                </a:lnTo>
                <a:lnTo>
                  <a:pt x="968" y="1944"/>
                </a:lnTo>
                <a:lnTo>
                  <a:pt x="976" y="1944"/>
                </a:lnTo>
                <a:lnTo>
                  <a:pt x="984" y="1944"/>
                </a:lnTo>
                <a:lnTo>
                  <a:pt x="992" y="1944"/>
                </a:lnTo>
                <a:lnTo>
                  <a:pt x="1000" y="1944"/>
                </a:lnTo>
                <a:lnTo>
                  <a:pt x="1008" y="1944"/>
                </a:lnTo>
                <a:lnTo>
                  <a:pt x="1016" y="1944"/>
                </a:lnTo>
                <a:lnTo>
                  <a:pt x="1024" y="1944"/>
                </a:lnTo>
                <a:lnTo>
                  <a:pt x="1032" y="1944"/>
                </a:lnTo>
                <a:lnTo>
                  <a:pt x="1040" y="1944"/>
                </a:lnTo>
                <a:lnTo>
                  <a:pt x="1048" y="1944"/>
                </a:lnTo>
                <a:lnTo>
                  <a:pt x="1056" y="1944"/>
                </a:lnTo>
                <a:lnTo>
                  <a:pt x="1064" y="1944"/>
                </a:lnTo>
                <a:lnTo>
                  <a:pt x="1072" y="1944"/>
                </a:lnTo>
                <a:lnTo>
                  <a:pt x="1080" y="1944"/>
                </a:lnTo>
                <a:lnTo>
                  <a:pt x="1088" y="1944"/>
                </a:lnTo>
                <a:lnTo>
                  <a:pt x="1096" y="1944"/>
                </a:lnTo>
                <a:lnTo>
                  <a:pt x="1104" y="1944"/>
                </a:lnTo>
                <a:lnTo>
                  <a:pt x="1112" y="1944"/>
                </a:lnTo>
                <a:lnTo>
                  <a:pt x="1120" y="1944"/>
                </a:lnTo>
                <a:lnTo>
                  <a:pt x="1128" y="1944"/>
                </a:lnTo>
                <a:lnTo>
                  <a:pt x="1136" y="1944"/>
                </a:lnTo>
                <a:lnTo>
                  <a:pt x="1144" y="1944"/>
                </a:lnTo>
                <a:lnTo>
                  <a:pt x="1152" y="1944"/>
                </a:lnTo>
                <a:lnTo>
                  <a:pt x="1160" y="1944"/>
                </a:lnTo>
                <a:lnTo>
                  <a:pt x="1168" y="1944"/>
                </a:lnTo>
                <a:lnTo>
                  <a:pt x="1176" y="1944"/>
                </a:lnTo>
                <a:lnTo>
                  <a:pt x="1184" y="1944"/>
                </a:lnTo>
                <a:lnTo>
                  <a:pt x="1192" y="1944"/>
                </a:lnTo>
                <a:lnTo>
                  <a:pt x="1200" y="1944"/>
                </a:lnTo>
                <a:lnTo>
                  <a:pt x="1208" y="1944"/>
                </a:lnTo>
                <a:lnTo>
                  <a:pt x="1216" y="1944"/>
                </a:lnTo>
                <a:lnTo>
                  <a:pt x="1224" y="1944"/>
                </a:lnTo>
                <a:lnTo>
                  <a:pt x="1232" y="1944"/>
                </a:lnTo>
                <a:lnTo>
                  <a:pt x="1240" y="1944"/>
                </a:lnTo>
                <a:lnTo>
                  <a:pt x="1248" y="1944"/>
                </a:lnTo>
                <a:lnTo>
                  <a:pt x="1256" y="1944"/>
                </a:lnTo>
                <a:lnTo>
                  <a:pt x="1264" y="1944"/>
                </a:lnTo>
                <a:lnTo>
                  <a:pt x="1272" y="1944"/>
                </a:lnTo>
                <a:lnTo>
                  <a:pt x="1280" y="1944"/>
                </a:lnTo>
                <a:lnTo>
                  <a:pt x="1288" y="1944"/>
                </a:lnTo>
                <a:lnTo>
                  <a:pt x="1296" y="1944"/>
                </a:lnTo>
                <a:lnTo>
                  <a:pt x="1304" y="1944"/>
                </a:lnTo>
                <a:lnTo>
                  <a:pt x="1312" y="1944"/>
                </a:lnTo>
                <a:lnTo>
                  <a:pt x="1320" y="1944"/>
                </a:lnTo>
                <a:lnTo>
                  <a:pt x="1328" y="1944"/>
                </a:lnTo>
                <a:lnTo>
                  <a:pt x="1336" y="1944"/>
                </a:lnTo>
                <a:lnTo>
                  <a:pt x="1344" y="1944"/>
                </a:lnTo>
                <a:lnTo>
                  <a:pt x="1352" y="1944"/>
                </a:lnTo>
                <a:lnTo>
                  <a:pt x="1360" y="1944"/>
                </a:lnTo>
                <a:lnTo>
                  <a:pt x="1368" y="1944"/>
                </a:lnTo>
                <a:lnTo>
                  <a:pt x="1376" y="1944"/>
                </a:lnTo>
                <a:lnTo>
                  <a:pt x="1384" y="1944"/>
                </a:lnTo>
                <a:lnTo>
                  <a:pt x="1392" y="1944"/>
                </a:lnTo>
                <a:lnTo>
                  <a:pt x="1400" y="1944"/>
                </a:lnTo>
                <a:lnTo>
                  <a:pt x="1408" y="1944"/>
                </a:lnTo>
                <a:lnTo>
                  <a:pt x="1416" y="1944"/>
                </a:lnTo>
                <a:lnTo>
                  <a:pt x="1424" y="1944"/>
                </a:lnTo>
                <a:lnTo>
                  <a:pt x="1432" y="1944"/>
                </a:lnTo>
                <a:lnTo>
                  <a:pt x="1440" y="1944"/>
                </a:lnTo>
                <a:lnTo>
                  <a:pt x="1448" y="1944"/>
                </a:lnTo>
                <a:lnTo>
                  <a:pt x="1456" y="1944"/>
                </a:lnTo>
                <a:lnTo>
                  <a:pt x="1464" y="1944"/>
                </a:lnTo>
                <a:lnTo>
                  <a:pt x="1472" y="1944"/>
                </a:lnTo>
                <a:lnTo>
                  <a:pt x="1480" y="1944"/>
                </a:lnTo>
                <a:lnTo>
                  <a:pt x="1488" y="1944"/>
                </a:lnTo>
                <a:lnTo>
                  <a:pt x="1496" y="1944"/>
                </a:lnTo>
                <a:lnTo>
                  <a:pt x="1504" y="1944"/>
                </a:lnTo>
                <a:lnTo>
                  <a:pt x="1512" y="1944"/>
                </a:lnTo>
                <a:lnTo>
                  <a:pt x="1520" y="1944"/>
                </a:lnTo>
                <a:lnTo>
                  <a:pt x="1528" y="1944"/>
                </a:lnTo>
                <a:lnTo>
                  <a:pt x="1536" y="1944"/>
                </a:lnTo>
                <a:lnTo>
                  <a:pt x="1544" y="1944"/>
                </a:lnTo>
                <a:lnTo>
                  <a:pt x="1552" y="1944"/>
                </a:lnTo>
                <a:lnTo>
                  <a:pt x="1560" y="1944"/>
                </a:lnTo>
                <a:lnTo>
                  <a:pt x="1568" y="1944"/>
                </a:lnTo>
                <a:lnTo>
                  <a:pt x="1576" y="1944"/>
                </a:lnTo>
                <a:lnTo>
                  <a:pt x="1584" y="1944"/>
                </a:lnTo>
                <a:lnTo>
                  <a:pt x="1592" y="1944"/>
                </a:lnTo>
                <a:lnTo>
                  <a:pt x="1600" y="1944"/>
                </a:lnTo>
                <a:lnTo>
                  <a:pt x="1608" y="1944"/>
                </a:lnTo>
                <a:lnTo>
                  <a:pt x="1616" y="1944"/>
                </a:lnTo>
                <a:lnTo>
                  <a:pt x="1624" y="1944"/>
                </a:lnTo>
                <a:lnTo>
                  <a:pt x="1632" y="1944"/>
                </a:lnTo>
                <a:lnTo>
                  <a:pt x="1640" y="1944"/>
                </a:lnTo>
                <a:lnTo>
                  <a:pt x="1648" y="1944"/>
                </a:lnTo>
                <a:lnTo>
                  <a:pt x="1656" y="1944"/>
                </a:lnTo>
                <a:lnTo>
                  <a:pt x="1664" y="1944"/>
                </a:lnTo>
                <a:lnTo>
                  <a:pt x="1672" y="1944"/>
                </a:lnTo>
                <a:lnTo>
                  <a:pt x="1680" y="1944"/>
                </a:lnTo>
                <a:lnTo>
                  <a:pt x="1688" y="1944"/>
                </a:lnTo>
                <a:lnTo>
                  <a:pt x="1696" y="1944"/>
                </a:lnTo>
                <a:lnTo>
                  <a:pt x="1704" y="1944"/>
                </a:lnTo>
                <a:lnTo>
                  <a:pt x="1712" y="1944"/>
                </a:lnTo>
                <a:lnTo>
                  <a:pt x="1720" y="1944"/>
                </a:lnTo>
                <a:lnTo>
                  <a:pt x="1728" y="1944"/>
                </a:lnTo>
                <a:lnTo>
                  <a:pt x="1736" y="1944"/>
                </a:lnTo>
                <a:lnTo>
                  <a:pt x="1744" y="1944"/>
                </a:lnTo>
                <a:lnTo>
                  <a:pt x="1752" y="1944"/>
                </a:lnTo>
                <a:lnTo>
                  <a:pt x="1760" y="1944"/>
                </a:lnTo>
                <a:lnTo>
                  <a:pt x="1768" y="1944"/>
                </a:lnTo>
                <a:lnTo>
                  <a:pt x="1776" y="1944"/>
                </a:lnTo>
                <a:lnTo>
                  <a:pt x="1784" y="1944"/>
                </a:lnTo>
                <a:lnTo>
                  <a:pt x="1792" y="1944"/>
                </a:lnTo>
                <a:lnTo>
                  <a:pt x="1800" y="1944"/>
                </a:lnTo>
                <a:lnTo>
                  <a:pt x="1808" y="1944"/>
                </a:lnTo>
                <a:lnTo>
                  <a:pt x="1816" y="1944"/>
                </a:lnTo>
                <a:lnTo>
                  <a:pt x="1824" y="1944"/>
                </a:lnTo>
                <a:lnTo>
                  <a:pt x="1832" y="1944"/>
                </a:lnTo>
                <a:lnTo>
                  <a:pt x="1840" y="1944"/>
                </a:lnTo>
                <a:lnTo>
                  <a:pt x="1848" y="1944"/>
                </a:lnTo>
                <a:lnTo>
                  <a:pt x="1856" y="1944"/>
                </a:lnTo>
                <a:lnTo>
                  <a:pt x="1864" y="1944"/>
                </a:lnTo>
                <a:lnTo>
                  <a:pt x="1872" y="1944"/>
                </a:lnTo>
                <a:lnTo>
                  <a:pt x="1880" y="1944"/>
                </a:lnTo>
                <a:lnTo>
                  <a:pt x="1888" y="1944"/>
                </a:lnTo>
                <a:lnTo>
                  <a:pt x="1896" y="1944"/>
                </a:lnTo>
                <a:lnTo>
                  <a:pt x="1904" y="1944"/>
                </a:lnTo>
                <a:lnTo>
                  <a:pt x="1912" y="1944"/>
                </a:lnTo>
                <a:lnTo>
                  <a:pt x="1920" y="1944"/>
                </a:lnTo>
                <a:lnTo>
                  <a:pt x="1928" y="1944"/>
                </a:lnTo>
                <a:lnTo>
                  <a:pt x="1936" y="1944"/>
                </a:lnTo>
                <a:lnTo>
                  <a:pt x="1944" y="1944"/>
                </a:lnTo>
                <a:lnTo>
                  <a:pt x="1952" y="1944"/>
                </a:lnTo>
                <a:lnTo>
                  <a:pt x="1960" y="1944"/>
                </a:lnTo>
                <a:lnTo>
                  <a:pt x="1968" y="1944"/>
                </a:lnTo>
                <a:lnTo>
                  <a:pt x="1976" y="1944"/>
                </a:lnTo>
                <a:lnTo>
                  <a:pt x="1984" y="1944"/>
                </a:lnTo>
                <a:lnTo>
                  <a:pt x="1992" y="1944"/>
                </a:lnTo>
                <a:lnTo>
                  <a:pt x="2000" y="1944"/>
                </a:lnTo>
                <a:lnTo>
                  <a:pt x="2008" y="1944"/>
                </a:lnTo>
                <a:lnTo>
                  <a:pt x="2016" y="1944"/>
                </a:lnTo>
                <a:lnTo>
                  <a:pt x="2024" y="1944"/>
                </a:lnTo>
                <a:lnTo>
                  <a:pt x="2032" y="1944"/>
                </a:lnTo>
              </a:path>
            </a:pathLst>
          </a:custGeom>
          <a:noFill/>
          <a:ln w="1260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19" name=""/>
          <p:cNvSpPr/>
          <p:nvPr/>
        </p:nvSpPr>
        <p:spPr>
          <a:xfrm>
            <a:off x="2898720" y="1444680"/>
            <a:ext cx="1417680" cy="1168200"/>
          </a:xfrm>
          <a:custGeom>
            <a:avLst/>
            <a:gdLst/>
            <a:ahLst/>
            <a:rect l="l" t="t" r="r" b="b"/>
            <a:pathLst>
              <a:path w="2032" h="1936">
                <a:moveTo>
                  <a:pt x="0" y="1936"/>
                </a:moveTo>
                <a:lnTo>
                  <a:pt x="0" y="144"/>
                </a:lnTo>
                <a:lnTo>
                  <a:pt x="0" y="1560"/>
                </a:lnTo>
                <a:lnTo>
                  <a:pt x="8" y="1504"/>
                </a:lnTo>
                <a:lnTo>
                  <a:pt x="16" y="1464"/>
                </a:lnTo>
                <a:lnTo>
                  <a:pt x="24" y="1456"/>
                </a:lnTo>
                <a:lnTo>
                  <a:pt x="32" y="1296"/>
                </a:lnTo>
                <a:lnTo>
                  <a:pt x="40" y="1320"/>
                </a:lnTo>
                <a:lnTo>
                  <a:pt x="48" y="1248"/>
                </a:lnTo>
                <a:lnTo>
                  <a:pt x="56" y="1248"/>
                </a:lnTo>
                <a:lnTo>
                  <a:pt x="64" y="968"/>
                </a:lnTo>
                <a:lnTo>
                  <a:pt x="72" y="1000"/>
                </a:lnTo>
                <a:lnTo>
                  <a:pt x="80" y="984"/>
                </a:lnTo>
                <a:lnTo>
                  <a:pt x="88" y="1056"/>
                </a:lnTo>
                <a:lnTo>
                  <a:pt x="96" y="768"/>
                </a:lnTo>
                <a:lnTo>
                  <a:pt x="104" y="864"/>
                </a:lnTo>
                <a:lnTo>
                  <a:pt x="112" y="840"/>
                </a:lnTo>
                <a:lnTo>
                  <a:pt x="120" y="872"/>
                </a:lnTo>
                <a:lnTo>
                  <a:pt x="128" y="680"/>
                </a:lnTo>
                <a:lnTo>
                  <a:pt x="136" y="736"/>
                </a:lnTo>
                <a:lnTo>
                  <a:pt x="144" y="864"/>
                </a:lnTo>
                <a:lnTo>
                  <a:pt x="152" y="904"/>
                </a:lnTo>
                <a:lnTo>
                  <a:pt x="160" y="552"/>
                </a:lnTo>
                <a:lnTo>
                  <a:pt x="168" y="744"/>
                </a:lnTo>
                <a:lnTo>
                  <a:pt x="176" y="592"/>
                </a:lnTo>
                <a:lnTo>
                  <a:pt x="184" y="792"/>
                </a:lnTo>
                <a:lnTo>
                  <a:pt x="192" y="480"/>
                </a:lnTo>
                <a:lnTo>
                  <a:pt x="200" y="600"/>
                </a:lnTo>
                <a:lnTo>
                  <a:pt x="208" y="536"/>
                </a:lnTo>
                <a:lnTo>
                  <a:pt x="216" y="664"/>
                </a:lnTo>
                <a:lnTo>
                  <a:pt x="224" y="568"/>
                </a:lnTo>
                <a:lnTo>
                  <a:pt x="232" y="504"/>
                </a:lnTo>
                <a:lnTo>
                  <a:pt x="240" y="560"/>
                </a:lnTo>
                <a:lnTo>
                  <a:pt x="248" y="720"/>
                </a:lnTo>
                <a:lnTo>
                  <a:pt x="256" y="504"/>
                </a:lnTo>
                <a:lnTo>
                  <a:pt x="264" y="640"/>
                </a:lnTo>
                <a:lnTo>
                  <a:pt x="272" y="488"/>
                </a:lnTo>
                <a:lnTo>
                  <a:pt x="280" y="392"/>
                </a:lnTo>
                <a:lnTo>
                  <a:pt x="288" y="520"/>
                </a:lnTo>
                <a:lnTo>
                  <a:pt x="296" y="448"/>
                </a:lnTo>
                <a:lnTo>
                  <a:pt x="304" y="400"/>
                </a:lnTo>
                <a:lnTo>
                  <a:pt x="312" y="464"/>
                </a:lnTo>
                <a:lnTo>
                  <a:pt x="320" y="0"/>
                </a:lnTo>
                <a:lnTo>
                  <a:pt x="328" y="320"/>
                </a:lnTo>
                <a:lnTo>
                  <a:pt x="336" y="600"/>
                </a:lnTo>
                <a:lnTo>
                  <a:pt x="344" y="480"/>
                </a:lnTo>
                <a:lnTo>
                  <a:pt x="352" y="384"/>
                </a:lnTo>
                <a:lnTo>
                  <a:pt x="360" y="280"/>
                </a:lnTo>
                <a:lnTo>
                  <a:pt x="368" y="232"/>
                </a:lnTo>
                <a:lnTo>
                  <a:pt x="376" y="400"/>
                </a:lnTo>
                <a:lnTo>
                  <a:pt x="384" y="88"/>
                </a:lnTo>
                <a:lnTo>
                  <a:pt x="392" y="552"/>
                </a:lnTo>
                <a:lnTo>
                  <a:pt x="400" y="480"/>
                </a:lnTo>
                <a:lnTo>
                  <a:pt x="408" y="120"/>
                </a:lnTo>
                <a:lnTo>
                  <a:pt x="416" y="432"/>
                </a:lnTo>
                <a:lnTo>
                  <a:pt x="424" y="512"/>
                </a:lnTo>
                <a:lnTo>
                  <a:pt x="432" y="512"/>
                </a:lnTo>
                <a:lnTo>
                  <a:pt x="440" y="696"/>
                </a:lnTo>
                <a:lnTo>
                  <a:pt x="448" y="632"/>
                </a:lnTo>
                <a:lnTo>
                  <a:pt x="456" y="760"/>
                </a:lnTo>
                <a:lnTo>
                  <a:pt x="464" y="888"/>
                </a:lnTo>
                <a:lnTo>
                  <a:pt x="472" y="904"/>
                </a:lnTo>
                <a:lnTo>
                  <a:pt x="480" y="1024"/>
                </a:lnTo>
                <a:lnTo>
                  <a:pt x="488" y="904"/>
                </a:lnTo>
                <a:lnTo>
                  <a:pt x="496" y="1160"/>
                </a:lnTo>
                <a:lnTo>
                  <a:pt x="504" y="1080"/>
                </a:lnTo>
                <a:lnTo>
                  <a:pt x="512" y="1208"/>
                </a:lnTo>
                <a:lnTo>
                  <a:pt x="520" y="1296"/>
                </a:lnTo>
                <a:lnTo>
                  <a:pt x="528" y="1368"/>
                </a:lnTo>
                <a:lnTo>
                  <a:pt x="536" y="1440"/>
                </a:lnTo>
                <a:lnTo>
                  <a:pt x="544" y="1336"/>
                </a:lnTo>
                <a:lnTo>
                  <a:pt x="552" y="1480"/>
                </a:lnTo>
                <a:lnTo>
                  <a:pt x="560" y="1392"/>
                </a:lnTo>
                <a:lnTo>
                  <a:pt x="568" y="1480"/>
                </a:lnTo>
                <a:lnTo>
                  <a:pt x="576" y="1624"/>
                </a:lnTo>
                <a:lnTo>
                  <a:pt x="584" y="1560"/>
                </a:lnTo>
                <a:lnTo>
                  <a:pt x="592" y="1552"/>
                </a:lnTo>
                <a:lnTo>
                  <a:pt x="600" y="1672"/>
                </a:lnTo>
                <a:lnTo>
                  <a:pt x="608" y="1720"/>
                </a:lnTo>
                <a:lnTo>
                  <a:pt x="616" y="1760"/>
                </a:lnTo>
                <a:lnTo>
                  <a:pt x="624" y="1704"/>
                </a:lnTo>
                <a:lnTo>
                  <a:pt x="632" y="1792"/>
                </a:lnTo>
                <a:lnTo>
                  <a:pt x="640" y="1760"/>
                </a:lnTo>
                <a:lnTo>
                  <a:pt x="648" y="1808"/>
                </a:lnTo>
                <a:lnTo>
                  <a:pt x="656" y="1808"/>
                </a:lnTo>
                <a:lnTo>
                  <a:pt x="664" y="1752"/>
                </a:lnTo>
                <a:lnTo>
                  <a:pt x="672" y="1816"/>
                </a:lnTo>
                <a:lnTo>
                  <a:pt x="680" y="1824"/>
                </a:lnTo>
                <a:lnTo>
                  <a:pt x="688" y="1832"/>
                </a:lnTo>
                <a:lnTo>
                  <a:pt x="696" y="1808"/>
                </a:lnTo>
                <a:lnTo>
                  <a:pt x="704" y="1784"/>
                </a:lnTo>
                <a:lnTo>
                  <a:pt x="712" y="1848"/>
                </a:lnTo>
                <a:lnTo>
                  <a:pt x="720" y="1848"/>
                </a:lnTo>
                <a:lnTo>
                  <a:pt x="728" y="1912"/>
                </a:lnTo>
                <a:lnTo>
                  <a:pt x="736" y="1864"/>
                </a:lnTo>
                <a:lnTo>
                  <a:pt x="744" y="1920"/>
                </a:lnTo>
                <a:lnTo>
                  <a:pt x="752" y="1896"/>
                </a:lnTo>
                <a:lnTo>
                  <a:pt x="760" y="1904"/>
                </a:lnTo>
                <a:lnTo>
                  <a:pt x="768" y="1928"/>
                </a:lnTo>
                <a:lnTo>
                  <a:pt x="776" y="1904"/>
                </a:lnTo>
                <a:lnTo>
                  <a:pt x="784" y="1904"/>
                </a:lnTo>
                <a:lnTo>
                  <a:pt x="792" y="1864"/>
                </a:lnTo>
                <a:lnTo>
                  <a:pt x="800" y="1920"/>
                </a:lnTo>
                <a:lnTo>
                  <a:pt x="808" y="1920"/>
                </a:lnTo>
                <a:lnTo>
                  <a:pt x="816" y="1928"/>
                </a:lnTo>
                <a:lnTo>
                  <a:pt x="824" y="1920"/>
                </a:lnTo>
                <a:lnTo>
                  <a:pt x="832" y="1928"/>
                </a:lnTo>
                <a:lnTo>
                  <a:pt x="840" y="1936"/>
                </a:lnTo>
                <a:lnTo>
                  <a:pt x="848" y="1928"/>
                </a:lnTo>
                <a:lnTo>
                  <a:pt x="856" y="1928"/>
                </a:lnTo>
                <a:lnTo>
                  <a:pt x="864" y="1928"/>
                </a:lnTo>
                <a:lnTo>
                  <a:pt x="872" y="1928"/>
                </a:lnTo>
                <a:lnTo>
                  <a:pt x="880" y="1936"/>
                </a:lnTo>
                <a:lnTo>
                  <a:pt x="888" y="1936"/>
                </a:lnTo>
                <a:lnTo>
                  <a:pt x="896" y="1936"/>
                </a:lnTo>
                <a:lnTo>
                  <a:pt x="904" y="1936"/>
                </a:lnTo>
                <a:lnTo>
                  <a:pt x="912" y="1936"/>
                </a:lnTo>
                <a:lnTo>
                  <a:pt x="920" y="1936"/>
                </a:lnTo>
                <a:lnTo>
                  <a:pt x="928" y="1936"/>
                </a:lnTo>
                <a:lnTo>
                  <a:pt x="936" y="1936"/>
                </a:lnTo>
                <a:lnTo>
                  <a:pt x="944" y="1936"/>
                </a:lnTo>
                <a:lnTo>
                  <a:pt x="952" y="1936"/>
                </a:lnTo>
                <a:lnTo>
                  <a:pt x="960" y="1936"/>
                </a:lnTo>
                <a:lnTo>
                  <a:pt x="968" y="1936"/>
                </a:lnTo>
                <a:lnTo>
                  <a:pt x="976" y="1936"/>
                </a:lnTo>
                <a:lnTo>
                  <a:pt x="984" y="1936"/>
                </a:lnTo>
                <a:lnTo>
                  <a:pt x="992" y="1936"/>
                </a:lnTo>
                <a:lnTo>
                  <a:pt x="1000" y="1936"/>
                </a:lnTo>
                <a:lnTo>
                  <a:pt x="1008" y="1936"/>
                </a:lnTo>
                <a:lnTo>
                  <a:pt x="1016" y="1936"/>
                </a:lnTo>
                <a:lnTo>
                  <a:pt x="1024" y="1936"/>
                </a:lnTo>
                <a:lnTo>
                  <a:pt x="1032" y="1936"/>
                </a:lnTo>
                <a:lnTo>
                  <a:pt x="1040" y="1936"/>
                </a:lnTo>
                <a:lnTo>
                  <a:pt x="1048" y="1936"/>
                </a:lnTo>
                <a:lnTo>
                  <a:pt x="1056" y="1936"/>
                </a:lnTo>
                <a:lnTo>
                  <a:pt x="1064" y="1936"/>
                </a:lnTo>
                <a:lnTo>
                  <a:pt x="1072" y="1936"/>
                </a:lnTo>
                <a:lnTo>
                  <a:pt x="1080" y="1936"/>
                </a:lnTo>
                <a:lnTo>
                  <a:pt x="1088" y="1936"/>
                </a:lnTo>
                <a:lnTo>
                  <a:pt x="1096" y="1936"/>
                </a:lnTo>
                <a:lnTo>
                  <a:pt x="1104" y="1936"/>
                </a:lnTo>
                <a:lnTo>
                  <a:pt x="1112" y="1936"/>
                </a:lnTo>
                <a:lnTo>
                  <a:pt x="1120" y="1936"/>
                </a:lnTo>
                <a:lnTo>
                  <a:pt x="1128" y="1936"/>
                </a:lnTo>
                <a:lnTo>
                  <a:pt x="1136" y="1936"/>
                </a:lnTo>
                <a:lnTo>
                  <a:pt x="1144" y="1936"/>
                </a:lnTo>
                <a:lnTo>
                  <a:pt x="1152" y="1936"/>
                </a:lnTo>
                <a:lnTo>
                  <a:pt x="1160" y="1936"/>
                </a:lnTo>
                <a:lnTo>
                  <a:pt x="1168" y="1936"/>
                </a:lnTo>
                <a:lnTo>
                  <a:pt x="1176" y="1936"/>
                </a:lnTo>
                <a:lnTo>
                  <a:pt x="1184" y="1936"/>
                </a:lnTo>
                <a:lnTo>
                  <a:pt x="1192" y="1936"/>
                </a:lnTo>
                <a:lnTo>
                  <a:pt x="1200" y="1936"/>
                </a:lnTo>
                <a:lnTo>
                  <a:pt x="1208" y="1936"/>
                </a:lnTo>
                <a:lnTo>
                  <a:pt x="1216" y="1936"/>
                </a:lnTo>
                <a:lnTo>
                  <a:pt x="1224" y="1936"/>
                </a:lnTo>
                <a:lnTo>
                  <a:pt x="1232" y="1936"/>
                </a:lnTo>
                <a:lnTo>
                  <a:pt x="1240" y="1936"/>
                </a:lnTo>
                <a:lnTo>
                  <a:pt x="1248" y="1936"/>
                </a:lnTo>
                <a:lnTo>
                  <a:pt x="1256" y="1936"/>
                </a:lnTo>
                <a:lnTo>
                  <a:pt x="1264" y="1936"/>
                </a:lnTo>
                <a:lnTo>
                  <a:pt x="1272" y="1936"/>
                </a:lnTo>
                <a:lnTo>
                  <a:pt x="1280" y="1936"/>
                </a:lnTo>
                <a:lnTo>
                  <a:pt x="1288" y="1936"/>
                </a:lnTo>
                <a:lnTo>
                  <a:pt x="1296" y="1936"/>
                </a:lnTo>
                <a:lnTo>
                  <a:pt x="1304" y="1936"/>
                </a:lnTo>
                <a:lnTo>
                  <a:pt x="1312" y="1936"/>
                </a:lnTo>
                <a:lnTo>
                  <a:pt x="1320" y="1936"/>
                </a:lnTo>
                <a:lnTo>
                  <a:pt x="1328" y="1936"/>
                </a:lnTo>
                <a:lnTo>
                  <a:pt x="1336" y="1936"/>
                </a:lnTo>
                <a:lnTo>
                  <a:pt x="1344" y="1936"/>
                </a:lnTo>
                <a:lnTo>
                  <a:pt x="1352" y="1936"/>
                </a:lnTo>
                <a:lnTo>
                  <a:pt x="1360" y="1936"/>
                </a:lnTo>
                <a:lnTo>
                  <a:pt x="1368" y="1936"/>
                </a:lnTo>
                <a:lnTo>
                  <a:pt x="1376" y="1936"/>
                </a:lnTo>
                <a:lnTo>
                  <a:pt x="1384" y="1936"/>
                </a:lnTo>
                <a:lnTo>
                  <a:pt x="1392" y="1936"/>
                </a:lnTo>
                <a:lnTo>
                  <a:pt x="1400" y="1936"/>
                </a:lnTo>
                <a:lnTo>
                  <a:pt x="1408" y="1936"/>
                </a:lnTo>
                <a:lnTo>
                  <a:pt x="1416" y="1936"/>
                </a:lnTo>
                <a:lnTo>
                  <a:pt x="1424" y="1936"/>
                </a:lnTo>
                <a:lnTo>
                  <a:pt x="1432" y="1936"/>
                </a:lnTo>
                <a:lnTo>
                  <a:pt x="1440" y="1936"/>
                </a:lnTo>
                <a:lnTo>
                  <a:pt x="1448" y="1936"/>
                </a:lnTo>
                <a:lnTo>
                  <a:pt x="1456" y="1936"/>
                </a:lnTo>
                <a:lnTo>
                  <a:pt x="1464" y="1936"/>
                </a:lnTo>
                <a:lnTo>
                  <a:pt x="1472" y="1936"/>
                </a:lnTo>
                <a:lnTo>
                  <a:pt x="1480" y="1936"/>
                </a:lnTo>
                <a:lnTo>
                  <a:pt x="1488" y="1936"/>
                </a:lnTo>
                <a:lnTo>
                  <a:pt x="1496" y="1936"/>
                </a:lnTo>
                <a:lnTo>
                  <a:pt x="1504" y="1936"/>
                </a:lnTo>
                <a:lnTo>
                  <a:pt x="1512" y="1936"/>
                </a:lnTo>
                <a:lnTo>
                  <a:pt x="1520" y="1936"/>
                </a:lnTo>
                <a:lnTo>
                  <a:pt x="1528" y="1936"/>
                </a:lnTo>
                <a:lnTo>
                  <a:pt x="1536" y="1936"/>
                </a:lnTo>
                <a:lnTo>
                  <a:pt x="1544" y="1936"/>
                </a:lnTo>
                <a:lnTo>
                  <a:pt x="1552" y="1936"/>
                </a:lnTo>
                <a:lnTo>
                  <a:pt x="1560" y="1936"/>
                </a:lnTo>
                <a:lnTo>
                  <a:pt x="1568" y="1936"/>
                </a:lnTo>
                <a:lnTo>
                  <a:pt x="1576" y="1936"/>
                </a:lnTo>
                <a:lnTo>
                  <a:pt x="1584" y="1936"/>
                </a:lnTo>
                <a:lnTo>
                  <a:pt x="1592" y="1936"/>
                </a:lnTo>
                <a:lnTo>
                  <a:pt x="1600" y="1936"/>
                </a:lnTo>
                <a:lnTo>
                  <a:pt x="1608" y="1936"/>
                </a:lnTo>
                <a:lnTo>
                  <a:pt x="1616" y="1936"/>
                </a:lnTo>
                <a:lnTo>
                  <a:pt x="1624" y="1936"/>
                </a:lnTo>
                <a:lnTo>
                  <a:pt x="1632" y="1936"/>
                </a:lnTo>
                <a:lnTo>
                  <a:pt x="1640" y="1936"/>
                </a:lnTo>
                <a:lnTo>
                  <a:pt x="1648" y="1936"/>
                </a:lnTo>
                <a:lnTo>
                  <a:pt x="1656" y="1936"/>
                </a:lnTo>
                <a:lnTo>
                  <a:pt x="1664" y="1936"/>
                </a:lnTo>
                <a:lnTo>
                  <a:pt x="1672" y="1936"/>
                </a:lnTo>
                <a:lnTo>
                  <a:pt x="1680" y="1936"/>
                </a:lnTo>
                <a:lnTo>
                  <a:pt x="1688" y="1936"/>
                </a:lnTo>
                <a:lnTo>
                  <a:pt x="1696" y="1936"/>
                </a:lnTo>
                <a:lnTo>
                  <a:pt x="1704" y="1936"/>
                </a:lnTo>
                <a:lnTo>
                  <a:pt x="1712" y="1936"/>
                </a:lnTo>
                <a:lnTo>
                  <a:pt x="1720" y="1936"/>
                </a:lnTo>
                <a:lnTo>
                  <a:pt x="1728" y="1936"/>
                </a:lnTo>
                <a:lnTo>
                  <a:pt x="1736" y="1936"/>
                </a:lnTo>
                <a:lnTo>
                  <a:pt x="1744" y="1936"/>
                </a:lnTo>
                <a:lnTo>
                  <a:pt x="1752" y="1936"/>
                </a:lnTo>
                <a:lnTo>
                  <a:pt x="1760" y="1936"/>
                </a:lnTo>
                <a:lnTo>
                  <a:pt x="1768" y="1936"/>
                </a:lnTo>
                <a:lnTo>
                  <a:pt x="1776" y="1936"/>
                </a:lnTo>
                <a:lnTo>
                  <a:pt x="1784" y="1936"/>
                </a:lnTo>
                <a:lnTo>
                  <a:pt x="1792" y="1936"/>
                </a:lnTo>
                <a:lnTo>
                  <a:pt x="1800" y="1936"/>
                </a:lnTo>
                <a:lnTo>
                  <a:pt x="1808" y="1936"/>
                </a:lnTo>
                <a:lnTo>
                  <a:pt x="1816" y="1936"/>
                </a:lnTo>
                <a:lnTo>
                  <a:pt x="1824" y="1936"/>
                </a:lnTo>
                <a:lnTo>
                  <a:pt x="1832" y="1936"/>
                </a:lnTo>
                <a:lnTo>
                  <a:pt x="1840" y="1936"/>
                </a:lnTo>
                <a:lnTo>
                  <a:pt x="1848" y="1936"/>
                </a:lnTo>
                <a:lnTo>
                  <a:pt x="1856" y="1936"/>
                </a:lnTo>
                <a:lnTo>
                  <a:pt x="1864" y="1936"/>
                </a:lnTo>
                <a:lnTo>
                  <a:pt x="1872" y="1936"/>
                </a:lnTo>
                <a:lnTo>
                  <a:pt x="1880" y="1936"/>
                </a:lnTo>
                <a:lnTo>
                  <a:pt x="1888" y="1936"/>
                </a:lnTo>
                <a:lnTo>
                  <a:pt x="1896" y="1936"/>
                </a:lnTo>
                <a:lnTo>
                  <a:pt x="1904" y="1936"/>
                </a:lnTo>
                <a:lnTo>
                  <a:pt x="1912" y="1936"/>
                </a:lnTo>
                <a:lnTo>
                  <a:pt x="1920" y="1936"/>
                </a:lnTo>
                <a:lnTo>
                  <a:pt x="1928" y="1936"/>
                </a:lnTo>
                <a:lnTo>
                  <a:pt x="1936" y="1936"/>
                </a:lnTo>
                <a:lnTo>
                  <a:pt x="1944" y="1936"/>
                </a:lnTo>
                <a:lnTo>
                  <a:pt x="1952" y="1936"/>
                </a:lnTo>
                <a:lnTo>
                  <a:pt x="1960" y="1936"/>
                </a:lnTo>
                <a:lnTo>
                  <a:pt x="1968" y="1936"/>
                </a:lnTo>
                <a:lnTo>
                  <a:pt x="1976" y="1936"/>
                </a:lnTo>
                <a:lnTo>
                  <a:pt x="1984" y="1936"/>
                </a:lnTo>
                <a:lnTo>
                  <a:pt x="1992" y="1936"/>
                </a:lnTo>
                <a:lnTo>
                  <a:pt x="2000" y="1936"/>
                </a:lnTo>
                <a:lnTo>
                  <a:pt x="2008" y="1936"/>
                </a:lnTo>
                <a:lnTo>
                  <a:pt x="2016" y="1936"/>
                </a:lnTo>
                <a:lnTo>
                  <a:pt x="2024" y="1936"/>
                </a:lnTo>
                <a:lnTo>
                  <a:pt x="2032" y="1936"/>
                </a:lnTo>
              </a:path>
            </a:pathLst>
          </a:custGeom>
          <a:noFill/>
          <a:ln w="12600">
            <a:solidFill>
              <a:srgbClr val="0000ff"/>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20" name=""/>
          <p:cNvSpPr/>
          <p:nvPr/>
        </p:nvSpPr>
        <p:spPr>
          <a:xfrm>
            <a:off x="1096920" y="2905200"/>
            <a:ext cx="1444680" cy="1252440"/>
          </a:xfrm>
          <a:prstGeom prst="rect">
            <a:avLst/>
          </a:prstGeom>
          <a:solidFill>
            <a:srgbClr val="ffffff"/>
          </a:solidFill>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21" name=""/>
          <p:cNvSpPr/>
          <p:nvPr/>
        </p:nvSpPr>
        <p:spPr>
          <a:xfrm>
            <a:off x="1096920" y="4152960"/>
            <a:ext cx="144000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22" name=""/>
          <p:cNvSpPr/>
          <p:nvPr/>
        </p:nvSpPr>
        <p:spPr>
          <a:xfrm>
            <a:off x="1096920" y="4157640"/>
            <a:ext cx="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sp>
        <p:nvSpPr>
          <p:cNvPr id="123" name=""/>
          <p:cNvSpPr/>
          <p:nvPr/>
        </p:nvSpPr>
        <p:spPr>
          <a:xfrm>
            <a:off x="1203480" y="41576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24" name=""/>
          <p:cNvSpPr/>
          <p:nvPr/>
        </p:nvSpPr>
        <p:spPr>
          <a:xfrm>
            <a:off x="1263600" y="415764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25" name=""/>
          <p:cNvSpPr/>
          <p:nvPr/>
        </p:nvSpPr>
        <p:spPr>
          <a:xfrm>
            <a:off x="1309680" y="41576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26" name=""/>
          <p:cNvSpPr/>
          <p:nvPr/>
        </p:nvSpPr>
        <p:spPr>
          <a:xfrm>
            <a:off x="1347840" y="4157640"/>
            <a:ext cx="144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127" name=""/>
          <p:cNvSpPr/>
          <p:nvPr/>
        </p:nvSpPr>
        <p:spPr>
          <a:xfrm>
            <a:off x="1376280" y="41576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28" name=""/>
          <p:cNvSpPr/>
          <p:nvPr/>
        </p:nvSpPr>
        <p:spPr>
          <a:xfrm>
            <a:off x="1398600" y="41576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29" name=""/>
          <p:cNvSpPr/>
          <p:nvPr/>
        </p:nvSpPr>
        <p:spPr>
          <a:xfrm>
            <a:off x="1420920" y="41576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30" name=""/>
          <p:cNvSpPr/>
          <p:nvPr/>
        </p:nvSpPr>
        <p:spPr>
          <a:xfrm>
            <a:off x="1436760" y="415764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31" name=""/>
          <p:cNvSpPr/>
          <p:nvPr/>
        </p:nvSpPr>
        <p:spPr>
          <a:xfrm>
            <a:off x="1454040" y="4157640"/>
            <a:ext cx="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sp>
        <p:nvSpPr>
          <p:cNvPr id="132" name=""/>
          <p:cNvSpPr/>
          <p:nvPr/>
        </p:nvSpPr>
        <p:spPr>
          <a:xfrm>
            <a:off x="1565280" y="415764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33" name=""/>
          <p:cNvSpPr/>
          <p:nvPr/>
        </p:nvSpPr>
        <p:spPr>
          <a:xfrm>
            <a:off x="1627200" y="41576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34" name=""/>
          <p:cNvSpPr/>
          <p:nvPr/>
        </p:nvSpPr>
        <p:spPr>
          <a:xfrm>
            <a:off x="1671480" y="41576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35" name=""/>
          <p:cNvSpPr/>
          <p:nvPr/>
        </p:nvSpPr>
        <p:spPr>
          <a:xfrm>
            <a:off x="1704960" y="4157640"/>
            <a:ext cx="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136" name=""/>
          <p:cNvSpPr/>
          <p:nvPr/>
        </p:nvSpPr>
        <p:spPr>
          <a:xfrm>
            <a:off x="1738440" y="415764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37" name=""/>
          <p:cNvSpPr/>
          <p:nvPr/>
        </p:nvSpPr>
        <p:spPr>
          <a:xfrm>
            <a:off x="1760400" y="415764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38" name=""/>
          <p:cNvSpPr/>
          <p:nvPr/>
        </p:nvSpPr>
        <p:spPr>
          <a:xfrm>
            <a:off x="1782720" y="415764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39" name=""/>
          <p:cNvSpPr/>
          <p:nvPr/>
        </p:nvSpPr>
        <p:spPr>
          <a:xfrm>
            <a:off x="1800360" y="41576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40" name=""/>
          <p:cNvSpPr/>
          <p:nvPr/>
        </p:nvSpPr>
        <p:spPr>
          <a:xfrm>
            <a:off x="1816200" y="4157640"/>
            <a:ext cx="144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sp>
        <p:nvSpPr>
          <p:cNvPr id="141" name=""/>
          <p:cNvSpPr/>
          <p:nvPr/>
        </p:nvSpPr>
        <p:spPr>
          <a:xfrm>
            <a:off x="1922400" y="41576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42" name=""/>
          <p:cNvSpPr/>
          <p:nvPr/>
        </p:nvSpPr>
        <p:spPr>
          <a:xfrm>
            <a:off x="1989000" y="415764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43" name=""/>
          <p:cNvSpPr/>
          <p:nvPr/>
        </p:nvSpPr>
        <p:spPr>
          <a:xfrm>
            <a:off x="2033640" y="415764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44" name=""/>
          <p:cNvSpPr/>
          <p:nvPr/>
        </p:nvSpPr>
        <p:spPr>
          <a:xfrm>
            <a:off x="2066760" y="4157640"/>
            <a:ext cx="180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145" name=""/>
          <p:cNvSpPr/>
          <p:nvPr/>
        </p:nvSpPr>
        <p:spPr>
          <a:xfrm>
            <a:off x="2095560" y="41576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46" name=""/>
          <p:cNvSpPr/>
          <p:nvPr/>
        </p:nvSpPr>
        <p:spPr>
          <a:xfrm>
            <a:off x="2124000" y="41576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47" name=""/>
          <p:cNvSpPr/>
          <p:nvPr/>
        </p:nvSpPr>
        <p:spPr>
          <a:xfrm>
            <a:off x="2139840" y="415764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48" name=""/>
          <p:cNvSpPr/>
          <p:nvPr/>
        </p:nvSpPr>
        <p:spPr>
          <a:xfrm>
            <a:off x="2162160" y="415764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49" name=""/>
          <p:cNvSpPr/>
          <p:nvPr/>
        </p:nvSpPr>
        <p:spPr>
          <a:xfrm>
            <a:off x="2179800" y="4157640"/>
            <a:ext cx="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sp>
        <p:nvSpPr>
          <p:cNvPr id="150" name=""/>
          <p:cNvSpPr/>
          <p:nvPr/>
        </p:nvSpPr>
        <p:spPr>
          <a:xfrm>
            <a:off x="2284560" y="415764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51" name=""/>
          <p:cNvSpPr/>
          <p:nvPr/>
        </p:nvSpPr>
        <p:spPr>
          <a:xfrm>
            <a:off x="2352600" y="41576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52" name=""/>
          <p:cNvSpPr/>
          <p:nvPr/>
        </p:nvSpPr>
        <p:spPr>
          <a:xfrm>
            <a:off x="2397240" y="41576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53" name=""/>
          <p:cNvSpPr/>
          <p:nvPr/>
        </p:nvSpPr>
        <p:spPr>
          <a:xfrm>
            <a:off x="2430360" y="4157640"/>
            <a:ext cx="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154" name=""/>
          <p:cNvSpPr/>
          <p:nvPr/>
        </p:nvSpPr>
        <p:spPr>
          <a:xfrm>
            <a:off x="2457360" y="415764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55" name=""/>
          <p:cNvSpPr/>
          <p:nvPr/>
        </p:nvSpPr>
        <p:spPr>
          <a:xfrm>
            <a:off x="2479680" y="415764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56" name=""/>
          <p:cNvSpPr/>
          <p:nvPr/>
        </p:nvSpPr>
        <p:spPr>
          <a:xfrm>
            <a:off x="2502000" y="415764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57" name=""/>
          <p:cNvSpPr/>
          <p:nvPr/>
        </p:nvSpPr>
        <p:spPr>
          <a:xfrm>
            <a:off x="2519280" y="415764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158" name=""/>
          <p:cNvSpPr/>
          <p:nvPr/>
        </p:nvSpPr>
        <p:spPr>
          <a:xfrm>
            <a:off x="2536920" y="4157640"/>
            <a:ext cx="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sp>
        <p:nvSpPr>
          <p:cNvPr id="159" name=""/>
          <p:cNvSpPr/>
          <p:nvPr/>
        </p:nvSpPr>
        <p:spPr>
          <a:xfrm flipV="1">
            <a:off x="1096920" y="2905200"/>
            <a:ext cx="0" cy="12477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60" name=""/>
          <p:cNvSpPr/>
          <p:nvPr/>
        </p:nvSpPr>
        <p:spPr>
          <a:xfrm>
            <a:off x="977400" y="4124160"/>
            <a:ext cx="648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0</a:t>
            </a:r>
            <a:endParaRPr b="0" lang="en-US" sz="900" spc="-1" strike="noStrike">
              <a:solidFill>
                <a:srgbClr val="000000"/>
              </a:solidFill>
              <a:latin typeface="Arial"/>
            </a:endParaRPr>
          </a:p>
        </p:txBody>
      </p:sp>
      <p:sp>
        <p:nvSpPr>
          <p:cNvPr id="161" name=""/>
          <p:cNvSpPr/>
          <p:nvPr/>
        </p:nvSpPr>
        <p:spPr>
          <a:xfrm>
            <a:off x="936000" y="39038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50</a:t>
            </a:r>
            <a:endParaRPr b="0" lang="en-US" sz="900" spc="-1" strike="noStrike">
              <a:solidFill>
                <a:srgbClr val="000000"/>
              </a:solidFill>
              <a:latin typeface="Arial"/>
            </a:endParaRPr>
          </a:p>
        </p:txBody>
      </p:sp>
      <p:sp>
        <p:nvSpPr>
          <p:cNvPr id="162" name=""/>
          <p:cNvSpPr/>
          <p:nvPr/>
        </p:nvSpPr>
        <p:spPr>
          <a:xfrm>
            <a:off x="896040" y="367344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0</a:t>
            </a:r>
            <a:endParaRPr b="0" lang="en-US" sz="900" spc="-1" strike="noStrike">
              <a:solidFill>
                <a:srgbClr val="000000"/>
              </a:solidFill>
              <a:latin typeface="Arial"/>
            </a:endParaRPr>
          </a:p>
        </p:txBody>
      </p:sp>
      <p:sp>
        <p:nvSpPr>
          <p:cNvPr id="163" name=""/>
          <p:cNvSpPr/>
          <p:nvPr/>
        </p:nvSpPr>
        <p:spPr>
          <a:xfrm>
            <a:off x="896040" y="345600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50</a:t>
            </a:r>
            <a:endParaRPr b="0" lang="en-US" sz="900" spc="-1" strike="noStrike">
              <a:solidFill>
                <a:srgbClr val="000000"/>
              </a:solidFill>
              <a:latin typeface="Arial"/>
            </a:endParaRPr>
          </a:p>
        </p:txBody>
      </p:sp>
      <p:sp>
        <p:nvSpPr>
          <p:cNvPr id="164" name=""/>
          <p:cNvSpPr/>
          <p:nvPr/>
        </p:nvSpPr>
        <p:spPr>
          <a:xfrm>
            <a:off x="896040" y="322416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200</a:t>
            </a:r>
            <a:endParaRPr b="0" lang="en-US" sz="900" spc="-1" strike="noStrike">
              <a:solidFill>
                <a:srgbClr val="000000"/>
              </a:solidFill>
              <a:latin typeface="Arial"/>
            </a:endParaRPr>
          </a:p>
        </p:txBody>
      </p:sp>
      <p:sp>
        <p:nvSpPr>
          <p:cNvPr id="165" name=""/>
          <p:cNvSpPr/>
          <p:nvPr/>
        </p:nvSpPr>
        <p:spPr>
          <a:xfrm>
            <a:off x="896040" y="300348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250</a:t>
            </a:r>
            <a:endParaRPr b="0" lang="en-US" sz="900" spc="-1" strike="noStrike">
              <a:solidFill>
                <a:srgbClr val="000000"/>
              </a:solidFill>
              <a:latin typeface="Arial"/>
            </a:endParaRPr>
          </a:p>
        </p:txBody>
      </p:sp>
      <p:sp>
        <p:nvSpPr>
          <p:cNvPr id="166" name=""/>
          <p:cNvSpPr/>
          <p:nvPr/>
        </p:nvSpPr>
        <p:spPr>
          <a:xfrm flipH="1">
            <a:off x="1063800" y="4152960"/>
            <a:ext cx="331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67" name=""/>
          <p:cNvSpPr/>
          <p:nvPr/>
        </p:nvSpPr>
        <p:spPr>
          <a:xfrm flipH="1">
            <a:off x="1085400" y="4108320"/>
            <a:ext cx="111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168" name=""/>
          <p:cNvSpPr/>
          <p:nvPr/>
        </p:nvSpPr>
        <p:spPr>
          <a:xfrm flipH="1">
            <a:off x="1085400" y="406548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69" name=""/>
          <p:cNvSpPr/>
          <p:nvPr/>
        </p:nvSpPr>
        <p:spPr>
          <a:xfrm flipH="1">
            <a:off x="1085400" y="4021200"/>
            <a:ext cx="111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170" name=""/>
          <p:cNvSpPr/>
          <p:nvPr/>
        </p:nvSpPr>
        <p:spPr>
          <a:xfrm flipH="1">
            <a:off x="1085400" y="397368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71" name=""/>
          <p:cNvSpPr/>
          <p:nvPr/>
        </p:nvSpPr>
        <p:spPr>
          <a:xfrm flipH="1">
            <a:off x="1063800" y="3929040"/>
            <a:ext cx="3312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172" name=""/>
          <p:cNvSpPr/>
          <p:nvPr/>
        </p:nvSpPr>
        <p:spPr>
          <a:xfrm flipH="1">
            <a:off x="1085400" y="388620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73" name=""/>
          <p:cNvSpPr/>
          <p:nvPr/>
        </p:nvSpPr>
        <p:spPr>
          <a:xfrm flipH="1">
            <a:off x="1085400" y="383868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74" name=""/>
          <p:cNvSpPr/>
          <p:nvPr/>
        </p:nvSpPr>
        <p:spPr>
          <a:xfrm flipH="1">
            <a:off x="1085400" y="3794040"/>
            <a:ext cx="111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175" name=""/>
          <p:cNvSpPr/>
          <p:nvPr/>
        </p:nvSpPr>
        <p:spPr>
          <a:xfrm flipH="1">
            <a:off x="1085400" y="375120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76" name=""/>
          <p:cNvSpPr/>
          <p:nvPr/>
        </p:nvSpPr>
        <p:spPr>
          <a:xfrm flipH="1">
            <a:off x="1063800" y="3701880"/>
            <a:ext cx="3312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177" name=""/>
          <p:cNvSpPr/>
          <p:nvPr/>
        </p:nvSpPr>
        <p:spPr>
          <a:xfrm flipH="1">
            <a:off x="1085400" y="365904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78" name=""/>
          <p:cNvSpPr/>
          <p:nvPr/>
        </p:nvSpPr>
        <p:spPr>
          <a:xfrm flipH="1">
            <a:off x="1085400" y="3614760"/>
            <a:ext cx="111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179" name=""/>
          <p:cNvSpPr/>
          <p:nvPr/>
        </p:nvSpPr>
        <p:spPr>
          <a:xfrm flipH="1">
            <a:off x="1085400" y="356724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80" name=""/>
          <p:cNvSpPr/>
          <p:nvPr/>
        </p:nvSpPr>
        <p:spPr>
          <a:xfrm flipH="1">
            <a:off x="1085400" y="352440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81" name=""/>
          <p:cNvSpPr/>
          <p:nvPr/>
        </p:nvSpPr>
        <p:spPr>
          <a:xfrm flipH="1">
            <a:off x="1063800" y="3479760"/>
            <a:ext cx="3312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182" name=""/>
          <p:cNvSpPr/>
          <p:nvPr/>
        </p:nvSpPr>
        <p:spPr>
          <a:xfrm flipH="1">
            <a:off x="1085400" y="343692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83" name=""/>
          <p:cNvSpPr/>
          <p:nvPr/>
        </p:nvSpPr>
        <p:spPr>
          <a:xfrm flipH="1">
            <a:off x="1085400" y="3387600"/>
            <a:ext cx="111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184" name=""/>
          <p:cNvSpPr/>
          <p:nvPr/>
        </p:nvSpPr>
        <p:spPr>
          <a:xfrm flipH="1">
            <a:off x="1085400" y="334476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85" name=""/>
          <p:cNvSpPr/>
          <p:nvPr/>
        </p:nvSpPr>
        <p:spPr>
          <a:xfrm flipH="1">
            <a:off x="1085400" y="3300480"/>
            <a:ext cx="111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186" name=""/>
          <p:cNvSpPr/>
          <p:nvPr/>
        </p:nvSpPr>
        <p:spPr>
          <a:xfrm flipH="1">
            <a:off x="1063800" y="3252960"/>
            <a:ext cx="331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87" name=""/>
          <p:cNvSpPr/>
          <p:nvPr/>
        </p:nvSpPr>
        <p:spPr>
          <a:xfrm flipH="1">
            <a:off x="1085400" y="320976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88" name=""/>
          <p:cNvSpPr/>
          <p:nvPr/>
        </p:nvSpPr>
        <p:spPr>
          <a:xfrm flipH="1">
            <a:off x="1085400" y="3165480"/>
            <a:ext cx="111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189" name=""/>
          <p:cNvSpPr/>
          <p:nvPr/>
        </p:nvSpPr>
        <p:spPr>
          <a:xfrm flipH="1">
            <a:off x="1085400" y="311796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90" name=""/>
          <p:cNvSpPr/>
          <p:nvPr/>
        </p:nvSpPr>
        <p:spPr>
          <a:xfrm flipH="1">
            <a:off x="1085400" y="3073320"/>
            <a:ext cx="111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191" name=""/>
          <p:cNvSpPr/>
          <p:nvPr/>
        </p:nvSpPr>
        <p:spPr>
          <a:xfrm flipH="1">
            <a:off x="1063800" y="3030480"/>
            <a:ext cx="331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92" name=""/>
          <p:cNvSpPr/>
          <p:nvPr/>
        </p:nvSpPr>
        <p:spPr>
          <a:xfrm flipH="1">
            <a:off x="1085400" y="2981160"/>
            <a:ext cx="111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193" name=""/>
          <p:cNvSpPr/>
          <p:nvPr/>
        </p:nvSpPr>
        <p:spPr>
          <a:xfrm flipH="1">
            <a:off x="1085400" y="293832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94" name=""/>
          <p:cNvSpPr/>
          <p:nvPr/>
        </p:nvSpPr>
        <p:spPr>
          <a:xfrm>
            <a:off x="1108080" y="2971800"/>
            <a:ext cx="1417680" cy="1176480"/>
          </a:xfrm>
          <a:custGeom>
            <a:avLst/>
            <a:gdLst/>
            <a:ahLst/>
            <a:rect l="l" t="t" r="r" b="b"/>
            <a:pathLst>
              <a:path w="2032" h="1944">
                <a:moveTo>
                  <a:pt x="0" y="1944"/>
                </a:moveTo>
                <a:lnTo>
                  <a:pt x="0" y="1888"/>
                </a:lnTo>
                <a:lnTo>
                  <a:pt x="0" y="1936"/>
                </a:lnTo>
                <a:lnTo>
                  <a:pt x="8" y="1944"/>
                </a:lnTo>
                <a:lnTo>
                  <a:pt x="16" y="1944"/>
                </a:lnTo>
                <a:lnTo>
                  <a:pt x="24" y="1928"/>
                </a:lnTo>
                <a:lnTo>
                  <a:pt x="32" y="1944"/>
                </a:lnTo>
                <a:lnTo>
                  <a:pt x="40" y="1936"/>
                </a:lnTo>
                <a:lnTo>
                  <a:pt x="48" y="1920"/>
                </a:lnTo>
                <a:lnTo>
                  <a:pt x="56" y="1944"/>
                </a:lnTo>
                <a:lnTo>
                  <a:pt x="64" y="1880"/>
                </a:lnTo>
                <a:lnTo>
                  <a:pt x="72" y="1920"/>
                </a:lnTo>
                <a:lnTo>
                  <a:pt x="80" y="1888"/>
                </a:lnTo>
                <a:lnTo>
                  <a:pt x="88" y="1880"/>
                </a:lnTo>
                <a:lnTo>
                  <a:pt x="96" y="1912"/>
                </a:lnTo>
                <a:lnTo>
                  <a:pt x="104" y="1856"/>
                </a:lnTo>
                <a:lnTo>
                  <a:pt x="112" y="1832"/>
                </a:lnTo>
                <a:lnTo>
                  <a:pt x="120" y="1800"/>
                </a:lnTo>
                <a:lnTo>
                  <a:pt x="128" y="1800"/>
                </a:lnTo>
                <a:lnTo>
                  <a:pt x="136" y="1760"/>
                </a:lnTo>
                <a:lnTo>
                  <a:pt x="144" y="1760"/>
                </a:lnTo>
                <a:lnTo>
                  <a:pt x="152" y="1760"/>
                </a:lnTo>
                <a:lnTo>
                  <a:pt x="160" y="1712"/>
                </a:lnTo>
                <a:lnTo>
                  <a:pt x="168" y="1736"/>
                </a:lnTo>
                <a:lnTo>
                  <a:pt x="176" y="1552"/>
                </a:lnTo>
                <a:lnTo>
                  <a:pt x="184" y="1624"/>
                </a:lnTo>
                <a:lnTo>
                  <a:pt x="192" y="1656"/>
                </a:lnTo>
                <a:lnTo>
                  <a:pt x="200" y="1664"/>
                </a:lnTo>
                <a:lnTo>
                  <a:pt x="208" y="1512"/>
                </a:lnTo>
                <a:lnTo>
                  <a:pt x="216" y="1552"/>
                </a:lnTo>
                <a:lnTo>
                  <a:pt x="224" y="1608"/>
                </a:lnTo>
                <a:lnTo>
                  <a:pt x="232" y="1584"/>
                </a:lnTo>
                <a:lnTo>
                  <a:pt x="240" y="1688"/>
                </a:lnTo>
                <a:lnTo>
                  <a:pt x="248" y="1480"/>
                </a:lnTo>
                <a:lnTo>
                  <a:pt x="256" y="1536"/>
                </a:lnTo>
                <a:lnTo>
                  <a:pt x="264" y="1632"/>
                </a:lnTo>
                <a:lnTo>
                  <a:pt x="272" y="1504"/>
                </a:lnTo>
                <a:lnTo>
                  <a:pt x="280" y="1528"/>
                </a:lnTo>
                <a:lnTo>
                  <a:pt x="288" y="1456"/>
                </a:lnTo>
                <a:lnTo>
                  <a:pt x="296" y="1480"/>
                </a:lnTo>
                <a:lnTo>
                  <a:pt x="304" y="1416"/>
                </a:lnTo>
                <a:lnTo>
                  <a:pt x="312" y="1416"/>
                </a:lnTo>
                <a:lnTo>
                  <a:pt x="320" y="1336"/>
                </a:lnTo>
                <a:lnTo>
                  <a:pt x="328" y="1376"/>
                </a:lnTo>
                <a:lnTo>
                  <a:pt x="336" y="1264"/>
                </a:lnTo>
                <a:lnTo>
                  <a:pt x="344" y="1320"/>
                </a:lnTo>
                <a:lnTo>
                  <a:pt x="352" y="1200"/>
                </a:lnTo>
                <a:lnTo>
                  <a:pt x="360" y="1208"/>
                </a:lnTo>
                <a:lnTo>
                  <a:pt x="368" y="1168"/>
                </a:lnTo>
                <a:lnTo>
                  <a:pt x="376" y="1072"/>
                </a:lnTo>
                <a:lnTo>
                  <a:pt x="384" y="1040"/>
                </a:lnTo>
                <a:lnTo>
                  <a:pt x="392" y="952"/>
                </a:lnTo>
                <a:lnTo>
                  <a:pt x="400" y="952"/>
                </a:lnTo>
                <a:lnTo>
                  <a:pt x="408" y="904"/>
                </a:lnTo>
                <a:lnTo>
                  <a:pt x="416" y="760"/>
                </a:lnTo>
                <a:lnTo>
                  <a:pt x="424" y="608"/>
                </a:lnTo>
                <a:lnTo>
                  <a:pt x="432" y="624"/>
                </a:lnTo>
                <a:lnTo>
                  <a:pt x="440" y="664"/>
                </a:lnTo>
                <a:lnTo>
                  <a:pt x="448" y="472"/>
                </a:lnTo>
                <a:lnTo>
                  <a:pt x="456" y="288"/>
                </a:lnTo>
                <a:lnTo>
                  <a:pt x="464" y="472"/>
                </a:lnTo>
                <a:lnTo>
                  <a:pt x="472" y="528"/>
                </a:lnTo>
                <a:lnTo>
                  <a:pt x="480" y="240"/>
                </a:lnTo>
                <a:lnTo>
                  <a:pt x="488" y="240"/>
                </a:lnTo>
                <a:lnTo>
                  <a:pt x="496" y="104"/>
                </a:lnTo>
                <a:lnTo>
                  <a:pt x="504" y="32"/>
                </a:lnTo>
                <a:lnTo>
                  <a:pt x="512" y="0"/>
                </a:lnTo>
                <a:lnTo>
                  <a:pt x="520" y="584"/>
                </a:lnTo>
                <a:lnTo>
                  <a:pt x="528" y="72"/>
                </a:lnTo>
                <a:lnTo>
                  <a:pt x="536" y="264"/>
                </a:lnTo>
                <a:lnTo>
                  <a:pt x="544" y="264"/>
                </a:lnTo>
                <a:lnTo>
                  <a:pt x="552" y="208"/>
                </a:lnTo>
                <a:lnTo>
                  <a:pt x="560" y="96"/>
                </a:lnTo>
                <a:lnTo>
                  <a:pt x="568" y="376"/>
                </a:lnTo>
                <a:lnTo>
                  <a:pt x="576" y="384"/>
                </a:lnTo>
                <a:lnTo>
                  <a:pt x="584" y="480"/>
                </a:lnTo>
                <a:lnTo>
                  <a:pt x="592" y="496"/>
                </a:lnTo>
                <a:lnTo>
                  <a:pt x="600" y="640"/>
                </a:lnTo>
                <a:lnTo>
                  <a:pt x="608" y="472"/>
                </a:lnTo>
                <a:lnTo>
                  <a:pt x="616" y="576"/>
                </a:lnTo>
                <a:lnTo>
                  <a:pt x="624" y="704"/>
                </a:lnTo>
                <a:lnTo>
                  <a:pt x="632" y="864"/>
                </a:lnTo>
                <a:lnTo>
                  <a:pt x="640" y="904"/>
                </a:lnTo>
                <a:lnTo>
                  <a:pt x="648" y="856"/>
                </a:lnTo>
                <a:lnTo>
                  <a:pt x="656" y="1152"/>
                </a:lnTo>
                <a:lnTo>
                  <a:pt x="664" y="1072"/>
                </a:lnTo>
                <a:lnTo>
                  <a:pt x="672" y="1096"/>
                </a:lnTo>
                <a:lnTo>
                  <a:pt x="680" y="1144"/>
                </a:lnTo>
                <a:lnTo>
                  <a:pt x="688" y="1376"/>
                </a:lnTo>
                <a:lnTo>
                  <a:pt x="696" y="1264"/>
                </a:lnTo>
                <a:lnTo>
                  <a:pt x="704" y="1304"/>
                </a:lnTo>
                <a:lnTo>
                  <a:pt x="712" y="1464"/>
                </a:lnTo>
                <a:lnTo>
                  <a:pt x="720" y="1448"/>
                </a:lnTo>
                <a:lnTo>
                  <a:pt x="728" y="1544"/>
                </a:lnTo>
                <a:lnTo>
                  <a:pt x="736" y="1592"/>
                </a:lnTo>
                <a:lnTo>
                  <a:pt x="744" y="1680"/>
                </a:lnTo>
                <a:lnTo>
                  <a:pt x="752" y="1680"/>
                </a:lnTo>
                <a:lnTo>
                  <a:pt x="760" y="1688"/>
                </a:lnTo>
                <a:lnTo>
                  <a:pt x="768" y="1768"/>
                </a:lnTo>
                <a:lnTo>
                  <a:pt x="776" y="1792"/>
                </a:lnTo>
                <a:lnTo>
                  <a:pt x="784" y="1712"/>
                </a:lnTo>
                <a:lnTo>
                  <a:pt x="792" y="1784"/>
                </a:lnTo>
                <a:lnTo>
                  <a:pt x="800" y="1760"/>
                </a:lnTo>
                <a:lnTo>
                  <a:pt x="808" y="1784"/>
                </a:lnTo>
                <a:lnTo>
                  <a:pt x="816" y="1848"/>
                </a:lnTo>
                <a:lnTo>
                  <a:pt x="824" y="1856"/>
                </a:lnTo>
                <a:lnTo>
                  <a:pt x="832" y="1872"/>
                </a:lnTo>
                <a:lnTo>
                  <a:pt x="840" y="1880"/>
                </a:lnTo>
                <a:lnTo>
                  <a:pt x="848" y="1888"/>
                </a:lnTo>
                <a:lnTo>
                  <a:pt x="856" y="1880"/>
                </a:lnTo>
                <a:lnTo>
                  <a:pt x="864" y="1904"/>
                </a:lnTo>
                <a:lnTo>
                  <a:pt x="872" y="1936"/>
                </a:lnTo>
                <a:lnTo>
                  <a:pt x="880" y="1920"/>
                </a:lnTo>
                <a:lnTo>
                  <a:pt x="888" y="1904"/>
                </a:lnTo>
                <a:lnTo>
                  <a:pt x="896" y="1936"/>
                </a:lnTo>
                <a:lnTo>
                  <a:pt x="904" y="1936"/>
                </a:lnTo>
                <a:lnTo>
                  <a:pt x="912" y="1936"/>
                </a:lnTo>
                <a:lnTo>
                  <a:pt x="920" y="1944"/>
                </a:lnTo>
                <a:lnTo>
                  <a:pt x="928" y="1944"/>
                </a:lnTo>
                <a:lnTo>
                  <a:pt x="936" y="1944"/>
                </a:lnTo>
                <a:lnTo>
                  <a:pt x="944" y="1944"/>
                </a:lnTo>
                <a:lnTo>
                  <a:pt x="952" y="1944"/>
                </a:lnTo>
                <a:lnTo>
                  <a:pt x="960" y="1944"/>
                </a:lnTo>
                <a:lnTo>
                  <a:pt x="968" y="1944"/>
                </a:lnTo>
                <a:lnTo>
                  <a:pt x="976" y="1944"/>
                </a:lnTo>
                <a:lnTo>
                  <a:pt x="984" y="1944"/>
                </a:lnTo>
                <a:lnTo>
                  <a:pt x="992" y="1944"/>
                </a:lnTo>
                <a:lnTo>
                  <a:pt x="1000" y="1944"/>
                </a:lnTo>
                <a:lnTo>
                  <a:pt x="1008" y="1944"/>
                </a:lnTo>
                <a:lnTo>
                  <a:pt x="1016" y="1944"/>
                </a:lnTo>
                <a:lnTo>
                  <a:pt x="1024" y="1944"/>
                </a:lnTo>
                <a:lnTo>
                  <a:pt x="1032" y="1944"/>
                </a:lnTo>
                <a:lnTo>
                  <a:pt x="1040" y="1944"/>
                </a:lnTo>
                <a:lnTo>
                  <a:pt x="1048" y="1944"/>
                </a:lnTo>
                <a:lnTo>
                  <a:pt x="1056" y="1944"/>
                </a:lnTo>
                <a:lnTo>
                  <a:pt x="1064" y="1944"/>
                </a:lnTo>
                <a:lnTo>
                  <a:pt x="1072" y="1944"/>
                </a:lnTo>
                <a:lnTo>
                  <a:pt x="1080" y="1944"/>
                </a:lnTo>
                <a:lnTo>
                  <a:pt x="1088" y="1944"/>
                </a:lnTo>
                <a:lnTo>
                  <a:pt x="1096" y="1944"/>
                </a:lnTo>
                <a:lnTo>
                  <a:pt x="1104" y="1944"/>
                </a:lnTo>
                <a:lnTo>
                  <a:pt x="1112" y="1944"/>
                </a:lnTo>
                <a:lnTo>
                  <a:pt x="1120" y="1944"/>
                </a:lnTo>
                <a:lnTo>
                  <a:pt x="1128" y="1944"/>
                </a:lnTo>
                <a:lnTo>
                  <a:pt x="1136" y="1944"/>
                </a:lnTo>
                <a:lnTo>
                  <a:pt x="1144" y="1944"/>
                </a:lnTo>
                <a:lnTo>
                  <a:pt x="1152" y="1944"/>
                </a:lnTo>
                <a:lnTo>
                  <a:pt x="1160" y="1944"/>
                </a:lnTo>
                <a:lnTo>
                  <a:pt x="1168" y="1944"/>
                </a:lnTo>
                <a:lnTo>
                  <a:pt x="1176" y="1944"/>
                </a:lnTo>
                <a:lnTo>
                  <a:pt x="1184" y="1944"/>
                </a:lnTo>
                <a:lnTo>
                  <a:pt x="1192" y="1944"/>
                </a:lnTo>
                <a:lnTo>
                  <a:pt x="1200" y="1944"/>
                </a:lnTo>
                <a:lnTo>
                  <a:pt x="1208" y="1944"/>
                </a:lnTo>
                <a:lnTo>
                  <a:pt x="1216" y="1944"/>
                </a:lnTo>
                <a:lnTo>
                  <a:pt x="1224" y="1944"/>
                </a:lnTo>
                <a:lnTo>
                  <a:pt x="1232" y="1944"/>
                </a:lnTo>
                <a:lnTo>
                  <a:pt x="1240" y="1944"/>
                </a:lnTo>
                <a:lnTo>
                  <a:pt x="1248" y="1944"/>
                </a:lnTo>
                <a:lnTo>
                  <a:pt x="1256" y="1944"/>
                </a:lnTo>
                <a:lnTo>
                  <a:pt x="1264" y="1944"/>
                </a:lnTo>
                <a:lnTo>
                  <a:pt x="1272" y="1944"/>
                </a:lnTo>
                <a:lnTo>
                  <a:pt x="1280" y="1944"/>
                </a:lnTo>
                <a:lnTo>
                  <a:pt x="1288" y="1944"/>
                </a:lnTo>
                <a:lnTo>
                  <a:pt x="1296" y="1944"/>
                </a:lnTo>
                <a:lnTo>
                  <a:pt x="1304" y="1944"/>
                </a:lnTo>
                <a:lnTo>
                  <a:pt x="1312" y="1944"/>
                </a:lnTo>
                <a:lnTo>
                  <a:pt x="1320" y="1944"/>
                </a:lnTo>
                <a:lnTo>
                  <a:pt x="1328" y="1944"/>
                </a:lnTo>
                <a:lnTo>
                  <a:pt x="1336" y="1944"/>
                </a:lnTo>
                <a:lnTo>
                  <a:pt x="1344" y="1944"/>
                </a:lnTo>
                <a:lnTo>
                  <a:pt x="1352" y="1944"/>
                </a:lnTo>
                <a:lnTo>
                  <a:pt x="1360" y="1944"/>
                </a:lnTo>
                <a:lnTo>
                  <a:pt x="1368" y="1944"/>
                </a:lnTo>
                <a:lnTo>
                  <a:pt x="1376" y="1944"/>
                </a:lnTo>
                <a:lnTo>
                  <a:pt x="1384" y="1944"/>
                </a:lnTo>
                <a:lnTo>
                  <a:pt x="1392" y="1944"/>
                </a:lnTo>
                <a:lnTo>
                  <a:pt x="1400" y="1944"/>
                </a:lnTo>
                <a:lnTo>
                  <a:pt x="1408" y="1944"/>
                </a:lnTo>
                <a:lnTo>
                  <a:pt x="1416" y="1944"/>
                </a:lnTo>
                <a:lnTo>
                  <a:pt x="1424" y="1944"/>
                </a:lnTo>
                <a:lnTo>
                  <a:pt x="1432" y="1944"/>
                </a:lnTo>
                <a:lnTo>
                  <a:pt x="1440" y="1944"/>
                </a:lnTo>
                <a:lnTo>
                  <a:pt x="1448" y="1944"/>
                </a:lnTo>
                <a:lnTo>
                  <a:pt x="1456" y="1944"/>
                </a:lnTo>
                <a:lnTo>
                  <a:pt x="1464" y="1944"/>
                </a:lnTo>
                <a:lnTo>
                  <a:pt x="1472" y="1944"/>
                </a:lnTo>
                <a:lnTo>
                  <a:pt x="1480" y="1944"/>
                </a:lnTo>
                <a:lnTo>
                  <a:pt x="1488" y="1944"/>
                </a:lnTo>
                <a:lnTo>
                  <a:pt x="1496" y="1944"/>
                </a:lnTo>
                <a:lnTo>
                  <a:pt x="1504" y="1944"/>
                </a:lnTo>
                <a:lnTo>
                  <a:pt x="1512" y="1944"/>
                </a:lnTo>
                <a:lnTo>
                  <a:pt x="1520" y="1944"/>
                </a:lnTo>
                <a:lnTo>
                  <a:pt x="1528" y="1944"/>
                </a:lnTo>
                <a:lnTo>
                  <a:pt x="1536" y="1944"/>
                </a:lnTo>
                <a:lnTo>
                  <a:pt x="1544" y="1944"/>
                </a:lnTo>
                <a:lnTo>
                  <a:pt x="1552" y="1944"/>
                </a:lnTo>
                <a:lnTo>
                  <a:pt x="1560" y="1944"/>
                </a:lnTo>
                <a:lnTo>
                  <a:pt x="1568" y="1944"/>
                </a:lnTo>
                <a:lnTo>
                  <a:pt x="1576" y="1944"/>
                </a:lnTo>
                <a:lnTo>
                  <a:pt x="1584" y="1944"/>
                </a:lnTo>
                <a:lnTo>
                  <a:pt x="1592" y="1944"/>
                </a:lnTo>
                <a:lnTo>
                  <a:pt x="1600" y="1944"/>
                </a:lnTo>
                <a:lnTo>
                  <a:pt x="1608" y="1944"/>
                </a:lnTo>
                <a:lnTo>
                  <a:pt x="1616" y="1944"/>
                </a:lnTo>
                <a:lnTo>
                  <a:pt x="1624" y="1944"/>
                </a:lnTo>
                <a:lnTo>
                  <a:pt x="1632" y="1944"/>
                </a:lnTo>
                <a:lnTo>
                  <a:pt x="1640" y="1944"/>
                </a:lnTo>
                <a:lnTo>
                  <a:pt x="1648" y="1944"/>
                </a:lnTo>
                <a:lnTo>
                  <a:pt x="1656" y="1944"/>
                </a:lnTo>
                <a:lnTo>
                  <a:pt x="1664" y="1944"/>
                </a:lnTo>
                <a:lnTo>
                  <a:pt x="1672" y="1944"/>
                </a:lnTo>
                <a:lnTo>
                  <a:pt x="1680" y="1944"/>
                </a:lnTo>
                <a:lnTo>
                  <a:pt x="1688" y="1944"/>
                </a:lnTo>
                <a:lnTo>
                  <a:pt x="1696" y="1944"/>
                </a:lnTo>
                <a:lnTo>
                  <a:pt x="1704" y="1944"/>
                </a:lnTo>
                <a:lnTo>
                  <a:pt x="1712" y="1944"/>
                </a:lnTo>
                <a:lnTo>
                  <a:pt x="1720" y="1944"/>
                </a:lnTo>
                <a:lnTo>
                  <a:pt x="1728" y="1944"/>
                </a:lnTo>
                <a:lnTo>
                  <a:pt x="1736" y="1944"/>
                </a:lnTo>
                <a:lnTo>
                  <a:pt x="1744" y="1944"/>
                </a:lnTo>
                <a:lnTo>
                  <a:pt x="1752" y="1944"/>
                </a:lnTo>
                <a:lnTo>
                  <a:pt x="1760" y="1944"/>
                </a:lnTo>
                <a:lnTo>
                  <a:pt x="1768" y="1944"/>
                </a:lnTo>
                <a:lnTo>
                  <a:pt x="1776" y="1944"/>
                </a:lnTo>
                <a:lnTo>
                  <a:pt x="1784" y="1944"/>
                </a:lnTo>
                <a:lnTo>
                  <a:pt x="1792" y="1944"/>
                </a:lnTo>
                <a:lnTo>
                  <a:pt x="1800" y="1944"/>
                </a:lnTo>
                <a:lnTo>
                  <a:pt x="1808" y="1944"/>
                </a:lnTo>
                <a:lnTo>
                  <a:pt x="1816" y="1944"/>
                </a:lnTo>
                <a:lnTo>
                  <a:pt x="1824" y="1944"/>
                </a:lnTo>
                <a:lnTo>
                  <a:pt x="1832" y="1944"/>
                </a:lnTo>
                <a:lnTo>
                  <a:pt x="1840" y="1944"/>
                </a:lnTo>
                <a:lnTo>
                  <a:pt x="1848" y="1944"/>
                </a:lnTo>
                <a:lnTo>
                  <a:pt x="1856" y="1944"/>
                </a:lnTo>
                <a:lnTo>
                  <a:pt x="1864" y="1944"/>
                </a:lnTo>
                <a:lnTo>
                  <a:pt x="1872" y="1944"/>
                </a:lnTo>
                <a:lnTo>
                  <a:pt x="1880" y="1944"/>
                </a:lnTo>
                <a:lnTo>
                  <a:pt x="1888" y="1944"/>
                </a:lnTo>
                <a:lnTo>
                  <a:pt x="1896" y="1944"/>
                </a:lnTo>
                <a:lnTo>
                  <a:pt x="1904" y="1944"/>
                </a:lnTo>
                <a:lnTo>
                  <a:pt x="1912" y="1944"/>
                </a:lnTo>
                <a:lnTo>
                  <a:pt x="1920" y="1944"/>
                </a:lnTo>
                <a:lnTo>
                  <a:pt x="1928" y="1944"/>
                </a:lnTo>
                <a:lnTo>
                  <a:pt x="1936" y="1944"/>
                </a:lnTo>
                <a:lnTo>
                  <a:pt x="1944" y="1944"/>
                </a:lnTo>
                <a:lnTo>
                  <a:pt x="1952" y="1944"/>
                </a:lnTo>
                <a:lnTo>
                  <a:pt x="1960" y="1944"/>
                </a:lnTo>
                <a:lnTo>
                  <a:pt x="1968" y="1944"/>
                </a:lnTo>
                <a:lnTo>
                  <a:pt x="1976" y="1944"/>
                </a:lnTo>
                <a:lnTo>
                  <a:pt x="1984" y="1944"/>
                </a:lnTo>
                <a:lnTo>
                  <a:pt x="1992" y="1944"/>
                </a:lnTo>
                <a:lnTo>
                  <a:pt x="2000" y="1944"/>
                </a:lnTo>
                <a:lnTo>
                  <a:pt x="2008" y="1944"/>
                </a:lnTo>
                <a:lnTo>
                  <a:pt x="2016" y="1944"/>
                </a:lnTo>
                <a:lnTo>
                  <a:pt x="2024" y="1944"/>
                </a:lnTo>
                <a:lnTo>
                  <a:pt x="2032" y="1944"/>
                </a:lnTo>
              </a:path>
            </a:pathLst>
          </a:custGeom>
          <a:noFill/>
          <a:ln w="1260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95" name=""/>
          <p:cNvSpPr/>
          <p:nvPr/>
        </p:nvSpPr>
        <p:spPr>
          <a:xfrm>
            <a:off x="1108080" y="2978280"/>
            <a:ext cx="1417680" cy="1170000"/>
          </a:xfrm>
          <a:custGeom>
            <a:avLst/>
            <a:gdLst/>
            <a:ahLst/>
            <a:rect l="l" t="t" r="r" b="b"/>
            <a:pathLst>
              <a:path w="2032" h="1936">
                <a:moveTo>
                  <a:pt x="0" y="1936"/>
                </a:moveTo>
                <a:lnTo>
                  <a:pt x="0" y="144"/>
                </a:lnTo>
                <a:lnTo>
                  <a:pt x="0" y="1560"/>
                </a:lnTo>
                <a:lnTo>
                  <a:pt x="8" y="1504"/>
                </a:lnTo>
                <a:lnTo>
                  <a:pt x="16" y="1464"/>
                </a:lnTo>
                <a:lnTo>
                  <a:pt x="24" y="1456"/>
                </a:lnTo>
                <a:lnTo>
                  <a:pt x="32" y="1296"/>
                </a:lnTo>
                <a:lnTo>
                  <a:pt x="40" y="1320"/>
                </a:lnTo>
                <a:lnTo>
                  <a:pt x="48" y="1248"/>
                </a:lnTo>
                <a:lnTo>
                  <a:pt x="56" y="1248"/>
                </a:lnTo>
                <a:lnTo>
                  <a:pt x="64" y="968"/>
                </a:lnTo>
                <a:lnTo>
                  <a:pt x="72" y="1000"/>
                </a:lnTo>
                <a:lnTo>
                  <a:pt x="80" y="984"/>
                </a:lnTo>
                <a:lnTo>
                  <a:pt x="88" y="1056"/>
                </a:lnTo>
                <a:lnTo>
                  <a:pt x="96" y="768"/>
                </a:lnTo>
                <a:lnTo>
                  <a:pt x="104" y="864"/>
                </a:lnTo>
                <a:lnTo>
                  <a:pt x="112" y="840"/>
                </a:lnTo>
                <a:lnTo>
                  <a:pt x="120" y="872"/>
                </a:lnTo>
                <a:lnTo>
                  <a:pt x="128" y="680"/>
                </a:lnTo>
                <a:lnTo>
                  <a:pt x="136" y="736"/>
                </a:lnTo>
                <a:lnTo>
                  <a:pt x="144" y="864"/>
                </a:lnTo>
                <a:lnTo>
                  <a:pt x="152" y="904"/>
                </a:lnTo>
                <a:lnTo>
                  <a:pt x="160" y="552"/>
                </a:lnTo>
                <a:lnTo>
                  <a:pt x="168" y="744"/>
                </a:lnTo>
                <a:lnTo>
                  <a:pt x="176" y="592"/>
                </a:lnTo>
                <a:lnTo>
                  <a:pt x="184" y="792"/>
                </a:lnTo>
                <a:lnTo>
                  <a:pt x="192" y="480"/>
                </a:lnTo>
                <a:lnTo>
                  <a:pt x="200" y="600"/>
                </a:lnTo>
                <a:lnTo>
                  <a:pt x="208" y="536"/>
                </a:lnTo>
                <a:lnTo>
                  <a:pt x="216" y="664"/>
                </a:lnTo>
                <a:lnTo>
                  <a:pt x="224" y="568"/>
                </a:lnTo>
                <a:lnTo>
                  <a:pt x="232" y="504"/>
                </a:lnTo>
                <a:lnTo>
                  <a:pt x="240" y="560"/>
                </a:lnTo>
                <a:lnTo>
                  <a:pt x="248" y="720"/>
                </a:lnTo>
                <a:lnTo>
                  <a:pt x="256" y="504"/>
                </a:lnTo>
                <a:lnTo>
                  <a:pt x="264" y="640"/>
                </a:lnTo>
                <a:lnTo>
                  <a:pt x="272" y="488"/>
                </a:lnTo>
                <a:lnTo>
                  <a:pt x="280" y="392"/>
                </a:lnTo>
                <a:lnTo>
                  <a:pt x="288" y="520"/>
                </a:lnTo>
                <a:lnTo>
                  <a:pt x="296" y="448"/>
                </a:lnTo>
                <a:lnTo>
                  <a:pt x="304" y="400"/>
                </a:lnTo>
                <a:lnTo>
                  <a:pt x="312" y="464"/>
                </a:lnTo>
                <a:lnTo>
                  <a:pt x="320" y="0"/>
                </a:lnTo>
                <a:lnTo>
                  <a:pt x="328" y="320"/>
                </a:lnTo>
                <a:lnTo>
                  <a:pt x="336" y="600"/>
                </a:lnTo>
                <a:lnTo>
                  <a:pt x="344" y="480"/>
                </a:lnTo>
                <a:lnTo>
                  <a:pt x="352" y="384"/>
                </a:lnTo>
                <a:lnTo>
                  <a:pt x="360" y="280"/>
                </a:lnTo>
                <a:lnTo>
                  <a:pt x="368" y="232"/>
                </a:lnTo>
                <a:lnTo>
                  <a:pt x="376" y="400"/>
                </a:lnTo>
                <a:lnTo>
                  <a:pt x="384" y="88"/>
                </a:lnTo>
                <a:lnTo>
                  <a:pt x="392" y="552"/>
                </a:lnTo>
                <a:lnTo>
                  <a:pt x="400" y="480"/>
                </a:lnTo>
                <a:lnTo>
                  <a:pt x="408" y="120"/>
                </a:lnTo>
                <a:lnTo>
                  <a:pt x="416" y="432"/>
                </a:lnTo>
                <a:lnTo>
                  <a:pt x="424" y="512"/>
                </a:lnTo>
                <a:lnTo>
                  <a:pt x="432" y="512"/>
                </a:lnTo>
                <a:lnTo>
                  <a:pt x="440" y="696"/>
                </a:lnTo>
                <a:lnTo>
                  <a:pt x="448" y="632"/>
                </a:lnTo>
                <a:lnTo>
                  <a:pt x="456" y="760"/>
                </a:lnTo>
                <a:lnTo>
                  <a:pt x="464" y="888"/>
                </a:lnTo>
                <a:lnTo>
                  <a:pt x="472" y="904"/>
                </a:lnTo>
                <a:lnTo>
                  <a:pt x="480" y="1024"/>
                </a:lnTo>
                <a:lnTo>
                  <a:pt x="488" y="904"/>
                </a:lnTo>
                <a:lnTo>
                  <a:pt x="496" y="1160"/>
                </a:lnTo>
                <a:lnTo>
                  <a:pt x="504" y="1080"/>
                </a:lnTo>
                <a:lnTo>
                  <a:pt x="512" y="1208"/>
                </a:lnTo>
                <a:lnTo>
                  <a:pt x="520" y="1296"/>
                </a:lnTo>
                <a:lnTo>
                  <a:pt x="528" y="1368"/>
                </a:lnTo>
                <a:lnTo>
                  <a:pt x="536" y="1440"/>
                </a:lnTo>
                <a:lnTo>
                  <a:pt x="544" y="1336"/>
                </a:lnTo>
                <a:lnTo>
                  <a:pt x="552" y="1480"/>
                </a:lnTo>
                <a:lnTo>
                  <a:pt x="560" y="1392"/>
                </a:lnTo>
                <a:lnTo>
                  <a:pt x="568" y="1480"/>
                </a:lnTo>
                <a:lnTo>
                  <a:pt x="576" y="1624"/>
                </a:lnTo>
                <a:lnTo>
                  <a:pt x="584" y="1560"/>
                </a:lnTo>
                <a:lnTo>
                  <a:pt x="592" y="1552"/>
                </a:lnTo>
                <a:lnTo>
                  <a:pt x="600" y="1672"/>
                </a:lnTo>
                <a:lnTo>
                  <a:pt x="608" y="1720"/>
                </a:lnTo>
                <a:lnTo>
                  <a:pt x="616" y="1760"/>
                </a:lnTo>
                <a:lnTo>
                  <a:pt x="624" y="1704"/>
                </a:lnTo>
                <a:lnTo>
                  <a:pt x="632" y="1792"/>
                </a:lnTo>
                <a:lnTo>
                  <a:pt x="640" y="1760"/>
                </a:lnTo>
                <a:lnTo>
                  <a:pt x="648" y="1808"/>
                </a:lnTo>
                <a:lnTo>
                  <a:pt x="656" y="1808"/>
                </a:lnTo>
                <a:lnTo>
                  <a:pt x="664" y="1752"/>
                </a:lnTo>
                <a:lnTo>
                  <a:pt x="672" y="1816"/>
                </a:lnTo>
                <a:lnTo>
                  <a:pt x="680" y="1824"/>
                </a:lnTo>
                <a:lnTo>
                  <a:pt x="688" y="1832"/>
                </a:lnTo>
                <a:lnTo>
                  <a:pt x="696" y="1808"/>
                </a:lnTo>
                <a:lnTo>
                  <a:pt x="704" y="1784"/>
                </a:lnTo>
                <a:lnTo>
                  <a:pt x="712" y="1848"/>
                </a:lnTo>
                <a:lnTo>
                  <a:pt x="720" y="1848"/>
                </a:lnTo>
                <a:lnTo>
                  <a:pt x="728" y="1912"/>
                </a:lnTo>
                <a:lnTo>
                  <a:pt x="736" y="1864"/>
                </a:lnTo>
                <a:lnTo>
                  <a:pt x="744" y="1920"/>
                </a:lnTo>
                <a:lnTo>
                  <a:pt x="752" y="1896"/>
                </a:lnTo>
                <a:lnTo>
                  <a:pt x="760" y="1904"/>
                </a:lnTo>
                <a:lnTo>
                  <a:pt x="768" y="1928"/>
                </a:lnTo>
                <a:lnTo>
                  <a:pt x="776" y="1904"/>
                </a:lnTo>
                <a:lnTo>
                  <a:pt x="784" y="1904"/>
                </a:lnTo>
                <a:lnTo>
                  <a:pt x="792" y="1864"/>
                </a:lnTo>
                <a:lnTo>
                  <a:pt x="800" y="1920"/>
                </a:lnTo>
                <a:lnTo>
                  <a:pt x="808" y="1920"/>
                </a:lnTo>
                <a:lnTo>
                  <a:pt x="816" y="1928"/>
                </a:lnTo>
                <a:lnTo>
                  <a:pt x="824" y="1920"/>
                </a:lnTo>
                <a:lnTo>
                  <a:pt x="832" y="1928"/>
                </a:lnTo>
                <a:lnTo>
                  <a:pt x="840" y="1936"/>
                </a:lnTo>
                <a:lnTo>
                  <a:pt x="848" y="1928"/>
                </a:lnTo>
                <a:lnTo>
                  <a:pt x="856" y="1928"/>
                </a:lnTo>
                <a:lnTo>
                  <a:pt x="864" y="1928"/>
                </a:lnTo>
                <a:lnTo>
                  <a:pt x="872" y="1928"/>
                </a:lnTo>
                <a:lnTo>
                  <a:pt x="880" y="1936"/>
                </a:lnTo>
                <a:lnTo>
                  <a:pt x="888" y="1936"/>
                </a:lnTo>
                <a:lnTo>
                  <a:pt x="896" y="1936"/>
                </a:lnTo>
                <a:lnTo>
                  <a:pt x="904" y="1936"/>
                </a:lnTo>
                <a:lnTo>
                  <a:pt x="912" y="1936"/>
                </a:lnTo>
                <a:lnTo>
                  <a:pt x="920" y="1936"/>
                </a:lnTo>
                <a:lnTo>
                  <a:pt x="928" y="1936"/>
                </a:lnTo>
                <a:lnTo>
                  <a:pt x="936" y="1936"/>
                </a:lnTo>
                <a:lnTo>
                  <a:pt x="944" y="1936"/>
                </a:lnTo>
                <a:lnTo>
                  <a:pt x="952" y="1936"/>
                </a:lnTo>
                <a:lnTo>
                  <a:pt x="960" y="1936"/>
                </a:lnTo>
                <a:lnTo>
                  <a:pt x="968" y="1936"/>
                </a:lnTo>
                <a:lnTo>
                  <a:pt x="976" y="1936"/>
                </a:lnTo>
                <a:lnTo>
                  <a:pt x="984" y="1936"/>
                </a:lnTo>
                <a:lnTo>
                  <a:pt x="992" y="1936"/>
                </a:lnTo>
                <a:lnTo>
                  <a:pt x="1000" y="1936"/>
                </a:lnTo>
                <a:lnTo>
                  <a:pt x="1008" y="1936"/>
                </a:lnTo>
                <a:lnTo>
                  <a:pt x="1016" y="1936"/>
                </a:lnTo>
                <a:lnTo>
                  <a:pt x="1024" y="1936"/>
                </a:lnTo>
                <a:lnTo>
                  <a:pt x="1032" y="1936"/>
                </a:lnTo>
                <a:lnTo>
                  <a:pt x="1040" y="1936"/>
                </a:lnTo>
                <a:lnTo>
                  <a:pt x="1048" y="1936"/>
                </a:lnTo>
                <a:lnTo>
                  <a:pt x="1056" y="1936"/>
                </a:lnTo>
                <a:lnTo>
                  <a:pt x="1064" y="1936"/>
                </a:lnTo>
                <a:lnTo>
                  <a:pt x="1072" y="1936"/>
                </a:lnTo>
                <a:lnTo>
                  <a:pt x="1080" y="1936"/>
                </a:lnTo>
                <a:lnTo>
                  <a:pt x="1088" y="1936"/>
                </a:lnTo>
                <a:lnTo>
                  <a:pt x="1096" y="1936"/>
                </a:lnTo>
                <a:lnTo>
                  <a:pt x="1104" y="1936"/>
                </a:lnTo>
                <a:lnTo>
                  <a:pt x="1112" y="1936"/>
                </a:lnTo>
                <a:lnTo>
                  <a:pt x="1120" y="1936"/>
                </a:lnTo>
                <a:lnTo>
                  <a:pt x="1128" y="1936"/>
                </a:lnTo>
                <a:lnTo>
                  <a:pt x="1136" y="1936"/>
                </a:lnTo>
                <a:lnTo>
                  <a:pt x="1144" y="1936"/>
                </a:lnTo>
                <a:lnTo>
                  <a:pt x="1152" y="1936"/>
                </a:lnTo>
                <a:lnTo>
                  <a:pt x="1160" y="1936"/>
                </a:lnTo>
                <a:lnTo>
                  <a:pt x="1168" y="1936"/>
                </a:lnTo>
                <a:lnTo>
                  <a:pt x="1176" y="1936"/>
                </a:lnTo>
                <a:lnTo>
                  <a:pt x="1184" y="1936"/>
                </a:lnTo>
                <a:lnTo>
                  <a:pt x="1192" y="1936"/>
                </a:lnTo>
                <a:lnTo>
                  <a:pt x="1200" y="1936"/>
                </a:lnTo>
                <a:lnTo>
                  <a:pt x="1208" y="1936"/>
                </a:lnTo>
                <a:lnTo>
                  <a:pt x="1216" y="1936"/>
                </a:lnTo>
                <a:lnTo>
                  <a:pt x="1224" y="1936"/>
                </a:lnTo>
                <a:lnTo>
                  <a:pt x="1232" y="1936"/>
                </a:lnTo>
                <a:lnTo>
                  <a:pt x="1240" y="1936"/>
                </a:lnTo>
                <a:lnTo>
                  <a:pt x="1248" y="1936"/>
                </a:lnTo>
                <a:lnTo>
                  <a:pt x="1256" y="1936"/>
                </a:lnTo>
                <a:lnTo>
                  <a:pt x="1264" y="1936"/>
                </a:lnTo>
                <a:lnTo>
                  <a:pt x="1272" y="1936"/>
                </a:lnTo>
                <a:lnTo>
                  <a:pt x="1280" y="1936"/>
                </a:lnTo>
                <a:lnTo>
                  <a:pt x="1288" y="1936"/>
                </a:lnTo>
                <a:lnTo>
                  <a:pt x="1296" y="1936"/>
                </a:lnTo>
                <a:lnTo>
                  <a:pt x="1304" y="1936"/>
                </a:lnTo>
                <a:lnTo>
                  <a:pt x="1312" y="1936"/>
                </a:lnTo>
                <a:lnTo>
                  <a:pt x="1320" y="1936"/>
                </a:lnTo>
                <a:lnTo>
                  <a:pt x="1328" y="1936"/>
                </a:lnTo>
                <a:lnTo>
                  <a:pt x="1336" y="1936"/>
                </a:lnTo>
                <a:lnTo>
                  <a:pt x="1344" y="1936"/>
                </a:lnTo>
                <a:lnTo>
                  <a:pt x="1352" y="1936"/>
                </a:lnTo>
                <a:lnTo>
                  <a:pt x="1360" y="1936"/>
                </a:lnTo>
                <a:lnTo>
                  <a:pt x="1368" y="1936"/>
                </a:lnTo>
                <a:lnTo>
                  <a:pt x="1376" y="1936"/>
                </a:lnTo>
                <a:lnTo>
                  <a:pt x="1384" y="1936"/>
                </a:lnTo>
                <a:lnTo>
                  <a:pt x="1392" y="1936"/>
                </a:lnTo>
                <a:lnTo>
                  <a:pt x="1400" y="1936"/>
                </a:lnTo>
                <a:lnTo>
                  <a:pt x="1408" y="1936"/>
                </a:lnTo>
                <a:lnTo>
                  <a:pt x="1416" y="1936"/>
                </a:lnTo>
                <a:lnTo>
                  <a:pt x="1424" y="1936"/>
                </a:lnTo>
                <a:lnTo>
                  <a:pt x="1432" y="1936"/>
                </a:lnTo>
                <a:lnTo>
                  <a:pt x="1440" y="1936"/>
                </a:lnTo>
                <a:lnTo>
                  <a:pt x="1448" y="1936"/>
                </a:lnTo>
                <a:lnTo>
                  <a:pt x="1456" y="1936"/>
                </a:lnTo>
                <a:lnTo>
                  <a:pt x="1464" y="1936"/>
                </a:lnTo>
                <a:lnTo>
                  <a:pt x="1472" y="1936"/>
                </a:lnTo>
                <a:lnTo>
                  <a:pt x="1480" y="1936"/>
                </a:lnTo>
                <a:lnTo>
                  <a:pt x="1488" y="1936"/>
                </a:lnTo>
                <a:lnTo>
                  <a:pt x="1496" y="1936"/>
                </a:lnTo>
                <a:lnTo>
                  <a:pt x="1504" y="1936"/>
                </a:lnTo>
                <a:lnTo>
                  <a:pt x="1512" y="1936"/>
                </a:lnTo>
                <a:lnTo>
                  <a:pt x="1520" y="1936"/>
                </a:lnTo>
                <a:lnTo>
                  <a:pt x="1528" y="1936"/>
                </a:lnTo>
                <a:lnTo>
                  <a:pt x="1536" y="1936"/>
                </a:lnTo>
                <a:lnTo>
                  <a:pt x="1544" y="1936"/>
                </a:lnTo>
                <a:lnTo>
                  <a:pt x="1552" y="1936"/>
                </a:lnTo>
                <a:lnTo>
                  <a:pt x="1560" y="1936"/>
                </a:lnTo>
                <a:lnTo>
                  <a:pt x="1568" y="1936"/>
                </a:lnTo>
                <a:lnTo>
                  <a:pt x="1576" y="1936"/>
                </a:lnTo>
                <a:lnTo>
                  <a:pt x="1584" y="1936"/>
                </a:lnTo>
                <a:lnTo>
                  <a:pt x="1592" y="1936"/>
                </a:lnTo>
                <a:lnTo>
                  <a:pt x="1600" y="1936"/>
                </a:lnTo>
                <a:lnTo>
                  <a:pt x="1608" y="1936"/>
                </a:lnTo>
                <a:lnTo>
                  <a:pt x="1616" y="1936"/>
                </a:lnTo>
                <a:lnTo>
                  <a:pt x="1624" y="1936"/>
                </a:lnTo>
                <a:lnTo>
                  <a:pt x="1632" y="1936"/>
                </a:lnTo>
                <a:lnTo>
                  <a:pt x="1640" y="1936"/>
                </a:lnTo>
                <a:lnTo>
                  <a:pt x="1648" y="1936"/>
                </a:lnTo>
                <a:lnTo>
                  <a:pt x="1656" y="1936"/>
                </a:lnTo>
                <a:lnTo>
                  <a:pt x="1664" y="1936"/>
                </a:lnTo>
                <a:lnTo>
                  <a:pt x="1672" y="1936"/>
                </a:lnTo>
                <a:lnTo>
                  <a:pt x="1680" y="1936"/>
                </a:lnTo>
                <a:lnTo>
                  <a:pt x="1688" y="1936"/>
                </a:lnTo>
                <a:lnTo>
                  <a:pt x="1696" y="1936"/>
                </a:lnTo>
                <a:lnTo>
                  <a:pt x="1704" y="1936"/>
                </a:lnTo>
                <a:lnTo>
                  <a:pt x="1712" y="1936"/>
                </a:lnTo>
                <a:lnTo>
                  <a:pt x="1720" y="1936"/>
                </a:lnTo>
                <a:lnTo>
                  <a:pt x="1728" y="1936"/>
                </a:lnTo>
                <a:lnTo>
                  <a:pt x="1736" y="1936"/>
                </a:lnTo>
                <a:lnTo>
                  <a:pt x="1744" y="1936"/>
                </a:lnTo>
                <a:lnTo>
                  <a:pt x="1752" y="1936"/>
                </a:lnTo>
                <a:lnTo>
                  <a:pt x="1760" y="1936"/>
                </a:lnTo>
                <a:lnTo>
                  <a:pt x="1768" y="1936"/>
                </a:lnTo>
                <a:lnTo>
                  <a:pt x="1776" y="1936"/>
                </a:lnTo>
                <a:lnTo>
                  <a:pt x="1784" y="1936"/>
                </a:lnTo>
                <a:lnTo>
                  <a:pt x="1792" y="1936"/>
                </a:lnTo>
                <a:lnTo>
                  <a:pt x="1800" y="1936"/>
                </a:lnTo>
                <a:lnTo>
                  <a:pt x="1808" y="1936"/>
                </a:lnTo>
                <a:lnTo>
                  <a:pt x="1816" y="1936"/>
                </a:lnTo>
                <a:lnTo>
                  <a:pt x="1824" y="1936"/>
                </a:lnTo>
                <a:lnTo>
                  <a:pt x="1832" y="1936"/>
                </a:lnTo>
                <a:lnTo>
                  <a:pt x="1840" y="1936"/>
                </a:lnTo>
                <a:lnTo>
                  <a:pt x="1848" y="1936"/>
                </a:lnTo>
                <a:lnTo>
                  <a:pt x="1856" y="1936"/>
                </a:lnTo>
                <a:lnTo>
                  <a:pt x="1864" y="1936"/>
                </a:lnTo>
                <a:lnTo>
                  <a:pt x="1872" y="1936"/>
                </a:lnTo>
                <a:lnTo>
                  <a:pt x="1880" y="1936"/>
                </a:lnTo>
                <a:lnTo>
                  <a:pt x="1888" y="1936"/>
                </a:lnTo>
                <a:lnTo>
                  <a:pt x="1896" y="1936"/>
                </a:lnTo>
                <a:lnTo>
                  <a:pt x="1904" y="1936"/>
                </a:lnTo>
                <a:lnTo>
                  <a:pt x="1912" y="1936"/>
                </a:lnTo>
                <a:lnTo>
                  <a:pt x="1920" y="1936"/>
                </a:lnTo>
                <a:lnTo>
                  <a:pt x="1928" y="1936"/>
                </a:lnTo>
                <a:lnTo>
                  <a:pt x="1936" y="1936"/>
                </a:lnTo>
                <a:lnTo>
                  <a:pt x="1944" y="1936"/>
                </a:lnTo>
                <a:lnTo>
                  <a:pt x="1952" y="1936"/>
                </a:lnTo>
                <a:lnTo>
                  <a:pt x="1960" y="1936"/>
                </a:lnTo>
                <a:lnTo>
                  <a:pt x="1968" y="1936"/>
                </a:lnTo>
                <a:lnTo>
                  <a:pt x="1976" y="1936"/>
                </a:lnTo>
                <a:lnTo>
                  <a:pt x="1984" y="1936"/>
                </a:lnTo>
                <a:lnTo>
                  <a:pt x="1992" y="1936"/>
                </a:lnTo>
                <a:lnTo>
                  <a:pt x="2000" y="1936"/>
                </a:lnTo>
                <a:lnTo>
                  <a:pt x="2008" y="1936"/>
                </a:lnTo>
                <a:lnTo>
                  <a:pt x="2016" y="1936"/>
                </a:lnTo>
                <a:lnTo>
                  <a:pt x="2024" y="1936"/>
                </a:lnTo>
                <a:lnTo>
                  <a:pt x="2032" y="1936"/>
                </a:lnTo>
              </a:path>
            </a:pathLst>
          </a:custGeom>
          <a:noFill/>
          <a:ln w="12600">
            <a:solidFill>
              <a:srgbClr val="0000ff"/>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96" name=""/>
          <p:cNvSpPr/>
          <p:nvPr/>
        </p:nvSpPr>
        <p:spPr>
          <a:xfrm>
            <a:off x="2887560" y="2909880"/>
            <a:ext cx="1444680" cy="1252440"/>
          </a:xfrm>
          <a:prstGeom prst="rect">
            <a:avLst/>
          </a:prstGeom>
          <a:solidFill>
            <a:srgbClr val="ffffff"/>
          </a:solidFill>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197" name=""/>
          <p:cNvSpPr/>
          <p:nvPr/>
        </p:nvSpPr>
        <p:spPr>
          <a:xfrm>
            <a:off x="2887560" y="4157640"/>
            <a:ext cx="14400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198" name=""/>
          <p:cNvSpPr/>
          <p:nvPr/>
        </p:nvSpPr>
        <p:spPr>
          <a:xfrm>
            <a:off x="2887560" y="4162320"/>
            <a:ext cx="0" cy="28800"/>
          </a:xfrm>
          <a:prstGeom prst="line">
            <a:avLst/>
          </a:prstGeom>
          <a:ln w="12600">
            <a:solidFill>
              <a:srgbClr val="000000"/>
            </a:solidFill>
            <a:miter/>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199" name=""/>
          <p:cNvSpPr/>
          <p:nvPr/>
        </p:nvSpPr>
        <p:spPr>
          <a:xfrm>
            <a:off x="2994120" y="416232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00" name=""/>
          <p:cNvSpPr/>
          <p:nvPr/>
        </p:nvSpPr>
        <p:spPr>
          <a:xfrm>
            <a:off x="3054240" y="416232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01" name=""/>
          <p:cNvSpPr/>
          <p:nvPr/>
        </p:nvSpPr>
        <p:spPr>
          <a:xfrm>
            <a:off x="3100320" y="416232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02" name=""/>
          <p:cNvSpPr/>
          <p:nvPr/>
        </p:nvSpPr>
        <p:spPr>
          <a:xfrm>
            <a:off x="3138480" y="4162320"/>
            <a:ext cx="144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203" name=""/>
          <p:cNvSpPr/>
          <p:nvPr/>
        </p:nvSpPr>
        <p:spPr>
          <a:xfrm>
            <a:off x="3166920" y="416232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04" name=""/>
          <p:cNvSpPr/>
          <p:nvPr/>
        </p:nvSpPr>
        <p:spPr>
          <a:xfrm>
            <a:off x="3189240" y="416232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05" name=""/>
          <p:cNvSpPr/>
          <p:nvPr/>
        </p:nvSpPr>
        <p:spPr>
          <a:xfrm>
            <a:off x="3211560" y="416232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06" name=""/>
          <p:cNvSpPr/>
          <p:nvPr/>
        </p:nvSpPr>
        <p:spPr>
          <a:xfrm>
            <a:off x="3227400" y="416232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07" name=""/>
          <p:cNvSpPr/>
          <p:nvPr/>
        </p:nvSpPr>
        <p:spPr>
          <a:xfrm>
            <a:off x="3244680" y="4162320"/>
            <a:ext cx="0" cy="28800"/>
          </a:xfrm>
          <a:prstGeom prst="line">
            <a:avLst/>
          </a:prstGeom>
          <a:ln w="12600">
            <a:solidFill>
              <a:srgbClr val="000000"/>
            </a:solidFill>
            <a:miter/>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208" name=""/>
          <p:cNvSpPr/>
          <p:nvPr/>
        </p:nvSpPr>
        <p:spPr>
          <a:xfrm>
            <a:off x="3355920" y="416232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09" name=""/>
          <p:cNvSpPr/>
          <p:nvPr/>
        </p:nvSpPr>
        <p:spPr>
          <a:xfrm>
            <a:off x="3417840" y="416232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10" name=""/>
          <p:cNvSpPr/>
          <p:nvPr/>
        </p:nvSpPr>
        <p:spPr>
          <a:xfrm>
            <a:off x="3462480" y="416232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11" name=""/>
          <p:cNvSpPr/>
          <p:nvPr/>
        </p:nvSpPr>
        <p:spPr>
          <a:xfrm>
            <a:off x="3495600" y="4162320"/>
            <a:ext cx="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212" name=""/>
          <p:cNvSpPr/>
          <p:nvPr/>
        </p:nvSpPr>
        <p:spPr>
          <a:xfrm>
            <a:off x="3529080" y="416232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13" name=""/>
          <p:cNvSpPr/>
          <p:nvPr/>
        </p:nvSpPr>
        <p:spPr>
          <a:xfrm>
            <a:off x="3551400" y="416232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14" name=""/>
          <p:cNvSpPr/>
          <p:nvPr/>
        </p:nvSpPr>
        <p:spPr>
          <a:xfrm>
            <a:off x="3573360" y="416232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15" name=""/>
          <p:cNvSpPr/>
          <p:nvPr/>
        </p:nvSpPr>
        <p:spPr>
          <a:xfrm>
            <a:off x="3591000" y="416232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16" name=""/>
          <p:cNvSpPr/>
          <p:nvPr/>
        </p:nvSpPr>
        <p:spPr>
          <a:xfrm>
            <a:off x="3606840" y="4162320"/>
            <a:ext cx="1440" cy="28800"/>
          </a:xfrm>
          <a:prstGeom prst="line">
            <a:avLst/>
          </a:prstGeom>
          <a:ln w="12600">
            <a:solidFill>
              <a:srgbClr val="000000"/>
            </a:solidFill>
            <a:miter/>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217" name=""/>
          <p:cNvSpPr/>
          <p:nvPr/>
        </p:nvSpPr>
        <p:spPr>
          <a:xfrm>
            <a:off x="3713040" y="416232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18" name=""/>
          <p:cNvSpPr/>
          <p:nvPr/>
        </p:nvSpPr>
        <p:spPr>
          <a:xfrm>
            <a:off x="3780000" y="416232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19" name=""/>
          <p:cNvSpPr/>
          <p:nvPr/>
        </p:nvSpPr>
        <p:spPr>
          <a:xfrm>
            <a:off x="3824280" y="416232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20" name=""/>
          <p:cNvSpPr/>
          <p:nvPr/>
        </p:nvSpPr>
        <p:spPr>
          <a:xfrm>
            <a:off x="3857760" y="4162320"/>
            <a:ext cx="144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221" name=""/>
          <p:cNvSpPr/>
          <p:nvPr/>
        </p:nvSpPr>
        <p:spPr>
          <a:xfrm>
            <a:off x="3886200" y="416232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22" name=""/>
          <p:cNvSpPr/>
          <p:nvPr/>
        </p:nvSpPr>
        <p:spPr>
          <a:xfrm>
            <a:off x="3914640" y="416232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23" name=""/>
          <p:cNvSpPr/>
          <p:nvPr/>
        </p:nvSpPr>
        <p:spPr>
          <a:xfrm>
            <a:off x="3930480" y="416232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24" name=""/>
          <p:cNvSpPr/>
          <p:nvPr/>
        </p:nvSpPr>
        <p:spPr>
          <a:xfrm>
            <a:off x="3952800" y="416232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25" name=""/>
          <p:cNvSpPr/>
          <p:nvPr/>
        </p:nvSpPr>
        <p:spPr>
          <a:xfrm>
            <a:off x="3970440" y="4162320"/>
            <a:ext cx="0" cy="28800"/>
          </a:xfrm>
          <a:prstGeom prst="line">
            <a:avLst/>
          </a:prstGeom>
          <a:ln w="12600">
            <a:solidFill>
              <a:srgbClr val="000000"/>
            </a:solidFill>
            <a:miter/>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226" name=""/>
          <p:cNvSpPr/>
          <p:nvPr/>
        </p:nvSpPr>
        <p:spPr>
          <a:xfrm>
            <a:off x="4075200" y="416232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27" name=""/>
          <p:cNvSpPr/>
          <p:nvPr/>
        </p:nvSpPr>
        <p:spPr>
          <a:xfrm>
            <a:off x="4143240" y="416232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28" name=""/>
          <p:cNvSpPr/>
          <p:nvPr/>
        </p:nvSpPr>
        <p:spPr>
          <a:xfrm>
            <a:off x="4187880" y="416232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29" name=""/>
          <p:cNvSpPr/>
          <p:nvPr/>
        </p:nvSpPr>
        <p:spPr>
          <a:xfrm>
            <a:off x="4221000" y="4162320"/>
            <a:ext cx="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230" name=""/>
          <p:cNvSpPr/>
          <p:nvPr/>
        </p:nvSpPr>
        <p:spPr>
          <a:xfrm>
            <a:off x="4248000" y="416232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31" name=""/>
          <p:cNvSpPr/>
          <p:nvPr/>
        </p:nvSpPr>
        <p:spPr>
          <a:xfrm>
            <a:off x="4270320" y="416232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32" name=""/>
          <p:cNvSpPr/>
          <p:nvPr/>
        </p:nvSpPr>
        <p:spPr>
          <a:xfrm>
            <a:off x="4292640" y="416232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33" name=""/>
          <p:cNvSpPr/>
          <p:nvPr/>
        </p:nvSpPr>
        <p:spPr>
          <a:xfrm>
            <a:off x="4309920" y="416232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34" name=""/>
          <p:cNvSpPr/>
          <p:nvPr/>
        </p:nvSpPr>
        <p:spPr>
          <a:xfrm>
            <a:off x="4327560" y="4162320"/>
            <a:ext cx="0" cy="28800"/>
          </a:xfrm>
          <a:prstGeom prst="line">
            <a:avLst/>
          </a:prstGeom>
          <a:ln w="12600">
            <a:solidFill>
              <a:srgbClr val="000000"/>
            </a:solidFill>
            <a:miter/>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235" name=""/>
          <p:cNvSpPr/>
          <p:nvPr/>
        </p:nvSpPr>
        <p:spPr>
          <a:xfrm flipV="1">
            <a:off x="2887560" y="2909880"/>
            <a:ext cx="1800" cy="12477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36" name=""/>
          <p:cNvSpPr/>
          <p:nvPr/>
        </p:nvSpPr>
        <p:spPr>
          <a:xfrm>
            <a:off x="2766600" y="4130640"/>
            <a:ext cx="648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0</a:t>
            </a:r>
            <a:endParaRPr b="0" lang="en-US" sz="900" spc="-1" strike="noStrike">
              <a:solidFill>
                <a:srgbClr val="000000"/>
              </a:solidFill>
              <a:latin typeface="Arial"/>
            </a:endParaRPr>
          </a:p>
        </p:txBody>
      </p:sp>
      <p:sp>
        <p:nvSpPr>
          <p:cNvPr id="237" name=""/>
          <p:cNvSpPr/>
          <p:nvPr/>
        </p:nvSpPr>
        <p:spPr>
          <a:xfrm>
            <a:off x="2726640" y="390672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50</a:t>
            </a:r>
            <a:endParaRPr b="0" lang="en-US" sz="900" spc="-1" strike="noStrike">
              <a:solidFill>
                <a:srgbClr val="000000"/>
              </a:solidFill>
              <a:latin typeface="Arial"/>
            </a:endParaRPr>
          </a:p>
        </p:txBody>
      </p:sp>
      <p:sp>
        <p:nvSpPr>
          <p:cNvPr id="238" name=""/>
          <p:cNvSpPr/>
          <p:nvPr/>
        </p:nvSpPr>
        <p:spPr>
          <a:xfrm>
            <a:off x="2689920" y="367992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0</a:t>
            </a:r>
            <a:endParaRPr b="0" lang="en-US" sz="900" spc="-1" strike="noStrike">
              <a:solidFill>
                <a:srgbClr val="000000"/>
              </a:solidFill>
              <a:latin typeface="Arial"/>
            </a:endParaRPr>
          </a:p>
        </p:txBody>
      </p:sp>
      <p:sp>
        <p:nvSpPr>
          <p:cNvPr id="239" name=""/>
          <p:cNvSpPr/>
          <p:nvPr/>
        </p:nvSpPr>
        <p:spPr>
          <a:xfrm>
            <a:off x="2689920" y="346068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50</a:t>
            </a:r>
            <a:endParaRPr b="0" lang="en-US" sz="900" spc="-1" strike="noStrike">
              <a:solidFill>
                <a:srgbClr val="000000"/>
              </a:solidFill>
              <a:latin typeface="Arial"/>
            </a:endParaRPr>
          </a:p>
        </p:txBody>
      </p:sp>
      <p:sp>
        <p:nvSpPr>
          <p:cNvPr id="240" name=""/>
          <p:cNvSpPr/>
          <p:nvPr/>
        </p:nvSpPr>
        <p:spPr>
          <a:xfrm>
            <a:off x="2689920" y="323064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200</a:t>
            </a:r>
            <a:endParaRPr b="0" lang="en-US" sz="900" spc="-1" strike="noStrike">
              <a:solidFill>
                <a:srgbClr val="000000"/>
              </a:solidFill>
              <a:latin typeface="Arial"/>
            </a:endParaRPr>
          </a:p>
        </p:txBody>
      </p:sp>
      <p:sp>
        <p:nvSpPr>
          <p:cNvPr id="241" name=""/>
          <p:cNvSpPr/>
          <p:nvPr/>
        </p:nvSpPr>
        <p:spPr>
          <a:xfrm>
            <a:off x="2686680" y="300996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250</a:t>
            </a:r>
            <a:endParaRPr b="0" lang="en-US" sz="900" spc="-1" strike="noStrike">
              <a:solidFill>
                <a:srgbClr val="000000"/>
              </a:solidFill>
              <a:latin typeface="Arial"/>
            </a:endParaRPr>
          </a:p>
        </p:txBody>
      </p:sp>
      <p:sp>
        <p:nvSpPr>
          <p:cNvPr id="242" name=""/>
          <p:cNvSpPr/>
          <p:nvPr/>
        </p:nvSpPr>
        <p:spPr>
          <a:xfrm flipH="1">
            <a:off x="2854440" y="4159080"/>
            <a:ext cx="331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43" name=""/>
          <p:cNvSpPr/>
          <p:nvPr/>
        </p:nvSpPr>
        <p:spPr>
          <a:xfrm flipH="1">
            <a:off x="2876040" y="4114800"/>
            <a:ext cx="111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44" name=""/>
          <p:cNvSpPr/>
          <p:nvPr/>
        </p:nvSpPr>
        <p:spPr>
          <a:xfrm flipH="1">
            <a:off x="2876040" y="407196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45" name=""/>
          <p:cNvSpPr/>
          <p:nvPr/>
        </p:nvSpPr>
        <p:spPr>
          <a:xfrm flipH="1">
            <a:off x="2876040" y="4027320"/>
            <a:ext cx="111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246" name=""/>
          <p:cNvSpPr/>
          <p:nvPr/>
        </p:nvSpPr>
        <p:spPr>
          <a:xfrm flipH="1">
            <a:off x="2876040" y="397980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47" name=""/>
          <p:cNvSpPr/>
          <p:nvPr/>
        </p:nvSpPr>
        <p:spPr>
          <a:xfrm flipH="1">
            <a:off x="2854440" y="3935520"/>
            <a:ext cx="3312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48" name=""/>
          <p:cNvSpPr/>
          <p:nvPr/>
        </p:nvSpPr>
        <p:spPr>
          <a:xfrm flipH="1">
            <a:off x="2876040" y="389268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49" name=""/>
          <p:cNvSpPr/>
          <p:nvPr/>
        </p:nvSpPr>
        <p:spPr>
          <a:xfrm flipH="1">
            <a:off x="2876040" y="3843360"/>
            <a:ext cx="111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50" name=""/>
          <p:cNvSpPr/>
          <p:nvPr/>
        </p:nvSpPr>
        <p:spPr>
          <a:xfrm flipH="1">
            <a:off x="2876040" y="380052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51" name=""/>
          <p:cNvSpPr/>
          <p:nvPr/>
        </p:nvSpPr>
        <p:spPr>
          <a:xfrm flipH="1">
            <a:off x="2876040" y="3755880"/>
            <a:ext cx="111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252" name=""/>
          <p:cNvSpPr/>
          <p:nvPr/>
        </p:nvSpPr>
        <p:spPr>
          <a:xfrm flipH="1">
            <a:off x="2854440" y="3708360"/>
            <a:ext cx="331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53" name=""/>
          <p:cNvSpPr/>
          <p:nvPr/>
        </p:nvSpPr>
        <p:spPr>
          <a:xfrm flipH="1">
            <a:off x="2876040" y="3664080"/>
            <a:ext cx="111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54" name=""/>
          <p:cNvSpPr/>
          <p:nvPr/>
        </p:nvSpPr>
        <p:spPr>
          <a:xfrm flipH="1">
            <a:off x="2876040" y="362124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55" name=""/>
          <p:cNvSpPr/>
          <p:nvPr/>
        </p:nvSpPr>
        <p:spPr>
          <a:xfrm flipH="1">
            <a:off x="2876040" y="357336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56" name=""/>
          <p:cNvSpPr/>
          <p:nvPr/>
        </p:nvSpPr>
        <p:spPr>
          <a:xfrm flipH="1">
            <a:off x="2876040" y="352908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57" name=""/>
          <p:cNvSpPr/>
          <p:nvPr/>
        </p:nvSpPr>
        <p:spPr>
          <a:xfrm flipH="1">
            <a:off x="2854440" y="3486240"/>
            <a:ext cx="331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58" name=""/>
          <p:cNvSpPr/>
          <p:nvPr/>
        </p:nvSpPr>
        <p:spPr>
          <a:xfrm flipH="1">
            <a:off x="2876040" y="3441600"/>
            <a:ext cx="111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259" name=""/>
          <p:cNvSpPr/>
          <p:nvPr/>
        </p:nvSpPr>
        <p:spPr>
          <a:xfrm flipH="1">
            <a:off x="2876040" y="339408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60" name=""/>
          <p:cNvSpPr/>
          <p:nvPr/>
        </p:nvSpPr>
        <p:spPr>
          <a:xfrm flipH="1">
            <a:off x="2876040" y="3349800"/>
            <a:ext cx="111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61" name=""/>
          <p:cNvSpPr/>
          <p:nvPr/>
        </p:nvSpPr>
        <p:spPr>
          <a:xfrm flipH="1">
            <a:off x="2876040" y="330660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62" name=""/>
          <p:cNvSpPr/>
          <p:nvPr/>
        </p:nvSpPr>
        <p:spPr>
          <a:xfrm flipH="1">
            <a:off x="2854440" y="3257640"/>
            <a:ext cx="3312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63" name=""/>
          <p:cNvSpPr/>
          <p:nvPr/>
        </p:nvSpPr>
        <p:spPr>
          <a:xfrm flipH="1">
            <a:off x="2876040" y="321480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64" name=""/>
          <p:cNvSpPr/>
          <p:nvPr/>
        </p:nvSpPr>
        <p:spPr>
          <a:xfrm flipH="1">
            <a:off x="2876040" y="3170160"/>
            <a:ext cx="111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265" name=""/>
          <p:cNvSpPr/>
          <p:nvPr/>
        </p:nvSpPr>
        <p:spPr>
          <a:xfrm flipH="1">
            <a:off x="2876040" y="312264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66" name=""/>
          <p:cNvSpPr/>
          <p:nvPr/>
        </p:nvSpPr>
        <p:spPr>
          <a:xfrm flipH="1">
            <a:off x="2876040" y="3078000"/>
            <a:ext cx="111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267" name=""/>
          <p:cNvSpPr/>
          <p:nvPr/>
        </p:nvSpPr>
        <p:spPr>
          <a:xfrm flipH="1">
            <a:off x="2854440" y="3035160"/>
            <a:ext cx="331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68" name=""/>
          <p:cNvSpPr/>
          <p:nvPr/>
        </p:nvSpPr>
        <p:spPr>
          <a:xfrm flipH="1">
            <a:off x="2876040" y="2986200"/>
            <a:ext cx="111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269" name=""/>
          <p:cNvSpPr/>
          <p:nvPr/>
        </p:nvSpPr>
        <p:spPr>
          <a:xfrm flipH="1">
            <a:off x="2876040" y="294336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70" name=""/>
          <p:cNvSpPr/>
          <p:nvPr/>
        </p:nvSpPr>
        <p:spPr>
          <a:xfrm>
            <a:off x="2898720" y="2978280"/>
            <a:ext cx="1417680" cy="1174680"/>
          </a:xfrm>
          <a:custGeom>
            <a:avLst/>
            <a:gdLst/>
            <a:ahLst/>
            <a:rect l="l" t="t" r="r" b="b"/>
            <a:pathLst>
              <a:path w="2032" h="1944">
                <a:moveTo>
                  <a:pt x="0" y="1944"/>
                </a:moveTo>
                <a:lnTo>
                  <a:pt x="0" y="1928"/>
                </a:lnTo>
                <a:lnTo>
                  <a:pt x="0" y="1944"/>
                </a:lnTo>
                <a:lnTo>
                  <a:pt x="8" y="1944"/>
                </a:lnTo>
                <a:lnTo>
                  <a:pt x="16" y="1944"/>
                </a:lnTo>
                <a:lnTo>
                  <a:pt x="24" y="1944"/>
                </a:lnTo>
                <a:lnTo>
                  <a:pt x="32" y="1928"/>
                </a:lnTo>
                <a:lnTo>
                  <a:pt x="40" y="1936"/>
                </a:lnTo>
                <a:lnTo>
                  <a:pt x="48" y="1936"/>
                </a:lnTo>
                <a:lnTo>
                  <a:pt x="56" y="1928"/>
                </a:lnTo>
                <a:lnTo>
                  <a:pt x="64" y="1936"/>
                </a:lnTo>
                <a:lnTo>
                  <a:pt x="72" y="1936"/>
                </a:lnTo>
                <a:lnTo>
                  <a:pt x="80" y="1912"/>
                </a:lnTo>
                <a:lnTo>
                  <a:pt x="88" y="1912"/>
                </a:lnTo>
                <a:lnTo>
                  <a:pt x="96" y="1912"/>
                </a:lnTo>
                <a:lnTo>
                  <a:pt x="104" y="1928"/>
                </a:lnTo>
                <a:lnTo>
                  <a:pt x="112" y="1896"/>
                </a:lnTo>
                <a:lnTo>
                  <a:pt x="120" y="1856"/>
                </a:lnTo>
                <a:lnTo>
                  <a:pt x="128" y="1888"/>
                </a:lnTo>
                <a:lnTo>
                  <a:pt x="136" y="1880"/>
                </a:lnTo>
                <a:lnTo>
                  <a:pt x="144" y="1880"/>
                </a:lnTo>
                <a:lnTo>
                  <a:pt x="152" y="1864"/>
                </a:lnTo>
                <a:lnTo>
                  <a:pt x="160" y="1848"/>
                </a:lnTo>
                <a:lnTo>
                  <a:pt x="168" y="1816"/>
                </a:lnTo>
                <a:lnTo>
                  <a:pt x="176" y="1856"/>
                </a:lnTo>
                <a:lnTo>
                  <a:pt x="184" y="1768"/>
                </a:lnTo>
                <a:lnTo>
                  <a:pt x="192" y="1824"/>
                </a:lnTo>
                <a:lnTo>
                  <a:pt x="200" y="1768"/>
                </a:lnTo>
                <a:lnTo>
                  <a:pt x="208" y="1816"/>
                </a:lnTo>
                <a:lnTo>
                  <a:pt x="216" y="1800"/>
                </a:lnTo>
                <a:lnTo>
                  <a:pt x="224" y="1808"/>
                </a:lnTo>
                <a:lnTo>
                  <a:pt x="232" y="1784"/>
                </a:lnTo>
                <a:lnTo>
                  <a:pt x="240" y="1744"/>
                </a:lnTo>
                <a:lnTo>
                  <a:pt x="248" y="1760"/>
                </a:lnTo>
                <a:lnTo>
                  <a:pt x="256" y="1768"/>
                </a:lnTo>
                <a:lnTo>
                  <a:pt x="264" y="1680"/>
                </a:lnTo>
                <a:lnTo>
                  <a:pt x="272" y="1696"/>
                </a:lnTo>
                <a:lnTo>
                  <a:pt x="280" y="1768"/>
                </a:lnTo>
                <a:lnTo>
                  <a:pt x="288" y="1776"/>
                </a:lnTo>
                <a:lnTo>
                  <a:pt x="296" y="1704"/>
                </a:lnTo>
                <a:lnTo>
                  <a:pt x="304" y="1664"/>
                </a:lnTo>
                <a:lnTo>
                  <a:pt x="312" y="1696"/>
                </a:lnTo>
                <a:lnTo>
                  <a:pt x="320" y="1664"/>
                </a:lnTo>
                <a:lnTo>
                  <a:pt x="328" y="1752"/>
                </a:lnTo>
                <a:lnTo>
                  <a:pt x="336" y="1696"/>
                </a:lnTo>
                <a:lnTo>
                  <a:pt x="344" y="1704"/>
                </a:lnTo>
                <a:lnTo>
                  <a:pt x="352" y="1696"/>
                </a:lnTo>
                <a:lnTo>
                  <a:pt x="360" y="1680"/>
                </a:lnTo>
                <a:lnTo>
                  <a:pt x="368" y="1680"/>
                </a:lnTo>
                <a:lnTo>
                  <a:pt x="376" y="1656"/>
                </a:lnTo>
                <a:lnTo>
                  <a:pt x="384" y="1688"/>
                </a:lnTo>
                <a:lnTo>
                  <a:pt x="392" y="1712"/>
                </a:lnTo>
                <a:lnTo>
                  <a:pt x="400" y="1584"/>
                </a:lnTo>
                <a:lnTo>
                  <a:pt x="408" y="1640"/>
                </a:lnTo>
                <a:lnTo>
                  <a:pt x="416" y="1648"/>
                </a:lnTo>
                <a:lnTo>
                  <a:pt x="424" y="1712"/>
                </a:lnTo>
                <a:lnTo>
                  <a:pt x="432" y="1616"/>
                </a:lnTo>
                <a:lnTo>
                  <a:pt x="440" y="1664"/>
                </a:lnTo>
                <a:lnTo>
                  <a:pt x="448" y="1704"/>
                </a:lnTo>
                <a:lnTo>
                  <a:pt x="456" y="1696"/>
                </a:lnTo>
                <a:lnTo>
                  <a:pt x="464" y="1680"/>
                </a:lnTo>
                <a:lnTo>
                  <a:pt x="472" y="1616"/>
                </a:lnTo>
                <a:lnTo>
                  <a:pt x="480" y="1608"/>
                </a:lnTo>
                <a:lnTo>
                  <a:pt x="488" y="1576"/>
                </a:lnTo>
                <a:lnTo>
                  <a:pt x="496" y="1576"/>
                </a:lnTo>
                <a:lnTo>
                  <a:pt x="504" y="1568"/>
                </a:lnTo>
                <a:lnTo>
                  <a:pt x="512" y="1592"/>
                </a:lnTo>
                <a:lnTo>
                  <a:pt x="520" y="1376"/>
                </a:lnTo>
                <a:lnTo>
                  <a:pt x="528" y="1536"/>
                </a:lnTo>
                <a:lnTo>
                  <a:pt x="536" y="1512"/>
                </a:lnTo>
                <a:lnTo>
                  <a:pt x="544" y="1400"/>
                </a:lnTo>
                <a:lnTo>
                  <a:pt x="552" y="1416"/>
                </a:lnTo>
                <a:lnTo>
                  <a:pt x="560" y="1416"/>
                </a:lnTo>
                <a:lnTo>
                  <a:pt x="568" y="1392"/>
                </a:lnTo>
                <a:lnTo>
                  <a:pt x="576" y="1232"/>
                </a:lnTo>
                <a:lnTo>
                  <a:pt x="584" y="1320"/>
                </a:lnTo>
                <a:lnTo>
                  <a:pt x="592" y="1160"/>
                </a:lnTo>
                <a:lnTo>
                  <a:pt x="600" y="1152"/>
                </a:lnTo>
                <a:lnTo>
                  <a:pt x="608" y="1016"/>
                </a:lnTo>
                <a:lnTo>
                  <a:pt x="616" y="960"/>
                </a:lnTo>
                <a:lnTo>
                  <a:pt x="624" y="896"/>
                </a:lnTo>
                <a:lnTo>
                  <a:pt x="632" y="848"/>
                </a:lnTo>
                <a:lnTo>
                  <a:pt x="640" y="888"/>
                </a:lnTo>
                <a:lnTo>
                  <a:pt x="648" y="696"/>
                </a:lnTo>
                <a:lnTo>
                  <a:pt x="656" y="792"/>
                </a:lnTo>
                <a:lnTo>
                  <a:pt x="664" y="408"/>
                </a:lnTo>
                <a:lnTo>
                  <a:pt x="672" y="504"/>
                </a:lnTo>
                <a:lnTo>
                  <a:pt x="680" y="432"/>
                </a:lnTo>
                <a:lnTo>
                  <a:pt x="688" y="536"/>
                </a:lnTo>
                <a:lnTo>
                  <a:pt x="696" y="192"/>
                </a:lnTo>
                <a:lnTo>
                  <a:pt x="704" y="232"/>
                </a:lnTo>
                <a:lnTo>
                  <a:pt x="712" y="336"/>
                </a:lnTo>
                <a:lnTo>
                  <a:pt x="720" y="96"/>
                </a:lnTo>
                <a:lnTo>
                  <a:pt x="728" y="128"/>
                </a:lnTo>
                <a:lnTo>
                  <a:pt x="736" y="264"/>
                </a:lnTo>
                <a:lnTo>
                  <a:pt x="744" y="160"/>
                </a:lnTo>
                <a:lnTo>
                  <a:pt x="752" y="288"/>
                </a:lnTo>
                <a:lnTo>
                  <a:pt x="760" y="320"/>
                </a:lnTo>
                <a:lnTo>
                  <a:pt x="768" y="0"/>
                </a:lnTo>
                <a:lnTo>
                  <a:pt x="776" y="120"/>
                </a:lnTo>
                <a:lnTo>
                  <a:pt x="784" y="328"/>
                </a:lnTo>
                <a:lnTo>
                  <a:pt x="792" y="336"/>
                </a:lnTo>
                <a:lnTo>
                  <a:pt x="800" y="104"/>
                </a:lnTo>
                <a:lnTo>
                  <a:pt x="808" y="352"/>
                </a:lnTo>
                <a:lnTo>
                  <a:pt x="816" y="448"/>
                </a:lnTo>
                <a:lnTo>
                  <a:pt x="824" y="488"/>
                </a:lnTo>
                <a:lnTo>
                  <a:pt x="832" y="616"/>
                </a:lnTo>
                <a:lnTo>
                  <a:pt x="840" y="584"/>
                </a:lnTo>
                <a:lnTo>
                  <a:pt x="848" y="760"/>
                </a:lnTo>
                <a:lnTo>
                  <a:pt x="856" y="896"/>
                </a:lnTo>
                <a:lnTo>
                  <a:pt x="864" y="1040"/>
                </a:lnTo>
                <a:lnTo>
                  <a:pt x="872" y="1096"/>
                </a:lnTo>
                <a:lnTo>
                  <a:pt x="880" y="1144"/>
                </a:lnTo>
                <a:lnTo>
                  <a:pt x="888" y="1408"/>
                </a:lnTo>
                <a:lnTo>
                  <a:pt x="896" y="1424"/>
                </a:lnTo>
                <a:lnTo>
                  <a:pt x="904" y="1336"/>
                </a:lnTo>
                <a:lnTo>
                  <a:pt x="912" y="1560"/>
                </a:lnTo>
                <a:lnTo>
                  <a:pt x="920" y="1616"/>
                </a:lnTo>
                <a:lnTo>
                  <a:pt x="928" y="1672"/>
                </a:lnTo>
                <a:lnTo>
                  <a:pt x="936" y="1576"/>
                </a:lnTo>
                <a:lnTo>
                  <a:pt x="944" y="1672"/>
                </a:lnTo>
                <a:lnTo>
                  <a:pt x="952" y="1760"/>
                </a:lnTo>
                <a:lnTo>
                  <a:pt x="960" y="1720"/>
                </a:lnTo>
                <a:lnTo>
                  <a:pt x="968" y="1848"/>
                </a:lnTo>
                <a:lnTo>
                  <a:pt x="976" y="1776"/>
                </a:lnTo>
                <a:lnTo>
                  <a:pt x="984" y="1840"/>
                </a:lnTo>
                <a:lnTo>
                  <a:pt x="992" y="1832"/>
                </a:lnTo>
                <a:lnTo>
                  <a:pt x="1000" y="1880"/>
                </a:lnTo>
                <a:lnTo>
                  <a:pt x="1008" y="1856"/>
                </a:lnTo>
                <a:lnTo>
                  <a:pt x="1016" y="1904"/>
                </a:lnTo>
                <a:lnTo>
                  <a:pt x="1024" y="1912"/>
                </a:lnTo>
                <a:lnTo>
                  <a:pt x="1032" y="1912"/>
                </a:lnTo>
                <a:lnTo>
                  <a:pt x="1040" y="1912"/>
                </a:lnTo>
                <a:lnTo>
                  <a:pt x="1048" y="1904"/>
                </a:lnTo>
                <a:lnTo>
                  <a:pt x="1056" y="1920"/>
                </a:lnTo>
                <a:lnTo>
                  <a:pt x="1064" y="1936"/>
                </a:lnTo>
                <a:lnTo>
                  <a:pt x="1072" y="1888"/>
                </a:lnTo>
                <a:lnTo>
                  <a:pt x="1080" y="1944"/>
                </a:lnTo>
                <a:lnTo>
                  <a:pt x="1088" y="1920"/>
                </a:lnTo>
                <a:lnTo>
                  <a:pt x="1096" y="1936"/>
                </a:lnTo>
                <a:lnTo>
                  <a:pt x="1104" y="1944"/>
                </a:lnTo>
                <a:lnTo>
                  <a:pt x="1112" y="1944"/>
                </a:lnTo>
                <a:lnTo>
                  <a:pt x="1120" y="1936"/>
                </a:lnTo>
                <a:lnTo>
                  <a:pt x="1128" y="1944"/>
                </a:lnTo>
                <a:lnTo>
                  <a:pt x="1136" y="1944"/>
                </a:lnTo>
                <a:lnTo>
                  <a:pt x="1144" y="1944"/>
                </a:lnTo>
                <a:lnTo>
                  <a:pt x="1152" y="1944"/>
                </a:lnTo>
                <a:lnTo>
                  <a:pt x="1160" y="1944"/>
                </a:lnTo>
                <a:lnTo>
                  <a:pt x="1168" y="1944"/>
                </a:lnTo>
                <a:lnTo>
                  <a:pt x="1176" y="1944"/>
                </a:lnTo>
                <a:lnTo>
                  <a:pt x="1184" y="1944"/>
                </a:lnTo>
                <a:lnTo>
                  <a:pt x="1192" y="1944"/>
                </a:lnTo>
                <a:lnTo>
                  <a:pt x="1200" y="1944"/>
                </a:lnTo>
                <a:lnTo>
                  <a:pt x="1208" y="1944"/>
                </a:lnTo>
                <a:lnTo>
                  <a:pt x="1216" y="1944"/>
                </a:lnTo>
                <a:lnTo>
                  <a:pt x="1224" y="1944"/>
                </a:lnTo>
                <a:lnTo>
                  <a:pt x="1232" y="1944"/>
                </a:lnTo>
                <a:lnTo>
                  <a:pt x="1240" y="1944"/>
                </a:lnTo>
                <a:lnTo>
                  <a:pt x="1248" y="1944"/>
                </a:lnTo>
                <a:lnTo>
                  <a:pt x="1256" y="1944"/>
                </a:lnTo>
                <a:lnTo>
                  <a:pt x="1264" y="1944"/>
                </a:lnTo>
                <a:lnTo>
                  <a:pt x="1272" y="1944"/>
                </a:lnTo>
                <a:lnTo>
                  <a:pt x="1280" y="1944"/>
                </a:lnTo>
                <a:lnTo>
                  <a:pt x="1288" y="1944"/>
                </a:lnTo>
                <a:lnTo>
                  <a:pt x="1296" y="1944"/>
                </a:lnTo>
                <a:lnTo>
                  <a:pt x="1304" y="1944"/>
                </a:lnTo>
                <a:lnTo>
                  <a:pt x="1312" y="1944"/>
                </a:lnTo>
                <a:lnTo>
                  <a:pt x="1320" y="1944"/>
                </a:lnTo>
                <a:lnTo>
                  <a:pt x="1328" y="1944"/>
                </a:lnTo>
                <a:lnTo>
                  <a:pt x="1336" y="1944"/>
                </a:lnTo>
                <a:lnTo>
                  <a:pt x="1344" y="1944"/>
                </a:lnTo>
                <a:lnTo>
                  <a:pt x="1352" y="1944"/>
                </a:lnTo>
                <a:lnTo>
                  <a:pt x="1360" y="1944"/>
                </a:lnTo>
                <a:lnTo>
                  <a:pt x="1368" y="1944"/>
                </a:lnTo>
                <a:lnTo>
                  <a:pt x="1376" y="1944"/>
                </a:lnTo>
                <a:lnTo>
                  <a:pt x="1384" y="1944"/>
                </a:lnTo>
                <a:lnTo>
                  <a:pt x="1392" y="1944"/>
                </a:lnTo>
                <a:lnTo>
                  <a:pt x="1400" y="1944"/>
                </a:lnTo>
                <a:lnTo>
                  <a:pt x="1408" y="1944"/>
                </a:lnTo>
                <a:lnTo>
                  <a:pt x="1416" y="1944"/>
                </a:lnTo>
                <a:lnTo>
                  <a:pt x="1424" y="1944"/>
                </a:lnTo>
                <a:lnTo>
                  <a:pt x="1432" y="1944"/>
                </a:lnTo>
                <a:lnTo>
                  <a:pt x="1440" y="1944"/>
                </a:lnTo>
                <a:lnTo>
                  <a:pt x="1448" y="1944"/>
                </a:lnTo>
                <a:lnTo>
                  <a:pt x="1456" y="1944"/>
                </a:lnTo>
                <a:lnTo>
                  <a:pt x="1464" y="1944"/>
                </a:lnTo>
                <a:lnTo>
                  <a:pt x="1472" y="1944"/>
                </a:lnTo>
                <a:lnTo>
                  <a:pt x="1480" y="1944"/>
                </a:lnTo>
                <a:lnTo>
                  <a:pt x="1488" y="1944"/>
                </a:lnTo>
                <a:lnTo>
                  <a:pt x="1496" y="1944"/>
                </a:lnTo>
                <a:lnTo>
                  <a:pt x="1504" y="1944"/>
                </a:lnTo>
                <a:lnTo>
                  <a:pt x="1512" y="1944"/>
                </a:lnTo>
                <a:lnTo>
                  <a:pt x="1520" y="1944"/>
                </a:lnTo>
                <a:lnTo>
                  <a:pt x="1528" y="1944"/>
                </a:lnTo>
                <a:lnTo>
                  <a:pt x="1536" y="1944"/>
                </a:lnTo>
                <a:lnTo>
                  <a:pt x="1544" y="1944"/>
                </a:lnTo>
                <a:lnTo>
                  <a:pt x="1552" y="1944"/>
                </a:lnTo>
                <a:lnTo>
                  <a:pt x="1560" y="1944"/>
                </a:lnTo>
                <a:lnTo>
                  <a:pt x="1568" y="1944"/>
                </a:lnTo>
                <a:lnTo>
                  <a:pt x="1576" y="1944"/>
                </a:lnTo>
                <a:lnTo>
                  <a:pt x="1584" y="1944"/>
                </a:lnTo>
                <a:lnTo>
                  <a:pt x="1592" y="1944"/>
                </a:lnTo>
                <a:lnTo>
                  <a:pt x="1600" y="1944"/>
                </a:lnTo>
                <a:lnTo>
                  <a:pt x="1608" y="1944"/>
                </a:lnTo>
                <a:lnTo>
                  <a:pt x="1616" y="1944"/>
                </a:lnTo>
                <a:lnTo>
                  <a:pt x="1624" y="1944"/>
                </a:lnTo>
                <a:lnTo>
                  <a:pt x="1632" y="1944"/>
                </a:lnTo>
                <a:lnTo>
                  <a:pt x="1640" y="1944"/>
                </a:lnTo>
                <a:lnTo>
                  <a:pt x="1648" y="1944"/>
                </a:lnTo>
                <a:lnTo>
                  <a:pt x="1656" y="1944"/>
                </a:lnTo>
                <a:lnTo>
                  <a:pt x="1664" y="1944"/>
                </a:lnTo>
                <a:lnTo>
                  <a:pt x="1672" y="1944"/>
                </a:lnTo>
                <a:lnTo>
                  <a:pt x="1680" y="1944"/>
                </a:lnTo>
                <a:lnTo>
                  <a:pt x="1688" y="1944"/>
                </a:lnTo>
                <a:lnTo>
                  <a:pt x="1696" y="1944"/>
                </a:lnTo>
                <a:lnTo>
                  <a:pt x="1704" y="1944"/>
                </a:lnTo>
                <a:lnTo>
                  <a:pt x="1712" y="1944"/>
                </a:lnTo>
                <a:lnTo>
                  <a:pt x="1720" y="1944"/>
                </a:lnTo>
                <a:lnTo>
                  <a:pt x="1728" y="1944"/>
                </a:lnTo>
                <a:lnTo>
                  <a:pt x="1736" y="1944"/>
                </a:lnTo>
                <a:lnTo>
                  <a:pt x="1744" y="1944"/>
                </a:lnTo>
                <a:lnTo>
                  <a:pt x="1752" y="1944"/>
                </a:lnTo>
                <a:lnTo>
                  <a:pt x="1760" y="1944"/>
                </a:lnTo>
                <a:lnTo>
                  <a:pt x="1768" y="1944"/>
                </a:lnTo>
                <a:lnTo>
                  <a:pt x="1776" y="1944"/>
                </a:lnTo>
                <a:lnTo>
                  <a:pt x="1784" y="1944"/>
                </a:lnTo>
                <a:lnTo>
                  <a:pt x="1792" y="1944"/>
                </a:lnTo>
                <a:lnTo>
                  <a:pt x="1800" y="1944"/>
                </a:lnTo>
                <a:lnTo>
                  <a:pt x="1808" y="1944"/>
                </a:lnTo>
                <a:lnTo>
                  <a:pt x="1816" y="1944"/>
                </a:lnTo>
                <a:lnTo>
                  <a:pt x="1824" y="1944"/>
                </a:lnTo>
                <a:lnTo>
                  <a:pt x="1832" y="1944"/>
                </a:lnTo>
                <a:lnTo>
                  <a:pt x="1840" y="1944"/>
                </a:lnTo>
                <a:lnTo>
                  <a:pt x="1848" y="1944"/>
                </a:lnTo>
                <a:lnTo>
                  <a:pt x="1856" y="1944"/>
                </a:lnTo>
                <a:lnTo>
                  <a:pt x="1864" y="1944"/>
                </a:lnTo>
                <a:lnTo>
                  <a:pt x="1872" y="1944"/>
                </a:lnTo>
                <a:lnTo>
                  <a:pt x="1880" y="1944"/>
                </a:lnTo>
                <a:lnTo>
                  <a:pt x="1888" y="1944"/>
                </a:lnTo>
                <a:lnTo>
                  <a:pt x="1896" y="1944"/>
                </a:lnTo>
                <a:lnTo>
                  <a:pt x="1904" y="1944"/>
                </a:lnTo>
                <a:lnTo>
                  <a:pt x="1912" y="1944"/>
                </a:lnTo>
                <a:lnTo>
                  <a:pt x="1920" y="1944"/>
                </a:lnTo>
                <a:lnTo>
                  <a:pt x="1928" y="1944"/>
                </a:lnTo>
                <a:lnTo>
                  <a:pt x="1936" y="1944"/>
                </a:lnTo>
                <a:lnTo>
                  <a:pt x="1944" y="1944"/>
                </a:lnTo>
                <a:lnTo>
                  <a:pt x="1952" y="1944"/>
                </a:lnTo>
                <a:lnTo>
                  <a:pt x="1960" y="1944"/>
                </a:lnTo>
                <a:lnTo>
                  <a:pt x="1968" y="1944"/>
                </a:lnTo>
                <a:lnTo>
                  <a:pt x="1976" y="1944"/>
                </a:lnTo>
                <a:lnTo>
                  <a:pt x="1984" y="1944"/>
                </a:lnTo>
                <a:lnTo>
                  <a:pt x="1992" y="1944"/>
                </a:lnTo>
                <a:lnTo>
                  <a:pt x="2000" y="1944"/>
                </a:lnTo>
                <a:lnTo>
                  <a:pt x="2008" y="1944"/>
                </a:lnTo>
                <a:lnTo>
                  <a:pt x="2016" y="1944"/>
                </a:lnTo>
                <a:lnTo>
                  <a:pt x="2024" y="1944"/>
                </a:lnTo>
                <a:lnTo>
                  <a:pt x="2032" y="1944"/>
                </a:lnTo>
              </a:path>
            </a:pathLst>
          </a:custGeom>
          <a:noFill/>
          <a:ln w="1260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71" name=""/>
          <p:cNvSpPr/>
          <p:nvPr/>
        </p:nvSpPr>
        <p:spPr>
          <a:xfrm>
            <a:off x="2898720" y="2982960"/>
            <a:ext cx="1417680" cy="1170000"/>
          </a:xfrm>
          <a:custGeom>
            <a:avLst/>
            <a:gdLst/>
            <a:ahLst/>
            <a:rect l="l" t="t" r="r" b="b"/>
            <a:pathLst>
              <a:path w="2032" h="1936">
                <a:moveTo>
                  <a:pt x="0" y="1936"/>
                </a:moveTo>
                <a:lnTo>
                  <a:pt x="0" y="144"/>
                </a:lnTo>
                <a:lnTo>
                  <a:pt x="0" y="1560"/>
                </a:lnTo>
                <a:lnTo>
                  <a:pt x="8" y="1504"/>
                </a:lnTo>
                <a:lnTo>
                  <a:pt x="16" y="1464"/>
                </a:lnTo>
                <a:lnTo>
                  <a:pt x="24" y="1456"/>
                </a:lnTo>
                <a:lnTo>
                  <a:pt x="32" y="1296"/>
                </a:lnTo>
                <a:lnTo>
                  <a:pt x="40" y="1320"/>
                </a:lnTo>
                <a:lnTo>
                  <a:pt x="48" y="1248"/>
                </a:lnTo>
                <a:lnTo>
                  <a:pt x="56" y="1248"/>
                </a:lnTo>
                <a:lnTo>
                  <a:pt x="64" y="968"/>
                </a:lnTo>
                <a:lnTo>
                  <a:pt x="72" y="1000"/>
                </a:lnTo>
                <a:lnTo>
                  <a:pt x="80" y="984"/>
                </a:lnTo>
                <a:lnTo>
                  <a:pt x="88" y="1056"/>
                </a:lnTo>
                <a:lnTo>
                  <a:pt x="96" y="768"/>
                </a:lnTo>
                <a:lnTo>
                  <a:pt x="104" y="864"/>
                </a:lnTo>
                <a:lnTo>
                  <a:pt x="112" y="840"/>
                </a:lnTo>
                <a:lnTo>
                  <a:pt x="120" y="872"/>
                </a:lnTo>
                <a:lnTo>
                  <a:pt x="128" y="680"/>
                </a:lnTo>
                <a:lnTo>
                  <a:pt x="136" y="736"/>
                </a:lnTo>
                <a:lnTo>
                  <a:pt x="144" y="864"/>
                </a:lnTo>
                <a:lnTo>
                  <a:pt x="152" y="904"/>
                </a:lnTo>
                <a:lnTo>
                  <a:pt x="160" y="552"/>
                </a:lnTo>
                <a:lnTo>
                  <a:pt x="168" y="744"/>
                </a:lnTo>
                <a:lnTo>
                  <a:pt x="176" y="592"/>
                </a:lnTo>
                <a:lnTo>
                  <a:pt x="184" y="792"/>
                </a:lnTo>
                <a:lnTo>
                  <a:pt x="192" y="480"/>
                </a:lnTo>
                <a:lnTo>
                  <a:pt x="200" y="600"/>
                </a:lnTo>
                <a:lnTo>
                  <a:pt x="208" y="536"/>
                </a:lnTo>
                <a:lnTo>
                  <a:pt x="216" y="664"/>
                </a:lnTo>
                <a:lnTo>
                  <a:pt x="224" y="568"/>
                </a:lnTo>
                <a:lnTo>
                  <a:pt x="232" y="504"/>
                </a:lnTo>
                <a:lnTo>
                  <a:pt x="240" y="560"/>
                </a:lnTo>
                <a:lnTo>
                  <a:pt x="248" y="720"/>
                </a:lnTo>
                <a:lnTo>
                  <a:pt x="256" y="504"/>
                </a:lnTo>
                <a:lnTo>
                  <a:pt x="264" y="640"/>
                </a:lnTo>
                <a:lnTo>
                  <a:pt x="272" y="488"/>
                </a:lnTo>
                <a:lnTo>
                  <a:pt x="280" y="392"/>
                </a:lnTo>
                <a:lnTo>
                  <a:pt x="288" y="520"/>
                </a:lnTo>
                <a:lnTo>
                  <a:pt x="296" y="448"/>
                </a:lnTo>
                <a:lnTo>
                  <a:pt x="304" y="400"/>
                </a:lnTo>
                <a:lnTo>
                  <a:pt x="312" y="464"/>
                </a:lnTo>
                <a:lnTo>
                  <a:pt x="320" y="0"/>
                </a:lnTo>
                <a:lnTo>
                  <a:pt x="328" y="320"/>
                </a:lnTo>
                <a:lnTo>
                  <a:pt x="336" y="600"/>
                </a:lnTo>
                <a:lnTo>
                  <a:pt x="344" y="480"/>
                </a:lnTo>
                <a:lnTo>
                  <a:pt x="352" y="384"/>
                </a:lnTo>
                <a:lnTo>
                  <a:pt x="360" y="280"/>
                </a:lnTo>
                <a:lnTo>
                  <a:pt x="368" y="232"/>
                </a:lnTo>
                <a:lnTo>
                  <a:pt x="376" y="400"/>
                </a:lnTo>
                <a:lnTo>
                  <a:pt x="384" y="88"/>
                </a:lnTo>
                <a:lnTo>
                  <a:pt x="392" y="552"/>
                </a:lnTo>
                <a:lnTo>
                  <a:pt x="400" y="480"/>
                </a:lnTo>
                <a:lnTo>
                  <a:pt x="408" y="120"/>
                </a:lnTo>
                <a:lnTo>
                  <a:pt x="416" y="432"/>
                </a:lnTo>
                <a:lnTo>
                  <a:pt x="424" y="512"/>
                </a:lnTo>
                <a:lnTo>
                  <a:pt x="432" y="512"/>
                </a:lnTo>
                <a:lnTo>
                  <a:pt x="440" y="696"/>
                </a:lnTo>
                <a:lnTo>
                  <a:pt x="448" y="632"/>
                </a:lnTo>
                <a:lnTo>
                  <a:pt x="456" y="760"/>
                </a:lnTo>
                <a:lnTo>
                  <a:pt x="464" y="888"/>
                </a:lnTo>
                <a:lnTo>
                  <a:pt x="472" y="904"/>
                </a:lnTo>
                <a:lnTo>
                  <a:pt x="480" y="1024"/>
                </a:lnTo>
                <a:lnTo>
                  <a:pt x="488" y="904"/>
                </a:lnTo>
                <a:lnTo>
                  <a:pt x="496" y="1160"/>
                </a:lnTo>
                <a:lnTo>
                  <a:pt x="504" y="1080"/>
                </a:lnTo>
                <a:lnTo>
                  <a:pt x="512" y="1208"/>
                </a:lnTo>
                <a:lnTo>
                  <a:pt x="520" y="1296"/>
                </a:lnTo>
                <a:lnTo>
                  <a:pt x="528" y="1368"/>
                </a:lnTo>
                <a:lnTo>
                  <a:pt x="536" y="1440"/>
                </a:lnTo>
                <a:lnTo>
                  <a:pt x="544" y="1336"/>
                </a:lnTo>
                <a:lnTo>
                  <a:pt x="552" y="1480"/>
                </a:lnTo>
                <a:lnTo>
                  <a:pt x="560" y="1392"/>
                </a:lnTo>
                <a:lnTo>
                  <a:pt x="568" y="1480"/>
                </a:lnTo>
                <a:lnTo>
                  <a:pt x="576" y="1624"/>
                </a:lnTo>
                <a:lnTo>
                  <a:pt x="584" y="1560"/>
                </a:lnTo>
                <a:lnTo>
                  <a:pt x="592" y="1552"/>
                </a:lnTo>
                <a:lnTo>
                  <a:pt x="600" y="1672"/>
                </a:lnTo>
                <a:lnTo>
                  <a:pt x="608" y="1720"/>
                </a:lnTo>
                <a:lnTo>
                  <a:pt x="616" y="1760"/>
                </a:lnTo>
                <a:lnTo>
                  <a:pt x="624" y="1704"/>
                </a:lnTo>
                <a:lnTo>
                  <a:pt x="632" y="1792"/>
                </a:lnTo>
                <a:lnTo>
                  <a:pt x="640" y="1760"/>
                </a:lnTo>
                <a:lnTo>
                  <a:pt x="648" y="1808"/>
                </a:lnTo>
                <a:lnTo>
                  <a:pt x="656" y="1808"/>
                </a:lnTo>
                <a:lnTo>
                  <a:pt x="664" y="1752"/>
                </a:lnTo>
                <a:lnTo>
                  <a:pt x="672" y="1816"/>
                </a:lnTo>
                <a:lnTo>
                  <a:pt x="680" y="1824"/>
                </a:lnTo>
                <a:lnTo>
                  <a:pt x="688" y="1832"/>
                </a:lnTo>
                <a:lnTo>
                  <a:pt x="696" y="1808"/>
                </a:lnTo>
                <a:lnTo>
                  <a:pt x="704" y="1784"/>
                </a:lnTo>
                <a:lnTo>
                  <a:pt x="712" y="1848"/>
                </a:lnTo>
                <a:lnTo>
                  <a:pt x="720" y="1848"/>
                </a:lnTo>
                <a:lnTo>
                  <a:pt x="728" y="1912"/>
                </a:lnTo>
                <a:lnTo>
                  <a:pt x="736" y="1864"/>
                </a:lnTo>
                <a:lnTo>
                  <a:pt x="744" y="1920"/>
                </a:lnTo>
                <a:lnTo>
                  <a:pt x="752" y="1896"/>
                </a:lnTo>
                <a:lnTo>
                  <a:pt x="760" y="1904"/>
                </a:lnTo>
                <a:lnTo>
                  <a:pt x="768" y="1928"/>
                </a:lnTo>
                <a:lnTo>
                  <a:pt x="776" y="1904"/>
                </a:lnTo>
                <a:lnTo>
                  <a:pt x="784" y="1904"/>
                </a:lnTo>
                <a:lnTo>
                  <a:pt x="792" y="1864"/>
                </a:lnTo>
                <a:lnTo>
                  <a:pt x="800" y="1920"/>
                </a:lnTo>
                <a:lnTo>
                  <a:pt x="808" y="1920"/>
                </a:lnTo>
                <a:lnTo>
                  <a:pt x="816" y="1928"/>
                </a:lnTo>
                <a:lnTo>
                  <a:pt x="824" y="1920"/>
                </a:lnTo>
                <a:lnTo>
                  <a:pt x="832" y="1928"/>
                </a:lnTo>
                <a:lnTo>
                  <a:pt x="840" y="1936"/>
                </a:lnTo>
                <a:lnTo>
                  <a:pt x="848" y="1928"/>
                </a:lnTo>
                <a:lnTo>
                  <a:pt x="856" y="1928"/>
                </a:lnTo>
                <a:lnTo>
                  <a:pt x="864" y="1928"/>
                </a:lnTo>
                <a:lnTo>
                  <a:pt x="872" y="1928"/>
                </a:lnTo>
                <a:lnTo>
                  <a:pt x="880" y="1936"/>
                </a:lnTo>
                <a:lnTo>
                  <a:pt x="888" y="1936"/>
                </a:lnTo>
                <a:lnTo>
                  <a:pt x="896" y="1936"/>
                </a:lnTo>
                <a:lnTo>
                  <a:pt x="904" y="1936"/>
                </a:lnTo>
                <a:lnTo>
                  <a:pt x="912" y="1936"/>
                </a:lnTo>
                <a:lnTo>
                  <a:pt x="920" y="1936"/>
                </a:lnTo>
                <a:lnTo>
                  <a:pt x="928" y="1936"/>
                </a:lnTo>
                <a:lnTo>
                  <a:pt x="936" y="1936"/>
                </a:lnTo>
                <a:lnTo>
                  <a:pt x="944" y="1936"/>
                </a:lnTo>
                <a:lnTo>
                  <a:pt x="952" y="1936"/>
                </a:lnTo>
                <a:lnTo>
                  <a:pt x="960" y="1936"/>
                </a:lnTo>
                <a:lnTo>
                  <a:pt x="968" y="1936"/>
                </a:lnTo>
                <a:lnTo>
                  <a:pt x="976" y="1936"/>
                </a:lnTo>
                <a:lnTo>
                  <a:pt x="984" y="1936"/>
                </a:lnTo>
                <a:lnTo>
                  <a:pt x="992" y="1936"/>
                </a:lnTo>
                <a:lnTo>
                  <a:pt x="1000" y="1936"/>
                </a:lnTo>
                <a:lnTo>
                  <a:pt x="1008" y="1936"/>
                </a:lnTo>
                <a:lnTo>
                  <a:pt x="1016" y="1936"/>
                </a:lnTo>
                <a:lnTo>
                  <a:pt x="1024" y="1936"/>
                </a:lnTo>
                <a:lnTo>
                  <a:pt x="1032" y="1936"/>
                </a:lnTo>
                <a:lnTo>
                  <a:pt x="1040" y="1936"/>
                </a:lnTo>
                <a:lnTo>
                  <a:pt x="1048" y="1936"/>
                </a:lnTo>
                <a:lnTo>
                  <a:pt x="1056" y="1936"/>
                </a:lnTo>
                <a:lnTo>
                  <a:pt x="1064" y="1936"/>
                </a:lnTo>
                <a:lnTo>
                  <a:pt x="1072" y="1936"/>
                </a:lnTo>
                <a:lnTo>
                  <a:pt x="1080" y="1936"/>
                </a:lnTo>
                <a:lnTo>
                  <a:pt x="1088" y="1936"/>
                </a:lnTo>
                <a:lnTo>
                  <a:pt x="1096" y="1936"/>
                </a:lnTo>
                <a:lnTo>
                  <a:pt x="1104" y="1936"/>
                </a:lnTo>
                <a:lnTo>
                  <a:pt x="1112" y="1936"/>
                </a:lnTo>
                <a:lnTo>
                  <a:pt x="1120" y="1936"/>
                </a:lnTo>
                <a:lnTo>
                  <a:pt x="1128" y="1936"/>
                </a:lnTo>
                <a:lnTo>
                  <a:pt x="1136" y="1936"/>
                </a:lnTo>
                <a:lnTo>
                  <a:pt x="1144" y="1936"/>
                </a:lnTo>
                <a:lnTo>
                  <a:pt x="1152" y="1936"/>
                </a:lnTo>
                <a:lnTo>
                  <a:pt x="1160" y="1936"/>
                </a:lnTo>
                <a:lnTo>
                  <a:pt x="1168" y="1936"/>
                </a:lnTo>
                <a:lnTo>
                  <a:pt x="1176" y="1936"/>
                </a:lnTo>
                <a:lnTo>
                  <a:pt x="1184" y="1936"/>
                </a:lnTo>
                <a:lnTo>
                  <a:pt x="1192" y="1936"/>
                </a:lnTo>
                <a:lnTo>
                  <a:pt x="1200" y="1936"/>
                </a:lnTo>
                <a:lnTo>
                  <a:pt x="1208" y="1936"/>
                </a:lnTo>
                <a:lnTo>
                  <a:pt x="1216" y="1936"/>
                </a:lnTo>
                <a:lnTo>
                  <a:pt x="1224" y="1936"/>
                </a:lnTo>
                <a:lnTo>
                  <a:pt x="1232" y="1936"/>
                </a:lnTo>
                <a:lnTo>
                  <a:pt x="1240" y="1936"/>
                </a:lnTo>
                <a:lnTo>
                  <a:pt x="1248" y="1936"/>
                </a:lnTo>
                <a:lnTo>
                  <a:pt x="1256" y="1936"/>
                </a:lnTo>
                <a:lnTo>
                  <a:pt x="1264" y="1936"/>
                </a:lnTo>
                <a:lnTo>
                  <a:pt x="1272" y="1936"/>
                </a:lnTo>
                <a:lnTo>
                  <a:pt x="1280" y="1936"/>
                </a:lnTo>
                <a:lnTo>
                  <a:pt x="1288" y="1936"/>
                </a:lnTo>
                <a:lnTo>
                  <a:pt x="1296" y="1936"/>
                </a:lnTo>
                <a:lnTo>
                  <a:pt x="1304" y="1936"/>
                </a:lnTo>
                <a:lnTo>
                  <a:pt x="1312" y="1936"/>
                </a:lnTo>
                <a:lnTo>
                  <a:pt x="1320" y="1936"/>
                </a:lnTo>
                <a:lnTo>
                  <a:pt x="1328" y="1936"/>
                </a:lnTo>
                <a:lnTo>
                  <a:pt x="1336" y="1936"/>
                </a:lnTo>
                <a:lnTo>
                  <a:pt x="1344" y="1936"/>
                </a:lnTo>
                <a:lnTo>
                  <a:pt x="1352" y="1936"/>
                </a:lnTo>
                <a:lnTo>
                  <a:pt x="1360" y="1936"/>
                </a:lnTo>
                <a:lnTo>
                  <a:pt x="1368" y="1936"/>
                </a:lnTo>
                <a:lnTo>
                  <a:pt x="1376" y="1936"/>
                </a:lnTo>
                <a:lnTo>
                  <a:pt x="1384" y="1936"/>
                </a:lnTo>
                <a:lnTo>
                  <a:pt x="1392" y="1936"/>
                </a:lnTo>
                <a:lnTo>
                  <a:pt x="1400" y="1936"/>
                </a:lnTo>
                <a:lnTo>
                  <a:pt x="1408" y="1936"/>
                </a:lnTo>
                <a:lnTo>
                  <a:pt x="1416" y="1936"/>
                </a:lnTo>
                <a:lnTo>
                  <a:pt x="1424" y="1936"/>
                </a:lnTo>
                <a:lnTo>
                  <a:pt x="1432" y="1936"/>
                </a:lnTo>
                <a:lnTo>
                  <a:pt x="1440" y="1936"/>
                </a:lnTo>
                <a:lnTo>
                  <a:pt x="1448" y="1936"/>
                </a:lnTo>
                <a:lnTo>
                  <a:pt x="1456" y="1936"/>
                </a:lnTo>
                <a:lnTo>
                  <a:pt x="1464" y="1936"/>
                </a:lnTo>
                <a:lnTo>
                  <a:pt x="1472" y="1936"/>
                </a:lnTo>
                <a:lnTo>
                  <a:pt x="1480" y="1936"/>
                </a:lnTo>
                <a:lnTo>
                  <a:pt x="1488" y="1936"/>
                </a:lnTo>
                <a:lnTo>
                  <a:pt x="1496" y="1936"/>
                </a:lnTo>
                <a:lnTo>
                  <a:pt x="1504" y="1936"/>
                </a:lnTo>
                <a:lnTo>
                  <a:pt x="1512" y="1936"/>
                </a:lnTo>
                <a:lnTo>
                  <a:pt x="1520" y="1936"/>
                </a:lnTo>
                <a:lnTo>
                  <a:pt x="1528" y="1936"/>
                </a:lnTo>
                <a:lnTo>
                  <a:pt x="1536" y="1936"/>
                </a:lnTo>
                <a:lnTo>
                  <a:pt x="1544" y="1936"/>
                </a:lnTo>
                <a:lnTo>
                  <a:pt x="1552" y="1936"/>
                </a:lnTo>
                <a:lnTo>
                  <a:pt x="1560" y="1936"/>
                </a:lnTo>
                <a:lnTo>
                  <a:pt x="1568" y="1936"/>
                </a:lnTo>
                <a:lnTo>
                  <a:pt x="1576" y="1936"/>
                </a:lnTo>
                <a:lnTo>
                  <a:pt x="1584" y="1936"/>
                </a:lnTo>
                <a:lnTo>
                  <a:pt x="1592" y="1936"/>
                </a:lnTo>
                <a:lnTo>
                  <a:pt x="1600" y="1936"/>
                </a:lnTo>
                <a:lnTo>
                  <a:pt x="1608" y="1936"/>
                </a:lnTo>
                <a:lnTo>
                  <a:pt x="1616" y="1936"/>
                </a:lnTo>
                <a:lnTo>
                  <a:pt x="1624" y="1936"/>
                </a:lnTo>
                <a:lnTo>
                  <a:pt x="1632" y="1936"/>
                </a:lnTo>
                <a:lnTo>
                  <a:pt x="1640" y="1936"/>
                </a:lnTo>
                <a:lnTo>
                  <a:pt x="1648" y="1936"/>
                </a:lnTo>
                <a:lnTo>
                  <a:pt x="1656" y="1936"/>
                </a:lnTo>
                <a:lnTo>
                  <a:pt x="1664" y="1936"/>
                </a:lnTo>
                <a:lnTo>
                  <a:pt x="1672" y="1936"/>
                </a:lnTo>
                <a:lnTo>
                  <a:pt x="1680" y="1936"/>
                </a:lnTo>
                <a:lnTo>
                  <a:pt x="1688" y="1936"/>
                </a:lnTo>
                <a:lnTo>
                  <a:pt x="1696" y="1936"/>
                </a:lnTo>
                <a:lnTo>
                  <a:pt x="1704" y="1936"/>
                </a:lnTo>
                <a:lnTo>
                  <a:pt x="1712" y="1936"/>
                </a:lnTo>
                <a:lnTo>
                  <a:pt x="1720" y="1936"/>
                </a:lnTo>
                <a:lnTo>
                  <a:pt x="1728" y="1936"/>
                </a:lnTo>
                <a:lnTo>
                  <a:pt x="1736" y="1936"/>
                </a:lnTo>
                <a:lnTo>
                  <a:pt x="1744" y="1936"/>
                </a:lnTo>
                <a:lnTo>
                  <a:pt x="1752" y="1936"/>
                </a:lnTo>
                <a:lnTo>
                  <a:pt x="1760" y="1936"/>
                </a:lnTo>
                <a:lnTo>
                  <a:pt x="1768" y="1936"/>
                </a:lnTo>
                <a:lnTo>
                  <a:pt x="1776" y="1936"/>
                </a:lnTo>
                <a:lnTo>
                  <a:pt x="1784" y="1936"/>
                </a:lnTo>
                <a:lnTo>
                  <a:pt x="1792" y="1936"/>
                </a:lnTo>
                <a:lnTo>
                  <a:pt x="1800" y="1936"/>
                </a:lnTo>
                <a:lnTo>
                  <a:pt x="1808" y="1936"/>
                </a:lnTo>
                <a:lnTo>
                  <a:pt x="1816" y="1936"/>
                </a:lnTo>
                <a:lnTo>
                  <a:pt x="1824" y="1936"/>
                </a:lnTo>
                <a:lnTo>
                  <a:pt x="1832" y="1936"/>
                </a:lnTo>
                <a:lnTo>
                  <a:pt x="1840" y="1936"/>
                </a:lnTo>
                <a:lnTo>
                  <a:pt x="1848" y="1936"/>
                </a:lnTo>
                <a:lnTo>
                  <a:pt x="1856" y="1936"/>
                </a:lnTo>
                <a:lnTo>
                  <a:pt x="1864" y="1936"/>
                </a:lnTo>
                <a:lnTo>
                  <a:pt x="1872" y="1936"/>
                </a:lnTo>
                <a:lnTo>
                  <a:pt x="1880" y="1936"/>
                </a:lnTo>
                <a:lnTo>
                  <a:pt x="1888" y="1936"/>
                </a:lnTo>
                <a:lnTo>
                  <a:pt x="1896" y="1936"/>
                </a:lnTo>
                <a:lnTo>
                  <a:pt x="1904" y="1936"/>
                </a:lnTo>
                <a:lnTo>
                  <a:pt x="1912" y="1936"/>
                </a:lnTo>
                <a:lnTo>
                  <a:pt x="1920" y="1936"/>
                </a:lnTo>
                <a:lnTo>
                  <a:pt x="1928" y="1936"/>
                </a:lnTo>
                <a:lnTo>
                  <a:pt x="1936" y="1936"/>
                </a:lnTo>
                <a:lnTo>
                  <a:pt x="1944" y="1936"/>
                </a:lnTo>
                <a:lnTo>
                  <a:pt x="1952" y="1936"/>
                </a:lnTo>
                <a:lnTo>
                  <a:pt x="1960" y="1936"/>
                </a:lnTo>
                <a:lnTo>
                  <a:pt x="1968" y="1936"/>
                </a:lnTo>
                <a:lnTo>
                  <a:pt x="1976" y="1936"/>
                </a:lnTo>
                <a:lnTo>
                  <a:pt x="1984" y="1936"/>
                </a:lnTo>
                <a:lnTo>
                  <a:pt x="1992" y="1936"/>
                </a:lnTo>
                <a:lnTo>
                  <a:pt x="2000" y="1936"/>
                </a:lnTo>
                <a:lnTo>
                  <a:pt x="2008" y="1936"/>
                </a:lnTo>
                <a:lnTo>
                  <a:pt x="2016" y="1936"/>
                </a:lnTo>
                <a:lnTo>
                  <a:pt x="2024" y="1936"/>
                </a:lnTo>
                <a:lnTo>
                  <a:pt x="2032" y="1936"/>
                </a:lnTo>
              </a:path>
            </a:pathLst>
          </a:custGeom>
          <a:noFill/>
          <a:ln w="12600">
            <a:solidFill>
              <a:srgbClr val="0000ff"/>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72" name=""/>
          <p:cNvSpPr/>
          <p:nvPr/>
        </p:nvSpPr>
        <p:spPr>
          <a:xfrm>
            <a:off x="1096920" y="1378080"/>
            <a:ext cx="1430280" cy="1241280"/>
          </a:xfrm>
          <a:prstGeom prst="rect">
            <a:avLst/>
          </a:prstGeom>
          <a:solidFill>
            <a:srgbClr val="ffffff"/>
          </a:solidFill>
          <a:ln w="1260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273" name=""/>
          <p:cNvSpPr/>
          <p:nvPr/>
        </p:nvSpPr>
        <p:spPr>
          <a:xfrm>
            <a:off x="1096920" y="2614680"/>
            <a:ext cx="142560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274" name=""/>
          <p:cNvSpPr/>
          <p:nvPr/>
        </p:nvSpPr>
        <p:spPr>
          <a:xfrm>
            <a:off x="1096920" y="2619360"/>
            <a:ext cx="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sp>
        <p:nvSpPr>
          <p:cNvPr id="275" name=""/>
          <p:cNvSpPr/>
          <p:nvPr/>
        </p:nvSpPr>
        <p:spPr>
          <a:xfrm>
            <a:off x="1201680" y="261936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76" name=""/>
          <p:cNvSpPr/>
          <p:nvPr/>
        </p:nvSpPr>
        <p:spPr>
          <a:xfrm>
            <a:off x="1262160" y="261936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77" name=""/>
          <p:cNvSpPr/>
          <p:nvPr/>
        </p:nvSpPr>
        <p:spPr>
          <a:xfrm>
            <a:off x="1306440" y="261936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78" name=""/>
          <p:cNvSpPr/>
          <p:nvPr/>
        </p:nvSpPr>
        <p:spPr>
          <a:xfrm>
            <a:off x="1346040" y="2619360"/>
            <a:ext cx="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279" name=""/>
          <p:cNvSpPr/>
          <p:nvPr/>
        </p:nvSpPr>
        <p:spPr>
          <a:xfrm>
            <a:off x="1373040" y="261936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80" name=""/>
          <p:cNvSpPr/>
          <p:nvPr/>
        </p:nvSpPr>
        <p:spPr>
          <a:xfrm>
            <a:off x="1395360" y="261936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81" name=""/>
          <p:cNvSpPr/>
          <p:nvPr/>
        </p:nvSpPr>
        <p:spPr>
          <a:xfrm>
            <a:off x="1417680" y="261936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82" name=""/>
          <p:cNvSpPr/>
          <p:nvPr/>
        </p:nvSpPr>
        <p:spPr>
          <a:xfrm>
            <a:off x="1433520" y="261936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83" name=""/>
          <p:cNvSpPr/>
          <p:nvPr/>
        </p:nvSpPr>
        <p:spPr>
          <a:xfrm>
            <a:off x="1450800" y="2619360"/>
            <a:ext cx="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sp>
        <p:nvSpPr>
          <p:cNvPr id="284" name=""/>
          <p:cNvSpPr/>
          <p:nvPr/>
        </p:nvSpPr>
        <p:spPr>
          <a:xfrm>
            <a:off x="1560600" y="261936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85" name=""/>
          <p:cNvSpPr/>
          <p:nvPr/>
        </p:nvSpPr>
        <p:spPr>
          <a:xfrm>
            <a:off x="1620720" y="261936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86" name=""/>
          <p:cNvSpPr/>
          <p:nvPr/>
        </p:nvSpPr>
        <p:spPr>
          <a:xfrm>
            <a:off x="1665360" y="261936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87" name=""/>
          <p:cNvSpPr/>
          <p:nvPr/>
        </p:nvSpPr>
        <p:spPr>
          <a:xfrm>
            <a:off x="1698480" y="2619360"/>
            <a:ext cx="180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288" name=""/>
          <p:cNvSpPr/>
          <p:nvPr/>
        </p:nvSpPr>
        <p:spPr>
          <a:xfrm>
            <a:off x="1731960" y="261936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89" name=""/>
          <p:cNvSpPr/>
          <p:nvPr/>
        </p:nvSpPr>
        <p:spPr>
          <a:xfrm>
            <a:off x="1754280" y="261936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90" name=""/>
          <p:cNvSpPr/>
          <p:nvPr/>
        </p:nvSpPr>
        <p:spPr>
          <a:xfrm>
            <a:off x="1776240" y="261936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91" name=""/>
          <p:cNvSpPr/>
          <p:nvPr/>
        </p:nvSpPr>
        <p:spPr>
          <a:xfrm>
            <a:off x="1792440" y="261936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92" name=""/>
          <p:cNvSpPr/>
          <p:nvPr/>
        </p:nvSpPr>
        <p:spPr>
          <a:xfrm>
            <a:off x="1809720" y="2619360"/>
            <a:ext cx="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sp>
        <p:nvSpPr>
          <p:cNvPr id="293" name=""/>
          <p:cNvSpPr/>
          <p:nvPr/>
        </p:nvSpPr>
        <p:spPr>
          <a:xfrm>
            <a:off x="1914480" y="261936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94" name=""/>
          <p:cNvSpPr/>
          <p:nvPr/>
        </p:nvSpPr>
        <p:spPr>
          <a:xfrm>
            <a:off x="1981080" y="261936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95" name=""/>
          <p:cNvSpPr/>
          <p:nvPr/>
        </p:nvSpPr>
        <p:spPr>
          <a:xfrm>
            <a:off x="2023920" y="261936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96" name=""/>
          <p:cNvSpPr/>
          <p:nvPr/>
        </p:nvSpPr>
        <p:spPr>
          <a:xfrm>
            <a:off x="2057400" y="2619360"/>
            <a:ext cx="144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297" name=""/>
          <p:cNvSpPr/>
          <p:nvPr/>
        </p:nvSpPr>
        <p:spPr>
          <a:xfrm>
            <a:off x="2085840" y="261936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98" name=""/>
          <p:cNvSpPr/>
          <p:nvPr/>
        </p:nvSpPr>
        <p:spPr>
          <a:xfrm>
            <a:off x="2112840" y="261936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299" name=""/>
          <p:cNvSpPr/>
          <p:nvPr/>
        </p:nvSpPr>
        <p:spPr>
          <a:xfrm>
            <a:off x="2130480" y="261936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300" name=""/>
          <p:cNvSpPr/>
          <p:nvPr/>
        </p:nvSpPr>
        <p:spPr>
          <a:xfrm>
            <a:off x="2151000" y="2619360"/>
            <a:ext cx="180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301" name=""/>
          <p:cNvSpPr/>
          <p:nvPr/>
        </p:nvSpPr>
        <p:spPr>
          <a:xfrm>
            <a:off x="2168640" y="2619360"/>
            <a:ext cx="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sp>
        <p:nvSpPr>
          <p:cNvPr id="302" name=""/>
          <p:cNvSpPr/>
          <p:nvPr/>
        </p:nvSpPr>
        <p:spPr>
          <a:xfrm>
            <a:off x="2273400" y="261936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303" name=""/>
          <p:cNvSpPr/>
          <p:nvPr/>
        </p:nvSpPr>
        <p:spPr>
          <a:xfrm>
            <a:off x="2340000" y="261936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304" name=""/>
          <p:cNvSpPr/>
          <p:nvPr/>
        </p:nvSpPr>
        <p:spPr>
          <a:xfrm>
            <a:off x="2384280" y="261936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305" name=""/>
          <p:cNvSpPr/>
          <p:nvPr/>
        </p:nvSpPr>
        <p:spPr>
          <a:xfrm>
            <a:off x="2416320" y="2619360"/>
            <a:ext cx="144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306" name=""/>
          <p:cNvSpPr/>
          <p:nvPr/>
        </p:nvSpPr>
        <p:spPr>
          <a:xfrm>
            <a:off x="2444760" y="261936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307" name=""/>
          <p:cNvSpPr/>
          <p:nvPr/>
        </p:nvSpPr>
        <p:spPr>
          <a:xfrm>
            <a:off x="2467080" y="261936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308" name=""/>
          <p:cNvSpPr/>
          <p:nvPr/>
        </p:nvSpPr>
        <p:spPr>
          <a:xfrm>
            <a:off x="2489040" y="2619360"/>
            <a:ext cx="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309" name=""/>
          <p:cNvSpPr/>
          <p:nvPr/>
        </p:nvSpPr>
        <p:spPr>
          <a:xfrm>
            <a:off x="2505240" y="2619360"/>
            <a:ext cx="1440" cy="9720"/>
          </a:xfrm>
          <a:prstGeom prst="line">
            <a:avLst/>
          </a:prstGeom>
          <a:ln w="12600">
            <a:solidFill>
              <a:srgbClr val="000000"/>
            </a:solidFill>
            <a:miter/>
          </a:ln>
        </p:spPr>
        <p:style>
          <a:lnRef idx="0"/>
          <a:fillRef idx="0"/>
          <a:effectRef idx="0"/>
          <a:fontRef idx="minor"/>
        </p:style>
        <p:txBody>
          <a:bodyPr lIns="90000" rIns="90000" tIns="-37080" bIns="-37080" anchor="t">
            <a:noAutofit/>
          </a:bodyPr>
          <a:p>
            <a:endParaRPr b="0" lang="en-US" sz="2400" spc="-1" strike="noStrike">
              <a:solidFill>
                <a:srgbClr val="000000"/>
              </a:solidFill>
              <a:latin typeface="Arial"/>
            </a:endParaRPr>
          </a:p>
        </p:txBody>
      </p:sp>
      <p:sp>
        <p:nvSpPr>
          <p:cNvPr id="310" name=""/>
          <p:cNvSpPr/>
          <p:nvPr/>
        </p:nvSpPr>
        <p:spPr>
          <a:xfrm>
            <a:off x="2522520" y="2619360"/>
            <a:ext cx="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grpSp>
        <p:nvGrpSpPr>
          <p:cNvPr id="311" name=""/>
          <p:cNvGrpSpPr/>
          <p:nvPr/>
        </p:nvGrpSpPr>
        <p:grpSpPr>
          <a:xfrm>
            <a:off x="1042200" y="2635200"/>
            <a:ext cx="1607400" cy="188280"/>
            <a:chOff x="1042200" y="2635200"/>
            <a:chExt cx="1607400" cy="188280"/>
          </a:xfrm>
        </p:grpSpPr>
        <p:sp>
          <p:nvSpPr>
            <p:cNvPr id="312" name=""/>
            <p:cNvSpPr/>
            <p:nvPr/>
          </p:nvSpPr>
          <p:spPr>
            <a:xfrm>
              <a:off x="1042200" y="26859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313" name=""/>
            <p:cNvSpPr/>
            <p:nvPr/>
          </p:nvSpPr>
          <p:spPr>
            <a:xfrm>
              <a:off x="1165320" y="263520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a:t>
              </a:r>
              <a:endParaRPr b="0" lang="en-US" sz="800" spc="-1" strike="noStrike">
                <a:solidFill>
                  <a:srgbClr val="000000"/>
                </a:solidFill>
                <a:latin typeface="Arial"/>
              </a:endParaRPr>
            </a:p>
          </p:txBody>
        </p:sp>
        <p:sp>
          <p:nvSpPr>
            <p:cNvPr id="314" name=""/>
            <p:cNvSpPr/>
            <p:nvPr/>
          </p:nvSpPr>
          <p:spPr>
            <a:xfrm>
              <a:off x="1396080" y="26859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315" name=""/>
            <p:cNvSpPr/>
            <p:nvPr/>
          </p:nvSpPr>
          <p:spPr>
            <a:xfrm>
              <a:off x="1512720" y="264780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a:t>
              </a:r>
              <a:endParaRPr b="0" lang="en-US" sz="800" spc="-1" strike="noStrike">
                <a:solidFill>
                  <a:srgbClr val="000000"/>
                </a:solidFill>
                <a:latin typeface="Arial"/>
              </a:endParaRPr>
            </a:p>
          </p:txBody>
        </p:sp>
        <p:sp>
          <p:nvSpPr>
            <p:cNvPr id="316" name=""/>
            <p:cNvSpPr/>
            <p:nvPr/>
          </p:nvSpPr>
          <p:spPr>
            <a:xfrm>
              <a:off x="1753560" y="26859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317" name=""/>
            <p:cNvSpPr/>
            <p:nvPr/>
          </p:nvSpPr>
          <p:spPr>
            <a:xfrm>
              <a:off x="1890720" y="265752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a:t>
              </a:r>
              <a:endParaRPr b="0" lang="en-US" sz="800" spc="-1" strike="noStrike">
                <a:solidFill>
                  <a:srgbClr val="000000"/>
                </a:solidFill>
                <a:latin typeface="Arial"/>
              </a:endParaRPr>
            </a:p>
          </p:txBody>
        </p:sp>
        <p:sp>
          <p:nvSpPr>
            <p:cNvPr id="318" name=""/>
            <p:cNvSpPr/>
            <p:nvPr/>
          </p:nvSpPr>
          <p:spPr>
            <a:xfrm>
              <a:off x="2115360" y="26859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319" name=""/>
            <p:cNvSpPr/>
            <p:nvPr/>
          </p:nvSpPr>
          <p:spPr>
            <a:xfrm>
              <a:off x="2241720" y="265752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3</a:t>
              </a:r>
              <a:endParaRPr b="0" lang="en-US" sz="800" spc="-1" strike="noStrike">
                <a:solidFill>
                  <a:srgbClr val="000000"/>
                </a:solidFill>
                <a:latin typeface="Arial"/>
              </a:endParaRPr>
            </a:p>
          </p:txBody>
        </p:sp>
        <p:sp>
          <p:nvSpPr>
            <p:cNvPr id="320" name=""/>
            <p:cNvSpPr/>
            <p:nvPr/>
          </p:nvSpPr>
          <p:spPr>
            <a:xfrm>
              <a:off x="2467800" y="26859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321" name=""/>
            <p:cNvSpPr/>
            <p:nvPr/>
          </p:nvSpPr>
          <p:spPr>
            <a:xfrm>
              <a:off x="2592360" y="265428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4</a:t>
              </a:r>
              <a:endParaRPr b="0" lang="en-US" sz="800" spc="-1" strike="noStrike">
                <a:solidFill>
                  <a:srgbClr val="000000"/>
                </a:solidFill>
                <a:latin typeface="Arial"/>
              </a:endParaRPr>
            </a:p>
          </p:txBody>
        </p:sp>
      </p:grpSp>
      <p:sp>
        <p:nvSpPr>
          <p:cNvPr id="322" name=""/>
          <p:cNvSpPr/>
          <p:nvPr/>
        </p:nvSpPr>
        <p:spPr>
          <a:xfrm flipV="1">
            <a:off x="1096920" y="1377720"/>
            <a:ext cx="0" cy="123660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23" name=""/>
          <p:cNvSpPr/>
          <p:nvPr/>
        </p:nvSpPr>
        <p:spPr>
          <a:xfrm>
            <a:off x="978840" y="2589120"/>
            <a:ext cx="648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0</a:t>
            </a:r>
            <a:endParaRPr b="0" lang="en-US" sz="900" spc="-1" strike="noStrike">
              <a:solidFill>
                <a:srgbClr val="000000"/>
              </a:solidFill>
              <a:latin typeface="Arial"/>
            </a:endParaRPr>
          </a:p>
        </p:txBody>
      </p:sp>
      <p:sp>
        <p:nvSpPr>
          <p:cNvPr id="324" name=""/>
          <p:cNvSpPr/>
          <p:nvPr/>
        </p:nvSpPr>
        <p:spPr>
          <a:xfrm>
            <a:off x="898920" y="218448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0</a:t>
            </a:r>
            <a:endParaRPr b="0" lang="en-US" sz="900" spc="-1" strike="noStrike">
              <a:solidFill>
                <a:srgbClr val="000000"/>
              </a:solidFill>
              <a:latin typeface="Arial"/>
            </a:endParaRPr>
          </a:p>
        </p:txBody>
      </p:sp>
      <p:sp>
        <p:nvSpPr>
          <p:cNvPr id="325" name=""/>
          <p:cNvSpPr/>
          <p:nvPr/>
        </p:nvSpPr>
        <p:spPr>
          <a:xfrm>
            <a:off x="898920" y="177948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200</a:t>
            </a:r>
            <a:endParaRPr b="0" lang="en-US" sz="900" spc="-1" strike="noStrike">
              <a:solidFill>
                <a:srgbClr val="000000"/>
              </a:solidFill>
              <a:latin typeface="Arial"/>
            </a:endParaRPr>
          </a:p>
        </p:txBody>
      </p:sp>
      <p:sp>
        <p:nvSpPr>
          <p:cNvPr id="326" name=""/>
          <p:cNvSpPr/>
          <p:nvPr/>
        </p:nvSpPr>
        <p:spPr>
          <a:xfrm>
            <a:off x="898920" y="137160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300</a:t>
            </a:r>
            <a:endParaRPr b="0" lang="en-US" sz="900" spc="-1" strike="noStrike">
              <a:solidFill>
                <a:srgbClr val="000000"/>
              </a:solidFill>
              <a:latin typeface="Arial"/>
            </a:endParaRPr>
          </a:p>
        </p:txBody>
      </p:sp>
      <p:sp>
        <p:nvSpPr>
          <p:cNvPr id="327" name=""/>
          <p:cNvSpPr/>
          <p:nvPr/>
        </p:nvSpPr>
        <p:spPr>
          <a:xfrm flipH="1">
            <a:off x="1063800" y="2614680"/>
            <a:ext cx="331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28" name=""/>
          <p:cNvSpPr/>
          <p:nvPr/>
        </p:nvSpPr>
        <p:spPr>
          <a:xfrm flipH="1">
            <a:off x="1085400" y="2513160"/>
            <a:ext cx="111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329" name=""/>
          <p:cNvSpPr/>
          <p:nvPr/>
        </p:nvSpPr>
        <p:spPr>
          <a:xfrm flipH="1">
            <a:off x="1085400" y="241308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30" name=""/>
          <p:cNvSpPr/>
          <p:nvPr/>
        </p:nvSpPr>
        <p:spPr>
          <a:xfrm flipH="1">
            <a:off x="1085400" y="2311560"/>
            <a:ext cx="111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331" name=""/>
          <p:cNvSpPr/>
          <p:nvPr/>
        </p:nvSpPr>
        <p:spPr>
          <a:xfrm flipH="1">
            <a:off x="1063800" y="2211480"/>
            <a:ext cx="331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32" name=""/>
          <p:cNvSpPr/>
          <p:nvPr/>
        </p:nvSpPr>
        <p:spPr>
          <a:xfrm flipH="1">
            <a:off x="1085400" y="211140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33" name=""/>
          <p:cNvSpPr/>
          <p:nvPr/>
        </p:nvSpPr>
        <p:spPr>
          <a:xfrm flipH="1">
            <a:off x="1085400" y="2004840"/>
            <a:ext cx="111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334" name=""/>
          <p:cNvSpPr/>
          <p:nvPr/>
        </p:nvSpPr>
        <p:spPr>
          <a:xfrm flipH="1">
            <a:off x="1085400" y="190512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35" name=""/>
          <p:cNvSpPr/>
          <p:nvPr/>
        </p:nvSpPr>
        <p:spPr>
          <a:xfrm flipH="1">
            <a:off x="1063800" y="1805040"/>
            <a:ext cx="331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36" name=""/>
          <p:cNvSpPr/>
          <p:nvPr/>
        </p:nvSpPr>
        <p:spPr>
          <a:xfrm flipH="1">
            <a:off x="1085400" y="1703520"/>
            <a:ext cx="111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337" name=""/>
          <p:cNvSpPr/>
          <p:nvPr/>
        </p:nvSpPr>
        <p:spPr>
          <a:xfrm flipH="1">
            <a:off x="1085400" y="1603440"/>
            <a:ext cx="11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38" name=""/>
          <p:cNvSpPr/>
          <p:nvPr/>
        </p:nvSpPr>
        <p:spPr>
          <a:xfrm flipH="1">
            <a:off x="1085400" y="1496880"/>
            <a:ext cx="111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339" name=""/>
          <p:cNvSpPr/>
          <p:nvPr/>
        </p:nvSpPr>
        <p:spPr>
          <a:xfrm flipH="1">
            <a:off x="1063800" y="1397160"/>
            <a:ext cx="331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40" name=""/>
          <p:cNvSpPr/>
          <p:nvPr/>
        </p:nvSpPr>
        <p:spPr>
          <a:xfrm>
            <a:off x="1108080" y="1446120"/>
            <a:ext cx="1403280" cy="1163880"/>
          </a:xfrm>
          <a:custGeom>
            <a:avLst/>
            <a:gdLst/>
            <a:ahLst/>
            <a:rect l="l" t="t" r="r" b="b"/>
            <a:pathLst>
              <a:path w="2032" h="1944">
                <a:moveTo>
                  <a:pt x="0" y="1944"/>
                </a:moveTo>
                <a:lnTo>
                  <a:pt x="0" y="1920"/>
                </a:lnTo>
                <a:lnTo>
                  <a:pt x="0" y="1944"/>
                </a:lnTo>
                <a:lnTo>
                  <a:pt x="8" y="1936"/>
                </a:lnTo>
                <a:lnTo>
                  <a:pt x="16" y="1944"/>
                </a:lnTo>
                <a:lnTo>
                  <a:pt x="24" y="1944"/>
                </a:lnTo>
                <a:lnTo>
                  <a:pt x="32" y="1944"/>
                </a:lnTo>
                <a:lnTo>
                  <a:pt x="40" y="1920"/>
                </a:lnTo>
                <a:lnTo>
                  <a:pt x="48" y="1936"/>
                </a:lnTo>
                <a:lnTo>
                  <a:pt x="56" y="1944"/>
                </a:lnTo>
                <a:lnTo>
                  <a:pt x="64" y="1928"/>
                </a:lnTo>
                <a:lnTo>
                  <a:pt x="72" y="1904"/>
                </a:lnTo>
                <a:lnTo>
                  <a:pt x="80" y="1920"/>
                </a:lnTo>
                <a:lnTo>
                  <a:pt x="88" y="1904"/>
                </a:lnTo>
                <a:lnTo>
                  <a:pt x="96" y="1904"/>
                </a:lnTo>
                <a:lnTo>
                  <a:pt x="104" y="1904"/>
                </a:lnTo>
                <a:lnTo>
                  <a:pt x="112" y="1904"/>
                </a:lnTo>
                <a:lnTo>
                  <a:pt x="120" y="1832"/>
                </a:lnTo>
                <a:lnTo>
                  <a:pt x="128" y="1880"/>
                </a:lnTo>
                <a:lnTo>
                  <a:pt x="136" y="1848"/>
                </a:lnTo>
                <a:lnTo>
                  <a:pt x="144" y="1760"/>
                </a:lnTo>
                <a:lnTo>
                  <a:pt x="152" y="1856"/>
                </a:lnTo>
                <a:lnTo>
                  <a:pt x="160" y="1832"/>
                </a:lnTo>
                <a:lnTo>
                  <a:pt x="168" y="1792"/>
                </a:lnTo>
                <a:lnTo>
                  <a:pt x="176" y="1864"/>
                </a:lnTo>
                <a:lnTo>
                  <a:pt x="184" y="1784"/>
                </a:lnTo>
                <a:lnTo>
                  <a:pt x="192" y="1832"/>
                </a:lnTo>
                <a:lnTo>
                  <a:pt x="200" y="1776"/>
                </a:lnTo>
                <a:lnTo>
                  <a:pt x="208" y="1744"/>
                </a:lnTo>
                <a:lnTo>
                  <a:pt x="216" y="1744"/>
                </a:lnTo>
                <a:lnTo>
                  <a:pt x="224" y="1736"/>
                </a:lnTo>
                <a:lnTo>
                  <a:pt x="232" y="1760"/>
                </a:lnTo>
                <a:lnTo>
                  <a:pt x="240" y="1712"/>
                </a:lnTo>
                <a:lnTo>
                  <a:pt x="248" y="1768"/>
                </a:lnTo>
                <a:lnTo>
                  <a:pt x="256" y="1656"/>
                </a:lnTo>
                <a:lnTo>
                  <a:pt x="264" y="1664"/>
                </a:lnTo>
                <a:lnTo>
                  <a:pt x="272" y="1664"/>
                </a:lnTo>
                <a:lnTo>
                  <a:pt x="280" y="1648"/>
                </a:lnTo>
                <a:lnTo>
                  <a:pt x="288" y="1624"/>
                </a:lnTo>
                <a:lnTo>
                  <a:pt x="296" y="1632"/>
                </a:lnTo>
                <a:lnTo>
                  <a:pt x="304" y="1536"/>
                </a:lnTo>
                <a:lnTo>
                  <a:pt x="312" y="1512"/>
                </a:lnTo>
                <a:lnTo>
                  <a:pt x="320" y="1520"/>
                </a:lnTo>
                <a:lnTo>
                  <a:pt x="328" y="1456"/>
                </a:lnTo>
                <a:lnTo>
                  <a:pt x="336" y="1328"/>
                </a:lnTo>
                <a:lnTo>
                  <a:pt x="344" y="1400"/>
                </a:lnTo>
                <a:lnTo>
                  <a:pt x="352" y="1312"/>
                </a:lnTo>
                <a:lnTo>
                  <a:pt x="360" y="1336"/>
                </a:lnTo>
                <a:lnTo>
                  <a:pt x="368" y="1336"/>
                </a:lnTo>
                <a:lnTo>
                  <a:pt x="376" y="1176"/>
                </a:lnTo>
                <a:lnTo>
                  <a:pt x="384" y="1128"/>
                </a:lnTo>
                <a:lnTo>
                  <a:pt x="392" y="1176"/>
                </a:lnTo>
                <a:lnTo>
                  <a:pt x="400" y="1088"/>
                </a:lnTo>
                <a:lnTo>
                  <a:pt x="408" y="1160"/>
                </a:lnTo>
                <a:lnTo>
                  <a:pt x="416" y="720"/>
                </a:lnTo>
                <a:lnTo>
                  <a:pt x="424" y="784"/>
                </a:lnTo>
                <a:lnTo>
                  <a:pt x="432" y="688"/>
                </a:lnTo>
                <a:lnTo>
                  <a:pt x="440" y="760"/>
                </a:lnTo>
                <a:lnTo>
                  <a:pt x="448" y="624"/>
                </a:lnTo>
                <a:lnTo>
                  <a:pt x="456" y="520"/>
                </a:lnTo>
                <a:lnTo>
                  <a:pt x="464" y="704"/>
                </a:lnTo>
                <a:lnTo>
                  <a:pt x="472" y="392"/>
                </a:lnTo>
                <a:lnTo>
                  <a:pt x="480" y="312"/>
                </a:lnTo>
                <a:lnTo>
                  <a:pt x="488" y="0"/>
                </a:lnTo>
                <a:lnTo>
                  <a:pt x="496" y="248"/>
                </a:lnTo>
                <a:lnTo>
                  <a:pt x="504" y="288"/>
                </a:lnTo>
                <a:lnTo>
                  <a:pt x="512" y="240"/>
                </a:lnTo>
                <a:lnTo>
                  <a:pt x="520" y="40"/>
                </a:lnTo>
                <a:lnTo>
                  <a:pt x="528" y="152"/>
                </a:lnTo>
                <a:lnTo>
                  <a:pt x="536" y="184"/>
                </a:lnTo>
                <a:lnTo>
                  <a:pt x="544" y="184"/>
                </a:lnTo>
                <a:lnTo>
                  <a:pt x="552" y="312"/>
                </a:lnTo>
                <a:lnTo>
                  <a:pt x="560" y="384"/>
                </a:lnTo>
                <a:lnTo>
                  <a:pt x="568" y="112"/>
                </a:lnTo>
                <a:lnTo>
                  <a:pt x="576" y="264"/>
                </a:lnTo>
                <a:lnTo>
                  <a:pt x="584" y="480"/>
                </a:lnTo>
                <a:lnTo>
                  <a:pt x="592" y="352"/>
                </a:lnTo>
                <a:lnTo>
                  <a:pt x="600" y="424"/>
                </a:lnTo>
                <a:lnTo>
                  <a:pt x="608" y="568"/>
                </a:lnTo>
                <a:lnTo>
                  <a:pt x="616" y="776"/>
                </a:lnTo>
                <a:lnTo>
                  <a:pt x="624" y="752"/>
                </a:lnTo>
                <a:lnTo>
                  <a:pt x="632" y="688"/>
                </a:lnTo>
                <a:lnTo>
                  <a:pt x="640" y="832"/>
                </a:lnTo>
                <a:lnTo>
                  <a:pt x="648" y="920"/>
                </a:lnTo>
                <a:lnTo>
                  <a:pt x="656" y="888"/>
                </a:lnTo>
                <a:lnTo>
                  <a:pt x="664" y="928"/>
                </a:lnTo>
                <a:lnTo>
                  <a:pt x="672" y="1256"/>
                </a:lnTo>
                <a:lnTo>
                  <a:pt x="680" y="1272"/>
                </a:lnTo>
                <a:lnTo>
                  <a:pt x="688" y="1280"/>
                </a:lnTo>
                <a:lnTo>
                  <a:pt x="696" y="1336"/>
                </a:lnTo>
                <a:lnTo>
                  <a:pt x="704" y="1464"/>
                </a:lnTo>
                <a:lnTo>
                  <a:pt x="712" y="1464"/>
                </a:lnTo>
                <a:lnTo>
                  <a:pt x="720" y="1456"/>
                </a:lnTo>
                <a:lnTo>
                  <a:pt x="728" y="1624"/>
                </a:lnTo>
                <a:lnTo>
                  <a:pt x="736" y="1656"/>
                </a:lnTo>
                <a:lnTo>
                  <a:pt x="744" y="1656"/>
                </a:lnTo>
                <a:lnTo>
                  <a:pt x="752" y="1720"/>
                </a:lnTo>
                <a:lnTo>
                  <a:pt x="760" y="1656"/>
                </a:lnTo>
                <a:lnTo>
                  <a:pt x="768" y="1784"/>
                </a:lnTo>
                <a:lnTo>
                  <a:pt x="776" y="1752"/>
                </a:lnTo>
                <a:lnTo>
                  <a:pt x="784" y="1808"/>
                </a:lnTo>
                <a:lnTo>
                  <a:pt x="792" y="1824"/>
                </a:lnTo>
                <a:lnTo>
                  <a:pt x="800" y="1800"/>
                </a:lnTo>
                <a:lnTo>
                  <a:pt x="808" y="1808"/>
                </a:lnTo>
                <a:lnTo>
                  <a:pt x="816" y="1848"/>
                </a:lnTo>
                <a:lnTo>
                  <a:pt x="824" y="1888"/>
                </a:lnTo>
                <a:lnTo>
                  <a:pt x="832" y="1888"/>
                </a:lnTo>
                <a:lnTo>
                  <a:pt x="840" y="1896"/>
                </a:lnTo>
                <a:lnTo>
                  <a:pt x="848" y="1920"/>
                </a:lnTo>
                <a:lnTo>
                  <a:pt x="856" y="1920"/>
                </a:lnTo>
                <a:lnTo>
                  <a:pt x="864" y="1904"/>
                </a:lnTo>
                <a:lnTo>
                  <a:pt x="872" y="1944"/>
                </a:lnTo>
                <a:lnTo>
                  <a:pt x="880" y="1920"/>
                </a:lnTo>
                <a:lnTo>
                  <a:pt x="888" y="1936"/>
                </a:lnTo>
                <a:lnTo>
                  <a:pt x="896" y="1936"/>
                </a:lnTo>
                <a:lnTo>
                  <a:pt x="904" y="1944"/>
                </a:lnTo>
                <a:lnTo>
                  <a:pt x="912" y="1944"/>
                </a:lnTo>
                <a:lnTo>
                  <a:pt x="920" y="1936"/>
                </a:lnTo>
                <a:lnTo>
                  <a:pt x="928" y="1944"/>
                </a:lnTo>
                <a:lnTo>
                  <a:pt x="936" y="1944"/>
                </a:lnTo>
                <a:lnTo>
                  <a:pt x="944" y="1944"/>
                </a:lnTo>
                <a:lnTo>
                  <a:pt x="952" y="1944"/>
                </a:lnTo>
                <a:lnTo>
                  <a:pt x="960" y="1944"/>
                </a:lnTo>
                <a:lnTo>
                  <a:pt x="968" y="1944"/>
                </a:lnTo>
                <a:lnTo>
                  <a:pt x="976" y="1944"/>
                </a:lnTo>
                <a:lnTo>
                  <a:pt x="984" y="1944"/>
                </a:lnTo>
                <a:lnTo>
                  <a:pt x="992" y="1944"/>
                </a:lnTo>
                <a:lnTo>
                  <a:pt x="1000" y="1944"/>
                </a:lnTo>
                <a:lnTo>
                  <a:pt x="1008" y="1944"/>
                </a:lnTo>
                <a:lnTo>
                  <a:pt x="1016" y="1944"/>
                </a:lnTo>
                <a:lnTo>
                  <a:pt x="1024" y="1944"/>
                </a:lnTo>
                <a:lnTo>
                  <a:pt x="1032" y="1944"/>
                </a:lnTo>
                <a:lnTo>
                  <a:pt x="1040" y="1944"/>
                </a:lnTo>
                <a:lnTo>
                  <a:pt x="1048" y="1944"/>
                </a:lnTo>
                <a:lnTo>
                  <a:pt x="1056" y="1944"/>
                </a:lnTo>
                <a:lnTo>
                  <a:pt x="1064" y="1944"/>
                </a:lnTo>
                <a:lnTo>
                  <a:pt x="1072" y="1944"/>
                </a:lnTo>
                <a:lnTo>
                  <a:pt x="1080" y="1944"/>
                </a:lnTo>
                <a:lnTo>
                  <a:pt x="1088" y="1944"/>
                </a:lnTo>
                <a:lnTo>
                  <a:pt x="1096" y="1944"/>
                </a:lnTo>
                <a:lnTo>
                  <a:pt x="1104" y="1944"/>
                </a:lnTo>
                <a:lnTo>
                  <a:pt x="1112" y="1944"/>
                </a:lnTo>
                <a:lnTo>
                  <a:pt x="1120" y="1944"/>
                </a:lnTo>
                <a:lnTo>
                  <a:pt x="1128" y="1944"/>
                </a:lnTo>
                <a:lnTo>
                  <a:pt x="1136" y="1944"/>
                </a:lnTo>
                <a:lnTo>
                  <a:pt x="1144" y="1944"/>
                </a:lnTo>
                <a:lnTo>
                  <a:pt x="1152" y="1944"/>
                </a:lnTo>
                <a:lnTo>
                  <a:pt x="1160" y="1944"/>
                </a:lnTo>
                <a:lnTo>
                  <a:pt x="1168" y="1944"/>
                </a:lnTo>
                <a:lnTo>
                  <a:pt x="1176" y="1944"/>
                </a:lnTo>
                <a:lnTo>
                  <a:pt x="1184" y="1944"/>
                </a:lnTo>
                <a:lnTo>
                  <a:pt x="1192" y="1944"/>
                </a:lnTo>
                <a:lnTo>
                  <a:pt x="1200" y="1944"/>
                </a:lnTo>
                <a:lnTo>
                  <a:pt x="1208" y="1944"/>
                </a:lnTo>
                <a:lnTo>
                  <a:pt x="1216" y="1944"/>
                </a:lnTo>
                <a:lnTo>
                  <a:pt x="1224" y="1944"/>
                </a:lnTo>
                <a:lnTo>
                  <a:pt x="1232" y="1944"/>
                </a:lnTo>
                <a:lnTo>
                  <a:pt x="1240" y="1944"/>
                </a:lnTo>
                <a:lnTo>
                  <a:pt x="1248" y="1944"/>
                </a:lnTo>
                <a:lnTo>
                  <a:pt x="1256" y="1944"/>
                </a:lnTo>
                <a:lnTo>
                  <a:pt x="1264" y="1944"/>
                </a:lnTo>
                <a:lnTo>
                  <a:pt x="1272" y="1944"/>
                </a:lnTo>
                <a:lnTo>
                  <a:pt x="1280" y="1944"/>
                </a:lnTo>
                <a:lnTo>
                  <a:pt x="1288" y="1944"/>
                </a:lnTo>
                <a:lnTo>
                  <a:pt x="1296" y="1944"/>
                </a:lnTo>
                <a:lnTo>
                  <a:pt x="1304" y="1944"/>
                </a:lnTo>
                <a:lnTo>
                  <a:pt x="1312" y="1944"/>
                </a:lnTo>
                <a:lnTo>
                  <a:pt x="1320" y="1944"/>
                </a:lnTo>
                <a:lnTo>
                  <a:pt x="1328" y="1944"/>
                </a:lnTo>
                <a:lnTo>
                  <a:pt x="1336" y="1944"/>
                </a:lnTo>
                <a:lnTo>
                  <a:pt x="1344" y="1944"/>
                </a:lnTo>
                <a:lnTo>
                  <a:pt x="1352" y="1944"/>
                </a:lnTo>
                <a:lnTo>
                  <a:pt x="1360" y="1944"/>
                </a:lnTo>
                <a:lnTo>
                  <a:pt x="1368" y="1944"/>
                </a:lnTo>
                <a:lnTo>
                  <a:pt x="1376" y="1944"/>
                </a:lnTo>
                <a:lnTo>
                  <a:pt x="1384" y="1944"/>
                </a:lnTo>
                <a:lnTo>
                  <a:pt x="1392" y="1944"/>
                </a:lnTo>
                <a:lnTo>
                  <a:pt x="1400" y="1944"/>
                </a:lnTo>
                <a:lnTo>
                  <a:pt x="1408" y="1944"/>
                </a:lnTo>
                <a:lnTo>
                  <a:pt x="1416" y="1944"/>
                </a:lnTo>
                <a:lnTo>
                  <a:pt x="1424" y="1944"/>
                </a:lnTo>
                <a:lnTo>
                  <a:pt x="1432" y="1944"/>
                </a:lnTo>
                <a:lnTo>
                  <a:pt x="1440" y="1944"/>
                </a:lnTo>
                <a:lnTo>
                  <a:pt x="1448" y="1944"/>
                </a:lnTo>
                <a:lnTo>
                  <a:pt x="1456" y="1944"/>
                </a:lnTo>
                <a:lnTo>
                  <a:pt x="1464" y="1944"/>
                </a:lnTo>
                <a:lnTo>
                  <a:pt x="1472" y="1944"/>
                </a:lnTo>
                <a:lnTo>
                  <a:pt x="1480" y="1944"/>
                </a:lnTo>
                <a:lnTo>
                  <a:pt x="1488" y="1944"/>
                </a:lnTo>
                <a:lnTo>
                  <a:pt x="1496" y="1944"/>
                </a:lnTo>
                <a:lnTo>
                  <a:pt x="1504" y="1944"/>
                </a:lnTo>
                <a:lnTo>
                  <a:pt x="1512" y="1944"/>
                </a:lnTo>
                <a:lnTo>
                  <a:pt x="1520" y="1944"/>
                </a:lnTo>
                <a:lnTo>
                  <a:pt x="1528" y="1944"/>
                </a:lnTo>
                <a:lnTo>
                  <a:pt x="1536" y="1944"/>
                </a:lnTo>
                <a:lnTo>
                  <a:pt x="1544" y="1944"/>
                </a:lnTo>
                <a:lnTo>
                  <a:pt x="1552" y="1944"/>
                </a:lnTo>
                <a:lnTo>
                  <a:pt x="1560" y="1944"/>
                </a:lnTo>
                <a:lnTo>
                  <a:pt x="1568" y="1944"/>
                </a:lnTo>
                <a:lnTo>
                  <a:pt x="1576" y="1944"/>
                </a:lnTo>
                <a:lnTo>
                  <a:pt x="1584" y="1944"/>
                </a:lnTo>
                <a:lnTo>
                  <a:pt x="1592" y="1944"/>
                </a:lnTo>
                <a:lnTo>
                  <a:pt x="1600" y="1944"/>
                </a:lnTo>
                <a:lnTo>
                  <a:pt x="1608" y="1944"/>
                </a:lnTo>
                <a:lnTo>
                  <a:pt x="1616" y="1944"/>
                </a:lnTo>
                <a:lnTo>
                  <a:pt x="1624" y="1944"/>
                </a:lnTo>
                <a:lnTo>
                  <a:pt x="1632" y="1944"/>
                </a:lnTo>
                <a:lnTo>
                  <a:pt x="1640" y="1944"/>
                </a:lnTo>
                <a:lnTo>
                  <a:pt x="1648" y="1944"/>
                </a:lnTo>
                <a:lnTo>
                  <a:pt x="1656" y="1944"/>
                </a:lnTo>
                <a:lnTo>
                  <a:pt x="1664" y="1944"/>
                </a:lnTo>
                <a:lnTo>
                  <a:pt x="1672" y="1944"/>
                </a:lnTo>
                <a:lnTo>
                  <a:pt x="1680" y="1944"/>
                </a:lnTo>
                <a:lnTo>
                  <a:pt x="1688" y="1944"/>
                </a:lnTo>
                <a:lnTo>
                  <a:pt x="1696" y="1944"/>
                </a:lnTo>
                <a:lnTo>
                  <a:pt x="1704" y="1944"/>
                </a:lnTo>
                <a:lnTo>
                  <a:pt x="1712" y="1944"/>
                </a:lnTo>
                <a:lnTo>
                  <a:pt x="1720" y="1944"/>
                </a:lnTo>
                <a:lnTo>
                  <a:pt x="1728" y="1944"/>
                </a:lnTo>
                <a:lnTo>
                  <a:pt x="1736" y="1944"/>
                </a:lnTo>
                <a:lnTo>
                  <a:pt x="1744" y="1944"/>
                </a:lnTo>
                <a:lnTo>
                  <a:pt x="1752" y="1944"/>
                </a:lnTo>
                <a:lnTo>
                  <a:pt x="1760" y="1944"/>
                </a:lnTo>
                <a:lnTo>
                  <a:pt x="1768" y="1944"/>
                </a:lnTo>
                <a:lnTo>
                  <a:pt x="1776" y="1944"/>
                </a:lnTo>
                <a:lnTo>
                  <a:pt x="1784" y="1944"/>
                </a:lnTo>
                <a:lnTo>
                  <a:pt x="1792" y="1944"/>
                </a:lnTo>
                <a:lnTo>
                  <a:pt x="1800" y="1944"/>
                </a:lnTo>
                <a:lnTo>
                  <a:pt x="1808" y="1944"/>
                </a:lnTo>
                <a:lnTo>
                  <a:pt x="1816" y="1944"/>
                </a:lnTo>
                <a:lnTo>
                  <a:pt x="1824" y="1944"/>
                </a:lnTo>
                <a:lnTo>
                  <a:pt x="1832" y="1944"/>
                </a:lnTo>
                <a:lnTo>
                  <a:pt x="1840" y="1944"/>
                </a:lnTo>
                <a:lnTo>
                  <a:pt x="1848" y="1944"/>
                </a:lnTo>
                <a:lnTo>
                  <a:pt x="1856" y="1944"/>
                </a:lnTo>
                <a:lnTo>
                  <a:pt x="1864" y="1944"/>
                </a:lnTo>
                <a:lnTo>
                  <a:pt x="1872" y="1944"/>
                </a:lnTo>
                <a:lnTo>
                  <a:pt x="1880" y="1944"/>
                </a:lnTo>
                <a:lnTo>
                  <a:pt x="1888" y="1944"/>
                </a:lnTo>
                <a:lnTo>
                  <a:pt x="1896" y="1944"/>
                </a:lnTo>
                <a:lnTo>
                  <a:pt x="1904" y="1944"/>
                </a:lnTo>
                <a:lnTo>
                  <a:pt x="1912" y="1944"/>
                </a:lnTo>
                <a:lnTo>
                  <a:pt x="1920" y="1944"/>
                </a:lnTo>
                <a:lnTo>
                  <a:pt x="1928" y="1944"/>
                </a:lnTo>
                <a:lnTo>
                  <a:pt x="1936" y="1944"/>
                </a:lnTo>
                <a:lnTo>
                  <a:pt x="1944" y="1944"/>
                </a:lnTo>
                <a:lnTo>
                  <a:pt x="1952" y="1944"/>
                </a:lnTo>
                <a:lnTo>
                  <a:pt x="1960" y="1944"/>
                </a:lnTo>
                <a:lnTo>
                  <a:pt x="1968" y="1944"/>
                </a:lnTo>
                <a:lnTo>
                  <a:pt x="1976" y="1944"/>
                </a:lnTo>
                <a:lnTo>
                  <a:pt x="1984" y="1944"/>
                </a:lnTo>
                <a:lnTo>
                  <a:pt x="1992" y="1944"/>
                </a:lnTo>
                <a:lnTo>
                  <a:pt x="2000" y="1944"/>
                </a:lnTo>
                <a:lnTo>
                  <a:pt x="2008" y="1944"/>
                </a:lnTo>
                <a:lnTo>
                  <a:pt x="2016" y="1944"/>
                </a:lnTo>
                <a:lnTo>
                  <a:pt x="2024" y="1944"/>
                </a:lnTo>
                <a:lnTo>
                  <a:pt x="2032" y="1944"/>
                </a:lnTo>
              </a:path>
            </a:pathLst>
          </a:custGeom>
          <a:noFill/>
          <a:ln w="1260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41" name=""/>
          <p:cNvSpPr/>
          <p:nvPr/>
        </p:nvSpPr>
        <p:spPr>
          <a:xfrm>
            <a:off x="1108080" y="1450800"/>
            <a:ext cx="1403280" cy="1159200"/>
          </a:xfrm>
          <a:custGeom>
            <a:avLst/>
            <a:gdLst/>
            <a:ahLst/>
            <a:rect l="l" t="t" r="r" b="b"/>
            <a:pathLst>
              <a:path w="2032" h="1936">
                <a:moveTo>
                  <a:pt x="0" y="1936"/>
                </a:moveTo>
                <a:lnTo>
                  <a:pt x="0" y="144"/>
                </a:lnTo>
                <a:lnTo>
                  <a:pt x="0" y="1560"/>
                </a:lnTo>
                <a:lnTo>
                  <a:pt x="8" y="1504"/>
                </a:lnTo>
                <a:lnTo>
                  <a:pt x="16" y="1464"/>
                </a:lnTo>
                <a:lnTo>
                  <a:pt x="24" y="1456"/>
                </a:lnTo>
                <a:lnTo>
                  <a:pt x="32" y="1296"/>
                </a:lnTo>
                <a:lnTo>
                  <a:pt x="40" y="1320"/>
                </a:lnTo>
                <a:lnTo>
                  <a:pt x="48" y="1248"/>
                </a:lnTo>
                <a:lnTo>
                  <a:pt x="56" y="1248"/>
                </a:lnTo>
                <a:lnTo>
                  <a:pt x="64" y="968"/>
                </a:lnTo>
                <a:lnTo>
                  <a:pt x="72" y="1000"/>
                </a:lnTo>
                <a:lnTo>
                  <a:pt x="80" y="984"/>
                </a:lnTo>
                <a:lnTo>
                  <a:pt x="88" y="1056"/>
                </a:lnTo>
                <a:lnTo>
                  <a:pt x="96" y="768"/>
                </a:lnTo>
                <a:lnTo>
                  <a:pt x="104" y="864"/>
                </a:lnTo>
                <a:lnTo>
                  <a:pt x="112" y="840"/>
                </a:lnTo>
                <a:lnTo>
                  <a:pt x="120" y="872"/>
                </a:lnTo>
                <a:lnTo>
                  <a:pt x="128" y="680"/>
                </a:lnTo>
                <a:lnTo>
                  <a:pt x="136" y="736"/>
                </a:lnTo>
                <a:lnTo>
                  <a:pt x="144" y="864"/>
                </a:lnTo>
                <a:lnTo>
                  <a:pt x="152" y="904"/>
                </a:lnTo>
                <a:lnTo>
                  <a:pt x="160" y="552"/>
                </a:lnTo>
                <a:lnTo>
                  <a:pt x="168" y="744"/>
                </a:lnTo>
                <a:lnTo>
                  <a:pt x="176" y="592"/>
                </a:lnTo>
                <a:lnTo>
                  <a:pt x="184" y="792"/>
                </a:lnTo>
                <a:lnTo>
                  <a:pt x="192" y="480"/>
                </a:lnTo>
                <a:lnTo>
                  <a:pt x="200" y="600"/>
                </a:lnTo>
                <a:lnTo>
                  <a:pt x="208" y="536"/>
                </a:lnTo>
                <a:lnTo>
                  <a:pt x="216" y="664"/>
                </a:lnTo>
                <a:lnTo>
                  <a:pt x="224" y="568"/>
                </a:lnTo>
                <a:lnTo>
                  <a:pt x="232" y="504"/>
                </a:lnTo>
                <a:lnTo>
                  <a:pt x="240" y="560"/>
                </a:lnTo>
                <a:lnTo>
                  <a:pt x="248" y="720"/>
                </a:lnTo>
                <a:lnTo>
                  <a:pt x="256" y="504"/>
                </a:lnTo>
                <a:lnTo>
                  <a:pt x="264" y="640"/>
                </a:lnTo>
                <a:lnTo>
                  <a:pt x="272" y="488"/>
                </a:lnTo>
                <a:lnTo>
                  <a:pt x="280" y="392"/>
                </a:lnTo>
                <a:lnTo>
                  <a:pt x="288" y="520"/>
                </a:lnTo>
                <a:lnTo>
                  <a:pt x="296" y="448"/>
                </a:lnTo>
                <a:lnTo>
                  <a:pt x="304" y="400"/>
                </a:lnTo>
                <a:lnTo>
                  <a:pt x="312" y="464"/>
                </a:lnTo>
                <a:lnTo>
                  <a:pt x="320" y="0"/>
                </a:lnTo>
                <a:lnTo>
                  <a:pt x="328" y="320"/>
                </a:lnTo>
                <a:lnTo>
                  <a:pt x="336" y="600"/>
                </a:lnTo>
                <a:lnTo>
                  <a:pt x="344" y="480"/>
                </a:lnTo>
                <a:lnTo>
                  <a:pt x="352" y="384"/>
                </a:lnTo>
                <a:lnTo>
                  <a:pt x="360" y="280"/>
                </a:lnTo>
                <a:lnTo>
                  <a:pt x="368" y="232"/>
                </a:lnTo>
                <a:lnTo>
                  <a:pt x="376" y="400"/>
                </a:lnTo>
                <a:lnTo>
                  <a:pt x="384" y="88"/>
                </a:lnTo>
                <a:lnTo>
                  <a:pt x="392" y="552"/>
                </a:lnTo>
                <a:lnTo>
                  <a:pt x="400" y="480"/>
                </a:lnTo>
                <a:lnTo>
                  <a:pt x="408" y="120"/>
                </a:lnTo>
                <a:lnTo>
                  <a:pt x="416" y="432"/>
                </a:lnTo>
                <a:lnTo>
                  <a:pt x="424" y="512"/>
                </a:lnTo>
                <a:lnTo>
                  <a:pt x="432" y="512"/>
                </a:lnTo>
                <a:lnTo>
                  <a:pt x="440" y="696"/>
                </a:lnTo>
                <a:lnTo>
                  <a:pt x="448" y="632"/>
                </a:lnTo>
                <a:lnTo>
                  <a:pt x="456" y="760"/>
                </a:lnTo>
                <a:lnTo>
                  <a:pt x="464" y="888"/>
                </a:lnTo>
                <a:lnTo>
                  <a:pt x="472" y="904"/>
                </a:lnTo>
                <a:lnTo>
                  <a:pt x="480" y="1024"/>
                </a:lnTo>
                <a:lnTo>
                  <a:pt x="488" y="904"/>
                </a:lnTo>
                <a:lnTo>
                  <a:pt x="496" y="1160"/>
                </a:lnTo>
                <a:lnTo>
                  <a:pt x="504" y="1080"/>
                </a:lnTo>
                <a:lnTo>
                  <a:pt x="512" y="1208"/>
                </a:lnTo>
                <a:lnTo>
                  <a:pt x="520" y="1296"/>
                </a:lnTo>
                <a:lnTo>
                  <a:pt x="528" y="1368"/>
                </a:lnTo>
                <a:lnTo>
                  <a:pt x="536" y="1440"/>
                </a:lnTo>
                <a:lnTo>
                  <a:pt x="544" y="1336"/>
                </a:lnTo>
                <a:lnTo>
                  <a:pt x="552" y="1480"/>
                </a:lnTo>
                <a:lnTo>
                  <a:pt x="560" y="1392"/>
                </a:lnTo>
                <a:lnTo>
                  <a:pt x="568" y="1480"/>
                </a:lnTo>
                <a:lnTo>
                  <a:pt x="576" y="1624"/>
                </a:lnTo>
                <a:lnTo>
                  <a:pt x="584" y="1560"/>
                </a:lnTo>
                <a:lnTo>
                  <a:pt x="592" y="1552"/>
                </a:lnTo>
                <a:lnTo>
                  <a:pt x="600" y="1672"/>
                </a:lnTo>
                <a:lnTo>
                  <a:pt x="608" y="1720"/>
                </a:lnTo>
                <a:lnTo>
                  <a:pt x="616" y="1760"/>
                </a:lnTo>
                <a:lnTo>
                  <a:pt x="624" y="1704"/>
                </a:lnTo>
                <a:lnTo>
                  <a:pt x="632" y="1792"/>
                </a:lnTo>
                <a:lnTo>
                  <a:pt x="640" y="1760"/>
                </a:lnTo>
                <a:lnTo>
                  <a:pt x="648" y="1808"/>
                </a:lnTo>
                <a:lnTo>
                  <a:pt x="656" y="1808"/>
                </a:lnTo>
                <a:lnTo>
                  <a:pt x="664" y="1752"/>
                </a:lnTo>
                <a:lnTo>
                  <a:pt x="672" y="1816"/>
                </a:lnTo>
                <a:lnTo>
                  <a:pt x="680" y="1824"/>
                </a:lnTo>
                <a:lnTo>
                  <a:pt x="688" y="1832"/>
                </a:lnTo>
                <a:lnTo>
                  <a:pt x="696" y="1808"/>
                </a:lnTo>
                <a:lnTo>
                  <a:pt x="704" y="1784"/>
                </a:lnTo>
                <a:lnTo>
                  <a:pt x="712" y="1848"/>
                </a:lnTo>
                <a:lnTo>
                  <a:pt x="720" y="1848"/>
                </a:lnTo>
                <a:lnTo>
                  <a:pt x="728" y="1912"/>
                </a:lnTo>
                <a:lnTo>
                  <a:pt x="736" y="1864"/>
                </a:lnTo>
                <a:lnTo>
                  <a:pt x="744" y="1920"/>
                </a:lnTo>
                <a:lnTo>
                  <a:pt x="752" y="1896"/>
                </a:lnTo>
                <a:lnTo>
                  <a:pt x="760" y="1904"/>
                </a:lnTo>
                <a:lnTo>
                  <a:pt x="768" y="1928"/>
                </a:lnTo>
                <a:lnTo>
                  <a:pt x="776" y="1904"/>
                </a:lnTo>
                <a:lnTo>
                  <a:pt x="784" y="1904"/>
                </a:lnTo>
                <a:lnTo>
                  <a:pt x="792" y="1864"/>
                </a:lnTo>
                <a:lnTo>
                  <a:pt x="800" y="1920"/>
                </a:lnTo>
                <a:lnTo>
                  <a:pt x="808" y="1920"/>
                </a:lnTo>
                <a:lnTo>
                  <a:pt x="816" y="1928"/>
                </a:lnTo>
                <a:lnTo>
                  <a:pt x="824" y="1920"/>
                </a:lnTo>
                <a:lnTo>
                  <a:pt x="832" y="1928"/>
                </a:lnTo>
                <a:lnTo>
                  <a:pt x="840" y="1936"/>
                </a:lnTo>
                <a:lnTo>
                  <a:pt x="848" y="1928"/>
                </a:lnTo>
                <a:lnTo>
                  <a:pt x="856" y="1928"/>
                </a:lnTo>
                <a:lnTo>
                  <a:pt x="864" y="1928"/>
                </a:lnTo>
                <a:lnTo>
                  <a:pt x="872" y="1928"/>
                </a:lnTo>
                <a:lnTo>
                  <a:pt x="880" y="1936"/>
                </a:lnTo>
                <a:lnTo>
                  <a:pt x="888" y="1936"/>
                </a:lnTo>
                <a:lnTo>
                  <a:pt x="896" y="1936"/>
                </a:lnTo>
                <a:lnTo>
                  <a:pt x="904" y="1936"/>
                </a:lnTo>
                <a:lnTo>
                  <a:pt x="912" y="1936"/>
                </a:lnTo>
                <a:lnTo>
                  <a:pt x="920" y="1936"/>
                </a:lnTo>
                <a:lnTo>
                  <a:pt x="928" y="1936"/>
                </a:lnTo>
                <a:lnTo>
                  <a:pt x="936" y="1936"/>
                </a:lnTo>
                <a:lnTo>
                  <a:pt x="944" y="1936"/>
                </a:lnTo>
                <a:lnTo>
                  <a:pt x="952" y="1936"/>
                </a:lnTo>
                <a:lnTo>
                  <a:pt x="960" y="1936"/>
                </a:lnTo>
                <a:lnTo>
                  <a:pt x="968" y="1936"/>
                </a:lnTo>
                <a:lnTo>
                  <a:pt x="976" y="1936"/>
                </a:lnTo>
                <a:lnTo>
                  <a:pt x="984" y="1936"/>
                </a:lnTo>
                <a:lnTo>
                  <a:pt x="992" y="1936"/>
                </a:lnTo>
                <a:lnTo>
                  <a:pt x="1000" y="1936"/>
                </a:lnTo>
                <a:lnTo>
                  <a:pt x="1008" y="1936"/>
                </a:lnTo>
                <a:lnTo>
                  <a:pt x="1016" y="1936"/>
                </a:lnTo>
                <a:lnTo>
                  <a:pt x="1024" y="1936"/>
                </a:lnTo>
                <a:lnTo>
                  <a:pt x="1032" y="1936"/>
                </a:lnTo>
                <a:lnTo>
                  <a:pt x="1040" y="1936"/>
                </a:lnTo>
                <a:lnTo>
                  <a:pt x="1048" y="1936"/>
                </a:lnTo>
                <a:lnTo>
                  <a:pt x="1056" y="1936"/>
                </a:lnTo>
                <a:lnTo>
                  <a:pt x="1064" y="1936"/>
                </a:lnTo>
                <a:lnTo>
                  <a:pt x="1072" y="1936"/>
                </a:lnTo>
                <a:lnTo>
                  <a:pt x="1080" y="1936"/>
                </a:lnTo>
                <a:lnTo>
                  <a:pt x="1088" y="1936"/>
                </a:lnTo>
                <a:lnTo>
                  <a:pt x="1096" y="1936"/>
                </a:lnTo>
                <a:lnTo>
                  <a:pt x="1104" y="1936"/>
                </a:lnTo>
                <a:lnTo>
                  <a:pt x="1112" y="1936"/>
                </a:lnTo>
                <a:lnTo>
                  <a:pt x="1120" y="1936"/>
                </a:lnTo>
                <a:lnTo>
                  <a:pt x="1128" y="1936"/>
                </a:lnTo>
                <a:lnTo>
                  <a:pt x="1136" y="1936"/>
                </a:lnTo>
                <a:lnTo>
                  <a:pt x="1144" y="1936"/>
                </a:lnTo>
                <a:lnTo>
                  <a:pt x="1152" y="1936"/>
                </a:lnTo>
                <a:lnTo>
                  <a:pt x="1160" y="1936"/>
                </a:lnTo>
                <a:lnTo>
                  <a:pt x="1168" y="1936"/>
                </a:lnTo>
                <a:lnTo>
                  <a:pt x="1176" y="1936"/>
                </a:lnTo>
                <a:lnTo>
                  <a:pt x="1184" y="1936"/>
                </a:lnTo>
                <a:lnTo>
                  <a:pt x="1192" y="1936"/>
                </a:lnTo>
                <a:lnTo>
                  <a:pt x="1200" y="1936"/>
                </a:lnTo>
                <a:lnTo>
                  <a:pt x="1208" y="1936"/>
                </a:lnTo>
                <a:lnTo>
                  <a:pt x="1216" y="1936"/>
                </a:lnTo>
                <a:lnTo>
                  <a:pt x="1224" y="1936"/>
                </a:lnTo>
                <a:lnTo>
                  <a:pt x="1232" y="1936"/>
                </a:lnTo>
                <a:lnTo>
                  <a:pt x="1240" y="1936"/>
                </a:lnTo>
                <a:lnTo>
                  <a:pt x="1248" y="1936"/>
                </a:lnTo>
                <a:lnTo>
                  <a:pt x="1256" y="1936"/>
                </a:lnTo>
                <a:lnTo>
                  <a:pt x="1264" y="1936"/>
                </a:lnTo>
                <a:lnTo>
                  <a:pt x="1272" y="1936"/>
                </a:lnTo>
                <a:lnTo>
                  <a:pt x="1280" y="1936"/>
                </a:lnTo>
                <a:lnTo>
                  <a:pt x="1288" y="1936"/>
                </a:lnTo>
                <a:lnTo>
                  <a:pt x="1296" y="1936"/>
                </a:lnTo>
                <a:lnTo>
                  <a:pt x="1304" y="1936"/>
                </a:lnTo>
                <a:lnTo>
                  <a:pt x="1312" y="1936"/>
                </a:lnTo>
                <a:lnTo>
                  <a:pt x="1320" y="1936"/>
                </a:lnTo>
                <a:lnTo>
                  <a:pt x="1328" y="1936"/>
                </a:lnTo>
                <a:lnTo>
                  <a:pt x="1336" y="1936"/>
                </a:lnTo>
                <a:lnTo>
                  <a:pt x="1344" y="1936"/>
                </a:lnTo>
                <a:lnTo>
                  <a:pt x="1352" y="1936"/>
                </a:lnTo>
                <a:lnTo>
                  <a:pt x="1360" y="1936"/>
                </a:lnTo>
                <a:lnTo>
                  <a:pt x="1368" y="1936"/>
                </a:lnTo>
                <a:lnTo>
                  <a:pt x="1376" y="1936"/>
                </a:lnTo>
                <a:lnTo>
                  <a:pt x="1384" y="1936"/>
                </a:lnTo>
                <a:lnTo>
                  <a:pt x="1392" y="1936"/>
                </a:lnTo>
                <a:lnTo>
                  <a:pt x="1400" y="1936"/>
                </a:lnTo>
                <a:lnTo>
                  <a:pt x="1408" y="1936"/>
                </a:lnTo>
                <a:lnTo>
                  <a:pt x="1416" y="1936"/>
                </a:lnTo>
                <a:lnTo>
                  <a:pt x="1424" y="1936"/>
                </a:lnTo>
                <a:lnTo>
                  <a:pt x="1432" y="1936"/>
                </a:lnTo>
                <a:lnTo>
                  <a:pt x="1440" y="1936"/>
                </a:lnTo>
                <a:lnTo>
                  <a:pt x="1448" y="1936"/>
                </a:lnTo>
                <a:lnTo>
                  <a:pt x="1456" y="1936"/>
                </a:lnTo>
                <a:lnTo>
                  <a:pt x="1464" y="1936"/>
                </a:lnTo>
                <a:lnTo>
                  <a:pt x="1472" y="1936"/>
                </a:lnTo>
                <a:lnTo>
                  <a:pt x="1480" y="1936"/>
                </a:lnTo>
                <a:lnTo>
                  <a:pt x="1488" y="1936"/>
                </a:lnTo>
                <a:lnTo>
                  <a:pt x="1496" y="1936"/>
                </a:lnTo>
                <a:lnTo>
                  <a:pt x="1504" y="1936"/>
                </a:lnTo>
                <a:lnTo>
                  <a:pt x="1512" y="1936"/>
                </a:lnTo>
                <a:lnTo>
                  <a:pt x="1520" y="1936"/>
                </a:lnTo>
                <a:lnTo>
                  <a:pt x="1528" y="1936"/>
                </a:lnTo>
                <a:lnTo>
                  <a:pt x="1536" y="1936"/>
                </a:lnTo>
                <a:lnTo>
                  <a:pt x="1544" y="1936"/>
                </a:lnTo>
                <a:lnTo>
                  <a:pt x="1552" y="1936"/>
                </a:lnTo>
                <a:lnTo>
                  <a:pt x="1560" y="1936"/>
                </a:lnTo>
                <a:lnTo>
                  <a:pt x="1568" y="1936"/>
                </a:lnTo>
                <a:lnTo>
                  <a:pt x="1576" y="1936"/>
                </a:lnTo>
                <a:lnTo>
                  <a:pt x="1584" y="1936"/>
                </a:lnTo>
                <a:lnTo>
                  <a:pt x="1592" y="1936"/>
                </a:lnTo>
                <a:lnTo>
                  <a:pt x="1600" y="1936"/>
                </a:lnTo>
                <a:lnTo>
                  <a:pt x="1608" y="1936"/>
                </a:lnTo>
                <a:lnTo>
                  <a:pt x="1616" y="1936"/>
                </a:lnTo>
                <a:lnTo>
                  <a:pt x="1624" y="1936"/>
                </a:lnTo>
                <a:lnTo>
                  <a:pt x="1632" y="1936"/>
                </a:lnTo>
                <a:lnTo>
                  <a:pt x="1640" y="1936"/>
                </a:lnTo>
                <a:lnTo>
                  <a:pt x="1648" y="1936"/>
                </a:lnTo>
                <a:lnTo>
                  <a:pt x="1656" y="1936"/>
                </a:lnTo>
                <a:lnTo>
                  <a:pt x="1664" y="1936"/>
                </a:lnTo>
                <a:lnTo>
                  <a:pt x="1672" y="1936"/>
                </a:lnTo>
                <a:lnTo>
                  <a:pt x="1680" y="1936"/>
                </a:lnTo>
                <a:lnTo>
                  <a:pt x="1688" y="1936"/>
                </a:lnTo>
                <a:lnTo>
                  <a:pt x="1696" y="1936"/>
                </a:lnTo>
                <a:lnTo>
                  <a:pt x="1704" y="1936"/>
                </a:lnTo>
                <a:lnTo>
                  <a:pt x="1712" y="1936"/>
                </a:lnTo>
                <a:lnTo>
                  <a:pt x="1720" y="1936"/>
                </a:lnTo>
                <a:lnTo>
                  <a:pt x="1728" y="1936"/>
                </a:lnTo>
                <a:lnTo>
                  <a:pt x="1736" y="1936"/>
                </a:lnTo>
                <a:lnTo>
                  <a:pt x="1744" y="1936"/>
                </a:lnTo>
                <a:lnTo>
                  <a:pt x="1752" y="1936"/>
                </a:lnTo>
                <a:lnTo>
                  <a:pt x="1760" y="1936"/>
                </a:lnTo>
                <a:lnTo>
                  <a:pt x="1768" y="1936"/>
                </a:lnTo>
                <a:lnTo>
                  <a:pt x="1776" y="1936"/>
                </a:lnTo>
                <a:lnTo>
                  <a:pt x="1784" y="1936"/>
                </a:lnTo>
                <a:lnTo>
                  <a:pt x="1792" y="1936"/>
                </a:lnTo>
                <a:lnTo>
                  <a:pt x="1800" y="1936"/>
                </a:lnTo>
                <a:lnTo>
                  <a:pt x="1808" y="1936"/>
                </a:lnTo>
                <a:lnTo>
                  <a:pt x="1816" y="1936"/>
                </a:lnTo>
                <a:lnTo>
                  <a:pt x="1824" y="1936"/>
                </a:lnTo>
                <a:lnTo>
                  <a:pt x="1832" y="1936"/>
                </a:lnTo>
                <a:lnTo>
                  <a:pt x="1840" y="1936"/>
                </a:lnTo>
                <a:lnTo>
                  <a:pt x="1848" y="1936"/>
                </a:lnTo>
                <a:lnTo>
                  <a:pt x="1856" y="1936"/>
                </a:lnTo>
                <a:lnTo>
                  <a:pt x="1864" y="1936"/>
                </a:lnTo>
                <a:lnTo>
                  <a:pt x="1872" y="1936"/>
                </a:lnTo>
                <a:lnTo>
                  <a:pt x="1880" y="1936"/>
                </a:lnTo>
                <a:lnTo>
                  <a:pt x="1888" y="1936"/>
                </a:lnTo>
                <a:lnTo>
                  <a:pt x="1896" y="1936"/>
                </a:lnTo>
                <a:lnTo>
                  <a:pt x="1904" y="1936"/>
                </a:lnTo>
                <a:lnTo>
                  <a:pt x="1912" y="1936"/>
                </a:lnTo>
                <a:lnTo>
                  <a:pt x="1920" y="1936"/>
                </a:lnTo>
                <a:lnTo>
                  <a:pt x="1928" y="1936"/>
                </a:lnTo>
                <a:lnTo>
                  <a:pt x="1936" y="1936"/>
                </a:lnTo>
                <a:lnTo>
                  <a:pt x="1944" y="1936"/>
                </a:lnTo>
                <a:lnTo>
                  <a:pt x="1952" y="1936"/>
                </a:lnTo>
                <a:lnTo>
                  <a:pt x="1960" y="1936"/>
                </a:lnTo>
                <a:lnTo>
                  <a:pt x="1968" y="1936"/>
                </a:lnTo>
                <a:lnTo>
                  <a:pt x="1976" y="1936"/>
                </a:lnTo>
                <a:lnTo>
                  <a:pt x="1984" y="1936"/>
                </a:lnTo>
                <a:lnTo>
                  <a:pt x="1992" y="1936"/>
                </a:lnTo>
                <a:lnTo>
                  <a:pt x="2000" y="1936"/>
                </a:lnTo>
                <a:lnTo>
                  <a:pt x="2008" y="1936"/>
                </a:lnTo>
                <a:lnTo>
                  <a:pt x="2016" y="1936"/>
                </a:lnTo>
                <a:lnTo>
                  <a:pt x="2024" y="1936"/>
                </a:lnTo>
                <a:lnTo>
                  <a:pt x="2032" y="1936"/>
                </a:lnTo>
              </a:path>
            </a:pathLst>
          </a:custGeom>
          <a:noFill/>
          <a:ln w="12600">
            <a:solidFill>
              <a:srgbClr val="0000ff"/>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42" name=""/>
          <p:cNvSpPr/>
          <p:nvPr/>
        </p:nvSpPr>
        <p:spPr>
          <a:xfrm rot="16200000">
            <a:off x="657360" y="1985400"/>
            <a:ext cx="352800" cy="13752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 Cells</a:t>
            </a:r>
            <a:endParaRPr b="0" lang="en-US" sz="900" spc="-1" strike="noStrike">
              <a:solidFill>
                <a:srgbClr val="000000"/>
              </a:solidFill>
              <a:latin typeface="Arial"/>
            </a:endParaRPr>
          </a:p>
        </p:txBody>
      </p:sp>
      <p:grpSp>
        <p:nvGrpSpPr>
          <p:cNvPr id="343" name=""/>
          <p:cNvGrpSpPr/>
          <p:nvPr/>
        </p:nvGrpSpPr>
        <p:grpSpPr>
          <a:xfrm>
            <a:off x="2818440" y="2629080"/>
            <a:ext cx="1607400" cy="188280"/>
            <a:chOff x="2818440" y="2629080"/>
            <a:chExt cx="1607400" cy="188280"/>
          </a:xfrm>
        </p:grpSpPr>
        <p:sp>
          <p:nvSpPr>
            <p:cNvPr id="344" name=""/>
            <p:cNvSpPr/>
            <p:nvPr/>
          </p:nvSpPr>
          <p:spPr>
            <a:xfrm>
              <a:off x="2818440" y="26798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345" name=""/>
            <p:cNvSpPr/>
            <p:nvPr/>
          </p:nvSpPr>
          <p:spPr>
            <a:xfrm>
              <a:off x="2941200" y="262908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a:t>
              </a:r>
              <a:endParaRPr b="0" lang="en-US" sz="800" spc="-1" strike="noStrike">
                <a:solidFill>
                  <a:srgbClr val="000000"/>
                </a:solidFill>
                <a:latin typeface="Arial"/>
              </a:endParaRPr>
            </a:p>
          </p:txBody>
        </p:sp>
        <p:sp>
          <p:nvSpPr>
            <p:cNvPr id="346" name=""/>
            <p:cNvSpPr/>
            <p:nvPr/>
          </p:nvSpPr>
          <p:spPr>
            <a:xfrm>
              <a:off x="3172320" y="26798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347" name=""/>
            <p:cNvSpPr/>
            <p:nvPr/>
          </p:nvSpPr>
          <p:spPr>
            <a:xfrm>
              <a:off x="3288960" y="264168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a:t>
              </a:r>
              <a:endParaRPr b="0" lang="en-US" sz="800" spc="-1" strike="noStrike">
                <a:solidFill>
                  <a:srgbClr val="000000"/>
                </a:solidFill>
                <a:latin typeface="Arial"/>
              </a:endParaRPr>
            </a:p>
          </p:txBody>
        </p:sp>
        <p:sp>
          <p:nvSpPr>
            <p:cNvPr id="348" name=""/>
            <p:cNvSpPr/>
            <p:nvPr/>
          </p:nvSpPr>
          <p:spPr>
            <a:xfrm>
              <a:off x="3529440" y="26798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349" name=""/>
            <p:cNvSpPr/>
            <p:nvPr/>
          </p:nvSpPr>
          <p:spPr>
            <a:xfrm>
              <a:off x="3666960" y="265140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a:t>
              </a:r>
              <a:endParaRPr b="0" lang="en-US" sz="800" spc="-1" strike="noStrike">
                <a:solidFill>
                  <a:srgbClr val="000000"/>
                </a:solidFill>
                <a:latin typeface="Arial"/>
              </a:endParaRPr>
            </a:p>
          </p:txBody>
        </p:sp>
        <p:sp>
          <p:nvSpPr>
            <p:cNvPr id="350" name=""/>
            <p:cNvSpPr/>
            <p:nvPr/>
          </p:nvSpPr>
          <p:spPr>
            <a:xfrm>
              <a:off x="3891240" y="26798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351" name=""/>
            <p:cNvSpPr/>
            <p:nvPr/>
          </p:nvSpPr>
          <p:spPr>
            <a:xfrm>
              <a:off x="4017600" y="265140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3</a:t>
              </a:r>
              <a:endParaRPr b="0" lang="en-US" sz="800" spc="-1" strike="noStrike">
                <a:solidFill>
                  <a:srgbClr val="000000"/>
                </a:solidFill>
                <a:latin typeface="Arial"/>
              </a:endParaRPr>
            </a:p>
          </p:txBody>
        </p:sp>
        <p:sp>
          <p:nvSpPr>
            <p:cNvPr id="352" name=""/>
            <p:cNvSpPr/>
            <p:nvPr/>
          </p:nvSpPr>
          <p:spPr>
            <a:xfrm>
              <a:off x="4243680" y="267984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353" name=""/>
            <p:cNvSpPr/>
            <p:nvPr/>
          </p:nvSpPr>
          <p:spPr>
            <a:xfrm>
              <a:off x="4368600" y="264816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4</a:t>
              </a:r>
              <a:endParaRPr b="0" lang="en-US" sz="800" spc="-1" strike="noStrike">
                <a:solidFill>
                  <a:srgbClr val="000000"/>
                </a:solidFill>
                <a:latin typeface="Arial"/>
              </a:endParaRPr>
            </a:p>
          </p:txBody>
        </p:sp>
      </p:grpSp>
      <p:grpSp>
        <p:nvGrpSpPr>
          <p:cNvPr id="354" name=""/>
          <p:cNvGrpSpPr/>
          <p:nvPr/>
        </p:nvGrpSpPr>
        <p:grpSpPr>
          <a:xfrm>
            <a:off x="1018440" y="4181400"/>
            <a:ext cx="1607400" cy="188280"/>
            <a:chOff x="1018440" y="4181400"/>
            <a:chExt cx="1607400" cy="188280"/>
          </a:xfrm>
        </p:grpSpPr>
        <p:sp>
          <p:nvSpPr>
            <p:cNvPr id="355" name=""/>
            <p:cNvSpPr/>
            <p:nvPr/>
          </p:nvSpPr>
          <p:spPr>
            <a:xfrm>
              <a:off x="1018440" y="42321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356" name=""/>
            <p:cNvSpPr/>
            <p:nvPr/>
          </p:nvSpPr>
          <p:spPr>
            <a:xfrm>
              <a:off x="1141560" y="418140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a:t>
              </a:r>
              <a:endParaRPr b="0" lang="en-US" sz="800" spc="-1" strike="noStrike">
                <a:solidFill>
                  <a:srgbClr val="000000"/>
                </a:solidFill>
                <a:latin typeface="Arial"/>
              </a:endParaRPr>
            </a:p>
          </p:txBody>
        </p:sp>
        <p:sp>
          <p:nvSpPr>
            <p:cNvPr id="357" name=""/>
            <p:cNvSpPr/>
            <p:nvPr/>
          </p:nvSpPr>
          <p:spPr>
            <a:xfrm>
              <a:off x="1372320" y="42321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358" name=""/>
            <p:cNvSpPr/>
            <p:nvPr/>
          </p:nvSpPr>
          <p:spPr>
            <a:xfrm>
              <a:off x="1488960" y="419400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a:t>
              </a:r>
              <a:endParaRPr b="0" lang="en-US" sz="800" spc="-1" strike="noStrike">
                <a:solidFill>
                  <a:srgbClr val="000000"/>
                </a:solidFill>
                <a:latin typeface="Arial"/>
              </a:endParaRPr>
            </a:p>
          </p:txBody>
        </p:sp>
        <p:sp>
          <p:nvSpPr>
            <p:cNvPr id="359" name=""/>
            <p:cNvSpPr/>
            <p:nvPr/>
          </p:nvSpPr>
          <p:spPr>
            <a:xfrm>
              <a:off x="1729800" y="42321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360" name=""/>
            <p:cNvSpPr/>
            <p:nvPr/>
          </p:nvSpPr>
          <p:spPr>
            <a:xfrm>
              <a:off x="1866960" y="420372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a:t>
              </a:r>
              <a:endParaRPr b="0" lang="en-US" sz="800" spc="-1" strike="noStrike">
                <a:solidFill>
                  <a:srgbClr val="000000"/>
                </a:solidFill>
                <a:latin typeface="Arial"/>
              </a:endParaRPr>
            </a:p>
          </p:txBody>
        </p:sp>
        <p:sp>
          <p:nvSpPr>
            <p:cNvPr id="361" name=""/>
            <p:cNvSpPr/>
            <p:nvPr/>
          </p:nvSpPr>
          <p:spPr>
            <a:xfrm>
              <a:off x="2091600" y="42321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362" name=""/>
            <p:cNvSpPr/>
            <p:nvPr/>
          </p:nvSpPr>
          <p:spPr>
            <a:xfrm>
              <a:off x="2217960" y="420372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3</a:t>
              </a:r>
              <a:endParaRPr b="0" lang="en-US" sz="800" spc="-1" strike="noStrike">
                <a:solidFill>
                  <a:srgbClr val="000000"/>
                </a:solidFill>
                <a:latin typeface="Arial"/>
              </a:endParaRPr>
            </a:p>
          </p:txBody>
        </p:sp>
        <p:sp>
          <p:nvSpPr>
            <p:cNvPr id="363" name=""/>
            <p:cNvSpPr/>
            <p:nvPr/>
          </p:nvSpPr>
          <p:spPr>
            <a:xfrm>
              <a:off x="2444040" y="42321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364" name=""/>
            <p:cNvSpPr/>
            <p:nvPr/>
          </p:nvSpPr>
          <p:spPr>
            <a:xfrm>
              <a:off x="2568600" y="420048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4</a:t>
              </a:r>
              <a:endParaRPr b="0" lang="en-US" sz="800" spc="-1" strike="noStrike">
                <a:solidFill>
                  <a:srgbClr val="000000"/>
                </a:solidFill>
                <a:latin typeface="Arial"/>
              </a:endParaRPr>
            </a:p>
          </p:txBody>
        </p:sp>
      </p:grpSp>
      <p:grpSp>
        <p:nvGrpSpPr>
          <p:cNvPr id="365" name=""/>
          <p:cNvGrpSpPr/>
          <p:nvPr/>
        </p:nvGrpSpPr>
        <p:grpSpPr>
          <a:xfrm>
            <a:off x="2818440" y="4172040"/>
            <a:ext cx="1607400" cy="188280"/>
            <a:chOff x="2818440" y="4172040"/>
            <a:chExt cx="1607400" cy="188280"/>
          </a:xfrm>
        </p:grpSpPr>
        <p:sp>
          <p:nvSpPr>
            <p:cNvPr id="366" name=""/>
            <p:cNvSpPr/>
            <p:nvPr/>
          </p:nvSpPr>
          <p:spPr>
            <a:xfrm>
              <a:off x="2818440" y="42228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367" name=""/>
            <p:cNvSpPr/>
            <p:nvPr/>
          </p:nvSpPr>
          <p:spPr>
            <a:xfrm>
              <a:off x="2941200" y="417204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a:t>
              </a:r>
              <a:endParaRPr b="0" lang="en-US" sz="800" spc="-1" strike="noStrike">
                <a:solidFill>
                  <a:srgbClr val="000000"/>
                </a:solidFill>
                <a:latin typeface="Arial"/>
              </a:endParaRPr>
            </a:p>
          </p:txBody>
        </p:sp>
        <p:sp>
          <p:nvSpPr>
            <p:cNvPr id="368" name=""/>
            <p:cNvSpPr/>
            <p:nvPr/>
          </p:nvSpPr>
          <p:spPr>
            <a:xfrm>
              <a:off x="3172320" y="42228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369" name=""/>
            <p:cNvSpPr/>
            <p:nvPr/>
          </p:nvSpPr>
          <p:spPr>
            <a:xfrm>
              <a:off x="3288960" y="418464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a:t>
              </a:r>
              <a:endParaRPr b="0" lang="en-US" sz="800" spc="-1" strike="noStrike">
                <a:solidFill>
                  <a:srgbClr val="000000"/>
                </a:solidFill>
                <a:latin typeface="Arial"/>
              </a:endParaRPr>
            </a:p>
          </p:txBody>
        </p:sp>
        <p:sp>
          <p:nvSpPr>
            <p:cNvPr id="370" name=""/>
            <p:cNvSpPr/>
            <p:nvPr/>
          </p:nvSpPr>
          <p:spPr>
            <a:xfrm>
              <a:off x="3529440" y="42228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371" name=""/>
            <p:cNvSpPr/>
            <p:nvPr/>
          </p:nvSpPr>
          <p:spPr>
            <a:xfrm>
              <a:off x="3666960" y="419436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a:t>
              </a:r>
              <a:endParaRPr b="0" lang="en-US" sz="800" spc="-1" strike="noStrike">
                <a:solidFill>
                  <a:srgbClr val="000000"/>
                </a:solidFill>
                <a:latin typeface="Arial"/>
              </a:endParaRPr>
            </a:p>
          </p:txBody>
        </p:sp>
        <p:sp>
          <p:nvSpPr>
            <p:cNvPr id="372" name=""/>
            <p:cNvSpPr/>
            <p:nvPr/>
          </p:nvSpPr>
          <p:spPr>
            <a:xfrm>
              <a:off x="3891240" y="42228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373" name=""/>
            <p:cNvSpPr/>
            <p:nvPr/>
          </p:nvSpPr>
          <p:spPr>
            <a:xfrm>
              <a:off x="4017600" y="419436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3</a:t>
              </a:r>
              <a:endParaRPr b="0" lang="en-US" sz="800" spc="-1" strike="noStrike">
                <a:solidFill>
                  <a:srgbClr val="000000"/>
                </a:solidFill>
                <a:latin typeface="Arial"/>
              </a:endParaRPr>
            </a:p>
          </p:txBody>
        </p:sp>
        <p:sp>
          <p:nvSpPr>
            <p:cNvPr id="374" name=""/>
            <p:cNvSpPr/>
            <p:nvPr/>
          </p:nvSpPr>
          <p:spPr>
            <a:xfrm>
              <a:off x="4243680" y="42228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375" name=""/>
            <p:cNvSpPr/>
            <p:nvPr/>
          </p:nvSpPr>
          <p:spPr>
            <a:xfrm>
              <a:off x="4368600" y="419112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4</a:t>
              </a:r>
              <a:endParaRPr b="0" lang="en-US" sz="800" spc="-1" strike="noStrike">
                <a:solidFill>
                  <a:srgbClr val="000000"/>
                </a:solidFill>
                <a:latin typeface="Arial"/>
              </a:endParaRPr>
            </a:p>
          </p:txBody>
        </p:sp>
      </p:grpSp>
      <p:sp>
        <p:nvSpPr>
          <p:cNvPr id="376" name=""/>
          <p:cNvSpPr/>
          <p:nvPr/>
        </p:nvSpPr>
        <p:spPr>
          <a:xfrm>
            <a:off x="5010120" y="2933640"/>
            <a:ext cx="1454040" cy="1227240"/>
          </a:xfrm>
          <a:prstGeom prst="rect">
            <a:avLst/>
          </a:prstGeom>
          <a:solidFill>
            <a:srgbClr val="ffffff"/>
          </a:solidFill>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377" name=""/>
          <p:cNvSpPr/>
          <p:nvPr/>
        </p:nvSpPr>
        <p:spPr>
          <a:xfrm>
            <a:off x="5010120" y="4156200"/>
            <a:ext cx="14479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nvGrpSpPr>
          <p:cNvPr id="378" name=""/>
          <p:cNvGrpSpPr/>
          <p:nvPr/>
        </p:nvGrpSpPr>
        <p:grpSpPr>
          <a:xfrm>
            <a:off x="5010120" y="4160880"/>
            <a:ext cx="1449000" cy="28440"/>
            <a:chOff x="5010120" y="4160880"/>
            <a:chExt cx="1449000" cy="28440"/>
          </a:xfrm>
        </p:grpSpPr>
        <p:sp>
          <p:nvSpPr>
            <p:cNvPr id="379" name=""/>
            <p:cNvSpPr/>
            <p:nvPr/>
          </p:nvSpPr>
          <p:spPr>
            <a:xfrm>
              <a:off x="5010120" y="4160880"/>
              <a:ext cx="36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sp>
          <p:nvSpPr>
            <p:cNvPr id="380" name=""/>
            <p:cNvSpPr/>
            <p:nvPr/>
          </p:nvSpPr>
          <p:spPr>
            <a:xfrm>
              <a:off x="5116680" y="416088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381" name=""/>
            <p:cNvSpPr/>
            <p:nvPr/>
          </p:nvSpPr>
          <p:spPr>
            <a:xfrm>
              <a:off x="5178240" y="416088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382" name=""/>
            <p:cNvSpPr/>
            <p:nvPr/>
          </p:nvSpPr>
          <p:spPr>
            <a:xfrm>
              <a:off x="5223240" y="4160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383" name=""/>
            <p:cNvSpPr/>
            <p:nvPr/>
          </p:nvSpPr>
          <p:spPr>
            <a:xfrm>
              <a:off x="5262840" y="4160880"/>
              <a:ext cx="360" cy="18720"/>
            </a:xfrm>
            <a:prstGeom prst="line">
              <a:avLst/>
            </a:prstGeom>
            <a:ln w="12600">
              <a:solidFill>
                <a:srgbClr val="000000"/>
              </a:solidFill>
              <a:miter/>
            </a:ln>
          </p:spPr>
          <p:style>
            <a:lnRef idx="0"/>
            <a:fillRef idx="0"/>
            <a:effectRef idx="0"/>
            <a:fontRef idx="minor"/>
          </p:style>
          <p:txBody>
            <a:bodyPr lIns="90000" rIns="90000" tIns="-28080" bIns="-28080" anchor="t">
              <a:noAutofit/>
            </a:bodyPr>
            <a:p>
              <a:endParaRPr b="0" lang="en-US" sz="2400" spc="-1" strike="noStrike">
                <a:solidFill>
                  <a:srgbClr val="000000"/>
                </a:solidFill>
                <a:latin typeface="Arial"/>
              </a:endParaRPr>
            </a:p>
          </p:txBody>
        </p:sp>
        <p:sp>
          <p:nvSpPr>
            <p:cNvPr id="384" name=""/>
            <p:cNvSpPr/>
            <p:nvPr/>
          </p:nvSpPr>
          <p:spPr>
            <a:xfrm>
              <a:off x="5290920" y="4160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385" name=""/>
            <p:cNvSpPr/>
            <p:nvPr/>
          </p:nvSpPr>
          <p:spPr>
            <a:xfrm>
              <a:off x="5313240" y="4160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386" name=""/>
            <p:cNvSpPr/>
            <p:nvPr/>
          </p:nvSpPr>
          <p:spPr>
            <a:xfrm>
              <a:off x="5335560" y="416088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387" name=""/>
            <p:cNvSpPr/>
            <p:nvPr/>
          </p:nvSpPr>
          <p:spPr>
            <a:xfrm>
              <a:off x="5352480" y="4160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388" name=""/>
            <p:cNvSpPr/>
            <p:nvPr/>
          </p:nvSpPr>
          <p:spPr>
            <a:xfrm>
              <a:off x="5369400" y="4160880"/>
              <a:ext cx="36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sp>
          <p:nvSpPr>
            <p:cNvPr id="389" name=""/>
            <p:cNvSpPr/>
            <p:nvPr/>
          </p:nvSpPr>
          <p:spPr>
            <a:xfrm>
              <a:off x="5481720" y="416088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390" name=""/>
            <p:cNvSpPr/>
            <p:nvPr/>
          </p:nvSpPr>
          <p:spPr>
            <a:xfrm>
              <a:off x="5543280" y="416088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391" name=""/>
            <p:cNvSpPr/>
            <p:nvPr/>
          </p:nvSpPr>
          <p:spPr>
            <a:xfrm>
              <a:off x="5588280" y="4160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392" name=""/>
            <p:cNvSpPr/>
            <p:nvPr/>
          </p:nvSpPr>
          <p:spPr>
            <a:xfrm>
              <a:off x="5622120" y="4160880"/>
              <a:ext cx="720" cy="18720"/>
            </a:xfrm>
            <a:prstGeom prst="line">
              <a:avLst/>
            </a:prstGeom>
            <a:ln w="12600">
              <a:solidFill>
                <a:srgbClr val="000000"/>
              </a:solidFill>
              <a:miter/>
            </a:ln>
          </p:spPr>
          <p:style>
            <a:lnRef idx="0"/>
            <a:fillRef idx="0"/>
            <a:effectRef idx="0"/>
            <a:fontRef idx="minor"/>
          </p:style>
          <p:txBody>
            <a:bodyPr lIns="90000" rIns="90000" tIns="-28080" bIns="-28080" anchor="t">
              <a:noAutofit/>
            </a:bodyPr>
            <a:p>
              <a:endParaRPr b="0" lang="en-US" sz="2400" spc="-1" strike="noStrike">
                <a:solidFill>
                  <a:srgbClr val="000000"/>
                </a:solidFill>
                <a:latin typeface="Arial"/>
              </a:endParaRPr>
            </a:p>
          </p:txBody>
        </p:sp>
        <p:sp>
          <p:nvSpPr>
            <p:cNvPr id="393" name=""/>
            <p:cNvSpPr/>
            <p:nvPr/>
          </p:nvSpPr>
          <p:spPr>
            <a:xfrm>
              <a:off x="5655600" y="4160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394" name=""/>
            <p:cNvSpPr/>
            <p:nvPr/>
          </p:nvSpPr>
          <p:spPr>
            <a:xfrm>
              <a:off x="5678280" y="4160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395" name=""/>
            <p:cNvSpPr/>
            <p:nvPr/>
          </p:nvSpPr>
          <p:spPr>
            <a:xfrm>
              <a:off x="5700600" y="416088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396" name=""/>
            <p:cNvSpPr/>
            <p:nvPr/>
          </p:nvSpPr>
          <p:spPr>
            <a:xfrm>
              <a:off x="5717520" y="4160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397" name=""/>
            <p:cNvSpPr/>
            <p:nvPr/>
          </p:nvSpPr>
          <p:spPr>
            <a:xfrm>
              <a:off x="5734440" y="4160880"/>
              <a:ext cx="36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sp>
          <p:nvSpPr>
            <p:cNvPr id="398" name=""/>
            <p:cNvSpPr/>
            <p:nvPr/>
          </p:nvSpPr>
          <p:spPr>
            <a:xfrm>
              <a:off x="5841000" y="416088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399" name=""/>
            <p:cNvSpPr/>
            <p:nvPr/>
          </p:nvSpPr>
          <p:spPr>
            <a:xfrm>
              <a:off x="5908320" y="416088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00" name=""/>
            <p:cNvSpPr/>
            <p:nvPr/>
          </p:nvSpPr>
          <p:spPr>
            <a:xfrm>
              <a:off x="5953320" y="4160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01" name=""/>
            <p:cNvSpPr/>
            <p:nvPr/>
          </p:nvSpPr>
          <p:spPr>
            <a:xfrm>
              <a:off x="5987160" y="4160880"/>
              <a:ext cx="720" cy="18720"/>
            </a:xfrm>
            <a:prstGeom prst="line">
              <a:avLst/>
            </a:prstGeom>
            <a:ln w="12600">
              <a:solidFill>
                <a:srgbClr val="000000"/>
              </a:solidFill>
              <a:miter/>
            </a:ln>
          </p:spPr>
          <p:style>
            <a:lnRef idx="0"/>
            <a:fillRef idx="0"/>
            <a:effectRef idx="0"/>
            <a:fontRef idx="minor"/>
          </p:style>
          <p:txBody>
            <a:bodyPr lIns="90000" rIns="90000" tIns="-28080" bIns="-28080" anchor="t">
              <a:noAutofit/>
            </a:bodyPr>
            <a:p>
              <a:endParaRPr b="0" lang="en-US" sz="2400" spc="-1" strike="noStrike">
                <a:solidFill>
                  <a:srgbClr val="000000"/>
                </a:solidFill>
                <a:latin typeface="Arial"/>
              </a:endParaRPr>
            </a:p>
          </p:txBody>
        </p:sp>
        <p:sp>
          <p:nvSpPr>
            <p:cNvPr id="402" name=""/>
            <p:cNvSpPr/>
            <p:nvPr/>
          </p:nvSpPr>
          <p:spPr>
            <a:xfrm>
              <a:off x="6015240" y="4160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03" name=""/>
            <p:cNvSpPr/>
            <p:nvPr/>
          </p:nvSpPr>
          <p:spPr>
            <a:xfrm>
              <a:off x="6043320" y="416088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04" name=""/>
            <p:cNvSpPr/>
            <p:nvPr/>
          </p:nvSpPr>
          <p:spPr>
            <a:xfrm>
              <a:off x="6060240" y="4160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05" name=""/>
            <p:cNvSpPr/>
            <p:nvPr/>
          </p:nvSpPr>
          <p:spPr>
            <a:xfrm>
              <a:off x="6082560" y="4160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06" name=""/>
            <p:cNvSpPr/>
            <p:nvPr/>
          </p:nvSpPr>
          <p:spPr>
            <a:xfrm>
              <a:off x="6099480" y="4160880"/>
              <a:ext cx="36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sp>
          <p:nvSpPr>
            <p:cNvPr id="407" name=""/>
            <p:cNvSpPr/>
            <p:nvPr/>
          </p:nvSpPr>
          <p:spPr>
            <a:xfrm>
              <a:off x="6206040" y="416088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08" name=""/>
            <p:cNvSpPr/>
            <p:nvPr/>
          </p:nvSpPr>
          <p:spPr>
            <a:xfrm>
              <a:off x="6273720" y="4160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09" name=""/>
            <p:cNvSpPr/>
            <p:nvPr/>
          </p:nvSpPr>
          <p:spPr>
            <a:xfrm>
              <a:off x="6318360" y="4160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10" name=""/>
            <p:cNvSpPr/>
            <p:nvPr/>
          </p:nvSpPr>
          <p:spPr>
            <a:xfrm>
              <a:off x="6352200" y="4160880"/>
              <a:ext cx="720" cy="18720"/>
            </a:xfrm>
            <a:prstGeom prst="line">
              <a:avLst/>
            </a:prstGeom>
            <a:ln w="12600">
              <a:solidFill>
                <a:srgbClr val="000000"/>
              </a:solidFill>
              <a:miter/>
            </a:ln>
          </p:spPr>
          <p:style>
            <a:lnRef idx="0"/>
            <a:fillRef idx="0"/>
            <a:effectRef idx="0"/>
            <a:fontRef idx="minor"/>
          </p:style>
          <p:txBody>
            <a:bodyPr lIns="90000" rIns="90000" tIns="-28080" bIns="-28080" anchor="t">
              <a:noAutofit/>
            </a:bodyPr>
            <a:p>
              <a:endParaRPr b="0" lang="en-US" sz="2400" spc="-1" strike="noStrike">
                <a:solidFill>
                  <a:srgbClr val="000000"/>
                </a:solidFill>
                <a:latin typeface="Arial"/>
              </a:endParaRPr>
            </a:p>
          </p:txBody>
        </p:sp>
        <p:sp>
          <p:nvSpPr>
            <p:cNvPr id="411" name=""/>
            <p:cNvSpPr/>
            <p:nvPr/>
          </p:nvSpPr>
          <p:spPr>
            <a:xfrm>
              <a:off x="6380280" y="4160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12" name=""/>
            <p:cNvSpPr/>
            <p:nvPr/>
          </p:nvSpPr>
          <p:spPr>
            <a:xfrm>
              <a:off x="6402600" y="4160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13" name=""/>
            <p:cNvSpPr/>
            <p:nvPr/>
          </p:nvSpPr>
          <p:spPr>
            <a:xfrm>
              <a:off x="6425280" y="4160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14" name=""/>
            <p:cNvSpPr/>
            <p:nvPr/>
          </p:nvSpPr>
          <p:spPr>
            <a:xfrm>
              <a:off x="6441840" y="4160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15" name=""/>
            <p:cNvSpPr/>
            <p:nvPr/>
          </p:nvSpPr>
          <p:spPr>
            <a:xfrm>
              <a:off x="6458760" y="4160880"/>
              <a:ext cx="36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grpSp>
      <p:sp>
        <p:nvSpPr>
          <p:cNvPr id="416" name=""/>
          <p:cNvSpPr/>
          <p:nvPr/>
        </p:nvSpPr>
        <p:spPr>
          <a:xfrm>
            <a:off x="5549040" y="4435560"/>
            <a:ext cx="3193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FL2-H</a:t>
            </a:r>
            <a:endParaRPr b="0" lang="en-US" sz="900" spc="-1" strike="noStrike">
              <a:solidFill>
                <a:srgbClr val="000000"/>
              </a:solidFill>
              <a:latin typeface="Arial"/>
            </a:endParaRPr>
          </a:p>
        </p:txBody>
      </p:sp>
      <p:sp>
        <p:nvSpPr>
          <p:cNvPr id="417" name=""/>
          <p:cNvSpPr/>
          <p:nvPr/>
        </p:nvSpPr>
        <p:spPr>
          <a:xfrm flipV="1">
            <a:off x="5010120" y="2933640"/>
            <a:ext cx="0" cy="12225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nvGrpSpPr>
          <p:cNvPr id="418" name=""/>
          <p:cNvGrpSpPr/>
          <p:nvPr/>
        </p:nvGrpSpPr>
        <p:grpSpPr>
          <a:xfrm>
            <a:off x="4770720" y="3049560"/>
            <a:ext cx="194040" cy="1215720"/>
            <a:chOff x="4770720" y="3049560"/>
            <a:chExt cx="194040" cy="1215720"/>
          </a:xfrm>
        </p:grpSpPr>
        <p:sp>
          <p:nvSpPr>
            <p:cNvPr id="419" name=""/>
            <p:cNvSpPr/>
            <p:nvPr/>
          </p:nvSpPr>
          <p:spPr>
            <a:xfrm>
              <a:off x="4848840" y="4127760"/>
              <a:ext cx="648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0</a:t>
              </a:r>
              <a:endParaRPr b="0" lang="en-US" sz="900" spc="-1" strike="noStrike">
                <a:solidFill>
                  <a:srgbClr val="000000"/>
                </a:solidFill>
                <a:latin typeface="Arial"/>
              </a:endParaRPr>
            </a:p>
          </p:txBody>
        </p:sp>
        <p:sp>
          <p:nvSpPr>
            <p:cNvPr id="420" name=""/>
            <p:cNvSpPr/>
            <p:nvPr/>
          </p:nvSpPr>
          <p:spPr>
            <a:xfrm>
              <a:off x="4772160" y="377028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0</a:t>
              </a:r>
              <a:endParaRPr b="0" lang="en-US" sz="900" spc="-1" strike="noStrike">
                <a:solidFill>
                  <a:srgbClr val="000000"/>
                </a:solidFill>
                <a:latin typeface="Arial"/>
              </a:endParaRPr>
            </a:p>
          </p:txBody>
        </p:sp>
        <p:sp>
          <p:nvSpPr>
            <p:cNvPr id="421" name=""/>
            <p:cNvSpPr/>
            <p:nvPr/>
          </p:nvSpPr>
          <p:spPr>
            <a:xfrm>
              <a:off x="4772160" y="340992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200</a:t>
              </a:r>
              <a:endParaRPr b="0" lang="en-US" sz="900" spc="-1" strike="noStrike">
                <a:solidFill>
                  <a:srgbClr val="000000"/>
                </a:solidFill>
                <a:latin typeface="Arial"/>
              </a:endParaRPr>
            </a:p>
          </p:txBody>
        </p:sp>
        <p:sp>
          <p:nvSpPr>
            <p:cNvPr id="422" name=""/>
            <p:cNvSpPr/>
            <p:nvPr/>
          </p:nvSpPr>
          <p:spPr>
            <a:xfrm>
              <a:off x="4770720" y="304956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300</a:t>
              </a:r>
              <a:endParaRPr b="0" lang="en-US" sz="900" spc="-1" strike="noStrike">
                <a:solidFill>
                  <a:srgbClr val="000000"/>
                </a:solidFill>
                <a:latin typeface="Arial"/>
              </a:endParaRPr>
            </a:p>
          </p:txBody>
        </p:sp>
      </p:grpSp>
      <p:grpSp>
        <p:nvGrpSpPr>
          <p:cNvPr id="423" name=""/>
          <p:cNvGrpSpPr/>
          <p:nvPr/>
        </p:nvGrpSpPr>
        <p:grpSpPr>
          <a:xfrm>
            <a:off x="4976280" y="2986200"/>
            <a:ext cx="33480" cy="1171440"/>
            <a:chOff x="4976280" y="2986200"/>
            <a:chExt cx="33480" cy="1171440"/>
          </a:xfrm>
        </p:grpSpPr>
        <p:sp>
          <p:nvSpPr>
            <p:cNvPr id="424" name=""/>
            <p:cNvSpPr/>
            <p:nvPr/>
          </p:nvSpPr>
          <p:spPr>
            <a:xfrm flipH="1">
              <a:off x="4976280" y="4157280"/>
              <a:ext cx="3348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425" name=""/>
            <p:cNvSpPr/>
            <p:nvPr/>
          </p:nvSpPr>
          <p:spPr>
            <a:xfrm flipH="1">
              <a:off x="4998600" y="406728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426" name=""/>
            <p:cNvSpPr/>
            <p:nvPr/>
          </p:nvSpPr>
          <p:spPr>
            <a:xfrm flipH="1">
              <a:off x="4998600" y="397692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427" name=""/>
            <p:cNvSpPr/>
            <p:nvPr/>
          </p:nvSpPr>
          <p:spPr>
            <a:xfrm flipH="1">
              <a:off x="4998600" y="388692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428" name=""/>
            <p:cNvSpPr/>
            <p:nvPr/>
          </p:nvSpPr>
          <p:spPr>
            <a:xfrm flipH="1">
              <a:off x="4976280" y="3796920"/>
              <a:ext cx="3348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429" name=""/>
            <p:cNvSpPr/>
            <p:nvPr/>
          </p:nvSpPr>
          <p:spPr>
            <a:xfrm flipH="1">
              <a:off x="4998600" y="370692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430" name=""/>
            <p:cNvSpPr/>
            <p:nvPr/>
          </p:nvSpPr>
          <p:spPr>
            <a:xfrm flipH="1">
              <a:off x="4998600" y="361656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431" name=""/>
            <p:cNvSpPr/>
            <p:nvPr/>
          </p:nvSpPr>
          <p:spPr>
            <a:xfrm flipH="1">
              <a:off x="4998600" y="352656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432" name=""/>
            <p:cNvSpPr/>
            <p:nvPr/>
          </p:nvSpPr>
          <p:spPr>
            <a:xfrm flipH="1">
              <a:off x="4976280" y="3436560"/>
              <a:ext cx="3348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433" name=""/>
            <p:cNvSpPr/>
            <p:nvPr/>
          </p:nvSpPr>
          <p:spPr>
            <a:xfrm flipH="1">
              <a:off x="4998600" y="334656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434" name=""/>
            <p:cNvSpPr/>
            <p:nvPr/>
          </p:nvSpPr>
          <p:spPr>
            <a:xfrm flipH="1">
              <a:off x="4998600" y="325620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435" name=""/>
            <p:cNvSpPr/>
            <p:nvPr/>
          </p:nvSpPr>
          <p:spPr>
            <a:xfrm flipH="1">
              <a:off x="4998600" y="316620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436" name=""/>
            <p:cNvSpPr/>
            <p:nvPr/>
          </p:nvSpPr>
          <p:spPr>
            <a:xfrm flipH="1">
              <a:off x="4976280" y="3076200"/>
              <a:ext cx="3348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437" name=""/>
            <p:cNvSpPr/>
            <p:nvPr/>
          </p:nvSpPr>
          <p:spPr>
            <a:xfrm flipH="1">
              <a:off x="4998600" y="298620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grpSp>
      <p:sp>
        <p:nvSpPr>
          <p:cNvPr id="438" name=""/>
          <p:cNvSpPr/>
          <p:nvPr/>
        </p:nvSpPr>
        <p:spPr>
          <a:xfrm rot="16200000">
            <a:off x="4518360" y="3460320"/>
            <a:ext cx="3528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 Cells</a:t>
            </a:r>
            <a:endParaRPr b="0" lang="en-US" sz="900" spc="-1" strike="noStrike">
              <a:solidFill>
                <a:srgbClr val="000000"/>
              </a:solidFill>
              <a:latin typeface="Arial"/>
            </a:endParaRPr>
          </a:p>
        </p:txBody>
      </p:sp>
      <p:sp>
        <p:nvSpPr>
          <p:cNvPr id="439" name=""/>
          <p:cNvSpPr/>
          <p:nvPr/>
        </p:nvSpPr>
        <p:spPr>
          <a:xfrm>
            <a:off x="5021280" y="3000240"/>
            <a:ext cx="1425600" cy="1150920"/>
          </a:xfrm>
          <a:custGeom>
            <a:avLst/>
            <a:gdLst/>
            <a:ahLst/>
            <a:rect l="l" t="t" r="r" b="b"/>
            <a:pathLst>
              <a:path w="2032" h="1944">
                <a:moveTo>
                  <a:pt x="0" y="1944"/>
                </a:moveTo>
                <a:lnTo>
                  <a:pt x="0" y="1568"/>
                </a:lnTo>
                <a:lnTo>
                  <a:pt x="0" y="1920"/>
                </a:lnTo>
                <a:lnTo>
                  <a:pt x="8" y="1944"/>
                </a:lnTo>
                <a:lnTo>
                  <a:pt x="16" y="1920"/>
                </a:lnTo>
                <a:lnTo>
                  <a:pt x="24" y="1928"/>
                </a:lnTo>
                <a:lnTo>
                  <a:pt x="32" y="1920"/>
                </a:lnTo>
                <a:lnTo>
                  <a:pt x="40" y="1920"/>
                </a:lnTo>
                <a:lnTo>
                  <a:pt x="48" y="1904"/>
                </a:lnTo>
                <a:lnTo>
                  <a:pt x="56" y="1920"/>
                </a:lnTo>
                <a:lnTo>
                  <a:pt x="64" y="1920"/>
                </a:lnTo>
                <a:lnTo>
                  <a:pt x="72" y="1928"/>
                </a:lnTo>
                <a:lnTo>
                  <a:pt x="80" y="1896"/>
                </a:lnTo>
                <a:lnTo>
                  <a:pt x="88" y="1896"/>
                </a:lnTo>
                <a:lnTo>
                  <a:pt x="96" y="1920"/>
                </a:lnTo>
                <a:lnTo>
                  <a:pt x="104" y="1864"/>
                </a:lnTo>
                <a:lnTo>
                  <a:pt x="112" y="1896"/>
                </a:lnTo>
                <a:lnTo>
                  <a:pt x="120" y="1896"/>
                </a:lnTo>
                <a:lnTo>
                  <a:pt x="128" y="1848"/>
                </a:lnTo>
                <a:lnTo>
                  <a:pt x="136" y="1880"/>
                </a:lnTo>
                <a:lnTo>
                  <a:pt x="144" y="1856"/>
                </a:lnTo>
                <a:lnTo>
                  <a:pt x="152" y="1840"/>
                </a:lnTo>
                <a:lnTo>
                  <a:pt x="160" y="1832"/>
                </a:lnTo>
                <a:lnTo>
                  <a:pt x="168" y="1776"/>
                </a:lnTo>
                <a:lnTo>
                  <a:pt x="176" y="1744"/>
                </a:lnTo>
                <a:lnTo>
                  <a:pt x="184" y="1736"/>
                </a:lnTo>
                <a:lnTo>
                  <a:pt x="192" y="1800"/>
                </a:lnTo>
                <a:lnTo>
                  <a:pt x="200" y="1744"/>
                </a:lnTo>
                <a:lnTo>
                  <a:pt x="208" y="1696"/>
                </a:lnTo>
                <a:lnTo>
                  <a:pt x="216" y="1728"/>
                </a:lnTo>
                <a:lnTo>
                  <a:pt x="224" y="1712"/>
                </a:lnTo>
                <a:lnTo>
                  <a:pt x="232" y="1720"/>
                </a:lnTo>
                <a:lnTo>
                  <a:pt x="240" y="1608"/>
                </a:lnTo>
                <a:lnTo>
                  <a:pt x="248" y="1608"/>
                </a:lnTo>
                <a:lnTo>
                  <a:pt x="256" y="1528"/>
                </a:lnTo>
                <a:lnTo>
                  <a:pt x="264" y="1488"/>
                </a:lnTo>
                <a:lnTo>
                  <a:pt x="272" y="1600"/>
                </a:lnTo>
                <a:lnTo>
                  <a:pt x="280" y="1408"/>
                </a:lnTo>
                <a:lnTo>
                  <a:pt x="288" y="1440"/>
                </a:lnTo>
                <a:lnTo>
                  <a:pt x="296" y="1384"/>
                </a:lnTo>
                <a:lnTo>
                  <a:pt x="304" y="1320"/>
                </a:lnTo>
                <a:lnTo>
                  <a:pt x="312" y="1232"/>
                </a:lnTo>
                <a:lnTo>
                  <a:pt x="320" y="1224"/>
                </a:lnTo>
                <a:lnTo>
                  <a:pt x="328" y="1056"/>
                </a:lnTo>
                <a:lnTo>
                  <a:pt x="336" y="1088"/>
                </a:lnTo>
                <a:lnTo>
                  <a:pt x="344" y="1000"/>
                </a:lnTo>
                <a:lnTo>
                  <a:pt x="352" y="888"/>
                </a:lnTo>
                <a:lnTo>
                  <a:pt x="360" y="792"/>
                </a:lnTo>
                <a:lnTo>
                  <a:pt x="368" y="624"/>
                </a:lnTo>
                <a:lnTo>
                  <a:pt x="376" y="736"/>
                </a:lnTo>
                <a:lnTo>
                  <a:pt x="384" y="576"/>
                </a:lnTo>
                <a:lnTo>
                  <a:pt x="392" y="568"/>
                </a:lnTo>
                <a:lnTo>
                  <a:pt x="400" y="408"/>
                </a:lnTo>
                <a:lnTo>
                  <a:pt x="408" y="384"/>
                </a:lnTo>
                <a:lnTo>
                  <a:pt x="416" y="280"/>
                </a:lnTo>
                <a:lnTo>
                  <a:pt x="424" y="216"/>
                </a:lnTo>
                <a:lnTo>
                  <a:pt x="432" y="136"/>
                </a:lnTo>
                <a:lnTo>
                  <a:pt x="440" y="248"/>
                </a:lnTo>
                <a:lnTo>
                  <a:pt x="448" y="16"/>
                </a:lnTo>
                <a:lnTo>
                  <a:pt x="456" y="72"/>
                </a:lnTo>
                <a:lnTo>
                  <a:pt x="464" y="48"/>
                </a:lnTo>
                <a:lnTo>
                  <a:pt x="472" y="0"/>
                </a:lnTo>
                <a:lnTo>
                  <a:pt x="480" y="168"/>
                </a:lnTo>
                <a:lnTo>
                  <a:pt x="488" y="24"/>
                </a:lnTo>
                <a:lnTo>
                  <a:pt x="496" y="168"/>
                </a:lnTo>
                <a:lnTo>
                  <a:pt x="504" y="168"/>
                </a:lnTo>
                <a:lnTo>
                  <a:pt x="512" y="312"/>
                </a:lnTo>
                <a:lnTo>
                  <a:pt x="520" y="144"/>
                </a:lnTo>
                <a:lnTo>
                  <a:pt x="528" y="336"/>
                </a:lnTo>
                <a:lnTo>
                  <a:pt x="536" y="496"/>
                </a:lnTo>
                <a:lnTo>
                  <a:pt x="544" y="584"/>
                </a:lnTo>
                <a:lnTo>
                  <a:pt x="552" y="768"/>
                </a:lnTo>
                <a:lnTo>
                  <a:pt x="560" y="832"/>
                </a:lnTo>
                <a:lnTo>
                  <a:pt x="568" y="976"/>
                </a:lnTo>
                <a:lnTo>
                  <a:pt x="576" y="1120"/>
                </a:lnTo>
                <a:lnTo>
                  <a:pt x="584" y="1304"/>
                </a:lnTo>
                <a:lnTo>
                  <a:pt x="592" y="1232"/>
                </a:lnTo>
                <a:lnTo>
                  <a:pt x="600" y="1280"/>
                </a:lnTo>
                <a:lnTo>
                  <a:pt x="608" y="1368"/>
                </a:lnTo>
                <a:lnTo>
                  <a:pt x="616" y="1480"/>
                </a:lnTo>
                <a:lnTo>
                  <a:pt x="624" y="1488"/>
                </a:lnTo>
                <a:lnTo>
                  <a:pt x="632" y="1600"/>
                </a:lnTo>
                <a:lnTo>
                  <a:pt x="640" y="1592"/>
                </a:lnTo>
                <a:lnTo>
                  <a:pt x="648" y="1656"/>
                </a:lnTo>
                <a:lnTo>
                  <a:pt x="656" y="1720"/>
                </a:lnTo>
                <a:lnTo>
                  <a:pt x="664" y="1704"/>
                </a:lnTo>
                <a:lnTo>
                  <a:pt x="672" y="1824"/>
                </a:lnTo>
                <a:lnTo>
                  <a:pt x="680" y="1808"/>
                </a:lnTo>
                <a:lnTo>
                  <a:pt x="688" y="1824"/>
                </a:lnTo>
                <a:lnTo>
                  <a:pt x="696" y="1800"/>
                </a:lnTo>
                <a:lnTo>
                  <a:pt x="704" y="1848"/>
                </a:lnTo>
                <a:lnTo>
                  <a:pt x="712" y="1824"/>
                </a:lnTo>
                <a:lnTo>
                  <a:pt x="720" y="1872"/>
                </a:lnTo>
                <a:lnTo>
                  <a:pt x="728" y="1888"/>
                </a:lnTo>
                <a:lnTo>
                  <a:pt x="736" y="1896"/>
                </a:lnTo>
                <a:lnTo>
                  <a:pt x="744" y="1896"/>
                </a:lnTo>
                <a:lnTo>
                  <a:pt x="752" y="1912"/>
                </a:lnTo>
                <a:lnTo>
                  <a:pt x="760" y="1912"/>
                </a:lnTo>
                <a:lnTo>
                  <a:pt x="768" y="1920"/>
                </a:lnTo>
                <a:lnTo>
                  <a:pt x="776" y="1904"/>
                </a:lnTo>
                <a:lnTo>
                  <a:pt x="784" y="1920"/>
                </a:lnTo>
                <a:lnTo>
                  <a:pt x="792" y="1936"/>
                </a:lnTo>
                <a:lnTo>
                  <a:pt x="800" y="1944"/>
                </a:lnTo>
                <a:lnTo>
                  <a:pt x="808" y="1928"/>
                </a:lnTo>
                <a:lnTo>
                  <a:pt x="816" y="1944"/>
                </a:lnTo>
                <a:lnTo>
                  <a:pt x="824" y="1928"/>
                </a:lnTo>
                <a:lnTo>
                  <a:pt x="832" y="1944"/>
                </a:lnTo>
                <a:lnTo>
                  <a:pt x="840" y="1928"/>
                </a:lnTo>
                <a:lnTo>
                  <a:pt x="848" y="1944"/>
                </a:lnTo>
                <a:lnTo>
                  <a:pt x="856" y="1944"/>
                </a:lnTo>
                <a:lnTo>
                  <a:pt x="864" y="1944"/>
                </a:lnTo>
                <a:lnTo>
                  <a:pt x="872" y="1944"/>
                </a:lnTo>
                <a:lnTo>
                  <a:pt x="880" y="1944"/>
                </a:lnTo>
                <a:lnTo>
                  <a:pt x="888" y="1944"/>
                </a:lnTo>
                <a:lnTo>
                  <a:pt x="896" y="1944"/>
                </a:lnTo>
                <a:lnTo>
                  <a:pt x="904" y="1944"/>
                </a:lnTo>
                <a:lnTo>
                  <a:pt x="912" y="1944"/>
                </a:lnTo>
                <a:lnTo>
                  <a:pt x="920" y="1944"/>
                </a:lnTo>
                <a:lnTo>
                  <a:pt x="928" y="1944"/>
                </a:lnTo>
                <a:lnTo>
                  <a:pt x="936" y="1944"/>
                </a:lnTo>
                <a:lnTo>
                  <a:pt x="944" y="1944"/>
                </a:lnTo>
                <a:lnTo>
                  <a:pt x="952" y="1944"/>
                </a:lnTo>
                <a:lnTo>
                  <a:pt x="960" y="1944"/>
                </a:lnTo>
                <a:lnTo>
                  <a:pt x="968" y="1944"/>
                </a:lnTo>
                <a:lnTo>
                  <a:pt x="976" y="1944"/>
                </a:lnTo>
                <a:lnTo>
                  <a:pt x="984" y="1944"/>
                </a:lnTo>
                <a:lnTo>
                  <a:pt x="992" y="1944"/>
                </a:lnTo>
                <a:lnTo>
                  <a:pt x="1000" y="1944"/>
                </a:lnTo>
                <a:lnTo>
                  <a:pt x="1008" y="1944"/>
                </a:lnTo>
                <a:lnTo>
                  <a:pt x="1016" y="1944"/>
                </a:lnTo>
                <a:lnTo>
                  <a:pt x="1024" y="1944"/>
                </a:lnTo>
                <a:lnTo>
                  <a:pt x="1032" y="1944"/>
                </a:lnTo>
                <a:lnTo>
                  <a:pt x="1040" y="1944"/>
                </a:lnTo>
                <a:lnTo>
                  <a:pt x="1048" y="1944"/>
                </a:lnTo>
                <a:lnTo>
                  <a:pt x="1056" y="1944"/>
                </a:lnTo>
                <a:lnTo>
                  <a:pt x="1064" y="1944"/>
                </a:lnTo>
                <a:lnTo>
                  <a:pt x="1072" y="1944"/>
                </a:lnTo>
                <a:lnTo>
                  <a:pt x="1080" y="1944"/>
                </a:lnTo>
                <a:lnTo>
                  <a:pt x="1088" y="1944"/>
                </a:lnTo>
                <a:lnTo>
                  <a:pt x="1096" y="1944"/>
                </a:lnTo>
                <a:lnTo>
                  <a:pt x="1104" y="1944"/>
                </a:lnTo>
                <a:lnTo>
                  <a:pt x="1112" y="1944"/>
                </a:lnTo>
                <a:lnTo>
                  <a:pt x="1120" y="1944"/>
                </a:lnTo>
                <a:lnTo>
                  <a:pt x="1128" y="1944"/>
                </a:lnTo>
                <a:lnTo>
                  <a:pt x="1136" y="1944"/>
                </a:lnTo>
                <a:lnTo>
                  <a:pt x="1144" y="1944"/>
                </a:lnTo>
                <a:lnTo>
                  <a:pt x="1152" y="1944"/>
                </a:lnTo>
                <a:lnTo>
                  <a:pt x="1160" y="1944"/>
                </a:lnTo>
                <a:lnTo>
                  <a:pt x="1168" y="1944"/>
                </a:lnTo>
                <a:lnTo>
                  <a:pt x="1176" y="1944"/>
                </a:lnTo>
                <a:lnTo>
                  <a:pt x="1184" y="1944"/>
                </a:lnTo>
                <a:lnTo>
                  <a:pt x="1192" y="1944"/>
                </a:lnTo>
                <a:lnTo>
                  <a:pt x="1200" y="1944"/>
                </a:lnTo>
                <a:lnTo>
                  <a:pt x="1208" y="1944"/>
                </a:lnTo>
                <a:lnTo>
                  <a:pt x="1216" y="1944"/>
                </a:lnTo>
                <a:lnTo>
                  <a:pt x="1224" y="1944"/>
                </a:lnTo>
                <a:lnTo>
                  <a:pt x="1232" y="1944"/>
                </a:lnTo>
                <a:lnTo>
                  <a:pt x="1240" y="1944"/>
                </a:lnTo>
                <a:lnTo>
                  <a:pt x="1248" y="1944"/>
                </a:lnTo>
                <a:lnTo>
                  <a:pt x="1256" y="1944"/>
                </a:lnTo>
                <a:lnTo>
                  <a:pt x="1264" y="1944"/>
                </a:lnTo>
                <a:lnTo>
                  <a:pt x="1272" y="1944"/>
                </a:lnTo>
                <a:lnTo>
                  <a:pt x="1280" y="1944"/>
                </a:lnTo>
                <a:lnTo>
                  <a:pt x="1288" y="1944"/>
                </a:lnTo>
                <a:lnTo>
                  <a:pt x="1296" y="1944"/>
                </a:lnTo>
                <a:lnTo>
                  <a:pt x="1304" y="1944"/>
                </a:lnTo>
                <a:lnTo>
                  <a:pt x="1312" y="1944"/>
                </a:lnTo>
                <a:lnTo>
                  <a:pt x="1320" y="1944"/>
                </a:lnTo>
                <a:lnTo>
                  <a:pt x="1328" y="1944"/>
                </a:lnTo>
                <a:lnTo>
                  <a:pt x="1336" y="1944"/>
                </a:lnTo>
                <a:lnTo>
                  <a:pt x="1344" y="1944"/>
                </a:lnTo>
                <a:lnTo>
                  <a:pt x="1352" y="1944"/>
                </a:lnTo>
                <a:lnTo>
                  <a:pt x="1360" y="1944"/>
                </a:lnTo>
                <a:lnTo>
                  <a:pt x="1368" y="1944"/>
                </a:lnTo>
                <a:lnTo>
                  <a:pt x="1376" y="1944"/>
                </a:lnTo>
                <a:lnTo>
                  <a:pt x="1384" y="1944"/>
                </a:lnTo>
                <a:lnTo>
                  <a:pt x="1392" y="1944"/>
                </a:lnTo>
                <a:lnTo>
                  <a:pt x="1400" y="1944"/>
                </a:lnTo>
                <a:lnTo>
                  <a:pt x="1408" y="1944"/>
                </a:lnTo>
                <a:lnTo>
                  <a:pt x="1416" y="1944"/>
                </a:lnTo>
                <a:lnTo>
                  <a:pt x="1424" y="1944"/>
                </a:lnTo>
                <a:lnTo>
                  <a:pt x="1432" y="1944"/>
                </a:lnTo>
                <a:lnTo>
                  <a:pt x="1440" y="1944"/>
                </a:lnTo>
                <a:lnTo>
                  <a:pt x="1448" y="1944"/>
                </a:lnTo>
                <a:lnTo>
                  <a:pt x="1456" y="1944"/>
                </a:lnTo>
                <a:lnTo>
                  <a:pt x="1464" y="1944"/>
                </a:lnTo>
                <a:lnTo>
                  <a:pt x="1472" y="1944"/>
                </a:lnTo>
                <a:lnTo>
                  <a:pt x="1480" y="1944"/>
                </a:lnTo>
                <a:lnTo>
                  <a:pt x="1488" y="1944"/>
                </a:lnTo>
                <a:lnTo>
                  <a:pt x="1496" y="1944"/>
                </a:lnTo>
                <a:lnTo>
                  <a:pt x="1504" y="1944"/>
                </a:lnTo>
                <a:lnTo>
                  <a:pt x="1512" y="1944"/>
                </a:lnTo>
                <a:lnTo>
                  <a:pt x="1520" y="1944"/>
                </a:lnTo>
                <a:lnTo>
                  <a:pt x="1528" y="1944"/>
                </a:lnTo>
                <a:lnTo>
                  <a:pt x="1536" y="1944"/>
                </a:lnTo>
                <a:lnTo>
                  <a:pt x="1544" y="1944"/>
                </a:lnTo>
                <a:lnTo>
                  <a:pt x="1552" y="1944"/>
                </a:lnTo>
                <a:lnTo>
                  <a:pt x="1560" y="1944"/>
                </a:lnTo>
                <a:lnTo>
                  <a:pt x="1568" y="1944"/>
                </a:lnTo>
                <a:lnTo>
                  <a:pt x="1576" y="1944"/>
                </a:lnTo>
                <a:lnTo>
                  <a:pt x="1584" y="1944"/>
                </a:lnTo>
                <a:lnTo>
                  <a:pt x="1592" y="1944"/>
                </a:lnTo>
                <a:lnTo>
                  <a:pt x="1600" y="1944"/>
                </a:lnTo>
                <a:lnTo>
                  <a:pt x="1608" y="1944"/>
                </a:lnTo>
                <a:lnTo>
                  <a:pt x="1616" y="1944"/>
                </a:lnTo>
                <a:lnTo>
                  <a:pt x="1624" y="1944"/>
                </a:lnTo>
                <a:lnTo>
                  <a:pt x="1632" y="1944"/>
                </a:lnTo>
                <a:lnTo>
                  <a:pt x="1640" y="1944"/>
                </a:lnTo>
                <a:lnTo>
                  <a:pt x="1648" y="1944"/>
                </a:lnTo>
                <a:lnTo>
                  <a:pt x="1656" y="1944"/>
                </a:lnTo>
                <a:lnTo>
                  <a:pt x="1664" y="1944"/>
                </a:lnTo>
                <a:lnTo>
                  <a:pt x="1672" y="1944"/>
                </a:lnTo>
                <a:lnTo>
                  <a:pt x="1680" y="1944"/>
                </a:lnTo>
                <a:lnTo>
                  <a:pt x="1688" y="1944"/>
                </a:lnTo>
                <a:lnTo>
                  <a:pt x="1696" y="1944"/>
                </a:lnTo>
                <a:lnTo>
                  <a:pt x="1704" y="1944"/>
                </a:lnTo>
                <a:lnTo>
                  <a:pt x="1712" y="1944"/>
                </a:lnTo>
                <a:lnTo>
                  <a:pt x="1720" y="1944"/>
                </a:lnTo>
                <a:lnTo>
                  <a:pt x="1728" y="1944"/>
                </a:lnTo>
                <a:lnTo>
                  <a:pt x="1736" y="1944"/>
                </a:lnTo>
                <a:lnTo>
                  <a:pt x="1744" y="1944"/>
                </a:lnTo>
                <a:lnTo>
                  <a:pt x="1752" y="1944"/>
                </a:lnTo>
                <a:lnTo>
                  <a:pt x="1760" y="1944"/>
                </a:lnTo>
                <a:lnTo>
                  <a:pt x="1768" y="1944"/>
                </a:lnTo>
                <a:lnTo>
                  <a:pt x="1776" y="1944"/>
                </a:lnTo>
                <a:lnTo>
                  <a:pt x="1784" y="1944"/>
                </a:lnTo>
                <a:lnTo>
                  <a:pt x="1792" y="1944"/>
                </a:lnTo>
                <a:lnTo>
                  <a:pt x="1800" y="1944"/>
                </a:lnTo>
                <a:lnTo>
                  <a:pt x="1808" y="1944"/>
                </a:lnTo>
                <a:lnTo>
                  <a:pt x="1816" y="1944"/>
                </a:lnTo>
                <a:lnTo>
                  <a:pt x="1824" y="1944"/>
                </a:lnTo>
                <a:lnTo>
                  <a:pt x="1832" y="1944"/>
                </a:lnTo>
                <a:lnTo>
                  <a:pt x="1840" y="1944"/>
                </a:lnTo>
                <a:lnTo>
                  <a:pt x="1848" y="1944"/>
                </a:lnTo>
                <a:lnTo>
                  <a:pt x="1856" y="1944"/>
                </a:lnTo>
                <a:lnTo>
                  <a:pt x="1864" y="1944"/>
                </a:lnTo>
                <a:lnTo>
                  <a:pt x="1872" y="1944"/>
                </a:lnTo>
                <a:lnTo>
                  <a:pt x="1880" y="1944"/>
                </a:lnTo>
                <a:lnTo>
                  <a:pt x="1888" y="1944"/>
                </a:lnTo>
                <a:lnTo>
                  <a:pt x="1896" y="1944"/>
                </a:lnTo>
                <a:lnTo>
                  <a:pt x="1904" y="1944"/>
                </a:lnTo>
                <a:lnTo>
                  <a:pt x="1912" y="1944"/>
                </a:lnTo>
                <a:lnTo>
                  <a:pt x="1920" y="1944"/>
                </a:lnTo>
                <a:lnTo>
                  <a:pt x="1928" y="1944"/>
                </a:lnTo>
                <a:lnTo>
                  <a:pt x="1936" y="1944"/>
                </a:lnTo>
                <a:lnTo>
                  <a:pt x="1944" y="1944"/>
                </a:lnTo>
                <a:lnTo>
                  <a:pt x="1952" y="1944"/>
                </a:lnTo>
                <a:lnTo>
                  <a:pt x="1960" y="1944"/>
                </a:lnTo>
                <a:lnTo>
                  <a:pt x="1968" y="1944"/>
                </a:lnTo>
                <a:lnTo>
                  <a:pt x="1976" y="1944"/>
                </a:lnTo>
                <a:lnTo>
                  <a:pt x="1984" y="1944"/>
                </a:lnTo>
                <a:lnTo>
                  <a:pt x="1992" y="1944"/>
                </a:lnTo>
                <a:lnTo>
                  <a:pt x="2000" y="1944"/>
                </a:lnTo>
                <a:lnTo>
                  <a:pt x="2008" y="1944"/>
                </a:lnTo>
                <a:lnTo>
                  <a:pt x="2016" y="1944"/>
                </a:lnTo>
                <a:lnTo>
                  <a:pt x="2024" y="1944"/>
                </a:lnTo>
                <a:lnTo>
                  <a:pt x="2032" y="1944"/>
                </a:lnTo>
              </a:path>
            </a:pathLst>
          </a:custGeom>
          <a:noFill/>
          <a:ln w="1260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440" name=""/>
          <p:cNvSpPr/>
          <p:nvPr/>
        </p:nvSpPr>
        <p:spPr>
          <a:xfrm>
            <a:off x="5021280" y="2943360"/>
            <a:ext cx="1425600" cy="1207800"/>
          </a:xfrm>
          <a:custGeom>
            <a:avLst/>
            <a:gdLst/>
            <a:ahLst/>
            <a:rect l="l" t="t" r="r" b="b"/>
            <a:pathLst>
              <a:path w="2032" h="2040">
                <a:moveTo>
                  <a:pt x="0" y="2040"/>
                </a:moveTo>
                <a:lnTo>
                  <a:pt x="0" y="0"/>
                </a:lnTo>
                <a:lnTo>
                  <a:pt x="0" y="1552"/>
                </a:lnTo>
                <a:lnTo>
                  <a:pt x="8" y="1472"/>
                </a:lnTo>
                <a:lnTo>
                  <a:pt x="16" y="1464"/>
                </a:lnTo>
                <a:lnTo>
                  <a:pt x="24" y="1488"/>
                </a:lnTo>
                <a:lnTo>
                  <a:pt x="32" y="1376"/>
                </a:lnTo>
                <a:lnTo>
                  <a:pt x="40" y="1136"/>
                </a:lnTo>
                <a:lnTo>
                  <a:pt x="48" y="1048"/>
                </a:lnTo>
                <a:lnTo>
                  <a:pt x="56" y="1064"/>
                </a:lnTo>
                <a:lnTo>
                  <a:pt x="64" y="1160"/>
                </a:lnTo>
                <a:lnTo>
                  <a:pt x="72" y="912"/>
                </a:lnTo>
                <a:lnTo>
                  <a:pt x="80" y="696"/>
                </a:lnTo>
                <a:lnTo>
                  <a:pt x="88" y="784"/>
                </a:lnTo>
                <a:lnTo>
                  <a:pt x="96" y="792"/>
                </a:lnTo>
                <a:lnTo>
                  <a:pt x="104" y="768"/>
                </a:lnTo>
                <a:lnTo>
                  <a:pt x="112" y="360"/>
                </a:lnTo>
                <a:lnTo>
                  <a:pt x="120" y="488"/>
                </a:lnTo>
                <a:lnTo>
                  <a:pt x="128" y="560"/>
                </a:lnTo>
                <a:lnTo>
                  <a:pt x="136" y="432"/>
                </a:lnTo>
                <a:lnTo>
                  <a:pt x="144" y="488"/>
                </a:lnTo>
                <a:lnTo>
                  <a:pt x="152" y="552"/>
                </a:lnTo>
                <a:lnTo>
                  <a:pt x="160" y="424"/>
                </a:lnTo>
                <a:lnTo>
                  <a:pt x="168" y="424"/>
                </a:lnTo>
                <a:lnTo>
                  <a:pt x="176" y="496"/>
                </a:lnTo>
                <a:lnTo>
                  <a:pt x="184" y="104"/>
                </a:lnTo>
                <a:lnTo>
                  <a:pt x="192" y="544"/>
                </a:lnTo>
                <a:lnTo>
                  <a:pt x="200" y="272"/>
                </a:lnTo>
                <a:lnTo>
                  <a:pt x="208" y="432"/>
                </a:lnTo>
                <a:lnTo>
                  <a:pt x="216" y="432"/>
                </a:lnTo>
                <a:lnTo>
                  <a:pt x="224" y="280"/>
                </a:lnTo>
                <a:lnTo>
                  <a:pt x="232" y="416"/>
                </a:lnTo>
                <a:lnTo>
                  <a:pt x="240" y="304"/>
                </a:lnTo>
                <a:lnTo>
                  <a:pt x="248" y="360"/>
                </a:lnTo>
                <a:lnTo>
                  <a:pt x="256" y="352"/>
                </a:lnTo>
                <a:lnTo>
                  <a:pt x="264" y="424"/>
                </a:lnTo>
                <a:lnTo>
                  <a:pt x="272" y="320"/>
                </a:lnTo>
                <a:lnTo>
                  <a:pt x="280" y="336"/>
                </a:lnTo>
                <a:lnTo>
                  <a:pt x="288" y="336"/>
                </a:lnTo>
                <a:lnTo>
                  <a:pt x="296" y="272"/>
                </a:lnTo>
                <a:lnTo>
                  <a:pt x="304" y="272"/>
                </a:lnTo>
                <a:lnTo>
                  <a:pt x="312" y="328"/>
                </a:lnTo>
                <a:lnTo>
                  <a:pt x="320" y="352"/>
                </a:lnTo>
                <a:lnTo>
                  <a:pt x="328" y="320"/>
                </a:lnTo>
                <a:lnTo>
                  <a:pt x="336" y="384"/>
                </a:lnTo>
                <a:lnTo>
                  <a:pt x="344" y="360"/>
                </a:lnTo>
                <a:lnTo>
                  <a:pt x="352" y="456"/>
                </a:lnTo>
                <a:lnTo>
                  <a:pt x="360" y="280"/>
                </a:lnTo>
                <a:lnTo>
                  <a:pt x="368" y="104"/>
                </a:lnTo>
                <a:lnTo>
                  <a:pt x="376" y="256"/>
                </a:lnTo>
                <a:lnTo>
                  <a:pt x="384" y="168"/>
                </a:lnTo>
                <a:lnTo>
                  <a:pt x="392" y="488"/>
                </a:lnTo>
                <a:lnTo>
                  <a:pt x="400" y="304"/>
                </a:lnTo>
                <a:lnTo>
                  <a:pt x="408" y="528"/>
                </a:lnTo>
                <a:lnTo>
                  <a:pt x="416" y="120"/>
                </a:lnTo>
                <a:lnTo>
                  <a:pt x="424" y="448"/>
                </a:lnTo>
                <a:lnTo>
                  <a:pt x="432" y="416"/>
                </a:lnTo>
                <a:lnTo>
                  <a:pt x="440" y="624"/>
                </a:lnTo>
                <a:lnTo>
                  <a:pt x="448" y="408"/>
                </a:lnTo>
                <a:lnTo>
                  <a:pt x="456" y="472"/>
                </a:lnTo>
                <a:lnTo>
                  <a:pt x="464" y="1104"/>
                </a:lnTo>
                <a:lnTo>
                  <a:pt x="472" y="672"/>
                </a:lnTo>
                <a:lnTo>
                  <a:pt x="480" y="936"/>
                </a:lnTo>
                <a:lnTo>
                  <a:pt x="488" y="928"/>
                </a:lnTo>
                <a:lnTo>
                  <a:pt x="496" y="808"/>
                </a:lnTo>
                <a:lnTo>
                  <a:pt x="504" y="968"/>
                </a:lnTo>
                <a:lnTo>
                  <a:pt x="512" y="1256"/>
                </a:lnTo>
                <a:lnTo>
                  <a:pt x="520" y="1192"/>
                </a:lnTo>
                <a:lnTo>
                  <a:pt x="528" y="1288"/>
                </a:lnTo>
                <a:lnTo>
                  <a:pt x="536" y="1360"/>
                </a:lnTo>
                <a:lnTo>
                  <a:pt x="544" y="1400"/>
                </a:lnTo>
                <a:lnTo>
                  <a:pt x="552" y="1424"/>
                </a:lnTo>
                <a:lnTo>
                  <a:pt x="560" y="1408"/>
                </a:lnTo>
                <a:lnTo>
                  <a:pt x="568" y="1608"/>
                </a:lnTo>
                <a:lnTo>
                  <a:pt x="576" y="1560"/>
                </a:lnTo>
                <a:lnTo>
                  <a:pt x="584" y="1704"/>
                </a:lnTo>
                <a:lnTo>
                  <a:pt x="592" y="1776"/>
                </a:lnTo>
                <a:lnTo>
                  <a:pt x="600" y="1752"/>
                </a:lnTo>
                <a:lnTo>
                  <a:pt x="608" y="1800"/>
                </a:lnTo>
                <a:lnTo>
                  <a:pt x="616" y="1752"/>
                </a:lnTo>
                <a:lnTo>
                  <a:pt x="624" y="1864"/>
                </a:lnTo>
                <a:lnTo>
                  <a:pt x="632" y="1832"/>
                </a:lnTo>
                <a:lnTo>
                  <a:pt x="640" y="1896"/>
                </a:lnTo>
                <a:lnTo>
                  <a:pt x="648" y="1960"/>
                </a:lnTo>
                <a:lnTo>
                  <a:pt x="656" y="1896"/>
                </a:lnTo>
                <a:lnTo>
                  <a:pt x="664" y="1880"/>
                </a:lnTo>
                <a:lnTo>
                  <a:pt x="672" y="1960"/>
                </a:lnTo>
                <a:lnTo>
                  <a:pt x="680" y="1968"/>
                </a:lnTo>
                <a:lnTo>
                  <a:pt x="688" y="1960"/>
                </a:lnTo>
                <a:lnTo>
                  <a:pt x="696" y="1960"/>
                </a:lnTo>
                <a:lnTo>
                  <a:pt x="704" y="1992"/>
                </a:lnTo>
                <a:lnTo>
                  <a:pt x="712" y="1944"/>
                </a:lnTo>
                <a:lnTo>
                  <a:pt x="720" y="2008"/>
                </a:lnTo>
                <a:lnTo>
                  <a:pt x="728" y="2016"/>
                </a:lnTo>
                <a:lnTo>
                  <a:pt x="736" y="2032"/>
                </a:lnTo>
                <a:lnTo>
                  <a:pt x="744" y="2016"/>
                </a:lnTo>
                <a:lnTo>
                  <a:pt x="752" y="2032"/>
                </a:lnTo>
                <a:lnTo>
                  <a:pt x="760" y="2016"/>
                </a:lnTo>
                <a:lnTo>
                  <a:pt x="768" y="2024"/>
                </a:lnTo>
                <a:lnTo>
                  <a:pt x="776" y="2032"/>
                </a:lnTo>
                <a:lnTo>
                  <a:pt x="784" y="2040"/>
                </a:lnTo>
                <a:lnTo>
                  <a:pt x="792" y="2040"/>
                </a:lnTo>
                <a:lnTo>
                  <a:pt x="800" y="2040"/>
                </a:lnTo>
                <a:lnTo>
                  <a:pt x="808" y="2040"/>
                </a:lnTo>
                <a:lnTo>
                  <a:pt x="816" y="2040"/>
                </a:lnTo>
                <a:lnTo>
                  <a:pt x="824" y="2040"/>
                </a:lnTo>
                <a:lnTo>
                  <a:pt x="832" y="2040"/>
                </a:lnTo>
                <a:lnTo>
                  <a:pt x="840" y="2040"/>
                </a:lnTo>
                <a:lnTo>
                  <a:pt x="848" y="2040"/>
                </a:lnTo>
                <a:lnTo>
                  <a:pt x="856" y="2040"/>
                </a:lnTo>
                <a:lnTo>
                  <a:pt x="864" y="2040"/>
                </a:lnTo>
                <a:lnTo>
                  <a:pt x="872" y="2040"/>
                </a:lnTo>
                <a:lnTo>
                  <a:pt x="880" y="2040"/>
                </a:lnTo>
                <a:lnTo>
                  <a:pt x="888" y="2040"/>
                </a:lnTo>
                <a:lnTo>
                  <a:pt x="896" y="2040"/>
                </a:lnTo>
                <a:lnTo>
                  <a:pt x="904" y="2040"/>
                </a:lnTo>
                <a:lnTo>
                  <a:pt x="912" y="2040"/>
                </a:lnTo>
                <a:lnTo>
                  <a:pt x="920" y="2040"/>
                </a:lnTo>
                <a:lnTo>
                  <a:pt x="928" y="2040"/>
                </a:lnTo>
                <a:lnTo>
                  <a:pt x="936" y="2040"/>
                </a:lnTo>
                <a:lnTo>
                  <a:pt x="944" y="2040"/>
                </a:lnTo>
                <a:lnTo>
                  <a:pt x="952" y="2040"/>
                </a:lnTo>
                <a:lnTo>
                  <a:pt x="960" y="2040"/>
                </a:lnTo>
                <a:lnTo>
                  <a:pt x="968" y="2040"/>
                </a:lnTo>
                <a:lnTo>
                  <a:pt x="976" y="2040"/>
                </a:lnTo>
                <a:lnTo>
                  <a:pt x="984" y="2040"/>
                </a:lnTo>
                <a:lnTo>
                  <a:pt x="992" y="2040"/>
                </a:lnTo>
                <a:lnTo>
                  <a:pt x="1000" y="2040"/>
                </a:lnTo>
                <a:lnTo>
                  <a:pt x="1008" y="2040"/>
                </a:lnTo>
                <a:lnTo>
                  <a:pt x="1016" y="2040"/>
                </a:lnTo>
                <a:lnTo>
                  <a:pt x="1024" y="2040"/>
                </a:lnTo>
                <a:lnTo>
                  <a:pt x="1032" y="2040"/>
                </a:lnTo>
                <a:lnTo>
                  <a:pt x="1040" y="2040"/>
                </a:lnTo>
                <a:lnTo>
                  <a:pt x="1048" y="2040"/>
                </a:lnTo>
                <a:lnTo>
                  <a:pt x="1056" y="2040"/>
                </a:lnTo>
                <a:lnTo>
                  <a:pt x="1064" y="2040"/>
                </a:lnTo>
                <a:lnTo>
                  <a:pt x="1072" y="2040"/>
                </a:lnTo>
                <a:lnTo>
                  <a:pt x="1080" y="2040"/>
                </a:lnTo>
                <a:lnTo>
                  <a:pt x="1088" y="2040"/>
                </a:lnTo>
                <a:lnTo>
                  <a:pt x="1096" y="2040"/>
                </a:lnTo>
                <a:lnTo>
                  <a:pt x="1104" y="2040"/>
                </a:lnTo>
                <a:lnTo>
                  <a:pt x="1112" y="2040"/>
                </a:lnTo>
                <a:lnTo>
                  <a:pt x="1120" y="2040"/>
                </a:lnTo>
                <a:lnTo>
                  <a:pt x="1128" y="2040"/>
                </a:lnTo>
                <a:lnTo>
                  <a:pt x="1136" y="2040"/>
                </a:lnTo>
                <a:lnTo>
                  <a:pt x="1144" y="2040"/>
                </a:lnTo>
                <a:lnTo>
                  <a:pt x="1152" y="2040"/>
                </a:lnTo>
                <a:lnTo>
                  <a:pt x="1160" y="2040"/>
                </a:lnTo>
                <a:lnTo>
                  <a:pt x="1168" y="2040"/>
                </a:lnTo>
                <a:lnTo>
                  <a:pt x="1176" y="2040"/>
                </a:lnTo>
                <a:lnTo>
                  <a:pt x="1184" y="2040"/>
                </a:lnTo>
                <a:lnTo>
                  <a:pt x="1192" y="2040"/>
                </a:lnTo>
                <a:lnTo>
                  <a:pt x="1200" y="2040"/>
                </a:lnTo>
                <a:lnTo>
                  <a:pt x="1208" y="2040"/>
                </a:lnTo>
                <a:lnTo>
                  <a:pt x="1216" y="2040"/>
                </a:lnTo>
                <a:lnTo>
                  <a:pt x="1224" y="2040"/>
                </a:lnTo>
                <a:lnTo>
                  <a:pt x="1232" y="2040"/>
                </a:lnTo>
                <a:lnTo>
                  <a:pt x="1240" y="2040"/>
                </a:lnTo>
                <a:lnTo>
                  <a:pt x="1248" y="2040"/>
                </a:lnTo>
                <a:lnTo>
                  <a:pt x="1256" y="2040"/>
                </a:lnTo>
                <a:lnTo>
                  <a:pt x="1264" y="2040"/>
                </a:lnTo>
                <a:lnTo>
                  <a:pt x="1272" y="2040"/>
                </a:lnTo>
                <a:lnTo>
                  <a:pt x="1280" y="2040"/>
                </a:lnTo>
                <a:lnTo>
                  <a:pt x="1288" y="2040"/>
                </a:lnTo>
                <a:lnTo>
                  <a:pt x="1296" y="2040"/>
                </a:lnTo>
                <a:lnTo>
                  <a:pt x="1304" y="2040"/>
                </a:lnTo>
                <a:lnTo>
                  <a:pt x="1312" y="2040"/>
                </a:lnTo>
                <a:lnTo>
                  <a:pt x="1320" y="2040"/>
                </a:lnTo>
                <a:lnTo>
                  <a:pt x="1328" y="2040"/>
                </a:lnTo>
                <a:lnTo>
                  <a:pt x="1336" y="2040"/>
                </a:lnTo>
                <a:lnTo>
                  <a:pt x="1344" y="2040"/>
                </a:lnTo>
                <a:lnTo>
                  <a:pt x="1352" y="2040"/>
                </a:lnTo>
                <a:lnTo>
                  <a:pt x="1360" y="2040"/>
                </a:lnTo>
                <a:lnTo>
                  <a:pt x="1368" y="2040"/>
                </a:lnTo>
                <a:lnTo>
                  <a:pt x="1376" y="2040"/>
                </a:lnTo>
                <a:lnTo>
                  <a:pt x="1384" y="2040"/>
                </a:lnTo>
                <a:lnTo>
                  <a:pt x="1392" y="2040"/>
                </a:lnTo>
                <a:lnTo>
                  <a:pt x="1400" y="2040"/>
                </a:lnTo>
                <a:lnTo>
                  <a:pt x="1408" y="2040"/>
                </a:lnTo>
                <a:lnTo>
                  <a:pt x="1416" y="2040"/>
                </a:lnTo>
                <a:lnTo>
                  <a:pt x="1424" y="2040"/>
                </a:lnTo>
                <a:lnTo>
                  <a:pt x="1432" y="2040"/>
                </a:lnTo>
                <a:lnTo>
                  <a:pt x="1440" y="2040"/>
                </a:lnTo>
                <a:lnTo>
                  <a:pt x="1448" y="2040"/>
                </a:lnTo>
                <a:lnTo>
                  <a:pt x="1456" y="2040"/>
                </a:lnTo>
                <a:lnTo>
                  <a:pt x="1464" y="2040"/>
                </a:lnTo>
                <a:lnTo>
                  <a:pt x="1472" y="2040"/>
                </a:lnTo>
                <a:lnTo>
                  <a:pt x="1480" y="2040"/>
                </a:lnTo>
                <a:lnTo>
                  <a:pt x="1488" y="2040"/>
                </a:lnTo>
                <a:lnTo>
                  <a:pt x="1496" y="2040"/>
                </a:lnTo>
                <a:lnTo>
                  <a:pt x="1504" y="2040"/>
                </a:lnTo>
                <a:lnTo>
                  <a:pt x="1512" y="2040"/>
                </a:lnTo>
                <a:lnTo>
                  <a:pt x="1520" y="2040"/>
                </a:lnTo>
                <a:lnTo>
                  <a:pt x="1528" y="2040"/>
                </a:lnTo>
                <a:lnTo>
                  <a:pt x="1536" y="2040"/>
                </a:lnTo>
                <a:lnTo>
                  <a:pt x="1544" y="2040"/>
                </a:lnTo>
                <a:lnTo>
                  <a:pt x="1552" y="2040"/>
                </a:lnTo>
                <a:lnTo>
                  <a:pt x="1560" y="2040"/>
                </a:lnTo>
                <a:lnTo>
                  <a:pt x="1568" y="2040"/>
                </a:lnTo>
                <a:lnTo>
                  <a:pt x="1576" y="2040"/>
                </a:lnTo>
                <a:lnTo>
                  <a:pt x="1584" y="2040"/>
                </a:lnTo>
                <a:lnTo>
                  <a:pt x="1592" y="2040"/>
                </a:lnTo>
                <a:lnTo>
                  <a:pt x="1600" y="2040"/>
                </a:lnTo>
                <a:lnTo>
                  <a:pt x="1608" y="2040"/>
                </a:lnTo>
                <a:lnTo>
                  <a:pt x="1616" y="2040"/>
                </a:lnTo>
                <a:lnTo>
                  <a:pt x="1624" y="2040"/>
                </a:lnTo>
                <a:lnTo>
                  <a:pt x="1632" y="2040"/>
                </a:lnTo>
                <a:lnTo>
                  <a:pt x="1640" y="2040"/>
                </a:lnTo>
                <a:lnTo>
                  <a:pt x="1648" y="2040"/>
                </a:lnTo>
                <a:lnTo>
                  <a:pt x="1656" y="2040"/>
                </a:lnTo>
                <a:lnTo>
                  <a:pt x="1664" y="2040"/>
                </a:lnTo>
                <a:lnTo>
                  <a:pt x="1672" y="2040"/>
                </a:lnTo>
                <a:lnTo>
                  <a:pt x="1680" y="2040"/>
                </a:lnTo>
                <a:lnTo>
                  <a:pt x="1688" y="2040"/>
                </a:lnTo>
                <a:lnTo>
                  <a:pt x="1696" y="2040"/>
                </a:lnTo>
                <a:lnTo>
                  <a:pt x="1704" y="2040"/>
                </a:lnTo>
                <a:lnTo>
                  <a:pt x="1712" y="2040"/>
                </a:lnTo>
                <a:lnTo>
                  <a:pt x="1720" y="2040"/>
                </a:lnTo>
                <a:lnTo>
                  <a:pt x="1728" y="2040"/>
                </a:lnTo>
                <a:lnTo>
                  <a:pt x="1736" y="2040"/>
                </a:lnTo>
                <a:lnTo>
                  <a:pt x="1744" y="2040"/>
                </a:lnTo>
                <a:lnTo>
                  <a:pt x="1752" y="2040"/>
                </a:lnTo>
                <a:lnTo>
                  <a:pt x="1760" y="2040"/>
                </a:lnTo>
                <a:lnTo>
                  <a:pt x="1768" y="2040"/>
                </a:lnTo>
                <a:lnTo>
                  <a:pt x="1776" y="2040"/>
                </a:lnTo>
                <a:lnTo>
                  <a:pt x="1784" y="2040"/>
                </a:lnTo>
                <a:lnTo>
                  <a:pt x="1792" y="2040"/>
                </a:lnTo>
                <a:lnTo>
                  <a:pt x="1800" y="2040"/>
                </a:lnTo>
                <a:lnTo>
                  <a:pt x="1808" y="2040"/>
                </a:lnTo>
                <a:lnTo>
                  <a:pt x="1816" y="2040"/>
                </a:lnTo>
                <a:lnTo>
                  <a:pt x="1824" y="2040"/>
                </a:lnTo>
                <a:lnTo>
                  <a:pt x="1832" y="2040"/>
                </a:lnTo>
                <a:lnTo>
                  <a:pt x="1840" y="2040"/>
                </a:lnTo>
                <a:lnTo>
                  <a:pt x="1848" y="2040"/>
                </a:lnTo>
                <a:lnTo>
                  <a:pt x="1856" y="2040"/>
                </a:lnTo>
                <a:lnTo>
                  <a:pt x="1864" y="2040"/>
                </a:lnTo>
                <a:lnTo>
                  <a:pt x="1872" y="2040"/>
                </a:lnTo>
                <a:lnTo>
                  <a:pt x="1880" y="2040"/>
                </a:lnTo>
                <a:lnTo>
                  <a:pt x="1888" y="2040"/>
                </a:lnTo>
                <a:lnTo>
                  <a:pt x="1896" y="2040"/>
                </a:lnTo>
                <a:lnTo>
                  <a:pt x="1904" y="2040"/>
                </a:lnTo>
                <a:lnTo>
                  <a:pt x="1912" y="2040"/>
                </a:lnTo>
                <a:lnTo>
                  <a:pt x="1920" y="2040"/>
                </a:lnTo>
                <a:lnTo>
                  <a:pt x="1928" y="2040"/>
                </a:lnTo>
                <a:lnTo>
                  <a:pt x="1936" y="2040"/>
                </a:lnTo>
                <a:lnTo>
                  <a:pt x="1944" y="2040"/>
                </a:lnTo>
                <a:lnTo>
                  <a:pt x="1952" y="2040"/>
                </a:lnTo>
                <a:lnTo>
                  <a:pt x="1960" y="2040"/>
                </a:lnTo>
                <a:lnTo>
                  <a:pt x="1968" y="2040"/>
                </a:lnTo>
                <a:lnTo>
                  <a:pt x="1976" y="2040"/>
                </a:lnTo>
                <a:lnTo>
                  <a:pt x="1984" y="2040"/>
                </a:lnTo>
                <a:lnTo>
                  <a:pt x="1992" y="2040"/>
                </a:lnTo>
                <a:lnTo>
                  <a:pt x="2000" y="2040"/>
                </a:lnTo>
                <a:lnTo>
                  <a:pt x="2008" y="2040"/>
                </a:lnTo>
                <a:lnTo>
                  <a:pt x="2016" y="2040"/>
                </a:lnTo>
                <a:lnTo>
                  <a:pt x="2024" y="2040"/>
                </a:lnTo>
                <a:lnTo>
                  <a:pt x="2032" y="2040"/>
                </a:lnTo>
              </a:path>
            </a:pathLst>
          </a:custGeom>
          <a:noFill/>
          <a:ln w="12600">
            <a:solidFill>
              <a:srgbClr val="0000ff"/>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441" name=""/>
          <p:cNvSpPr/>
          <p:nvPr/>
        </p:nvSpPr>
        <p:spPr>
          <a:xfrm>
            <a:off x="6848640" y="2943360"/>
            <a:ext cx="1454040" cy="1225440"/>
          </a:xfrm>
          <a:prstGeom prst="rect">
            <a:avLst/>
          </a:prstGeom>
          <a:solidFill>
            <a:srgbClr val="ffffff"/>
          </a:solidFill>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442" name=""/>
          <p:cNvSpPr/>
          <p:nvPr/>
        </p:nvSpPr>
        <p:spPr>
          <a:xfrm>
            <a:off x="6848640" y="4164120"/>
            <a:ext cx="14475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nvGrpSpPr>
          <p:cNvPr id="443" name=""/>
          <p:cNvGrpSpPr/>
          <p:nvPr/>
        </p:nvGrpSpPr>
        <p:grpSpPr>
          <a:xfrm>
            <a:off x="6848640" y="4168800"/>
            <a:ext cx="1449000" cy="28440"/>
            <a:chOff x="6848640" y="4168800"/>
            <a:chExt cx="1449000" cy="28440"/>
          </a:xfrm>
        </p:grpSpPr>
        <p:sp>
          <p:nvSpPr>
            <p:cNvPr id="444" name=""/>
            <p:cNvSpPr/>
            <p:nvPr/>
          </p:nvSpPr>
          <p:spPr>
            <a:xfrm>
              <a:off x="6848640" y="4168800"/>
              <a:ext cx="72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sp>
          <p:nvSpPr>
            <p:cNvPr id="445" name=""/>
            <p:cNvSpPr/>
            <p:nvPr/>
          </p:nvSpPr>
          <p:spPr>
            <a:xfrm>
              <a:off x="6955200" y="416880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46" name=""/>
            <p:cNvSpPr/>
            <p:nvPr/>
          </p:nvSpPr>
          <p:spPr>
            <a:xfrm>
              <a:off x="7017120" y="416880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47" name=""/>
            <p:cNvSpPr/>
            <p:nvPr/>
          </p:nvSpPr>
          <p:spPr>
            <a:xfrm>
              <a:off x="7061760" y="416880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48" name=""/>
            <p:cNvSpPr/>
            <p:nvPr/>
          </p:nvSpPr>
          <p:spPr>
            <a:xfrm>
              <a:off x="7101360" y="4168800"/>
              <a:ext cx="36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449" name=""/>
            <p:cNvSpPr/>
            <p:nvPr/>
          </p:nvSpPr>
          <p:spPr>
            <a:xfrm>
              <a:off x="7129440" y="416880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50" name=""/>
            <p:cNvSpPr/>
            <p:nvPr/>
          </p:nvSpPr>
          <p:spPr>
            <a:xfrm>
              <a:off x="7151760" y="416880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51" name=""/>
            <p:cNvSpPr/>
            <p:nvPr/>
          </p:nvSpPr>
          <p:spPr>
            <a:xfrm>
              <a:off x="7174080" y="416880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52" name=""/>
            <p:cNvSpPr/>
            <p:nvPr/>
          </p:nvSpPr>
          <p:spPr>
            <a:xfrm>
              <a:off x="7191000" y="416880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53" name=""/>
            <p:cNvSpPr/>
            <p:nvPr/>
          </p:nvSpPr>
          <p:spPr>
            <a:xfrm>
              <a:off x="7207920" y="4168800"/>
              <a:ext cx="36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sp>
          <p:nvSpPr>
            <p:cNvPr id="454" name=""/>
            <p:cNvSpPr/>
            <p:nvPr/>
          </p:nvSpPr>
          <p:spPr>
            <a:xfrm>
              <a:off x="7320240" y="416880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55" name=""/>
            <p:cNvSpPr/>
            <p:nvPr/>
          </p:nvSpPr>
          <p:spPr>
            <a:xfrm>
              <a:off x="7382160" y="416880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56" name=""/>
            <p:cNvSpPr/>
            <p:nvPr/>
          </p:nvSpPr>
          <p:spPr>
            <a:xfrm>
              <a:off x="7426800" y="416880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57" name=""/>
            <p:cNvSpPr/>
            <p:nvPr/>
          </p:nvSpPr>
          <p:spPr>
            <a:xfrm>
              <a:off x="7460640" y="4168800"/>
              <a:ext cx="36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458" name=""/>
            <p:cNvSpPr/>
            <p:nvPr/>
          </p:nvSpPr>
          <p:spPr>
            <a:xfrm>
              <a:off x="7494120" y="416880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59" name=""/>
            <p:cNvSpPr/>
            <p:nvPr/>
          </p:nvSpPr>
          <p:spPr>
            <a:xfrm>
              <a:off x="7516800" y="416880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60" name=""/>
            <p:cNvSpPr/>
            <p:nvPr/>
          </p:nvSpPr>
          <p:spPr>
            <a:xfrm>
              <a:off x="7539120" y="416880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61" name=""/>
            <p:cNvSpPr/>
            <p:nvPr/>
          </p:nvSpPr>
          <p:spPr>
            <a:xfrm>
              <a:off x="7556040" y="416880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62" name=""/>
            <p:cNvSpPr/>
            <p:nvPr/>
          </p:nvSpPr>
          <p:spPr>
            <a:xfrm>
              <a:off x="7572960" y="4168800"/>
              <a:ext cx="72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sp>
          <p:nvSpPr>
            <p:cNvPr id="463" name=""/>
            <p:cNvSpPr/>
            <p:nvPr/>
          </p:nvSpPr>
          <p:spPr>
            <a:xfrm>
              <a:off x="7679520" y="416880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64" name=""/>
            <p:cNvSpPr/>
            <p:nvPr/>
          </p:nvSpPr>
          <p:spPr>
            <a:xfrm>
              <a:off x="7747200" y="416880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65" name=""/>
            <p:cNvSpPr/>
            <p:nvPr/>
          </p:nvSpPr>
          <p:spPr>
            <a:xfrm>
              <a:off x="7791840" y="416880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66" name=""/>
            <p:cNvSpPr/>
            <p:nvPr/>
          </p:nvSpPr>
          <p:spPr>
            <a:xfrm>
              <a:off x="7825680" y="4168800"/>
              <a:ext cx="36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467" name=""/>
            <p:cNvSpPr/>
            <p:nvPr/>
          </p:nvSpPr>
          <p:spPr>
            <a:xfrm>
              <a:off x="7853760" y="416880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68" name=""/>
            <p:cNvSpPr/>
            <p:nvPr/>
          </p:nvSpPr>
          <p:spPr>
            <a:xfrm>
              <a:off x="7881840" y="416880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69" name=""/>
            <p:cNvSpPr/>
            <p:nvPr/>
          </p:nvSpPr>
          <p:spPr>
            <a:xfrm>
              <a:off x="7898760" y="416880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70" name=""/>
            <p:cNvSpPr/>
            <p:nvPr/>
          </p:nvSpPr>
          <p:spPr>
            <a:xfrm>
              <a:off x="7921080" y="416880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71" name=""/>
            <p:cNvSpPr/>
            <p:nvPr/>
          </p:nvSpPr>
          <p:spPr>
            <a:xfrm>
              <a:off x="7938000" y="4168800"/>
              <a:ext cx="72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sp>
          <p:nvSpPr>
            <p:cNvPr id="472" name=""/>
            <p:cNvSpPr/>
            <p:nvPr/>
          </p:nvSpPr>
          <p:spPr>
            <a:xfrm>
              <a:off x="8044560" y="416880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73" name=""/>
            <p:cNvSpPr/>
            <p:nvPr/>
          </p:nvSpPr>
          <p:spPr>
            <a:xfrm>
              <a:off x="8112240" y="416880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74" name=""/>
            <p:cNvSpPr/>
            <p:nvPr/>
          </p:nvSpPr>
          <p:spPr>
            <a:xfrm>
              <a:off x="8156880" y="416880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75" name=""/>
            <p:cNvSpPr/>
            <p:nvPr/>
          </p:nvSpPr>
          <p:spPr>
            <a:xfrm>
              <a:off x="8190720" y="4168800"/>
              <a:ext cx="36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476" name=""/>
            <p:cNvSpPr/>
            <p:nvPr/>
          </p:nvSpPr>
          <p:spPr>
            <a:xfrm>
              <a:off x="8218800" y="416880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77" name=""/>
            <p:cNvSpPr/>
            <p:nvPr/>
          </p:nvSpPr>
          <p:spPr>
            <a:xfrm>
              <a:off x="8241120" y="416880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78" name=""/>
            <p:cNvSpPr/>
            <p:nvPr/>
          </p:nvSpPr>
          <p:spPr>
            <a:xfrm>
              <a:off x="8263800" y="416880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79" name=""/>
            <p:cNvSpPr/>
            <p:nvPr/>
          </p:nvSpPr>
          <p:spPr>
            <a:xfrm>
              <a:off x="8280360" y="416880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480" name=""/>
            <p:cNvSpPr/>
            <p:nvPr/>
          </p:nvSpPr>
          <p:spPr>
            <a:xfrm>
              <a:off x="8297280" y="4168800"/>
              <a:ext cx="36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grpSp>
      <p:sp>
        <p:nvSpPr>
          <p:cNvPr id="481" name=""/>
          <p:cNvSpPr/>
          <p:nvPr/>
        </p:nvSpPr>
        <p:spPr>
          <a:xfrm>
            <a:off x="7450920" y="4435560"/>
            <a:ext cx="31932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FL2-H</a:t>
            </a:r>
            <a:endParaRPr b="0" lang="en-US" sz="900" spc="-1" strike="noStrike">
              <a:solidFill>
                <a:srgbClr val="000000"/>
              </a:solidFill>
              <a:latin typeface="Arial"/>
            </a:endParaRPr>
          </a:p>
        </p:txBody>
      </p:sp>
      <p:sp>
        <p:nvSpPr>
          <p:cNvPr id="482" name=""/>
          <p:cNvSpPr/>
          <p:nvPr/>
        </p:nvSpPr>
        <p:spPr>
          <a:xfrm flipV="1">
            <a:off x="6848640" y="2943000"/>
            <a:ext cx="0" cy="122076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nvGrpSpPr>
          <p:cNvPr id="483" name=""/>
          <p:cNvGrpSpPr/>
          <p:nvPr/>
        </p:nvGrpSpPr>
        <p:grpSpPr>
          <a:xfrm>
            <a:off x="6675840" y="2922480"/>
            <a:ext cx="192600" cy="1353240"/>
            <a:chOff x="6675840" y="2922480"/>
            <a:chExt cx="192600" cy="1353240"/>
          </a:xfrm>
        </p:grpSpPr>
        <p:sp>
          <p:nvSpPr>
            <p:cNvPr id="484" name=""/>
            <p:cNvSpPr/>
            <p:nvPr/>
          </p:nvSpPr>
          <p:spPr>
            <a:xfrm>
              <a:off x="6754320" y="4138200"/>
              <a:ext cx="648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0</a:t>
              </a:r>
              <a:endParaRPr b="0" lang="en-US" sz="900" spc="-1" strike="noStrike">
                <a:solidFill>
                  <a:srgbClr val="000000"/>
                </a:solidFill>
                <a:latin typeface="Arial"/>
              </a:endParaRPr>
            </a:p>
          </p:txBody>
        </p:sp>
        <p:sp>
          <p:nvSpPr>
            <p:cNvPr id="485" name=""/>
            <p:cNvSpPr/>
            <p:nvPr/>
          </p:nvSpPr>
          <p:spPr>
            <a:xfrm>
              <a:off x="6675840" y="373500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0</a:t>
              </a:r>
              <a:endParaRPr b="0" lang="en-US" sz="900" spc="-1" strike="noStrike">
                <a:solidFill>
                  <a:srgbClr val="000000"/>
                </a:solidFill>
                <a:latin typeface="Arial"/>
              </a:endParaRPr>
            </a:p>
          </p:txBody>
        </p:sp>
        <p:sp>
          <p:nvSpPr>
            <p:cNvPr id="486" name=""/>
            <p:cNvSpPr/>
            <p:nvPr/>
          </p:nvSpPr>
          <p:spPr>
            <a:xfrm>
              <a:off x="6675840" y="333036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200</a:t>
              </a:r>
              <a:endParaRPr b="0" lang="en-US" sz="900" spc="-1" strike="noStrike">
                <a:solidFill>
                  <a:srgbClr val="000000"/>
                </a:solidFill>
                <a:latin typeface="Arial"/>
              </a:endParaRPr>
            </a:p>
          </p:txBody>
        </p:sp>
        <p:sp>
          <p:nvSpPr>
            <p:cNvPr id="487" name=""/>
            <p:cNvSpPr/>
            <p:nvPr/>
          </p:nvSpPr>
          <p:spPr>
            <a:xfrm>
              <a:off x="6675840" y="292248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300</a:t>
              </a:r>
              <a:endParaRPr b="0" lang="en-US" sz="900" spc="-1" strike="noStrike">
                <a:solidFill>
                  <a:srgbClr val="000000"/>
                </a:solidFill>
                <a:latin typeface="Arial"/>
              </a:endParaRPr>
            </a:p>
          </p:txBody>
        </p:sp>
      </p:grpSp>
      <p:grpSp>
        <p:nvGrpSpPr>
          <p:cNvPr id="488" name=""/>
          <p:cNvGrpSpPr/>
          <p:nvPr/>
        </p:nvGrpSpPr>
        <p:grpSpPr>
          <a:xfrm>
            <a:off x="6814800" y="2948040"/>
            <a:ext cx="33480" cy="1217160"/>
            <a:chOff x="6814800" y="2948040"/>
            <a:chExt cx="33480" cy="1217160"/>
          </a:xfrm>
        </p:grpSpPr>
        <p:sp>
          <p:nvSpPr>
            <p:cNvPr id="489" name=""/>
            <p:cNvSpPr/>
            <p:nvPr/>
          </p:nvSpPr>
          <p:spPr>
            <a:xfrm flipH="1">
              <a:off x="6814800" y="4164840"/>
              <a:ext cx="3348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490" name=""/>
            <p:cNvSpPr/>
            <p:nvPr/>
          </p:nvSpPr>
          <p:spPr>
            <a:xfrm flipH="1">
              <a:off x="6837120" y="406548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491" name=""/>
            <p:cNvSpPr/>
            <p:nvPr/>
          </p:nvSpPr>
          <p:spPr>
            <a:xfrm flipH="1">
              <a:off x="6837120" y="396612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492" name=""/>
            <p:cNvSpPr/>
            <p:nvPr/>
          </p:nvSpPr>
          <p:spPr>
            <a:xfrm flipH="1">
              <a:off x="6837120" y="386172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493" name=""/>
            <p:cNvSpPr/>
            <p:nvPr/>
          </p:nvSpPr>
          <p:spPr>
            <a:xfrm flipH="1">
              <a:off x="6814800" y="3762360"/>
              <a:ext cx="3348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494" name=""/>
            <p:cNvSpPr/>
            <p:nvPr/>
          </p:nvSpPr>
          <p:spPr>
            <a:xfrm flipH="1">
              <a:off x="6837120" y="365832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495" name=""/>
            <p:cNvSpPr/>
            <p:nvPr/>
          </p:nvSpPr>
          <p:spPr>
            <a:xfrm flipH="1">
              <a:off x="6837120" y="355896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496" name=""/>
            <p:cNvSpPr/>
            <p:nvPr/>
          </p:nvSpPr>
          <p:spPr>
            <a:xfrm flipH="1">
              <a:off x="6837120" y="345456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497" name=""/>
            <p:cNvSpPr/>
            <p:nvPr/>
          </p:nvSpPr>
          <p:spPr>
            <a:xfrm flipH="1">
              <a:off x="6814800" y="3355200"/>
              <a:ext cx="3348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498" name=""/>
            <p:cNvSpPr/>
            <p:nvPr/>
          </p:nvSpPr>
          <p:spPr>
            <a:xfrm flipH="1">
              <a:off x="6837120" y="325116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499" name=""/>
            <p:cNvSpPr/>
            <p:nvPr/>
          </p:nvSpPr>
          <p:spPr>
            <a:xfrm flipH="1">
              <a:off x="6837120" y="315144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500" name=""/>
            <p:cNvSpPr/>
            <p:nvPr/>
          </p:nvSpPr>
          <p:spPr>
            <a:xfrm flipH="1">
              <a:off x="6837120" y="304740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501" name=""/>
            <p:cNvSpPr/>
            <p:nvPr/>
          </p:nvSpPr>
          <p:spPr>
            <a:xfrm flipH="1">
              <a:off x="6814800" y="2948040"/>
              <a:ext cx="3348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grpSp>
      <p:sp>
        <p:nvSpPr>
          <p:cNvPr id="502" name=""/>
          <p:cNvSpPr/>
          <p:nvPr/>
        </p:nvSpPr>
        <p:spPr>
          <a:xfrm rot="16200000">
            <a:off x="6413760" y="3468240"/>
            <a:ext cx="3528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 Cells</a:t>
            </a:r>
            <a:endParaRPr b="0" lang="en-US" sz="900" spc="-1" strike="noStrike">
              <a:solidFill>
                <a:srgbClr val="000000"/>
              </a:solidFill>
              <a:latin typeface="Arial"/>
            </a:endParaRPr>
          </a:p>
        </p:txBody>
      </p:sp>
      <p:sp>
        <p:nvSpPr>
          <p:cNvPr id="503" name=""/>
          <p:cNvSpPr/>
          <p:nvPr/>
        </p:nvSpPr>
        <p:spPr>
          <a:xfrm>
            <a:off x="6859440" y="3009960"/>
            <a:ext cx="1425600" cy="1149120"/>
          </a:xfrm>
          <a:custGeom>
            <a:avLst/>
            <a:gdLst/>
            <a:ahLst/>
            <a:rect l="l" t="t" r="r" b="b"/>
            <a:pathLst>
              <a:path w="2032" h="1944">
                <a:moveTo>
                  <a:pt x="0" y="1944"/>
                </a:moveTo>
                <a:lnTo>
                  <a:pt x="0" y="1712"/>
                </a:lnTo>
                <a:lnTo>
                  <a:pt x="0" y="1928"/>
                </a:lnTo>
                <a:lnTo>
                  <a:pt x="8" y="1904"/>
                </a:lnTo>
                <a:lnTo>
                  <a:pt x="16" y="1920"/>
                </a:lnTo>
                <a:lnTo>
                  <a:pt x="24" y="1872"/>
                </a:lnTo>
                <a:lnTo>
                  <a:pt x="32" y="1824"/>
                </a:lnTo>
                <a:lnTo>
                  <a:pt x="40" y="1888"/>
                </a:lnTo>
                <a:lnTo>
                  <a:pt x="48" y="1856"/>
                </a:lnTo>
                <a:lnTo>
                  <a:pt x="56" y="1840"/>
                </a:lnTo>
                <a:lnTo>
                  <a:pt x="64" y="1792"/>
                </a:lnTo>
                <a:lnTo>
                  <a:pt x="72" y="1800"/>
                </a:lnTo>
                <a:lnTo>
                  <a:pt x="80" y="1784"/>
                </a:lnTo>
                <a:lnTo>
                  <a:pt x="88" y="1760"/>
                </a:lnTo>
                <a:lnTo>
                  <a:pt x="96" y="1760"/>
                </a:lnTo>
                <a:lnTo>
                  <a:pt x="104" y="1680"/>
                </a:lnTo>
                <a:lnTo>
                  <a:pt x="112" y="1640"/>
                </a:lnTo>
                <a:lnTo>
                  <a:pt x="120" y="1592"/>
                </a:lnTo>
                <a:lnTo>
                  <a:pt x="128" y="1488"/>
                </a:lnTo>
                <a:lnTo>
                  <a:pt x="136" y="1592"/>
                </a:lnTo>
                <a:lnTo>
                  <a:pt x="144" y="1584"/>
                </a:lnTo>
                <a:lnTo>
                  <a:pt x="152" y="1536"/>
                </a:lnTo>
                <a:lnTo>
                  <a:pt x="160" y="1400"/>
                </a:lnTo>
                <a:lnTo>
                  <a:pt x="168" y="1464"/>
                </a:lnTo>
                <a:lnTo>
                  <a:pt x="176" y="1248"/>
                </a:lnTo>
                <a:lnTo>
                  <a:pt x="184" y="1200"/>
                </a:lnTo>
                <a:lnTo>
                  <a:pt x="192" y="1352"/>
                </a:lnTo>
                <a:lnTo>
                  <a:pt x="200" y="1328"/>
                </a:lnTo>
                <a:lnTo>
                  <a:pt x="208" y="1048"/>
                </a:lnTo>
                <a:lnTo>
                  <a:pt x="216" y="1208"/>
                </a:lnTo>
                <a:lnTo>
                  <a:pt x="224" y="976"/>
                </a:lnTo>
                <a:lnTo>
                  <a:pt x="232" y="1032"/>
                </a:lnTo>
                <a:lnTo>
                  <a:pt x="240" y="1104"/>
                </a:lnTo>
                <a:lnTo>
                  <a:pt x="248" y="928"/>
                </a:lnTo>
                <a:lnTo>
                  <a:pt x="256" y="976"/>
                </a:lnTo>
                <a:lnTo>
                  <a:pt x="264" y="936"/>
                </a:lnTo>
                <a:lnTo>
                  <a:pt x="272" y="760"/>
                </a:lnTo>
                <a:lnTo>
                  <a:pt x="280" y="632"/>
                </a:lnTo>
                <a:lnTo>
                  <a:pt x="288" y="952"/>
                </a:lnTo>
                <a:lnTo>
                  <a:pt x="296" y="752"/>
                </a:lnTo>
                <a:lnTo>
                  <a:pt x="304" y="848"/>
                </a:lnTo>
                <a:lnTo>
                  <a:pt x="312" y="576"/>
                </a:lnTo>
                <a:lnTo>
                  <a:pt x="320" y="616"/>
                </a:lnTo>
                <a:lnTo>
                  <a:pt x="328" y="472"/>
                </a:lnTo>
                <a:lnTo>
                  <a:pt x="336" y="448"/>
                </a:lnTo>
                <a:lnTo>
                  <a:pt x="344" y="328"/>
                </a:lnTo>
                <a:lnTo>
                  <a:pt x="352" y="296"/>
                </a:lnTo>
                <a:lnTo>
                  <a:pt x="360" y="288"/>
                </a:lnTo>
                <a:lnTo>
                  <a:pt x="368" y="312"/>
                </a:lnTo>
                <a:lnTo>
                  <a:pt x="376" y="424"/>
                </a:lnTo>
                <a:lnTo>
                  <a:pt x="384" y="440"/>
                </a:lnTo>
                <a:lnTo>
                  <a:pt x="392" y="176"/>
                </a:lnTo>
                <a:lnTo>
                  <a:pt x="400" y="112"/>
                </a:lnTo>
                <a:lnTo>
                  <a:pt x="408" y="192"/>
                </a:lnTo>
                <a:lnTo>
                  <a:pt x="416" y="256"/>
                </a:lnTo>
                <a:lnTo>
                  <a:pt x="424" y="96"/>
                </a:lnTo>
                <a:lnTo>
                  <a:pt x="432" y="0"/>
                </a:lnTo>
                <a:lnTo>
                  <a:pt x="440" y="128"/>
                </a:lnTo>
                <a:lnTo>
                  <a:pt x="448" y="0"/>
                </a:lnTo>
                <a:lnTo>
                  <a:pt x="456" y="216"/>
                </a:lnTo>
                <a:lnTo>
                  <a:pt x="464" y="200"/>
                </a:lnTo>
                <a:lnTo>
                  <a:pt x="472" y="216"/>
                </a:lnTo>
                <a:lnTo>
                  <a:pt x="480" y="256"/>
                </a:lnTo>
                <a:lnTo>
                  <a:pt x="488" y="296"/>
                </a:lnTo>
                <a:lnTo>
                  <a:pt x="496" y="192"/>
                </a:lnTo>
                <a:lnTo>
                  <a:pt x="504" y="216"/>
                </a:lnTo>
                <a:lnTo>
                  <a:pt x="512" y="328"/>
                </a:lnTo>
                <a:lnTo>
                  <a:pt x="520" y="440"/>
                </a:lnTo>
                <a:lnTo>
                  <a:pt x="528" y="560"/>
                </a:lnTo>
                <a:lnTo>
                  <a:pt x="536" y="904"/>
                </a:lnTo>
                <a:lnTo>
                  <a:pt x="544" y="808"/>
                </a:lnTo>
                <a:lnTo>
                  <a:pt x="552" y="880"/>
                </a:lnTo>
                <a:lnTo>
                  <a:pt x="560" y="936"/>
                </a:lnTo>
                <a:lnTo>
                  <a:pt x="568" y="1112"/>
                </a:lnTo>
                <a:lnTo>
                  <a:pt x="576" y="1080"/>
                </a:lnTo>
                <a:lnTo>
                  <a:pt x="584" y="1240"/>
                </a:lnTo>
                <a:lnTo>
                  <a:pt x="592" y="1328"/>
                </a:lnTo>
                <a:lnTo>
                  <a:pt x="600" y="1352"/>
                </a:lnTo>
                <a:lnTo>
                  <a:pt x="608" y="1504"/>
                </a:lnTo>
                <a:lnTo>
                  <a:pt x="616" y="1408"/>
                </a:lnTo>
                <a:lnTo>
                  <a:pt x="624" y="1616"/>
                </a:lnTo>
                <a:lnTo>
                  <a:pt x="632" y="1624"/>
                </a:lnTo>
                <a:lnTo>
                  <a:pt x="640" y="1624"/>
                </a:lnTo>
                <a:lnTo>
                  <a:pt x="648" y="1728"/>
                </a:lnTo>
                <a:lnTo>
                  <a:pt x="656" y="1680"/>
                </a:lnTo>
                <a:lnTo>
                  <a:pt x="664" y="1728"/>
                </a:lnTo>
                <a:lnTo>
                  <a:pt x="672" y="1728"/>
                </a:lnTo>
                <a:lnTo>
                  <a:pt x="680" y="1704"/>
                </a:lnTo>
                <a:lnTo>
                  <a:pt x="688" y="1792"/>
                </a:lnTo>
                <a:lnTo>
                  <a:pt x="696" y="1784"/>
                </a:lnTo>
                <a:lnTo>
                  <a:pt x="704" y="1800"/>
                </a:lnTo>
                <a:lnTo>
                  <a:pt x="712" y="1776"/>
                </a:lnTo>
                <a:lnTo>
                  <a:pt x="720" y="1800"/>
                </a:lnTo>
                <a:lnTo>
                  <a:pt x="728" y="1848"/>
                </a:lnTo>
                <a:lnTo>
                  <a:pt x="736" y="1848"/>
                </a:lnTo>
                <a:lnTo>
                  <a:pt x="744" y="1856"/>
                </a:lnTo>
                <a:lnTo>
                  <a:pt x="752" y="1880"/>
                </a:lnTo>
                <a:lnTo>
                  <a:pt x="760" y="1880"/>
                </a:lnTo>
                <a:lnTo>
                  <a:pt x="768" y="1904"/>
                </a:lnTo>
                <a:lnTo>
                  <a:pt x="776" y="1880"/>
                </a:lnTo>
                <a:lnTo>
                  <a:pt x="784" y="1904"/>
                </a:lnTo>
                <a:lnTo>
                  <a:pt x="792" y="1872"/>
                </a:lnTo>
                <a:lnTo>
                  <a:pt x="800" y="1872"/>
                </a:lnTo>
                <a:lnTo>
                  <a:pt x="808" y="1912"/>
                </a:lnTo>
                <a:lnTo>
                  <a:pt x="816" y="1920"/>
                </a:lnTo>
                <a:lnTo>
                  <a:pt x="824" y="1912"/>
                </a:lnTo>
                <a:lnTo>
                  <a:pt x="832" y="1944"/>
                </a:lnTo>
                <a:lnTo>
                  <a:pt x="840" y="1928"/>
                </a:lnTo>
                <a:lnTo>
                  <a:pt x="848" y="1920"/>
                </a:lnTo>
                <a:lnTo>
                  <a:pt x="856" y="1944"/>
                </a:lnTo>
                <a:lnTo>
                  <a:pt x="864" y="1904"/>
                </a:lnTo>
                <a:lnTo>
                  <a:pt x="872" y="1944"/>
                </a:lnTo>
                <a:lnTo>
                  <a:pt x="880" y="1944"/>
                </a:lnTo>
                <a:lnTo>
                  <a:pt x="888" y="1944"/>
                </a:lnTo>
                <a:lnTo>
                  <a:pt x="896" y="1936"/>
                </a:lnTo>
                <a:lnTo>
                  <a:pt x="904" y="1944"/>
                </a:lnTo>
                <a:lnTo>
                  <a:pt x="912" y="1944"/>
                </a:lnTo>
                <a:lnTo>
                  <a:pt x="920" y="1944"/>
                </a:lnTo>
                <a:lnTo>
                  <a:pt x="928" y="1944"/>
                </a:lnTo>
                <a:lnTo>
                  <a:pt x="936" y="1944"/>
                </a:lnTo>
                <a:lnTo>
                  <a:pt x="944" y="1944"/>
                </a:lnTo>
                <a:lnTo>
                  <a:pt x="952" y="1944"/>
                </a:lnTo>
                <a:lnTo>
                  <a:pt x="960" y="1944"/>
                </a:lnTo>
                <a:lnTo>
                  <a:pt x="968" y="1944"/>
                </a:lnTo>
                <a:lnTo>
                  <a:pt x="976" y="1944"/>
                </a:lnTo>
                <a:lnTo>
                  <a:pt x="984" y="1944"/>
                </a:lnTo>
                <a:lnTo>
                  <a:pt x="992" y="1944"/>
                </a:lnTo>
                <a:lnTo>
                  <a:pt x="1000" y="1944"/>
                </a:lnTo>
                <a:lnTo>
                  <a:pt x="1008" y="1944"/>
                </a:lnTo>
                <a:lnTo>
                  <a:pt x="1016" y="1944"/>
                </a:lnTo>
                <a:lnTo>
                  <a:pt x="1024" y="1944"/>
                </a:lnTo>
                <a:lnTo>
                  <a:pt x="1032" y="1944"/>
                </a:lnTo>
                <a:lnTo>
                  <a:pt x="1040" y="1944"/>
                </a:lnTo>
                <a:lnTo>
                  <a:pt x="1048" y="1944"/>
                </a:lnTo>
                <a:lnTo>
                  <a:pt x="1056" y="1944"/>
                </a:lnTo>
                <a:lnTo>
                  <a:pt x="1064" y="1944"/>
                </a:lnTo>
                <a:lnTo>
                  <a:pt x="1072" y="1944"/>
                </a:lnTo>
                <a:lnTo>
                  <a:pt x="1080" y="1944"/>
                </a:lnTo>
                <a:lnTo>
                  <a:pt x="1088" y="1944"/>
                </a:lnTo>
                <a:lnTo>
                  <a:pt x="1096" y="1944"/>
                </a:lnTo>
                <a:lnTo>
                  <a:pt x="1104" y="1944"/>
                </a:lnTo>
                <a:lnTo>
                  <a:pt x="1112" y="1944"/>
                </a:lnTo>
                <a:lnTo>
                  <a:pt x="1120" y="1944"/>
                </a:lnTo>
                <a:lnTo>
                  <a:pt x="1128" y="1944"/>
                </a:lnTo>
                <a:lnTo>
                  <a:pt x="1136" y="1944"/>
                </a:lnTo>
                <a:lnTo>
                  <a:pt x="1144" y="1944"/>
                </a:lnTo>
                <a:lnTo>
                  <a:pt x="1152" y="1944"/>
                </a:lnTo>
                <a:lnTo>
                  <a:pt x="1160" y="1944"/>
                </a:lnTo>
                <a:lnTo>
                  <a:pt x="1168" y="1944"/>
                </a:lnTo>
                <a:lnTo>
                  <a:pt x="1176" y="1944"/>
                </a:lnTo>
                <a:lnTo>
                  <a:pt x="1184" y="1944"/>
                </a:lnTo>
                <a:lnTo>
                  <a:pt x="1192" y="1944"/>
                </a:lnTo>
                <a:lnTo>
                  <a:pt x="1200" y="1944"/>
                </a:lnTo>
                <a:lnTo>
                  <a:pt x="1208" y="1944"/>
                </a:lnTo>
                <a:lnTo>
                  <a:pt x="1216" y="1944"/>
                </a:lnTo>
                <a:lnTo>
                  <a:pt x="1224" y="1944"/>
                </a:lnTo>
                <a:lnTo>
                  <a:pt x="1232" y="1944"/>
                </a:lnTo>
                <a:lnTo>
                  <a:pt x="1240" y="1944"/>
                </a:lnTo>
                <a:lnTo>
                  <a:pt x="1248" y="1944"/>
                </a:lnTo>
                <a:lnTo>
                  <a:pt x="1256" y="1944"/>
                </a:lnTo>
                <a:lnTo>
                  <a:pt x="1264" y="1944"/>
                </a:lnTo>
                <a:lnTo>
                  <a:pt x="1272" y="1944"/>
                </a:lnTo>
                <a:lnTo>
                  <a:pt x="1280" y="1944"/>
                </a:lnTo>
                <a:lnTo>
                  <a:pt x="1288" y="1944"/>
                </a:lnTo>
                <a:lnTo>
                  <a:pt x="1296" y="1944"/>
                </a:lnTo>
                <a:lnTo>
                  <a:pt x="1304" y="1944"/>
                </a:lnTo>
                <a:lnTo>
                  <a:pt x="1312" y="1944"/>
                </a:lnTo>
                <a:lnTo>
                  <a:pt x="1320" y="1944"/>
                </a:lnTo>
                <a:lnTo>
                  <a:pt x="1328" y="1944"/>
                </a:lnTo>
                <a:lnTo>
                  <a:pt x="1336" y="1944"/>
                </a:lnTo>
                <a:lnTo>
                  <a:pt x="1344" y="1944"/>
                </a:lnTo>
                <a:lnTo>
                  <a:pt x="1352" y="1944"/>
                </a:lnTo>
                <a:lnTo>
                  <a:pt x="1360" y="1944"/>
                </a:lnTo>
                <a:lnTo>
                  <a:pt x="1368" y="1944"/>
                </a:lnTo>
                <a:lnTo>
                  <a:pt x="1376" y="1944"/>
                </a:lnTo>
                <a:lnTo>
                  <a:pt x="1384" y="1944"/>
                </a:lnTo>
                <a:lnTo>
                  <a:pt x="1392" y="1944"/>
                </a:lnTo>
                <a:lnTo>
                  <a:pt x="1400" y="1944"/>
                </a:lnTo>
                <a:lnTo>
                  <a:pt x="1408" y="1944"/>
                </a:lnTo>
                <a:lnTo>
                  <a:pt x="1416" y="1944"/>
                </a:lnTo>
                <a:lnTo>
                  <a:pt x="1424" y="1944"/>
                </a:lnTo>
                <a:lnTo>
                  <a:pt x="1432" y="1944"/>
                </a:lnTo>
                <a:lnTo>
                  <a:pt x="1440" y="1944"/>
                </a:lnTo>
                <a:lnTo>
                  <a:pt x="1448" y="1944"/>
                </a:lnTo>
                <a:lnTo>
                  <a:pt x="1456" y="1944"/>
                </a:lnTo>
                <a:lnTo>
                  <a:pt x="1464" y="1944"/>
                </a:lnTo>
                <a:lnTo>
                  <a:pt x="1472" y="1944"/>
                </a:lnTo>
                <a:lnTo>
                  <a:pt x="1480" y="1944"/>
                </a:lnTo>
                <a:lnTo>
                  <a:pt x="1488" y="1944"/>
                </a:lnTo>
                <a:lnTo>
                  <a:pt x="1496" y="1944"/>
                </a:lnTo>
                <a:lnTo>
                  <a:pt x="1504" y="1944"/>
                </a:lnTo>
                <a:lnTo>
                  <a:pt x="1512" y="1944"/>
                </a:lnTo>
                <a:lnTo>
                  <a:pt x="1520" y="1944"/>
                </a:lnTo>
                <a:lnTo>
                  <a:pt x="1528" y="1944"/>
                </a:lnTo>
                <a:lnTo>
                  <a:pt x="1536" y="1944"/>
                </a:lnTo>
                <a:lnTo>
                  <a:pt x="1544" y="1944"/>
                </a:lnTo>
                <a:lnTo>
                  <a:pt x="1552" y="1944"/>
                </a:lnTo>
                <a:lnTo>
                  <a:pt x="1560" y="1944"/>
                </a:lnTo>
                <a:lnTo>
                  <a:pt x="1568" y="1944"/>
                </a:lnTo>
                <a:lnTo>
                  <a:pt x="1576" y="1944"/>
                </a:lnTo>
                <a:lnTo>
                  <a:pt x="1584" y="1944"/>
                </a:lnTo>
                <a:lnTo>
                  <a:pt x="1592" y="1944"/>
                </a:lnTo>
                <a:lnTo>
                  <a:pt x="1600" y="1944"/>
                </a:lnTo>
                <a:lnTo>
                  <a:pt x="1608" y="1944"/>
                </a:lnTo>
                <a:lnTo>
                  <a:pt x="1616" y="1944"/>
                </a:lnTo>
                <a:lnTo>
                  <a:pt x="1624" y="1944"/>
                </a:lnTo>
                <a:lnTo>
                  <a:pt x="1632" y="1944"/>
                </a:lnTo>
                <a:lnTo>
                  <a:pt x="1640" y="1944"/>
                </a:lnTo>
                <a:lnTo>
                  <a:pt x="1648" y="1944"/>
                </a:lnTo>
                <a:lnTo>
                  <a:pt x="1656" y="1944"/>
                </a:lnTo>
                <a:lnTo>
                  <a:pt x="1664" y="1944"/>
                </a:lnTo>
                <a:lnTo>
                  <a:pt x="1672" y="1944"/>
                </a:lnTo>
                <a:lnTo>
                  <a:pt x="1680" y="1944"/>
                </a:lnTo>
                <a:lnTo>
                  <a:pt x="1688" y="1944"/>
                </a:lnTo>
                <a:lnTo>
                  <a:pt x="1696" y="1944"/>
                </a:lnTo>
                <a:lnTo>
                  <a:pt x="1704" y="1944"/>
                </a:lnTo>
                <a:lnTo>
                  <a:pt x="1712" y="1944"/>
                </a:lnTo>
                <a:lnTo>
                  <a:pt x="1720" y="1944"/>
                </a:lnTo>
                <a:lnTo>
                  <a:pt x="1728" y="1944"/>
                </a:lnTo>
                <a:lnTo>
                  <a:pt x="1736" y="1944"/>
                </a:lnTo>
                <a:lnTo>
                  <a:pt x="1744" y="1944"/>
                </a:lnTo>
                <a:lnTo>
                  <a:pt x="1752" y="1944"/>
                </a:lnTo>
                <a:lnTo>
                  <a:pt x="1760" y="1944"/>
                </a:lnTo>
                <a:lnTo>
                  <a:pt x="1768" y="1944"/>
                </a:lnTo>
                <a:lnTo>
                  <a:pt x="1776" y="1944"/>
                </a:lnTo>
                <a:lnTo>
                  <a:pt x="1784" y="1944"/>
                </a:lnTo>
                <a:lnTo>
                  <a:pt x="1792" y="1944"/>
                </a:lnTo>
                <a:lnTo>
                  <a:pt x="1800" y="1944"/>
                </a:lnTo>
                <a:lnTo>
                  <a:pt x="1808" y="1944"/>
                </a:lnTo>
                <a:lnTo>
                  <a:pt x="1816" y="1944"/>
                </a:lnTo>
                <a:lnTo>
                  <a:pt x="1824" y="1944"/>
                </a:lnTo>
                <a:lnTo>
                  <a:pt x="1832" y="1944"/>
                </a:lnTo>
                <a:lnTo>
                  <a:pt x="1840" y="1944"/>
                </a:lnTo>
                <a:lnTo>
                  <a:pt x="1848" y="1944"/>
                </a:lnTo>
                <a:lnTo>
                  <a:pt x="1856" y="1944"/>
                </a:lnTo>
                <a:lnTo>
                  <a:pt x="1864" y="1944"/>
                </a:lnTo>
                <a:lnTo>
                  <a:pt x="1872" y="1944"/>
                </a:lnTo>
                <a:lnTo>
                  <a:pt x="1880" y="1944"/>
                </a:lnTo>
                <a:lnTo>
                  <a:pt x="1888" y="1944"/>
                </a:lnTo>
                <a:lnTo>
                  <a:pt x="1896" y="1944"/>
                </a:lnTo>
                <a:lnTo>
                  <a:pt x="1904" y="1944"/>
                </a:lnTo>
                <a:lnTo>
                  <a:pt x="1912" y="1944"/>
                </a:lnTo>
                <a:lnTo>
                  <a:pt x="1920" y="1944"/>
                </a:lnTo>
                <a:lnTo>
                  <a:pt x="1928" y="1944"/>
                </a:lnTo>
                <a:lnTo>
                  <a:pt x="1936" y="1944"/>
                </a:lnTo>
                <a:lnTo>
                  <a:pt x="1944" y="1944"/>
                </a:lnTo>
                <a:lnTo>
                  <a:pt x="1952" y="1944"/>
                </a:lnTo>
                <a:lnTo>
                  <a:pt x="1960" y="1944"/>
                </a:lnTo>
                <a:lnTo>
                  <a:pt x="1968" y="1944"/>
                </a:lnTo>
                <a:lnTo>
                  <a:pt x="1976" y="1944"/>
                </a:lnTo>
                <a:lnTo>
                  <a:pt x="1984" y="1944"/>
                </a:lnTo>
                <a:lnTo>
                  <a:pt x="1992" y="1944"/>
                </a:lnTo>
                <a:lnTo>
                  <a:pt x="2000" y="1944"/>
                </a:lnTo>
                <a:lnTo>
                  <a:pt x="2008" y="1944"/>
                </a:lnTo>
                <a:lnTo>
                  <a:pt x="2016" y="1944"/>
                </a:lnTo>
                <a:lnTo>
                  <a:pt x="2024" y="1944"/>
                </a:lnTo>
                <a:lnTo>
                  <a:pt x="2032" y="1944"/>
                </a:lnTo>
              </a:path>
            </a:pathLst>
          </a:custGeom>
          <a:noFill/>
          <a:ln w="1260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504" name=""/>
          <p:cNvSpPr/>
          <p:nvPr/>
        </p:nvSpPr>
        <p:spPr>
          <a:xfrm>
            <a:off x="6859440" y="2952720"/>
            <a:ext cx="1425600" cy="1206360"/>
          </a:xfrm>
          <a:custGeom>
            <a:avLst/>
            <a:gdLst/>
            <a:ahLst/>
            <a:rect l="l" t="t" r="r" b="b"/>
            <a:pathLst>
              <a:path w="2032" h="2040">
                <a:moveTo>
                  <a:pt x="0" y="2040"/>
                </a:moveTo>
                <a:lnTo>
                  <a:pt x="0" y="0"/>
                </a:lnTo>
                <a:lnTo>
                  <a:pt x="0" y="1552"/>
                </a:lnTo>
                <a:lnTo>
                  <a:pt x="8" y="1472"/>
                </a:lnTo>
                <a:lnTo>
                  <a:pt x="16" y="1464"/>
                </a:lnTo>
                <a:lnTo>
                  <a:pt x="24" y="1488"/>
                </a:lnTo>
                <a:lnTo>
                  <a:pt x="32" y="1376"/>
                </a:lnTo>
                <a:lnTo>
                  <a:pt x="40" y="1136"/>
                </a:lnTo>
                <a:lnTo>
                  <a:pt x="48" y="1048"/>
                </a:lnTo>
                <a:lnTo>
                  <a:pt x="56" y="1064"/>
                </a:lnTo>
                <a:lnTo>
                  <a:pt x="64" y="1160"/>
                </a:lnTo>
                <a:lnTo>
                  <a:pt x="72" y="912"/>
                </a:lnTo>
                <a:lnTo>
                  <a:pt x="80" y="696"/>
                </a:lnTo>
                <a:lnTo>
                  <a:pt x="88" y="784"/>
                </a:lnTo>
                <a:lnTo>
                  <a:pt x="96" y="792"/>
                </a:lnTo>
                <a:lnTo>
                  <a:pt x="104" y="768"/>
                </a:lnTo>
                <a:lnTo>
                  <a:pt x="112" y="360"/>
                </a:lnTo>
                <a:lnTo>
                  <a:pt x="120" y="488"/>
                </a:lnTo>
                <a:lnTo>
                  <a:pt x="128" y="560"/>
                </a:lnTo>
                <a:lnTo>
                  <a:pt x="136" y="432"/>
                </a:lnTo>
                <a:lnTo>
                  <a:pt x="144" y="488"/>
                </a:lnTo>
                <a:lnTo>
                  <a:pt x="152" y="552"/>
                </a:lnTo>
                <a:lnTo>
                  <a:pt x="160" y="424"/>
                </a:lnTo>
                <a:lnTo>
                  <a:pt x="168" y="424"/>
                </a:lnTo>
                <a:lnTo>
                  <a:pt x="176" y="496"/>
                </a:lnTo>
                <a:lnTo>
                  <a:pt x="184" y="104"/>
                </a:lnTo>
                <a:lnTo>
                  <a:pt x="192" y="544"/>
                </a:lnTo>
                <a:lnTo>
                  <a:pt x="200" y="272"/>
                </a:lnTo>
                <a:lnTo>
                  <a:pt x="208" y="432"/>
                </a:lnTo>
                <a:lnTo>
                  <a:pt x="216" y="432"/>
                </a:lnTo>
                <a:lnTo>
                  <a:pt x="224" y="280"/>
                </a:lnTo>
                <a:lnTo>
                  <a:pt x="232" y="416"/>
                </a:lnTo>
                <a:lnTo>
                  <a:pt x="240" y="304"/>
                </a:lnTo>
                <a:lnTo>
                  <a:pt x="248" y="360"/>
                </a:lnTo>
                <a:lnTo>
                  <a:pt x="256" y="352"/>
                </a:lnTo>
                <a:lnTo>
                  <a:pt x="264" y="424"/>
                </a:lnTo>
                <a:lnTo>
                  <a:pt x="272" y="320"/>
                </a:lnTo>
                <a:lnTo>
                  <a:pt x="280" y="336"/>
                </a:lnTo>
                <a:lnTo>
                  <a:pt x="288" y="336"/>
                </a:lnTo>
                <a:lnTo>
                  <a:pt x="296" y="272"/>
                </a:lnTo>
                <a:lnTo>
                  <a:pt x="304" y="272"/>
                </a:lnTo>
                <a:lnTo>
                  <a:pt x="312" y="328"/>
                </a:lnTo>
                <a:lnTo>
                  <a:pt x="320" y="352"/>
                </a:lnTo>
                <a:lnTo>
                  <a:pt x="328" y="320"/>
                </a:lnTo>
                <a:lnTo>
                  <a:pt x="336" y="384"/>
                </a:lnTo>
                <a:lnTo>
                  <a:pt x="344" y="360"/>
                </a:lnTo>
                <a:lnTo>
                  <a:pt x="352" y="456"/>
                </a:lnTo>
                <a:lnTo>
                  <a:pt x="360" y="280"/>
                </a:lnTo>
                <a:lnTo>
                  <a:pt x="368" y="104"/>
                </a:lnTo>
                <a:lnTo>
                  <a:pt x="376" y="256"/>
                </a:lnTo>
                <a:lnTo>
                  <a:pt x="384" y="168"/>
                </a:lnTo>
                <a:lnTo>
                  <a:pt x="392" y="488"/>
                </a:lnTo>
                <a:lnTo>
                  <a:pt x="400" y="304"/>
                </a:lnTo>
                <a:lnTo>
                  <a:pt x="408" y="528"/>
                </a:lnTo>
                <a:lnTo>
                  <a:pt x="416" y="120"/>
                </a:lnTo>
                <a:lnTo>
                  <a:pt x="424" y="448"/>
                </a:lnTo>
                <a:lnTo>
                  <a:pt x="432" y="416"/>
                </a:lnTo>
                <a:lnTo>
                  <a:pt x="440" y="624"/>
                </a:lnTo>
                <a:lnTo>
                  <a:pt x="448" y="408"/>
                </a:lnTo>
                <a:lnTo>
                  <a:pt x="456" y="472"/>
                </a:lnTo>
                <a:lnTo>
                  <a:pt x="464" y="1104"/>
                </a:lnTo>
                <a:lnTo>
                  <a:pt x="472" y="672"/>
                </a:lnTo>
                <a:lnTo>
                  <a:pt x="480" y="936"/>
                </a:lnTo>
                <a:lnTo>
                  <a:pt x="488" y="928"/>
                </a:lnTo>
                <a:lnTo>
                  <a:pt x="496" y="808"/>
                </a:lnTo>
                <a:lnTo>
                  <a:pt x="504" y="968"/>
                </a:lnTo>
                <a:lnTo>
                  <a:pt x="512" y="1256"/>
                </a:lnTo>
                <a:lnTo>
                  <a:pt x="520" y="1192"/>
                </a:lnTo>
                <a:lnTo>
                  <a:pt x="528" y="1288"/>
                </a:lnTo>
                <a:lnTo>
                  <a:pt x="536" y="1360"/>
                </a:lnTo>
                <a:lnTo>
                  <a:pt x="544" y="1400"/>
                </a:lnTo>
                <a:lnTo>
                  <a:pt x="552" y="1424"/>
                </a:lnTo>
                <a:lnTo>
                  <a:pt x="560" y="1408"/>
                </a:lnTo>
                <a:lnTo>
                  <a:pt x="568" y="1608"/>
                </a:lnTo>
                <a:lnTo>
                  <a:pt x="576" y="1560"/>
                </a:lnTo>
                <a:lnTo>
                  <a:pt x="584" y="1704"/>
                </a:lnTo>
                <a:lnTo>
                  <a:pt x="592" y="1776"/>
                </a:lnTo>
                <a:lnTo>
                  <a:pt x="600" y="1752"/>
                </a:lnTo>
                <a:lnTo>
                  <a:pt x="608" y="1800"/>
                </a:lnTo>
                <a:lnTo>
                  <a:pt x="616" y="1752"/>
                </a:lnTo>
                <a:lnTo>
                  <a:pt x="624" y="1864"/>
                </a:lnTo>
                <a:lnTo>
                  <a:pt x="632" y="1832"/>
                </a:lnTo>
                <a:lnTo>
                  <a:pt x="640" y="1896"/>
                </a:lnTo>
                <a:lnTo>
                  <a:pt x="648" y="1960"/>
                </a:lnTo>
                <a:lnTo>
                  <a:pt x="656" y="1896"/>
                </a:lnTo>
                <a:lnTo>
                  <a:pt x="664" y="1880"/>
                </a:lnTo>
                <a:lnTo>
                  <a:pt x="672" y="1960"/>
                </a:lnTo>
                <a:lnTo>
                  <a:pt x="680" y="1968"/>
                </a:lnTo>
                <a:lnTo>
                  <a:pt x="688" y="1960"/>
                </a:lnTo>
                <a:lnTo>
                  <a:pt x="696" y="1960"/>
                </a:lnTo>
                <a:lnTo>
                  <a:pt x="704" y="1992"/>
                </a:lnTo>
                <a:lnTo>
                  <a:pt x="712" y="1944"/>
                </a:lnTo>
                <a:lnTo>
                  <a:pt x="720" y="2008"/>
                </a:lnTo>
                <a:lnTo>
                  <a:pt x="728" y="2016"/>
                </a:lnTo>
                <a:lnTo>
                  <a:pt x="736" y="2032"/>
                </a:lnTo>
                <a:lnTo>
                  <a:pt x="744" y="2016"/>
                </a:lnTo>
                <a:lnTo>
                  <a:pt x="752" y="2032"/>
                </a:lnTo>
                <a:lnTo>
                  <a:pt x="760" y="2016"/>
                </a:lnTo>
                <a:lnTo>
                  <a:pt x="768" y="2024"/>
                </a:lnTo>
                <a:lnTo>
                  <a:pt x="776" y="2032"/>
                </a:lnTo>
                <a:lnTo>
                  <a:pt x="784" y="2040"/>
                </a:lnTo>
                <a:lnTo>
                  <a:pt x="792" y="2040"/>
                </a:lnTo>
                <a:lnTo>
                  <a:pt x="800" y="2040"/>
                </a:lnTo>
                <a:lnTo>
                  <a:pt x="808" y="2040"/>
                </a:lnTo>
                <a:lnTo>
                  <a:pt x="816" y="2040"/>
                </a:lnTo>
                <a:lnTo>
                  <a:pt x="824" y="2040"/>
                </a:lnTo>
                <a:lnTo>
                  <a:pt x="832" y="2040"/>
                </a:lnTo>
                <a:lnTo>
                  <a:pt x="840" y="2040"/>
                </a:lnTo>
                <a:lnTo>
                  <a:pt x="848" y="2040"/>
                </a:lnTo>
                <a:lnTo>
                  <a:pt x="856" y="2040"/>
                </a:lnTo>
                <a:lnTo>
                  <a:pt x="864" y="2040"/>
                </a:lnTo>
                <a:lnTo>
                  <a:pt x="872" y="2040"/>
                </a:lnTo>
                <a:lnTo>
                  <a:pt x="880" y="2040"/>
                </a:lnTo>
                <a:lnTo>
                  <a:pt x="888" y="2040"/>
                </a:lnTo>
                <a:lnTo>
                  <a:pt x="896" y="2040"/>
                </a:lnTo>
                <a:lnTo>
                  <a:pt x="904" y="2040"/>
                </a:lnTo>
                <a:lnTo>
                  <a:pt x="912" y="2040"/>
                </a:lnTo>
                <a:lnTo>
                  <a:pt x="920" y="2040"/>
                </a:lnTo>
                <a:lnTo>
                  <a:pt x="928" y="2040"/>
                </a:lnTo>
                <a:lnTo>
                  <a:pt x="936" y="2040"/>
                </a:lnTo>
                <a:lnTo>
                  <a:pt x="944" y="2040"/>
                </a:lnTo>
                <a:lnTo>
                  <a:pt x="952" y="2040"/>
                </a:lnTo>
                <a:lnTo>
                  <a:pt x="960" y="2040"/>
                </a:lnTo>
                <a:lnTo>
                  <a:pt x="968" y="2040"/>
                </a:lnTo>
                <a:lnTo>
                  <a:pt x="976" y="2040"/>
                </a:lnTo>
                <a:lnTo>
                  <a:pt x="984" y="2040"/>
                </a:lnTo>
                <a:lnTo>
                  <a:pt x="992" y="2040"/>
                </a:lnTo>
                <a:lnTo>
                  <a:pt x="1000" y="2040"/>
                </a:lnTo>
                <a:lnTo>
                  <a:pt x="1008" y="2040"/>
                </a:lnTo>
                <a:lnTo>
                  <a:pt x="1016" y="2040"/>
                </a:lnTo>
                <a:lnTo>
                  <a:pt x="1024" y="2040"/>
                </a:lnTo>
                <a:lnTo>
                  <a:pt x="1032" y="2040"/>
                </a:lnTo>
                <a:lnTo>
                  <a:pt x="1040" y="2040"/>
                </a:lnTo>
                <a:lnTo>
                  <a:pt x="1048" y="2040"/>
                </a:lnTo>
                <a:lnTo>
                  <a:pt x="1056" y="2040"/>
                </a:lnTo>
                <a:lnTo>
                  <a:pt x="1064" y="2040"/>
                </a:lnTo>
                <a:lnTo>
                  <a:pt x="1072" y="2040"/>
                </a:lnTo>
                <a:lnTo>
                  <a:pt x="1080" y="2040"/>
                </a:lnTo>
                <a:lnTo>
                  <a:pt x="1088" y="2040"/>
                </a:lnTo>
                <a:lnTo>
                  <a:pt x="1096" y="2040"/>
                </a:lnTo>
                <a:lnTo>
                  <a:pt x="1104" y="2040"/>
                </a:lnTo>
                <a:lnTo>
                  <a:pt x="1112" y="2040"/>
                </a:lnTo>
                <a:lnTo>
                  <a:pt x="1120" y="2040"/>
                </a:lnTo>
                <a:lnTo>
                  <a:pt x="1128" y="2040"/>
                </a:lnTo>
                <a:lnTo>
                  <a:pt x="1136" y="2040"/>
                </a:lnTo>
                <a:lnTo>
                  <a:pt x="1144" y="2040"/>
                </a:lnTo>
                <a:lnTo>
                  <a:pt x="1152" y="2040"/>
                </a:lnTo>
                <a:lnTo>
                  <a:pt x="1160" y="2040"/>
                </a:lnTo>
                <a:lnTo>
                  <a:pt x="1168" y="2040"/>
                </a:lnTo>
                <a:lnTo>
                  <a:pt x="1176" y="2040"/>
                </a:lnTo>
                <a:lnTo>
                  <a:pt x="1184" y="2040"/>
                </a:lnTo>
                <a:lnTo>
                  <a:pt x="1192" y="2040"/>
                </a:lnTo>
                <a:lnTo>
                  <a:pt x="1200" y="2040"/>
                </a:lnTo>
                <a:lnTo>
                  <a:pt x="1208" y="2040"/>
                </a:lnTo>
                <a:lnTo>
                  <a:pt x="1216" y="2040"/>
                </a:lnTo>
                <a:lnTo>
                  <a:pt x="1224" y="2040"/>
                </a:lnTo>
                <a:lnTo>
                  <a:pt x="1232" y="2040"/>
                </a:lnTo>
                <a:lnTo>
                  <a:pt x="1240" y="2040"/>
                </a:lnTo>
                <a:lnTo>
                  <a:pt x="1248" y="2040"/>
                </a:lnTo>
                <a:lnTo>
                  <a:pt x="1256" y="2040"/>
                </a:lnTo>
                <a:lnTo>
                  <a:pt x="1264" y="2040"/>
                </a:lnTo>
                <a:lnTo>
                  <a:pt x="1272" y="2040"/>
                </a:lnTo>
                <a:lnTo>
                  <a:pt x="1280" y="2040"/>
                </a:lnTo>
                <a:lnTo>
                  <a:pt x="1288" y="2040"/>
                </a:lnTo>
                <a:lnTo>
                  <a:pt x="1296" y="2040"/>
                </a:lnTo>
                <a:lnTo>
                  <a:pt x="1304" y="2040"/>
                </a:lnTo>
                <a:lnTo>
                  <a:pt x="1312" y="2040"/>
                </a:lnTo>
                <a:lnTo>
                  <a:pt x="1320" y="2040"/>
                </a:lnTo>
                <a:lnTo>
                  <a:pt x="1328" y="2040"/>
                </a:lnTo>
                <a:lnTo>
                  <a:pt x="1336" y="2040"/>
                </a:lnTo>
                <a:lnTo>
                  <a:pt x="1344" y="2040"/>
                </a:lnTo>
                <a:lnTo>
                  <a:pt x="1352" y="2040"/>
                </a:lnTo>
                <a:lnTo>
                  <a:pt x="1360" y="2040"/>
                </a:lnTo>
                <a:lnTo>
                  <a:pt x="1368" y="2040"/>
                </a:lnTo>
                <a:lnTo>
                  <a:pt x="1376" y="2040"/>
                </a:lnTo>
                <a:lnTo>
                  <a:pt x="1384" y="2040"/>
                </a:lnTo>
                <a:lnTo>
                  <a:pt x="1392" y="2040"/>
                </a:lnTo>
                <a:lnTo>
                  <a:pt x="1400" y="2040"/>
                </a:lnTo>
                <a:lnTo>
                  <a:pt x="1408" y="2040"/>
                </a:lnTo>
                <a:lnTo>
                  <a:pt x="1416" y="2040"/>
                </a:lnTo>
                <a:lnTo>
                  <a:pt x="1424" y="2040"/>
                </a:lnTo>
                <a:lnTo>
                  <a:pt x="1432" y="2040"/>
                </a:lnTo>
                <a:lnTo>
                  <a:pt x="1440" y="2040"/>
                </a:lnTo>
                <a:lnTo>
                  <a:pt x="1448" y="2040"/>
                </a:lnTo>
                <a:lnTo>
                  <a:pt x="1456" y="2040"/>
                </a:lnTo>
                <a:lnTo>
                  <a:pt x="1464" y="2040"/>
                </a:lnTo>
                <a:lnTo>
                  <a:pt x="1472" y="2040"/>
                </a:lnTo>
                <a:lnTo>
                  <a:pt x="1480" y="2040"/>
                </a:lnTo>
                <a:lnTo>
                  <a:pt x="1488" y="2040"/>
                </a:lnTo>
                <a:lnTo>
                  <a:pt x="1496" y="2040"/>
                </a:lnTo>
                <a:lnTo>
                  <a:pt x="1504" y="2040"/>
                </a:lnTo>
                <a:lnTo>
                  <a:pt x="1512" y="2040"/>
                </a:lnTo>
                <a:lnTo>
                  <a:pt x="1520" y="2040"/>
                </a:lnTo>
                <a:lnTo>
                  <a:pt x="1528" y="2040"/>
                </a:lnTo>
                <a:lnTo>
                  <a:pt x="1536" y="2040"/>
                </a:lnTo>
                <a:lnTo>
                  <a:pt x="1544" y="2040"/>
                </a:lnTo>
                <a:lnTo>
                  <a:pt x="1552" y="2040"/>
                </a:lnTo>
                <a:lnTo>
                  <a:pt x="1560" y="2040"/>
                </a:lnTo>
                <a:lnTo>
                  <a:pt x="1568" y="2040"/>
                </a:lnTo>
                <a:lnTo>
                  <a:pt x="1576" y="2040"/>
                </a:lnTo>
                <a:lnTo>
                  <a:pt x="1584" y="2040"/>
                </a:lnTo>
                <a:lnTo>
                  <a:pt x="1592" y="2040"/>
                </a:lnTo>
                <a:lnTo>
                  <a:pt x="1600" y="2040"/>
                </a:lnTo>
                <a:lnTo>
                  <a:pt x="1608" y="2040"/>
                </a:lnTo>
                <a:lnTo>
                  <a:pt x="1616" y="2040"/>
                </a:lnTo>
                <a:lnTo>
                  <a:pt x="1624" y="2040"/>
                </a:lnTo>
                <a:lnTo>
                  <a:pt x="1632" y="2040"/>
                </a:lnTo>
                <a:lnTo>
                  <a:pt x="1640" y="2040"/>
                </a:lnTo>
                <a:lnTo>
                  <a:pt x="1648" y="2040"/>
                </a:lnTo>
                <a:lnTo>
                  <a:pt x="1656" y="2040"/>
                </a:lnTo>
                <a:lnTo>
                  <a:pt x="1664" y="2040"/>
                </a:lnTo>
                <a:lnTo>
                  <a:pt x="1672" y="2040"/>
                </a:lnTo>
                <a:lnTo>
                  <a:pt x="1680" y="2040"/>
                </a:lnTo>
                <a:lnTo>
                  <a:pt x="1688" y="2040"/>
                </a:lnTo>
                <a:lnTo>
                  <a:pt x="1696" y="2040"/>
                </a:lnTo>
                <a:lnTo>
                  <a:pt x="1704" y="2040"/>
                </a:lnTo>
                <a:lnTo>
                  <a:pt x="1712" y="2040"/>
                </a:lnTo>
                <a:lnTo>
                  <a:pt x="1720" y="2040"/>
                </a:lnTo>
                <a:lnTo>
                  <a:pt x="1728" y="2040"/>
                </a:lnTo>
                <a:lnTo>
                  <a:pt x="1736" y="2040"/>
                </a:lnTo>
                <a:lnTo>
                  <a:pt x="1744" y="2040"/>
                </a:lnTo>
                <a:lnTo>
                  <a:pt x="1752" y="2040"/>
                </a:lnTo>
                <a:lnTo>
                  <a:pt x="1760" y="2040"/>
                </a:lnTo>
                <a:lnTo>
                  <a:pt x="1768" y="2040"/>
                </a:lnTo>
                <a:lnTo>
                  <a:pt x="1776" y="2040"/>
                </a:lnTo>
                <a:lnTo>
                  <a:pt x="1784" y="2040"/>
                </a:lnTo>
                <a:lnTo>
                  <a:pt x="1792" y="2040"/>
                </a:lnTo>
                <a:lnTo>
                  <a:pt x="1800" y="2040"/>
                </a:lnTo>
                <a:lnTo>
                  <a:pt x="1808" y="2040"/>
                </a:lnTo>
                <a:lnTo>
                  <a:pt x="1816" y="2040"/>
                </a:lnTo>
                <a:lnTo>
                  <a:pt x="1824" y="2040"/>
                </a:lnTo>
                <a:lnTo>
                  <a:pt x="1832" y="2040"/>
                </a:lnTo>
                <a:lnTo>
                  <a:pt x="1840" y="2040"/>
                </a:lnTo>
                <a:lnTo>
                  <a:pt x="1848" y="2040"/>
                </a:lnTo>
                <a:lnTo>
                  <a:pt x="1856" y="2040"/>
                </a:lnTo>
                <a:lnTo>
                  <a:pt x="1864" y="2040"/>
                </a:lnTo>
                <a:lnTo>
                  <a:pt x="1872" y="2040"/>
                </a:lnTo>
                <a:lnTo>
                  <a:pt x="1880" y="2040"/>
                </a:lnTo>
                <a:lnTo>
                  <a:pt x="1888" y="2040"/>
                </a:lnTo>
                <a:lnTo>
                  <a:pt x="1896" y="2040"/>
                </a:lnTo>
                <a:lnTo>
                  <a:pt x="1904" y="2040"/>
                </a:lnTo>
                <a:lnTo>
                  <a:pt x="1912" y="2040"/>
                </a:lnTo>
                <a:lnTo>
                  <a:pt x="1920" y="2040"/>
                </a:lnTo>
                <a:lnTo>
                  <a:pt x="1928" y="2040"/>
                </a:lnTo>
                <a:lnTo>
                  <a:pt x="1936" y="2040"/>
                </a:lnTo>
                <a:lnTo>
                  <a:pt x="1944" y="2040"/>
                </a:lnTo>
                <a:lnTo>
                  <a:pt x="1952" y="2040"/>
                </a:lnTo>
                <a:lnTo>
                  <a:pt x="1960" y="2040"/>
                </a:lnTo>
                <a:lnTo>
                  <a:pt x="1968" y="2040"/>
                </a:lnTo>
                <a:lnTo>
                  <a:pt x="1976" y="2040"/>
                </a:lnTo>
                <a:lnTo>
                  <a:pt x="1984" y="2040"/>
                </a:lnTo>
                <a:lnTo>
                  <a:pt x="1992" y="2040"/>
                </a:lnTo>
                <a:lnTo>
                  <a:pt x="2000" y="2040"/>
                </a:lnTo>
                <a:lnTo>
                  <a:pt x="2008" y="2040"/>
                </a:lnTo>
                <a:lnTo>
                  <a:pt x="2016" y="2040"/>
                </a:lnTo>
                <a:lnTo>
                  <a:pt x="2024" y="2040"/>
                </a:lnTo>
                <a:lnTo>
                  <a:pt x="2032" y="2040"/>
                </a:lnTo>
              </a:path>
            </a:pathLst>
          </a:custGeom>
          <a:noFill/>
          <a:ln w="12600">
            <a:solidFill>
              <a:srgbClr val="0000ff"/>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505" name=""/>
          <p:cNvSpPr/>
          <p:nvPr/>
        </p:nvSpPr>
        <p:spPr>
          <a:xfrm>
            <a:off x="5016600" y="1386000"/>
            <a:ext cx="1452600" cy="1226880"/>
          </a:xfrm>
          <a:prstGeom prst="rect">
            <a:avLst/>
          </a:prstGeom>
          <a:solidFill>
            <a:srgbClr val="ffffff"/>
          </a:solidFill>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506" name=""/>
          <p:cNvSpPr/>
          <p:nvPr/>
        </p:nvSpPr>
        <p:spPr>
          <a:xfrm>
            <a:off x="5014800" y="2608200"/>
            <a:ext cx="14479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nvGrpSpPr>
          <p:cNvPr id="507" name=""/>
          <p:cNvGrpSpPr/>
          <p:nvPr/>
        </p:nvGrpSpPr>
        <p:grpSpPr>
          <a:xfrm>
            <a:off x="5014800" y="2612880"/>
            <a:ext cx="1449000" cy="28800"/>
            <a:chOff x="5014800" y="2612880"/>
            <a:chExt cx="1449000" cy="28800"/>
          </a:xfrm>
        </p:grpSpPr>
        <p:sp>
          <p:nvSpPr>
            <p:cNvPr id="508" name=""/>
            <p:cNvSpPr/>
            <p:nvPr/>
          </p:nvSpPr>
          <p:spPr>
            <a:xfrm>
              <a:off x="5014800" y="2612880"/>
              <a:ext cx="360" cy="28800"/>
            </a:xfrm>
            <a:prstGeom prst="line">
              <a:avLst/>
            </a:prstGeom>
            <a:ln w="12600">
              <a:solidFill>
                <a:srgbClr val="000000"/>
              </a:solidFill>
              <a:miter/>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509" name=""/>
            <p:cNvSpPr/>
            <p:nvPr/>
          </p:nvSpPr>
          <p:spPr>
            <a:xfrm>
              <a:off x="5121360" y="261288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10" name=""/>
            <p:cNvSpPr/>
            <p:nvPr/>
          </p:nvSpPr>
          <p:spPr>
            <a:xfrm>
              <a:off x="5182920" y="261288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11" name=""/>
            <p:cNvSpPr/>
            <p:nvPr/>
          </p:nvSpPr>
          <p:spPr>
            <a:xfrm>
              <a:off x="5227920" y="2612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12" name=""/>
            <p:cNvSpPr/>
            <p:nvPr/>
          </p:nvSpPr>
          <p:spPr>
            <a:xfrm>
              <a:off x="5267160" y="2612880"/>
              <a:ext cx="72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513" name=""/>
            <p:cNvSpPr/>
            <p:nvPr/>
          </p:nvSpPr>
          <p:spPr>
            <a:xfrm>
              <a:off x="5295600" y="2612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14" name=""/>
            <p:cNvSpPr/>
            <p:nvPr/>
          </p:nvSpPr>
          <p:spPr>
            <a:xfrm>
              <a:off x="5317920" y="2612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15" name=""/>
            <p:cNvSpPr/>
            <p:nvPr/>
          </p:nvSpPr>
          <p:spPr>
            <a:xfrm>
              <a:off x="5340240" y="2612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16" name=""/>
            <p:cNvSpPr/>
            <p:nvPr/>
          </p:nvSpPr>
          <p:spPr>
            <a:xfrm>
              <a:off x="5357160" y="2612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17" name=""/>
            <p:cNvSpPr/>
            <p:nvPr/>
          </p:nvSpPr>
          <p:spPr>
            <a:xfrm>
              <a:off x="5374080" y="2612880"/>
              <a:ext cx="360" cy="28800"/>
            </a:xfrm>
            <a:prstGeom prst="line">
              <a:avLst/>
            </a:prstGeom>
            <a:ln w="12600">
              <a:solidFill>
                <a:srgbClr val="000000"/>
              </a:solidFill>
              <a:miter/>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518" name=""/>
            <p:cNvSpPr/>
            <p:nvPr/>
          </p:nvSpPr>
          <p:spPr>
            <a:xfrm>
              <a:off x="5486400" y="261288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19" name=""/>
            <p:cNvSpPr/>
            <p:nvPr/>
          </p:nvSpPr>
          <p:spPr>
            <a:xfrm>
              <a:off x="5547960" y="261288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20" name=""/>
            <p:cNvSpPr/>
            <p:nvPr/>
          </p:nvSpPr>
          <p:spPr>
            <a:xfrm>
              <a:off x="5592960" y="2612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21" name=""/>
            <p:cNvSpPr/>
            <p:nvPr/>
          </p:nvSpPr>
          <p:spPr>
            <a:xfrm>
              <a:off x="5626800" y="2612880"/>
              <a:ext cx="72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522" name=""/>
            <p:cNvSpPr/>
            <p:nvPr/>
          </p:nvSpPr>
          <p:spPr>
            <a:xfrm>
              <a:off x="5660280" y="2612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23" name=""/>
            <p:cNvSpPr/>
            <p:nvPr/>
          </p:nvSpPr>
          <p:spPr>
            <a:xfrm>
              <a:off x="5682960" y="2612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24" name=""/>
            <p:cNvSpPr/>
            <p:nvPr/>
          </p:nvSpPr>
          <p:spPr>
            <a:xfrm>
              <a:off x="5705280" y="261288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25" name=""/>
            <p:cNvSpPr/>
            <p:nvPr/>
          </p:nvSpPr>
          <p:spPr>
            <a:xfrm>
              <a:off x="5722200" y="2612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26" name=""/>
            <p:cNvSpPr/>
            <p:nvPr/>
          </p:nvSpPr>
          <p:spPr>
            <a:xfrm>
              <a:off x="5739120" y="2612880"/>
              <a:ext cx="360" cy="28800"/>
            </a:xfrm>
            <a:prstGeom prst="line">
              <a:avLst/>
            </a:prstGeom>
            <a:ln w="12600">
              <a:solidFill>
                <a:srgbClr val="000000"/>
              </a:solidFill>
              <a:miter/>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527" name=""/>
            <p:cNvSpPr/>
            <p:nvPr/>
          </p:nvSpPr>
          <p:spPr>
            <a:xfrm>
              <a:off x="5845680" y="2612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28" name=""/>
            <p:cNvSpPr/>
            <p:nvPr/>
          </p:nvSpPr>
          <p:spPr>
            <a:xfrm>
              <a:off x="5913000" y="261288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29" name=""/>
            <p:cNvSpPr/>
            <p:nvPr/>
          </p:nvSpPr>
          <p:spPr>
            <a:xfrm>
              <a:off x="5958000" y="2612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30" name=""/>
            <p:cNvSpPr/>
            <p:nvPr/>
          </p:nvSpPr>
          <p:spPr>
            <a:xfrm>
              <a:off x="5991840" y="2612880"/>
              <a:ext cx="72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531" name=""/>
            <p:cNvSpPr/>
            <p:nvPr/>
          </p:nvSpPr>
          <p:spPr>
            <a:xfrm>
              <a:off x="6019920" y="2612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32" name=""/>
            <p:cNvSpPr/>
            <p:nvPr/>
          </p:nvSpPr>
          <p:spPr>
            <a:xfrm>
              <a:off x="6048000" y="2612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33" name=""/>
            <p:cNvSpPr/>
            <p:nvPr/>
          </p:nvSpPr>
          <p:spPr>
            <a:xfrm>
              <a:off x="6064920" y="2612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34" name=""/>
            <p:cNvSpPr/>
            <p:nvPr/>
          </p:nvSpPr>
          <p:spPr>
            <a:xfrm>
              <a:off x="6087240" y="2612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35" name=""/>
            <p:cNvSpPr/>
            <p:nvPr/>
          </p:nvSpPr>
          <p:spPr>
            <a:xfrm>
              <a:off x="6104160" y="2612880"/>
              <a:ext cx="360" cy="28800"/>
            </a:xfrm>
            <a:prstGeom prst="line">
              <a:avLst/>
            </a:prstGeom>
            <a:ln w="12600">
              <a:solidFill>
                <a:srgbClr val="000000"/>
              </a:solidFill>
              <a:miter/>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sp>
          <p:nvSpPr>
            <p:cNvPr id="536" name=""/>
            <p:cNvSpPr/>
            <p:nvPr/>
          </p:nvSpPr>
          <p:spPr>
            <a:xfrm>
              <a:off x="6210720" y="261288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37" name=""/>
            <p:cNvSpPr/>
            <p:nvPr/>
          </p:nvSpPr>
          <p:spPr>
            <a:xfrm>
              <a:off x="6278040" y="261288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38" name=""/>
            <p:cNvSpPr/>
            <p:nvPr/>
          </p:nvSpPr>
          <p:spPr>
            <a:xfrm>
              <a:off x="6323040" y="2612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39" name=""/>
            <p:cNvSpPr/>
            <p:nvPr/>
          </p:nvSpPr>
          <p:spPr>
            <a:xfrm>
              <a:off x="6356880" y="2612880"/>
              <a:ext cx="72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540" name=""/>
            <p:cNvSpPr/>
            <p:nvPr/>
          </p:nvSpPr>
          <p:spPr>
            <a:xfrm>
              <a:off x="6384960" y="2612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41" name=""/>
            <p:cNvSpPr/>
            <p:nvPr/>
          </p:nvSpPr>
          <p:spPr>
            <a:xfrm>
              <a:off x="6407280" y="2612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42" name=""/>
            <p:cNvSpPr/>
            <p:nvPr/>
          </p:nvSpPr>
          <p:spPr>
            <a:xfrm>
              <a:off x="6429960" y="2612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43" name=""/>
            <p:cNvSpPr/>
            <p:nvPr/>
          </p:nvSpPr>
          <p:spPr>
            <a:xfrm>
              <a:off x="6446520" y="261288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44" name=""/>
            <p:cNvSpPr/>
            <p:nvPr/>
          </p:nvSpPr>
          <p:spPr>
            <a:xfrm>
              <a:off x="6463440" y="2612880"/>
              <a:ext cx="360" cy="28800"/>
            </a:xfrm>
            <a:prstGeom prst="line">
              <a:avLst/>
            </a:prstGeom>
            <a:ln w="12600">
              <a:solidFill>
                <a:srgbClr val="000000"/>
              </a:solidFill>
              <a:miter/>
            </a:ln>
          </p:spPr>
          <p:style>
            <a:lnRef idx="0"/>
            <a:fillRef idx="0"/>
            <a:effectRef idx="0"/>
            <a:fontRef idx="minor"/>
          </p:style>
          <p:txBody>
            <a:bodyPr lIns="90000" rIns="90000" tIns="-18000" bIns="-18000" anchor="t">
              <a:noAutofit/>
            </a:bodyPr>
            <a:p>
              <a:endParaRPr b="0" lang="en-US" sz="2400" spc="-1" strike="noStrike">
                <a:solidFill>
                  <a:srgbClr val="000000"/>
                </a:solidFill>
                <a:latin typeface="Arial"/>
              </a:endParaRPr>
            </a:p>
          </p:txBody>
        </p:sp>
      </p:grpSp>
      <p:sp>
        <p:nvSpPr>
          <p:cNvPr id="545" name=""/>
          <p:cNvSpPr/>
          <p:nvPr/>
        </p:nvSpPr>
        <p:spPr>
          <a:xfrm flipV="1">
            <a:off x="5016600" y="1385640"/>
            <a:ext cx="0" cy="122220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nvGrpSpPr>
          <p:cNvPr id="546" name=""/>
          <p:cNvGrpSpPr/>
          <p:nvPr/>
        </p:nvGrpSpPr>
        <p:grpSpPr>
          <a:xfrm>
            <a:off x="4796280" y="1494000"/>
            <a:ext cx="192600" cy="1223280"/>
            <a:chOff x="4796280" y="1494000"/>
            <a:chExt cx="192600" cy="1223280"/>
          </a:xfrm>
        </p:grpSpPr>
        <p:sp>
          <p:nvSpPr>
            <p:cNvPr id="547" name=""/>
            <p:cNvSpPr/>
            <p:nvPr/>
          </p:nvSpPr>
          <p:spPr>
            <a:xfrm>
              <a:off x="4874400" y="2579760"/>
              <a:ext cx="648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0</a:t>
              </a:r>
              <a:endParaRPr b="0" lang="en-US" sz="900" spc="-1" strike="noStrike">
                <a:solidFill>
                  <a:srgbClr val="000000"/>
                </a:solidFill>
                <a:latin typeface="Arial"/>
              </a:endParaRPr>
            </a:p>
          </p:txBody>
        </p:sp>
        <p:sp>
          <p:nvSpPr>
            <p:cNvPr id="548" name=""/>
            <p:cNvSpPr/>
            <p:nvPr/>
          </p:nvSpPr>
          <p:spPr>
            <a:xfrm>
              <a:off x="4796280" y="222264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0</a:t>
              </a:r>
              <a:endParaRPr b="0" lang="en-US" sz="900" spc="-1" strike="noStrike">
                <a:solidFill>
                  <a:srgbClr val="000000"/>
                </a:solidFill>
                <a:latin typeface="Arial"/>
              </a:endParaRPr>
            </a:p>
          </p:txBody>
        </p:sp>
        <p:sp>
          <p:nvSpPr>
            <p:cNvPr id="549" name=""/>
            <p:cNvSpPr/>
            <p:nvPr/>
          </p:nvSpPr>
          <p:spPr>
            <a:xfrm>
              <a:off x="4796280" y="185760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200</a:t>
              </a:r>
              <a:endParaRPr b="0" lang="en-US" sz="900" spc="-1" strike="noStrike">
                <a:solidFill>
                  <a:srgbClr val="000000"/>
                </a:solidFill>
                <a:latin typeface="Arial"/>
              </a:endParaRPr>
            </a:p>
          </p:txBody>
        </p:sp>
        <p:sp>
          <p:nvSpPr>
            <p:cNvPr id="550" name=""/>
            <p:cNvSpPr/>
            <p:nvPr/>
          </p:nvSpPr>
          <p:spPr>
            <a:xfrm>
              <a:off x="4796280" y="149400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300</a:t>
              </a:r>
              <a:endParaRPr b="0" lang="en-US" sz="900" spc="-1" strike="noStrike">
                <a:solidFill>
                  <a:srgbClr val="000000"/>
                </a:solidFill>
                <a:latin typeface="Arial"/>
              </a:endParaRPr>
            </a:p>
          </p:txBody>
        </p:sp>
      </p:grpSp>
      <p:grpSp>
        <p:nvGrpSpPr>
          <p:cNvPr id="551" name=""/>
          <p:cNvGrpSpPr/>
          <p:nvPr/>
        </p:nvGrpSpPr>
        <p:grpSpPr>
          <a:xfrm>
            <a:off x="4981320" y="1428840"/>
            <a:ext cx="34920" cy="1180800"/>
            <a:chOff x="4981320" y="1428840"/>
            <a:chExt cx="34920" cy="1180800"/>
          </a:xfrm>
        </p:grpSpPr>
        <p:sp>
          <p:nvSpPr>
            <p:cNvPr id="552" name=""/>
            <p:cNvSpPr/>
            <p:nvPr/>
          </p:nvSpPr>
          <p:spPr>
            <a:xfrm flipH="1">
              <a:off x="4981320" y="2609280"/>
              <a:ext cx="3492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553" name=""/>
            <p:cNvSpPr/>
            <p:nvPr/>
          </p:nvSpPr>
          <p:spPr>
            <a:xfrm flipH="1">
              <a:off x="5004720" y="2519280"/>
              <a:ext cx="1152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554" name=""/>
            <p:cNvSpPr/>
            <p:nvPr/>
          </p:nvSpPr>
          <p:spPr>
            <a:xfrm flipH="1">
              <a:off x="5004720" y="2429280"/>
              <a:ext cx="1152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555" name=""/>
            <p:cNvSpPr/>
            <p:nvPr/>
          </p:nvSpPr>
          <p:spPr>
            <a:xfrm flipH="1">
              <a:off x="5004720" y="2339280"/>
              <a:ext cx="1152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556" name=""/>
            <p:cNvSpPr/>
            <p:nvPr/>
          </p:nvSpPr>
          <p:spPr>
            <a:xfrm flipH="1">
              <a:off x="4981320" y="2248920"/>
              <a:ext cx="3492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557" name=""/>
            <p:cNvSpPr/>
            <p:nvPr/>
          </p:nvSpPr>
          <p:spPr>
            <a:xfrm flipH="1">
              <a:off x="5004720" y="2154240"/>
              <a:ext cx="1152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558" name=""/>
            <p:cNvSpPr/>
            <p:nvPr/>
          </p:nvSpPr>
          <p:spPr>
            <a:xfrm flipH="1">
              <a:off x="5004720" y="2063880"/>
              <a:ext cx="1152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559" name=""/>
            <p:cNvSpPr/>
            <p:nvPr/>
          </p:nvSpPr>
          <p:spPr>
            <a:xfrm flipH="1">
              <a:off x="5004720" y="1973880"/>
              <a:ext cx="1152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560" name=""/>
            <p:cNvSpPr/>
            <p:nvPr/>
          </p:nvSpPr>
          <p:spPr>
            <a:xfrm flipH="1">
              <a:off x="4981320" y="1883880"/>
              <a:ext cx="3492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561" name=""/>
            <p:cNvSpPr/>
            <p:nvPr/>
          </p:nvSpPr>
          <p:spPr>
            <a:xfrm flipH="1">
              <a:off x="5004720" y="1793880"/>
              <a:ext cx="1152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562" name=""/>
            <p:cNvSpPr/>
            <p:nvPr/>
          </p:nvSpPr>
          <p:spPr>
            <a:xfrm flipH="1">
              <a:off x="5004720" y="1698840"/>
              <a:ext cx="1152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563" name=""/>
            <p:cNvSpPr/>
            <p:nvPr/>
          </p:nvSpPr>
          <p:spPr>
            <a:xfrm flipH="1">
              <a:off x="5004720" y="1608840"/>
              <a:ext cx="1152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564" name=""/>
            <p:cNvSpPr/>
            <p:nvPr/>
          </p:nvSpPr>
          <p:spPr>
            <a:xfrm flipH="1">
              <a:off x="4981320" y="1518840"/>
              <a:ext cx="3492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565" name=""/>
            <p:cNvSpPr/>
            <p:nvPr/>
          </p:nvSpPr>
          <p:spPr>
            <a:xfrm flipH="1">
              <a:off x="5004720" y="1428840"/>
              <a:ext cx="1152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grpSp>
      <p:sp>
        <p:nvSpPr>
          <p:cNvPr id="566" name=""/>
          <p:cNvSpPr/>
          <p:nvPr/>
        </p:nvSpPr>
        <p:spPr>
          <a:xfrm rot="16200000">
            <a:off x="4521600" y="2010960"/>
            <a:ext cx="3528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 Cells</a:t>
            </a:r>
            <a:endParaRPr b="0" lang="en-US" sz="900" spc="-1" strike="noStrike">
              <a:solidFill>
                <a:srgbClr val="000000"/>
              </a:solidFill>
              <a:latin typeface="Arial"/>
            </a:endParaRPr>
          </a:p>
        </p:txBody>
      </p:sp>
      <p:sp>
        <p:nvSpPr>
          <p:cNvPr id="567" name=""/>
          <p:cNvSpPr/>
          <p:nvPr/>
        </p:nvSpPr>
        <p:spPr>
          <a:xfrm>
            <a:off x="5027760" y="1457280"/>
            <a:ext cx="1423800" cy="1146240"/>
          </a:xfrm>
          <a:custGeom>
            <a:avLst/>
            <a:gdLst/>
            <a:ahLst/>
            <a:rect l="l" t="t" r="r" b="b"/>
            <a:pathLst>
              <a:path w="2032" h="1936">
                <a:moveTo>
                  <a:pt x="0" y="1936"/>
                </a:moveTo>
                <a:lnTo>
                  <a:pt x="0" y="1760"/>
                </a:lnTo>
                <a:lnTo>
                  <a:pt x="0" y="1928"/>
                </a:lnTo>
                <a:lnTo>
                  <a:pt x="8" y="1904"/>
                </a:lnTo>
                <a:lnTo>
                  <a:pt x="16" y="1872"/>
                </a:lnTo>
                <a:lnTo>
                  <a:pt x="24" y="1840"/>
                </a:lnTo>
                <a:lnTo>
                  <a:pt x="32" y="1888"/>
                </a:lnTo>
                <a:lnTo>
                  <a:pt x="40" y="1872"/>
                </a:lnTo>
                <a:lnTo>
                  <a:pt x="48" y="1808"/>
                </a:lnTo>
                <a:lnTo>
                  <a:pt x="56" y="1816"/>
                </a:lnTo>
                <a:lnTo>
                  <a:pt x="64" y="1784"/>
                </a:lnTo>
                <a:lnTo>
                  <a:pt x="72" y="1792"/>
                </a:lnTo>
                <a:lnTo>
                  <a:pt x="80" y="1800"/>
                </a:lnTo>
                <a:lnTo>
                  <a:pt x="88" y="1776"/>
                </a:lnTo>
                <a:lnTo>
                  <a:pt x="96" y="1768"/>
                </a:lnTo>
                <a:lnTo>
                  <a:pt x="104" y="1664"/>
                </a:lnTo>
                <a:lnTo>
                  <a:pt x="112" y="1688"/>
                </a:lnTo>
                <a:lnTo>
                  <a:pt x="120" y="1632"/>
                </a:lnTo>
                <a:lnTo>
                  <a:pt x="128" y="1576"/>
                </a:lnTo>
                <a:lnTo>
                  <a:pt x="136" y="1512"/>
                </a:lnTo>
                <a:lnTo>
                  <a:pt x="144" y="1520"/>
                </a:lnTo>
                <a:lnTo>
                  <a:pt x="152" y="1488"/>
                </a:lnTo>
                <a:lnTo>
                  <a:pt x="160" y="1432"/>
                </a:lnTo>
                <a:lnTo>
                  <a:pt x="168" y="1416"/>
                </a:lnTo>
                <a:lnTo>
                  <a:pt x="176" y="1424"/>
                </a:lnTo>
                <a:lnTo>
                  <a:pt x="184" y="1360"/>
                </a:lnTo>
                <a:lnTo>
                  <a:pt x="192" y="1272"/>
                </a:lnTo>
                <a:lnTo>
                  <a:pt x="200" y="1272"/>
                </a:lnTo>
                <a:lnTo>
                  <a:pt x="208" y="1216"/>
                </a:lnTo>
                <a:lnTo>
                  <a:pt x="216" y="1128"/>
                </a:lnTo>
                <a:lnTo>
                  <a:pt x="224" y="1048"/>
                </a:lnTo>
                <a:lnTo>
                  <a:pt x="232" y="984"/>
                </a:lnTo>
                <a:lnTo>
                  <a:pt x="240" y="856"/>
                </a:lnTo>
                <a:lnTo>
                  <a:pt x="248" y="840"/>
                </a:lnTo>
                <a:lnTo>
                  <a:pt x="256" y="776"/>
                </a:lnTo>
                <a:lnTo>
                  <a:pt x="264" y="912"/>
                </a:lnTo>
                <a:lnTo>
                  <a:pt x="272" y="544"/>
                </a:lnTo>
                <a:lnTo>
                  <a:pt x="280" y="616"/>
                </a:lnTo>
                <a:lnTo>
                  <a:pt x="288" y="520"/>
                </a:lnTo>
                <a:lnTo>
                  <a:pt x="296" y="376"/>
                </a:lnTo>
                <a:lnTo>
                  <a:pt x="304" y="304"/>
                </a:lnTo>
                <a:lnTo>
                  <a:pt x="312" y="416"/>
                </a:lnTo>
                <a:lnTo>
                  <a:pt x="320" y="200"/>
                </a:lnTo>
                <a:lnTo>
                  <a:pt x="328" y="128"/>
                </a:lnTo>
                <a:lnTo>
                  <a:pt x="336" y="280"/>
                </a:lnTo>
                <a:lnTo>
                  <a:pt x="344" y="176"/>
                </a:lnTo>
                <a:lnTo>
                  <a:pt x="352" y="216"/>
                </a:lnTo>
                <a:lnTo>
                  <a:pt x="360" y="24"/>
                </a:lnTo>
                <a:lnTo>
                  <a:pt x="368" y="0"/>
                </a:lnTo>
                <a:lnTo>
                  <a:pt x="376" y="168"/>
                </a:lnTo>
                <a:lnTo>
                  <a:pt x="384" y="72"/>
                </a:lnTo>
                <a:lnTo>
                  <a:pt x="392" y="112"/>
                </a:lnTo>
                <a:lnTo>
                  <a:pt x="400" y="96"/>
                </a:lnTo>
                <a:lnTo>
                  <a:pt x="408" y="168"/>
                </a:lnTo>
                <a:lnTo>
                  <a:pt x="416" y="144"/>
                </a:lnTo>
                <a:lnTo>
                  <a:pt x="424" y="224"/>
                </a:lnTo>
                <a:lnTo>
                  <a:pt x="432" y="288"/>
                </a:lnTo>
                <a:lnTo>
                  <a:pt x="440" y="152"/>
                </a:lnTo>
                <a:lnTo>
                  <a:pt x="448" y="344"/>
                </a:lnTo>
                <a:lnTo>
                  <a:pt x="456" y="456"/>
                </a:lnTo>
                <a:lnTo>
                  <a:pt x="464" y="680"/>
                </a:lnTo>
                <a:lnTo>
                  <a:pt x="472" y="720"/>
                </a:lnTo>
                <a:lnTo>
                  <a:pt x="480" y="600"/>
                </a:lnTo>
                <a:lnTo>
                  <a:pt x="488" y="896"/>
                </a:lnTo>
                <a:lnTo>
                  <a:pt x="496" y="1000"/>
                </a:lnTo>
                <a:lnTo>
                  <a:pt x="504" y="1104"/>
                </a:lnTo>
                <a:lnTo>
                  <a:pt x="512" y="1216"/>
                </a:lnTo>
                <a:lnTo>
                  <a:pt x="520" y="1240"/>
                </a:lnTo>
                <a:lnTo>
                  <a:pt x="528" y="1336"/>
                </a:lnTo>
                <a:lnTo>
                  <a:pt x="536" y="1336"/>
                </a:lnTo>
                <a:lnTo>
                  <a:pt x="544" y="1392"/>
                </a:lnTo>
                <a:lnTo>
                  <a:pt x="552" y="1480"/>
                </a:lnTo>
                <a:lnTo>
                  <a:pt x="560" y="1544"/>
                </a:lnTo>
                <a:lnTo>
                  <a:pt x="568" y="1568"/>
                </a:lnTo>
                <a:lnTo>
                  <a:pt x="576" y="1576"/>
                </a:lnTo>
                <a:lnTo>
                  <a:pt x="584" y="1544"/>
                </a:lnTo>
                <a:lnTo>
                  <a:pt x="592" y="1640"/>
                </a:lnTo>
                <a:lnTo>
                  <a:pt x="600" y="1680"/>
                </a:lnTo>
                <a:lnTo>
                  <a:pt x="608" y="1744"/>
                </a:lnTo>
                <a:lnTo>
                  <a:pt x="616" y="1776"/>
                </a:lnTo>
                <a:lnTo>
                  <a:pt x="624" y="1776"/>
                </a:lnTo>
                <a:lnTo>
                  <a:pt x="632" y="1784"/>
                </a:lnTo>
                <a:lnTo>
                  <a:pt x="640" y="1776"/>
                </a:lnTo>
                <a:lnTo>
                  <a:pt x="648" y="1888"/>
                </a:lnTo>
                <a:lnTo>
                  <a:pt x="656" y="1848"/>
                </a:lnTo>
                <a:lnTo>
                  <a:pt x="664" y="1872"/>
                </a:lnTo>
                <a:lnTo>
                  <a:pt x="672" y="1832"/>
                </a:lnTo>
                <a:lnTo>
                  <a:pt x="680" y="1864"/>
                </a:lnTo>
                <a:lnTo>
                  <a:pt x="688" y="1872"/>
                </a:lnTo>
                <a:lnTo>
                  <a:pt x="696" y="1848"/>
                </a:lnTo>
                <a:lnTo>
                  <a:pt x="704" y="1888"/>
                </a:lnTo>
                <a:lnTo>
                  <a:pt x="712" y="1904"/>
                </a:lnTo>
                <a:lnTo>
                  <a:pt x="720" y="1920"/>
                </a:lnTo>
                <a:lnTo>
                  <a:pt x="728" y="1888"/>
                </a:lnTo>
                <a:lnTo>
                  <a:pt x="736" y="1920"/>
                </a:lnTo>
                <a:lnTo>
                  <a:pt x="744" y="1912"/>
                </a:lnTo>
                <a:lnTo>
                  <a:pt x="752" y="1920"/>
                </a:lnTo>
                <a:lnTo>
                  <a:pt x="760" y="1936"/>
                </a:lnTo>
                <a:lnTo>
                  <a:pt x="768" y="1936"/>
                </a:lnTo>
                <a:lnTo>
                  <a:pt x="776" y="1912"/>
                </a:lnTo>
                <a:lnTo>
                  <a:pt x="784" y="1928"/>
                </a:lnTo>
                <a:lnTo>
                  <a:pt x="792" y="1936"/>
                </a:lnTo>
                <a:lnTo>
                  <a:pt x="800" y="1936"/>
                </a:lnTo>
                <a:lnTo>
                  <a:pt x="808" y="1936"/>
                </a:lnTo>
                <a:lnTo>
                  <a:pt x="816" y="1936"/>
                </a:lnTo>
                <a:lnTo>
                  <a:pt x="824" y="1928"/>
                </a:lnTo>
                <a:lnTo>
                  <a:pt x="832" y="1936"/>
                </a:lnTo>
                <a:lnTo>
                  <a:pt x="840" y="1936"/>
                </a:lnTo>
                <a:lnTo>
                  <a:pt x="848" y="1936"/>
                </a:lnTo>
                <a:lnTo>
                  <a:pt x="856" y="1936"/>
                </a:lnTo>
                <a:lnTo>
                  <a:pt x="864" y="1936"/>
                </a:lnTo>
                <a:lnTo>
                  <a:pt x="872" y="1936"/>
                </a:lnTo>
                <a:lnTo>
                  <a:pt x="880" y="1936"/>
                </a:lnTo>
                <a:lnTo>
                  <a:pt x="888" y="1936"/>
                </a:lnTo>
                <a:lnTo>
                  <a:pt x="896" y="1936"/>
                </a:lnTo>
                <a:lnTo>
                  <a:pt x="904" y="1936"/>
                </a:lnTo>
                <a:lnTo>
                  <a:pt x="912" y="1936"/>
                </a:lnTo>
                <a:lnTo>
                  <a:pt x="920" y="1936"/>
                </a:lnTo>
                <a:lnTo>
                  <a:pt x="928" y="1936"/>
                </a:lnTo>
                <a:lnTo>
                  <a:pt x="936" y="1936"/>
                </a:lnTo>
                <a:lnTo>
                  <a:pt x="944" y="1936"/>
                </a:lnTo>
                <a:lnTo>
                  <a:pt x="952" y="1936"/>
                </a:lnTo>
                <a:lnTo>
                  <a:pt x="960" y="1936"/>
                </a:lnTo>
                <a:lnTo>
                  <a:pt x="968" y="1936"/>
                </a:lnTo>
                <a:lnTo>
                  <a:pt x="976" y="1936"/>
                </a:lnTo>
                <a:lnTo>
                  <a:pt x="984" y="1936"/>
                </a:lnTo>
                <a:lnTo>
                  <a:pt x="992" y="1936"/>
                </a:lnTo>
                <a:lnTo>
                  <a:pt x="1000" y="1936"/>
                </a:lnTo>
                <a:lnTo>
                  <a:pt x="1008" y="1936"/>
                </a:lnTo>
                <a:lnTo>
                  <a:pt x="1016" y="1936"/>
                </a:lnTo>
                <a:lnTo>
                  <a:pt x="1024" y="1936"/>
                </a:lnTo>
                <a:lnTo>
                  <a:pt x="1032" y="1936"/>
                </a:lnTo>
                <a:lnTo>
                  <a:pt x="1040" y="1936"/>
                </a:lnTo>
                <a:lnTo>
                  <a:pt x="1048" y="1936"/>
                </a:lnTo>
                <a:lnTo>
                  <a:pt x="1056" y="1936"/>
                </a:lnTo>
                <a:lnTo>
                  <a:pt x="1064" y="1936"/>
                </a:lnTo>
                <a:lnTo>
                  <a:pt x="1072" y="1936"/>
                </a:lnTo>
                <a:lnTo>
                  <a:pt x="1080" y="1936"/>
                </a:lnTo>
                <a:lnTo>
                  <a:pt x="1088" y="1936"/>
                </a:lnTo>
                <a:lnTo>
                  <a:pt x="1096" y="1936"/>
                </a:lnTo>
                <a:lnTo>
                  <a:pt x="1104" y="1936"/>
                </a:lnTo>
                <a:lnTo>
                  <a:pt x="1112" y="1936"/>
                </a:lnTo>
                <a:lnTo>
                  <a:pt x="1120" y="1936"/>
                </a:lnTo>
                <a:lnTo>
                  <a:pt x="1128" y="1936"/>
                </a:lnTo>
                <a:lnTo>
                  <a:pt x="1136" y="1936"/>
                </a:lnTo>
                <a:lnTo>
                  <a:pt x="1144" y="1936"/>
                </a:lnTo>
                <a:lnTo>
                  <a:pt x="1152" y="1936"/>
                </a:lnTo>
                <a:lnTo>
                  <a:pt x="1160" y="1936"/>
                </a:lnTo>
                <a:lnTo>
                  <a:pt x="1168" y="1936"/>
                </a:lnTo>
                <a:lnTo>
                  <a:pt x="1176" y="1936"/>
                </a:lnTo>
                <a:lnTo>
                  <a:pt x="1184" y="1936"/>
                </a:lnTo>
                <a:lnTo>
                  <a:pt x="1192" y="1936"/>
                </a:lnTo>
                <a:lnTo>
                  <a:pt x="1200" y="1936"/>
                </a:lnTo>
                <a:lnTo>
                  <a:pt x="1208" y="1936"/>
                </a:lnTo>
                <a:lnTo>
                  <a:pt x="1216" y="1936"/>
                </a:lnTo>
                <a:lnTo>
                  <a:pt x="1224" y="1936"/>
                </a:lnTo>
                <a:lnTo>
                  <a:pt x="1232" y="1936"/>
                </a:lnTo>
                <a:lnTo>
                  <a:pt x="1240" y="1936"/>
                </a:lnTo>
                <a:lnTo>
                  <a:pt x="1248" y="1936"/>
                </a:lnTo>
                <a:lnTo>
                  <a:pt x="1256" y="1936"/>
                </a:lnTo>
                <a:lnTo>
                  <a:pt x="1264" y="1936"/>
                </a:lnTo>
                <a:lnTo>
                  <a:pt x="1272" y="1936"/>
                </a:lnTo>
                <a:lnTo>
                  <a:pt x="1280" y="1936"/>
                </a:lnTo>
                <a:lnTo>
                  <a:pt x="1288" y="1936"/>
                </a:lnTo>
                <a:lnTo>
                  <a:pt x="1296" y="1936"/>
                </a:lnTo>
                <a:lnTo>
                  <a:pt x="1304" y="1936"/>
                </a:lnTo>
                <a:lnTo>
                  <a:pt x="1312" y="1936"/>
                </a:lnTo>
                <a:lnTo>
                  <a:pt x="1320" y="1936"/>
                </a:lnTo>
                <a:lnTo>
                  <a:pt x="1328" y="1936"/>
                </a:lnTo>
                <a:lnTo>
                  <a:pt x="1336" y="1936"/>
                </a:lnTo>
                <a:lnTo>
                  <a:pt x="1344" y="1936"/>
                </a:lnTo>
                <a:lnTo>
                  <a:pt x="1352" y="1936"/>
                </a:lnTo>
                <a:lnTo>
                  <a:pt x="1360" y="1936"/>
                </a:lnTo>
                <a:lnTo>
                  <a:pt x="1368" y="1936"/>
                </a:lnTo>
                <a:lnTo>
                  <a:pt x="1376" y="1936"/>
                </a:lnTo>
                <a:lnTo>
                  <a:pt x="1384" y="1936"/>
                </a:lnTo>
                <a:lnTo>
                  <a:pt x="1392" y="1936"/>
                </a:lnTo>
                <a:lnTo>
                  <a:pt x="1400" y="1936"/>
                </a:lnTo>
                <a:lnTo>
                  <a:pt x="1408" y="1936"/>
                </a:lnTo>
                <a:lnTo>
                  <a:pt x="1416" y="1936"/>
                </a:lnTo>
                <a:lnTo>
                  <a:pt x="1424" y="1936"/>
                </a:lnTo>
                <a:lnTo>
                  <a:pt x="1432" y="1936"/>
                </a:lnTo>
                <a:lnTo>
                  <a:pt x="1440" y="1936"/>
                </a:lnTo>
                <a:lnTo>
                  <a:pt x="1448" y="1936"/>
                </a:lnTo>
                <a:lnTo>
                  <a:pt x="1456" y="1936"/>
                </a:lnTo>
                <a:lnTo>
                  <a:pt x="1464" y="1936"/>
                </a:lnTo>
                <a:lnTo>
                  <a:pt x="1472" y="1936"/>
                </a:lnTo>
                <a:lnTo>
                  <a:pt x="1480" y="1936"/>
                </a:lnTo>
                <a:lnTo>
                  <a:pt x="1488" y="1936"/>
                </a:lnTo>
                <a:lnTo>
                  <a:pt x="1496" y="1936"/>
                </a:lnTo>
                <a:lnTo>
                  <a:pt x="1504" y="1936"/>
                </a:lnTo>
                <a:lnTo>
                  <a:pt x="1512" y="1936"/>
                </a:lnTo>
                <a:lnTo>
                  <a:pt x="1520" y="1936"/>
                </a:lnTo>
                <a:lnTo>
                  <a:pt x="1528" y="1936"/>
                </a:lnTo>
                <a:lnTo>
                  <a:pt x="1536" y="1936"/>
                </a:lnTo>
                <a:lnTo>
                  <a:pt x="1544" y="1936"/>
                </a:lnTo>
                <a:lnTo>
                  <a:pt x="1552" y="1936"/>
                </a:lnTo>
                <a:lnTo>
                  <a:pt x="1560" y="1936"/>
                </a:lnTo>
                <a:lnTo>
                  <a:pt x="1568" y="1936"/>
                </a:lnTo>
                <a:lnTo>
                  <a:pt x="1576" y="1936"/>
                </a:lnTo>
                <a:lnTo>
                  <a:pt x="1584" y="1936"/>
                </a:lnTo>
                <a:lnTo>
                  <a:pt x="1592" y="1936"/>
                </a:lnTo>
                <a:lnTo>
                  <a:pt x="1600" y="1936"/>
                </a:lnTo>
                <a:lnTo>
                  <a:pt x="1608" y="1936"/>
                </a:lnTo>
                <a:lnTo>
                  <a:pt x="1616" y="1936"/>
                </a:lnTo>
                <a:lnTo>
                  <a:pt x="1624" y="1936"/>
                </a:lnTo>
                <a:lnTo>
                  <a:pt x="1632" y="1936"/>
                </a:lnTo>
                <a:lnTo>
                  <a:pt x="1640" y="1936"/>
                </a:lnTo>
                <a:lnTo>
                  <a:pt x="1648" y="1936"/>
                </a:lnTo>
                <a:lnTo>
                  <a:pt x="1656" y="1936"/>
                </a:lnTo>
                <a:lnTo>
                  <a:pt x="1664" y="1936"/>
                </a:lnTo>
                <a:lnTo>
                  <a:pt x="1672" y="1936"/>
                </a:lnTo>
                <a:lnTo>
                  <a:pt x="1680" y="1936"/>
                </a:lnTo>
                <a:lnTo>
                  <a:pt x="1688" y="1936"/>
                </a:lnTo>
                <a:lnTo>
                  <a:pt x="1696" y="1936"/>
                </a:lnTo>
                <a:lnTo>
                  <a:pt x="1704" y="1936"/>
                </a:lnTo>
                <a:lnTo>
                  <a:pt x="1712" y="1936"/>
                </a:lnTo>
                <a:lnTo>
                  <a:pt x="1720" y="1936"/>
                </a:lnTo>
                <a:lnTo>
                  <a:pt x="1728" y="1936"/>
                </a:lnTo>
                <a:lnTo>
                  <a:pt x="1736" y="1936"/>
                </a:lnTo>
                <a:lnTo>
                  <a:pt x="1744" y="1936"/>
                </a:lnTo>
                <a:lnTo>
                  <a:pt x="1752" y="1936"/>
                </a:lnTo>
                <a:lnTo>
                  <a:pt x="1760" y="1936"/>
                </a:lnTo>
                <a:lnTo>
                  <a:pt x="1768" y="1936"/>
                </a:lnTo>
                <a:lnTo>
                  <a:pt x="1776" y="1936"/>
                </a:lnTo>
                <a:lnTo>
                  <a:pt x="1784" y="1936"/>
                </a:lnTo>
                <a:lnTo>
                  <a:pt x="1792" y="1936"/>
                </a:lnTo>
                <a:lnTo>
                  <a:pt x="1800" y="1936"/>
                </a:lnTo>
                <a:lnTo>
                  <a:pt x="1808" y="1936"/>
                </a:lnTo>
                <a:lnTo>
                  <a:pt x="1816" y="1936"/>
                </a:lnTo>
                <a:lnTo>
                  <a:pt x="1824" y="1936"/>
                </a:lnTo>
                <a:lnTo>
                  <a:pt x="1832" y="1936"/>
                </a:lnTo>
                <a:lnTo>
                  <a:pt x="1840" y="1936"/>
                </a:lnTo>
                <a:lnTo>
                  <a:pt x="1848" y="1936"/>
                </a:lnTo>
                <a:lnTo>
                  <a:pt x="1856" y="1936"/>
                </a:lnTo>
                <a:lnTo>
                  <a:pt x="1864" y="1936"/>
                </a:lnTo>
                <a:lnTo>
                  <a:pt x="1872" y="1936"/>
                </a:lnTo>
                <a:lnTo>
                  <a:pt x="1880" y="1936"/>
                </a:lnTo>
                <a:lnTo>
                  <a:pt x="1888" y="1936"/>
                </a:lnTo>
                <a:lnTo>
                  <a:pt x="1896" y="1936"/>
                </a:lnTo>
                <a:lnTo>
                  <a:pt x="1904" y="1936"/>
                </a:lnTo>
                <a:lnTo>
                  <a:pt x="1912" y="1936"/>
                </a:lnTo>
                <a:lnTo>
                  <a:pt x="1920" y="1936"/>
                </a:lnTo>
                <a:lnTo>
                  <a:pt x="1928" y="1936"/>
                </a:lnTo>
                <a:lnTo>
                  <a:pt x="1936" y="1936"/>
                </a:lnTo>
                <a:lnTo>
                  <a:pt x="1944" y="1936"/>
                </a:lnTo>
                <a:lnTo>
                  <a:pt x="1952" y="1936"/>
                </a:lnTo>
                <a:lnTo>
                  <a:pt x="1960" y="1936"/>
                </a:lnTo>
                <a:lnTo>
                  <a:pt x="1968" y="1936"/>
                </a:lnTo>
                <a:lnTo>
                  <a:pt x="1976" y="1936"/>
                </a:lnTo>
                <a:lnTo>
                  <a:pt x="1984" y="1936"/>
                </a:lnTo>
                <a:lnTo>
                  <a:pt x="1992" y="1936"/>
                </a:lnTo>
                <a:lnTo>
                  <a:pt x="2000" y="1936"/>
                </a:lnTo>
                <a:lnTo>
                  <a:pt x="2008" y="1936"/>
                </a:lnTo>
                <a:lnTo>
                  <a:pt x="2016" y="1936"/>
                </a:lnTo>
                <a:lnTo>
                  <a:pt x="2024" y="1936"/>
                </a:lnTo>
                <a:lnTo>
                  <a:pt x="2032" y="1936"/>
                </a:lnTo>
              </a:path>
            </a:pathLst>
          </a:custGeom>
          <a:noFill/>
          <a:ln w="1260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568" name=""/>
          <p:cNvSpPr/>
          <p:nvPr/>
        </p:nvSpPr>
        <p:spPr>
          <a:xfrm>
            <a:off x="5027760" y="1395360"/>
            <a:ext cx="1423800" cy="1208160"/>
          </a:xfrm>
          <a:custGeom>
            <a:avLst/>
            <a:gdLst/>
            <a:ahLst/>
            <a:rect l="l" t="t" r="r" b="b"/>
            <a:pathLst>
              <a:path w="2032" h="2040">
                <a:moveTo>
                  <a:pt x="0" y="2040"/>
                </a:moveTo>
                <a:lnTo>
                  <a:pt x="0" y="0"/>
                </a:lnTo>
                <a:lnTo>
                  <a:pt x="0" y="1552"/>
                </a:lnTo>
                <a:lnTo>
                  <a:pt x="8" y="1472"/>
                </a:lnTo>
                <a:lnTo>
                  <a:pt x="16" y="1464"/>
                </a:lnTo>
                <a:lnTo>
                  <a:pt x="24" y="1488"/>
                </a:lnTo>
                <a:lnTo>
                  <a:pt x="32" y="1376"/>
                </a:lnTo>
                <a:lnTo>
                  <a:pt x="40" y="1136"/>
                </a:lnTo>
                <a:lnTo>
                  <a:pt x="48" y="1048"/>
                </a:lnTo>
                <a:lnTo>
                  <a:pt x="56" y="1064"/>
                </a:lnTo>
                <a:lnTo>
                  <a:pt x="64" y="1160"/>
                </a:lnTo>
                <a:lnTo>
                  <a:pt x="72" y="912"/>
                </a:lnTo>
                <a:lnTo>
                  <a:pt x="80" y="696"/>
                </a:lnTo>
                <a:lnTo>
                  <a:pt x="88" y="784"/>
                </a:lnTo>
                <a:lnTo>
                  <a:pt x="96" y="792"/>
                </a:lnTo>
                <a:lnTo>
                  <a:pt x="104" y="768"/>
                </a:lnTo>
                <a:lnTo>
                  <a:pt x="112" y="360"/>
                </a:lnTo>
                <a:lnTo>
                  <a:pt x="120" y="488"/>
                </a:lnTo>
                <a:lnTo>
                  <a:pt x="128" y="560"/>
                </a:lnTo>
                <a:lnTo>
                  <a:pt x="136" y="432"/>
                </a:lnTo>
                <a:lnTo>
                  <a:pt x="144" y="488"/>
                </a:lnTo>
                <a:lnTo>
                  <a:pt x="152" y="552"/>
                </a:lnTo>
                <a:lnTo>
                  <a:pt x="160" y="424"/>
                </a:lnTo>
                <a:lnTo>
                  <a:pt x="168" y="424"/>
                </a:lnTo>
                <a:lnTo>
                  <a:pt x="176" y="496"/>
                </a:lnTo>
                <a:lnTo>
                  <a:pt x="184" y="104"/>
                </a:lnTo>
                <a:lnTo>
                  <a:pt x="192" y="544"/>
                </a:lnTo>
                <a:lnTo>
                  <a:pt x="200" y="272"/>
                </a:lnTo>
                <a:lnTo>
                  <a:pt x="208" y="432"/>
                </a:lnTo>
                <a:lnTo>
                  <a:pt x="216" y="432"/>
                </a:lnTo>
                <a:lnTo>
                  <a:pt x="224" y="280"/>
                </a:lnTo>
                <a:lnTo>
                  <a:pt x="232" y="416"/>
                </a:lnTo>
                <a:lnTo>
                  <a:pt x="240" y="304"/>
                </a:lnTo>
                <a:lnTo>
                  <a:pt x="248" y="360"/>
                </a:lnTo>
                <a:lnTo>
                  <a:pt x="256" y="352"/>
                </a:lnTo>
                <a:lnTo>
                  <a:pt x="264" y="424"/>
                </a:lnTo>
                <a:lnTo>
                  <a:pt x="272" y="320"/>
                </a:lnTo>
                <a:lnTo>
                  <a:pt x="280" y="336"/>
                </a:lnTo>
                <a:lnTo>
                  <a:pt x="288" y="336"/>
                </a:lnTo>
                <a:lnTo>
                  <a:pt x="296" y="272"/>
                </a:lnTo>
                <a:lnTo>
                  <a:pt x="304" y="272"/>
                </a:lnTo>
                <a:lnTo>
                  <a:pt x="312" y="328"/>
                </a:lnTo>
                <a:lnTo>
                  <a:pt x="320" y="352"/>
                </a:lnTo>
                <a:lnTo>
                  <a:pt x="328" y="320"/>
                </a:lnTo>
                <a:lnTo>
                  <a:pt x="336" y="384"/>
                </a:lnTo>
                <a:lnTo>
                  <a:pt x="344" y="360"/>
                </a:lnTo>
                <a:lnTo>
                  <a:pt x="352" y="456"/>
                </a:lnTo>
                <a:lnTo>
                  <a:pt x="360" y="280"/>
                </a:lnTo>
                <a:lnTo>
                  <a:pt x="368" y="104"/>
                </a:lnTo>
                <a:lnTo>
                  <a:pt x="376" y="256"/>
                </a:lnTo>
                <a:lnTo>
                  <a:pt x="384" y="168"/>
                </a:lnTo>
                <a:lnTo>
                  <a:pt x="392" y="488"/>
                </a:lnTo>
                <a:lnTo>
                  <a:pt x="400" y="304"/>
                </a:lnTo>
                <a:lnTo>
                  <a:pt x="408" y="528"/>
                </a:lnTo>
                <a:lnTo>
                  <a:pt x="416" y="120"/>
                </a:lnTo>
                <a:lnTo>
                  <a:pt x="424" y="448"/>
                </a:lnTo>
                <a:lnTo>
                  <a:pt x="432" y="416"/>
                </a:lnTo>
                <a:lnTo>
                  <a:pt x="440" y="624"/>
                </a:lnTo>
                <a:lnTo>
                  <a:pt x="448" y="408"/>
                </a:lnTo>
                <a:lnTo>
                  <a:pt x="456" y="472"/>
                </a:lnTo>
                <a:lnTo>
                  <a:pt x="464" y="1104"/>
                </a:lnTo>
                <a:lnTo>
                  <a:pt x="472" y="672"/>
                </a:lnTo>
                <a:lnTo>
                  <a:pt x="480" y="936"/>
                </a:lnTo>
                <a:lnTo>
                  <a:pt x="488" y="928"/>
                </a:lnTo>
                <a:lnTo>
                  <a:pt x="496" y="808"/>
                </a:lnTo>
                <a:lnTo>
                  <a:pt x="504" y="968"/>
                </a:lnTo>
                <a:lnTo>
                  <a:pt x="512" y="1256"/>
                </a:lnTo>
                <a:lnTo>
                  <a:pt x="520" y="1192"/>
                </a:lnTo>
                <a:lnTo>
                  <a:pt x="528" y="1288"/>
                </a:lnTo>
                <a:lnTo>
                  <a:pt x="536" y="1360"/>
                </a:lnTo>
                <a:lnTo>
                  <a:pt x="544" y="1400"/>
                </a:lnTo>
                <a:lnTo>
                  <a:pt x="552" y="1424"/>
                </a:lnTo>
                <a:lnTo>
                  <a:pt x="560" y="1408"/>
                </a:lnTo>
                <a:lnTo>
                  <a:pt x="568" y="1608"/>
                </a:lnTo>
                <a:lnTo>
                  <a:pt x="576" y="1560"/>
                </a:lnTo>
                <a:lnTo>
                  <a:pt x="584" y="1704"/>
                </a:lnTo>
                <a:lnTo>
                  <a:pt x="592" y="1776"/>
                </a:lnTo>
                <a:lnTo>
                  <a:pt x="600" y="1752"/>
                </a:lnTo>
                <a:lnTo>
                  <a:pt x="608" y="1800"/>
                </a:lnTo>
                <a:lnTo>
                  <a:pt x="616" y="1752"/>
                </a:lnTo>
                <a:lnTo>
                  <a:pt x="624" y="1864"/>
                </a:lnTo>
                <a:lnTo>
                  <a:pt x="632" y="1832"/>
                </a:lnTo>
                <a:lnTo>
                  <a:pt x="640" y="1896"/>
                </a:lnTo>
                <a:lnTo>
                  <a:pt x="648" y="1960"/>
                </a:lnTo>
                <a:lnTo>
                  <a:pt x="656" y="1896"/>
                </a:lnTo>
                <a:lnTo>
                  <a:pt x="664" y="1880"/>
                </a:lnTo>
                <a:lnTo>
                  <a:pt x="672" y="1960"/>
                </a:lnTo>
                <a:lnTo>
                  <a:pt x="680" y="1968"/>
                </a:lnTo>
                <a:lnTo>
                  <a:pt x="688" y="1960"/>
                </a:lnTo>
                <a:lnTo>
                  <a:pt x="696" y="1960"/>
                </a:lnTo>
                <a:lnTo>
                  <a:pt x="704" y="1992"/>
                </a:lnTo>
                <a:lnTo>
                  <a:pt x="712" y="1944"/>
                </a:lnTo>
                <a:lnTo>
                  <a:pt x="720" y="2008"/>
                </a:lnTo>
                <a:lnTo>
                  <a:pt x="728" y="2016"/>
                </a:lnTo>
                <a:lnTo>
                  <a:pt x="736" y="2032"/>
                </a:lnTo>
                <a:lnTo>
                  <a:pt x="744" y="2016"/>
                </a:lnTo>
                <a:lnTo>
                  <a:pt x="752" y="2032"/>
                </a:lnTo>
                <a:lnTo>
                  <a:pt x="760" y="2016"/>
                </a:lnTo>
                <a:lnTo>
                  <a:pt x="768" y="2024"/>
                </a:lnTo>
                <a:lnTo>
                  <a:pt x="776" y="2032"/>
                </a:lnTo>
                <a:lnTo>
                  <a:pt x="784" y="2040"/>
                </a:lnTo>
                <a:lnTo>
                  <a:pt x="792" y="2040"/>
                </a:lnTo>
                <a:lnTo>
                  <a:pt x="800" y="2040"/>
                </a:lnTo>
                <a:lnTo>
                  <a:pt x="808" y="2040"/>
                </a:lnTo>
                <a:lnTo>
                  <a:pt x="816" y="2040"/>
                </a:lnTo>
                <a:lnTo>
                  <a:pt x="824" y="2040"/>
                </a:lnTo>
                <a:lnTo>
                  <a:pt x="832" y="2040"/>
                </a:lnTo>
                <a:lnTo>
                  <a:pt x="840" y="2040"/>
                </a:lnTo>
                <a:lnTo>
                  <a:pt x="848" y="2040"/>
                </a:lnTo>
                <a:lnTo>
                  <a:pt x="856" y="2040"/>
                </a:lnTo>
                <a:lnTo>
                  <a:pt x="864" y="2040"/>
                </a:lnTo>
                <a:lnTo>
                  <a:pt x="872" y="2040"/>
                </a:lnTo>
                <a:lnTo>
                  <a:pt x="880" y="2040"/>
                </a:lnTo>
                <a:lnTo>
                  <a:pt x="888" y="2040"/>
                </a:lnTo>
                <a:lnTo>
                  <a:pt x="896" y="2040"/>
                </a:lnTo>
                <a:lnTo>
                  <a:pt x="904" y="2040"/>
                </a:lnTo>
                <a:lnTo>
                  <a:pt x="912" y="2040"/>
                </a:lnTo>
                <a:lnTo>
                  <a:pt x="920" y="2040"/>
                </a:lnTo>
                <a:lnTo>
                  <a:pt x="928" y="2040"/>
                </a:lnTo>
                <a:lnTo>
                  <a:pt x="936" y="2040"/>
                </a:lnTo>
                <a:lnTo>
                  <a:pt x="944" y="2040"/>
                </a:lnTo>
                <a:lnTo>
                  <a:pt x="952" y="2040"/>
                </a:lnTo>
                <a:lnTo>
                  <a:pt x="960" y="2040"/>
                </a:lnTo>
                <a:lnTo>
                  <a:pt x="968" y="2040"/>
                </a:lnTo>
                <a:lnTo>
                  <a:pt x="976" y="2040"/>
                </a:lnTo>
                <a:lnTo>
                  <a:pt x="984" y="2040"/>
                </a:lnTo>
                <a:lnTo>
                  <a:pt x="992" y="2040"/>
                </a:lnTo>
                <a:lnTo>
                  <a:pt x="1000" y="2040"/>
                </a:lnTo>
                <a:lnTo>
                  <a:pt x="1008" y="2040"/>
                </a:lnTo>
                <a:lnTo>
                  <a:pt x="1016" y="2040"/>
                </a:lnTo>
                <a:lnTo>
                  <a:pt x="1024" y="2040"/>
                </a:lnTo>
                <a:lnTo>
                  <a:pt x="1032" y="2040"/>
                </a:lnTo>
                <a:lnTo>
                  <a:pt x="1040" y="2040"/>
                </a:lnTo>
                <a:lnTo>
                  <a:pt x="1048" y="2040"/>
                </a:lnTo>
                <a:lnTo>
                  <a:pt x="1056" y="2040"/>
                </a:lnTo>
                <a:lnTo>
                  <a:pt x="1064" y="2040"/>
                </a:lnTo>
                <a:lnTo>
                  <a:pt x="1072" y="2040"/>
                </a:lnTo>
                <a:lnTo>
                  <a:pt x="1080" y="2040"/>
                </a:lnTo>
                <a:lnTo>
                  <a:pt x="1088" y="2040"/>
                </a:lnTo>
                <a:lnTo>
                  <a:pt x="1096" y="2040"/>
                </a:lnTo>
                <a:lnTo>
                  <a:pt x="1104" y="2040"/>
                </a:lnTo>
                <a:lnTo>
                  <a:pt x="1112" y="2040"/>
                </a:lnTo>
                <a:lnTo>
                  <a:pt x="1120" y="2040"/>
                </a:lnTo>
                <a:lnTo>
                  <a:pt x="1128" y="2040"/>
                </a:lnTo>
                <a:lnTo>
                  <a:pt x="1136" y="2040"/>
                </a:lnTo>
                <a:lnTo>
                  <a:pt x="1144" y="2040"/>
                </a:lnTo>
                <a:lnTo>
                  <a:pt x="1152" y="2040"/>
                </a:lnTo>
                <a:lnTo>
                  <a:pt x="1160" y="2040"/>
                </a:lnTo>
                <a:lnTo>
                  <a:pt x="1168" y="2040"/>
                </a:lnTo>
                <a:lnTo>
                  <a:pt x="1176" y="2040"/>
                </a:lnTo>
                <a:lnTo>
                  <a:pt x="1184" y="2040"/>
                </a:lnTo>
                <a:lnTo>
                  <a:pt x="1192" y="2040"/>
                </a:lnTo>
                <a:lnTo>
                  <a:pt x="1200" y="2040"/>
                </a:lnTo>
                <a:lnTo>
                  <a:pt x="1208" y="2040"/>
                </a:lnTo>
                <a:lnTo>
                  <a:pt x="1216" y="2040"/>
                </a:lnTo>
                <a:lnTo>
                  <a:pt x="1224" y="2040"/>
                </a:lnTo>
                <a:lnTo>
                  <a:pt x="1232" y="2040"/>
                </a:lnTo>
                <a:lnTo>
                  <a:pt x="1240" y="2040"/>
                </a:lnTo>
                <a:lnTo>
                  <a:pt x="1248" y="2040"/>
                </a:lnTo>
                <a:lnTo>
                  <a:pt x="1256" y="2040"/>
                </a:lnTo>
                <a:lnTo>
                  <a:pt x="1264" y="2040"/>
                </a:lnTo>
                <a:lnTo>
                  <a:pt x="1272" y="2040"/>
                </a:lnTo>
                <a:lnTo>
                  <a:pt x="1280" y="2040"/>
                </a:lnTo>
                <a:lnTo>
                  <a:pt x="1288" y="2040"/>
                </a:lnTo>
                <a:lnTo>
                  <a:pt x="1296" y="2040"/>
                </a:lnTo>
                <a:lnTo>
                  <a:pt x="1304" y="2040"/>
                </a:lnTo>
                <a:lnTo>
                  <a:pt x="1312" y="2040"/>
                </a:lnTo>
                <a:lnTo>
                  <a:pt x="1320" y="2040"/>
                </a:lnTo>
                <a:lnTo>
                  <a:pt x="1328" y="2040"/>
                </a:lnTo>
                <a:lnTo>
                  <a:pt x="1336" y="2040"/>
                </a:lnTo>
                <a:lnTo>
                  <a:pt x="1344" y="2040"/>
                </a:lnTo>
                <a:lnTo>
                  <a:pt x="1352" y="2040"/>
                </a:lnTo>
                <a:lnTo>
                  <a:pt x="1360" y="2040"/>
                </a:lnTo>
                <a:lnTo>
                  <a:pt x="1368" y="2040"/>
                </a:lnTo>
                <a:lnTo>
                  <a:pt x="1376" y="2040"/>
                </a:lnTo>
                <a:lnTo>
                  <a:pt x="1384" y="2040"/>
                </a:lnTo>
                <a:lnTo>
                  <a:pt x="1392" y="2040"/>
                </a:lnTo>
                <a:lnTo>
                  <a:pt x="1400" y="2040"/>
                </a:lnTo>
                <a:lnTo>
                  <a:pt x="1408" y="2040"/>
                </a:lnTo>
                <a:lnTo>
                  <a:pt x="1416" y="2040"/>
                </a:lnTo>
                <a:lnTo>
                  <a:pt x="1424" y="2040"/>
                </a:lnTo>
                <a:lnTo>
                  <a:pt x="1432" y="2040"/>
                </a:lnTo>
                <a:lnTo>
                  <a:pt x="1440" y="2040"/>
                </a:lnTo>
                <a:lnTo>
                  <a:pt x="1448" y="2040"/>
                </a:lnTo>
                <a:lnTo>
                  <a:pt x="1456" y="2040"/>
                </a:lnTo>
                <a:lnTo>
                  <a:pt x="1464" y="2040"/>
                </a:lnTo>
                <a:lnTo>
                  <a:pt x="1472" y="2040"/>
                </a:lnTo>
                <a:lnTo>
                  <a:pt x="1480" y="2040"/>
                </a:lnTo>
                <a:lnTo>
                  <a:pt x="1488" y="2040"/>
                </a:lnTo>
                <a:lnTo>
                  <a:pt x="1496" y="2040"/>
                </a:lnTo>
                <a:lnTo>
                  <a:pt x="1504" y="2040"/>
                </a:lnTo>
                <a:lnTo>
                  <a:pt x="1512" y="2040"/>
                </a:lnTo>
                <a:lnTo>
                  <a:pt x="1520" y="2040"/>
                </a:lnTo>
                <a:lnTo>
                  <a:pt x="1528" y="2040"/>
                </a:lnTo>
                <a:lnTo>
                  <a:pt x="1536" y="2040"/>
                </a:lnTo>
                <a:lnTo>
                  <a:pt x="1544" y="2040"/>
                </a:lnTo>
                <a:lnTo>
                  <a:pt x="1552" y="2040"/>
                </a:lnTo>
                <a:lnTo>
                  <a:pt x="1560" y="2040"/>
                </a:lnTo>
                <a:lnTo>
                  <a:pt x="1568" y="2040"/>
                </a:lnTo>
                <a:lnTo>
                  <a:pt x="1576" y="2040"/>
                </a:lnTo>
                <a:lnTo>
                  <a:pt x="1584" y="2040"/>
                </a:lnTo>
                <a:lnTo>
                  <a:pt x="1592" y="2040"/>
                </a:lnTo>
                <a:lnTo>
                  <a:pt x="1600" y="2040"/>
                </a:lnTo>
                <a:lnTo>
                  <a:pt x="1608" y="2040"/>
                </a:lnTo>
                <a:lnTo>
                  <a:pt x="1616" y="2040"/>
                </a:lnTo>
                <a:lnTo>
                  <a:pt x="1624" y="2040"/>
                </a:lnTo>
                <a:lnTo>
                  <a:pt x="1632" y="2040"/>
                </a:lnTo>
                <a:lnTo>
                  <a:pt x="1640" y="2040"/>
                </a:lnTo>
                <a:lnTo>
                  <a:pt x="1648" y="2040"/>
                </a:lnTo>
                <a:lnTo>
                  <a:pt x="1656" y="2040"/>
                </a:lnTo>
                <a:lnTo>
                  <a:pt x="1664" y="2040"/>
                </a:lnTo>
                <a:lnTo>
                  <a:pt x="1672" y="2040"/>
                </a:lnTo>
                <a:lnTo>
                  <a:pt x="1680" y="2040"/>
                </a:lnTo>
                <a:lnTo>
                  <a:pt x="1688" y="2040"/>
                </a:lnTo>
                <a:lnTo>
                  <a:pt x="1696" y="2040"/>
                </a:lnTo>
                <a:lnTo>
                  <a:pt x="1704" y="2040"/>
                </a:lnTo>
                <a:lnTo>
                  <a:pt x="1712" y="2040"/>
                </a:lnTo>
                <a:lnTo>
                  <a:pt x="1720" y="2040"/>
                </a:lnTo>
                <a:lnTo>
                  <a:pt x="1728" y="2040"/>
                </a:lnTo>
                <a:lnTo>
                  <a:pt x="1736" y="2040"/>
                </a:lnTo>
                <a:lnTo>
                  <a:pt x="1744" y="2040"/>
                </a:lnTo>
                <a:lnTo>
                  <a:pt x="1752" y="2040"/>
                </a:lnTo>
                <a:lnTo>
                  <a:pt x="1760" y="2040"/>
                </a:lnTo>
                <a:lnTo>
                  <a:pt x="1768" y="2040"/>
                </a:lnTo>
                <a:lnTo>
                  <a:pt x="1776" y="2040"/>
                </a:lnTo>
                <a:lnTo>
                  <a:pt x="1784" y="2040"/>
                </a:lnTo>
                <a:lnTo>
                  <a:pt x="1792" y="2040"/>
                </a:lnTo>
                <a:lnTo>
                  <a:pt x="1800" y="2040"/>
                </a:lnTo>
                <a:lnTo>
                  <a:pt x="1808" y="2040"/>
                </a:lnTo>
                <a:lnTo>
                  <a:pt x="1816" y="2040"/>
                </a:lnTo>
                <a:lnTo>
                  <a:pt x="1824" y="2040"/>
                </a:lnTo>
                <a:lnTo>
                  <a:pt x="1832" y="2040"/>
                </a:lnTo>
                <a:lnTo>
                  <a:pt x="1840" y="2040"/>
                </a:lnTo>
                <a:lnTo>
                  <a:pt x="1848" y="2040"/>
                </a:lnTo>
                <a:lnTo>
                  <a:pt x="1856" y="2040"/>
                </a:lnTo>
                <a:lnTo>
                  <a:pt x="1864" y="2040"/>
                </a:lnTo>
                <a:lnTo>
                  <a:pt x="1872" y="2040"/>
                </a:lnTo>
                <a:lnTo>
                  <a:pt x="1880" y="2040"/>
                </a:lnTo>
                <a:lnTo>
                  <a:pt x="1888" y="2040"/>
                </a:lnTo>
                <a:lnTo>
                  <a:pt x="1896" y="2040"/>
                </a:lnTo>
                <a:lnTo>
                  <a:pt x="1904" y="2040"/>
                </a:lnTo>
                <a:lnTo>
                  <a:pt x="1912" y="2040"/>
                </a:lnTo>
                <a:lnTo>
                  <a:pt x="1920" y="2040"/>
                </a:lnTo>
                <a:lnTo>
                  <a:pt x="1928" y="2040"/>
                </a:lnTo>
                <a:lnTo>
                  <a:pt x="1936" y="2040"/>
                </a:lnTo>
                <a:lnTo>
                  <a:pt x="1944" y="2040"/>
                </a:lnTo>
                <a:lnTo>
                  <a:pt x="1952" y="2040"/>
                </a:lnTo>
                <a:lnTo>
                  <a:pt x="1960" y="2040"/>
                </a:lnTo>
                <a:lnTo>
                  <a:pt x="1968" y="2040"/>
                </a:lnTo>
                <a:lnTo>
                  <a:pt x="1976" y="2040"/>
                </a:lnTo>
                <a:lnTo>
                  <a:pt x="1984" y="2040"/>
                </a:lnTo>
                <a:lnTo>
                  <a:pt x="1992" y="2040"/>
                </a:lnTo>
                <a:lnTo>
                  <a:pt x="2000" y="2040"/>
                </a:lnTo>
                <a:lnTo>
                  <a:pt x="2008" y="2040"/>
                </a:lnTo>
                <a:lnTo>
                  <a:pt x="2016" y="2040"/>
                </a:lnTo>
                <a:lnTo>
                  <a:pt x="2024" y="2040"/>
                </a:lnTo>
                <a:lnTo>
                  <a:pt x="2032" y="2040"/>
                </a:lnTo>
              </a:path>
            </a:pathLst>
          </a:custGeom>
          <a:noFill/>
          <a:ln w="12600">
            <a:solidFill>
              <a:srgbClr val="0000ff"/>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569" name=""/>
          <p:cNvSpPr/>
          <p:nvPr/>
        </p:nvSpPr>
        <p:spPr>
          <a:xfrm>
            <a:off x="6858000" y="1400040"/>
            <a:ext cx="1459080" cy="1217880"/>
          </a:xfrm>
          <a:prstGeom prst="rect">
            <a:avLst/>
          </a:prstGeom>
          <a:solidFill>
            <a:srgbClr val="ffffff"/>
          </a:solidFill>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570" name=""/>
          <p:cNvSpPr/>
          <p:nvPr/>
        </p:nvSpPr>
        <p:spPr>
          <a:xfrm>
            <a:off x="6858000" y="2612880"/>
            <a:ext cx="145260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nvGrpSpPr>
          <p:cNvPr id="571" name=""/>
          <p:cNvGrpSpPr/>
          <p:nvPr/>
        </p:nvGrpSpPr>
        <p:grpSpPr>
          <a:xfrm>
            <a:off x="6858000" y="2617920"/>
            <a:ext cx="1453680" cy="28440"/>
            <a:chOff x="6858000" y="2617920"/>
            <a:chExt cx="1453680" cy="28440"/>
          </a:xfrm>
        </p:grpSpPr>
        <p:sp>
          <p:nvSpPr>
            <p:cNvPr id="572" name=""/>
            <p:cNvSpPr/>
            <p:nvPr/>
          </p:nvSpPr>
          <p:spPr>
            <a:xfrm>
              <a:off x="6858000" y="2617920"/>
              <a:ext cx="36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sp>
          <p:nvSpPr>
            <p:cNvPr id="573" name=""/>
            <p:cNvSpPr/>
            <p:nvPr/>
          </p:nvSpPr>
          <p:spPr>
            <a:xfrm>
              <a:off x="6964920" y="261792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74" name=""/>
            <p:cNvSpPr/>
            <p:nvPr/>
          </p:nvSpPr>
          <p:spPr>
            <a:xfrm>
              <a:off x="7026840" y="261792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75" name=""/>
            <p:cNvSpPr/>
            <p:nvPr/>
          </p:nvSpPr>
          <p:spPr>
            <a:xfrm>
              <a:off x="7071840" y="261792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76" name=""/>
            <p:cNvSpPr/>
            <p:nvPr/>
          </p:nvSpPr>
          <p:spPr>
            <a:xfrm>
              <a:off x="7111440" y="2617920"/>
              <a:ext cx="72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577" name=""/>
            <p:cNvSpPr/>
            <p:nvPr/>
          </p:nvSpPr>
          <p:spPr>
            <a:xfrm>
              <a:off x="7139520" y="261792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78" name=""/>
            <p:cNvSpPr/>
            <p:nvPr/>
          </p:nvSpPr>
          <p:spPr>
            <a:xfrm>
              <a:off x="7162200" y="261792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79" name=""/>
            <p:cNvSpPr/>
            <p:nvPr/>
          </p:nvSpPr>
          <p:spPr>
            <a:xfrm>
              <a:off x="7184520" y="261792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80" name=""/>
            <p:cNvSpPr/>
            <p:nvPr/>
          </p:nvSpPr>
          <p:spPr>
            <a:xfrm>
              <a:off x="7201440" y="261792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81" name=""/>
            <p:cNvSpPr/>
            <p:nvPr/>
          </p:nvSpPr>
          <p:spPr>
            <a:xfrm>
              <a:off x="7218360" y="2617920"/>
              <a:ext cx="36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sp>
          <p:nvSpPr>
            <p:cNvPr id="582" name=""/>
            <p:cNvSpPr/>
            <p:nvPr/>
          </p:nvSpPr>
          <p:spPr>
            <a:xfrm>
              <a:off x="7331040" y="261792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83" name=""/>
            <p:cNvSpPr/>
            <p:nvPr/>
          </p:nvSpPr>
          <p:spPr>
            <a:xfrm>
              <a:off x="7392960" y="261792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84" name=""/>
            <p:cNvSpPr/>
            <p:nvPr/>
          </p:nvSpPr>
          <p:spPr>
            <a:xfrm>
              <a:off x="7438320" y="261792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85" name=""/>
            <p:cNvSpPr/>
            <p:nvPr/>
          </p:nvSpPr>
          <p:spPr>
            <a:xfrm>
              <a:off x="7471800" y="2617920"/>
              <a:ext cx="72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586" name=""/>
            <p:cNvSpPr/>
            <p:nvPr/>
          </p:nvSpPr>
          <p:spPr>
            <a:xfrm>
              <a:off x="7505640" y="261792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87" name=""/>
            <p:cNvSpPr/>
            <p:nvPr/>
          </p:nvSpPr>
          <p:spPr>
            <a:xfrm>
              <a:off x="7528320" y="261792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88" name=""/>
            <p:cNvSpPr/>
            <p:nvPr/>
          </p:nvSpPr>
          <p:spPr>
            <a:xfrm>
              <a:off x="7550640" y="261792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89" name=""/>
            <p:cNvSpPr/>
            <p:nvPr/>
          </p:nvSpPr>
          <p:spPr>
            <a:xfrm>
              <a:off x="7567560" y="261792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90" name=""/>
            <p:cNvSpPr/>
            <p:nvPr/>
          </p:nvSpPr>
          <p:spPr>
            <a:xfrm>
              <a:off x="7584480" y="2617920"/>
              <a:ext cx="36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sp>
          <p:nvSpPr>
            <p:cNvPr id="591" name=""/>
            <p:cNvSpPr/>
            <p:nvPr/>
          </p:nvSpPr>
          <p:spPr>
            <a:xfrm>
              <a:off x="7691760" y="261792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92" name=""/>
            <p:cNvSpPr/>
            <p:nvPr/>
          </p:nvSpPr>
          <p:spPr>
            <a:xfrm>
              <a:off x="7759080" y="261792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93" name=""/>
            <p:cNvSpPr/>
            <p:nvPr/>
          </p:nvSpPr>
          <p:spPr>
            <a:xfrm>
              <a:off x="7804440" y="261792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94" name=""/>
            <p:cNvSpPr/>
            <p:nvPr/>
          </p:nvSpPr>
          <p:spPr>
            <a:xfrm>
              <a:off x="7837920" y="2617920"/>
              <a:ext cx="72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595" name=""/>
            <p:cNvSpPr/>
            <p:nvPr/>
          </p:nvSpPr>
          <p:spPr>
            <a:xfrm>
              <a:off x="7866360" y="261792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96" name=""/>
            <p:cNvSpPr/>
            <p:nvPr/>
          </p:nvSpPr>
          <p:spPr>
            <a:xfrm>
              <a:off x="7894440" y="261792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97" name=""/>
            <p:cNvSpPr/>
            <p:nvPr/>
          </p:nvSpPr>
          <p:spPr>
            <a:xfrm>
              <a:off x="7911360" y="261792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98" name=""/>
            <p:cNvSpPr/>
            <p:nvPr/>
          </p:nvSpPr>
          <p:spPr>
            <a:xfrm>
              <a:off x="7934040" y="261792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599" name=""/>
            <p:cNvSpPr/>
            <p:nvPr/>
          </p:nvSpPr>
          <p:spPr>
            <a:xfrm>
              <a:off x="7950960" y="2617920"/>
              <a:ext cx="36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sp>
          <p:nvSpPr>
            <p:cNvPr id="600" name=""/>
            <p:cNvSpPr/>
            <p:nvPr/>
          </p:nvSpPr>
          <p:spPr>
            <a:xfrm>
              <a:off x="8057880" y="261792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601" name=""/>
            <p:cNvSpPr/>
            <p:nvPr/>
          </p:nvSpPr>
          <p:spPr>
            <a:xfrm>
              <a:off x="8125200" y="2617920"/>
              <a:ext cx="72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602" name=""/>
            <p:cNvSpPr/>
            <p:nvPr/>
          </p:nvSpPr>
          <p:spPr>
            <a:xfrm>
              <a:off x="8170560" y="261792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603" name=""/>
            <p:cNvSpPr/>
            <p:nvPr/>
          </p:nvSpPr>
          <p:spPr>
            <a:xfrm>
              <a:off x="8204400" y="2617920"/>
              <a:ext cx="720" cy="19080"/>
            </a:xfrm>
            <a:prstGeom prst="line">
              <a:avLst/>
            </a:prstGeom>
            <a:ln w="12600">
              <a:solidFill>
                <a:srgbClr val="000000"/>
              </a:solidFill>
              <a:miter/>
            </a:ln>
          </p:spPr>
          <p:style>
            <a:lnRef idx="0"/>
            <a:fillRef idx="0"/>
            <a:effectRef idx="0"/>
            <a:fontRef idx="minor"/>
          </p:style>
          <p:txBody>
            <a:bodyPr lIns="90000" rIns="90000" tIns="-27720" bIns="-27720" anchor="t">
              <a:noAutofit/>
            </a:bodyPr>
            <a:p>
              <a:endParaRPr b="0" lang="en-US" sz="2400" spc="-1" strike="noStrike">
                <a:solidFill>
                  <a:srgbClr val="000000"/>
                </a:solidFill>
                <a:latin typeface="Arial"/>
              </a:endParaRPr>
            </a:p>
          </p:txBody>
        </p:sp>
        <p:sp>
          <p:nvSpPr>
            <p:cNvPr id="604" name=""/>
            <p:cNvSpPr/>
            <p:nvPr/>
          </p:nvSpPr>
          <p:spPr>
            <a:xfrm>
              <a:off x="8232480" y="261792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605" name=""/>
            <p:cNvSpPr/>
            <p:nvPr/>
          </p:nvSpPr>
          <p:spPr>
            <a:xfrm>
              <a:off x="8255160" y="261792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606" name=""/>
            <p:cNvSpPr/>
            <p:nvPr/>
          </p:nvSpPr>
          <p:spPr>
            <a:xfrm>
              <a:off x="8277480" y="261792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607" name=""/>
            <p:cNvSpPr/>
            <p:nvPr/>
          </p:nvSpPr>
          <p:spPr>
            <a:xfrm>
              <a:off x="8294400" y="2617920"/>
              <a:ext cx="360" cy="9360"/>
            </a:xfrm>
            <a:prstGeom prst="line">
              <a:avLst/>
            </a:prstGeom>
            <a:ln w="12600">
              <a:solidFill>
                <a:srgbClr val="000000"/>
              </a:solidFill>
              <a:miter/>
            </a:ln>
          </p:spPr>
          <p:style>
            <a:lnRef idx="0"/>
            <a:fillRef idx="0"/>
            <a:effectRef idx="0"/>
            <a:fontRef idx="minor"/>
          </p:style>
          <p:txBody>
            <a:bodyPr lIns="90000" rIns="90000" tIns="-37440" bIns="-37440" anchor="t">
              <a:noAutofit/>
            </a:bodyPr>
            <a:p>
              <a:endParaRPr b="0" lang="en-US" sz="2400" spc="-1" strike="noStrike">
                <a:solidFill>
                  <a:srgbClr val="000000"/>
                </a:solidFill>
                <a:latin typeface="Arial"/>
              </a:endParaRPr>
            </a:p>
          </p:txBody>
        </p:sp>
        <p:sp>
          <p:nvSpPr>
            <p:cNvPr id="608" name=""/>
            <p:cNvSpPr/>
            <p:nvPr/>
          </p:nvSpPr>
          <p:spPr>
            <a:xfrm>
              <a:off x="8311320" y="2617920"/>
              <a:ext cx="360" cy="28440"/>
            </a:xfrm>
            <a:prstGeom prst="line">
              <a:avLst/>
            </a:prstGeom>
            <a:ln w="12600">
              <a:solidFill>
                <a:srgbClr val="000000"/>
              </a:solidFill>
              <a:miter/>
            </a:ln>
          </p:spPr>
          <p:style>
            <a:lnRef idx="0"/>
            <a:fillRef idx="0"/>
            <a:effectRef idx="0"/>
            <a:fontRef idx="minor"/>
          </p:style>
          <p:txBody>
            <a:bodyPr lIns="90000" rIns="90000" tIns="-18360" bIns="-18360" anchor="t">
              <a:noAutofit/>
            </a:bodyPr>
            <a:p>
              <a:endParaRPr b="0" lang="en-US" sz="2400" spc="-1" strike="noStrike">
                <a:solidFill>
                  <a:srgbClr val="000000"/>
                </a:solidFill>
                <a:latin typeface="Arial"/>
              </a:endParaRPr>
            </a:p>
          </p:txBody>
        </p:sp>
      </p:grpSp>
      <p:sp>
        <p:nvSpPr>
          <p:cNvPr id="609" name=""/>
          <p:cNvSpPr/>
          <p:nvPr/>
        </p:nvSpPr>
        <p:spPr>
          <a:xfrm flipV="1">
            <a:off x="6858000" y="1399680"/>
            <a:ext cx="0" cy="121284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nvGrpSpPr>
          <p:cNvPr id="610" name=""/>
          <p:cNvGrpSpPr/>
          <p:nvPr/>
        </p:nvGrpSpPr>
        <p:grpSpPr>
          <a:xfrm>
            <a:off x="6684120" y="1590840"/>
            <a:ext cx="193680" cy="1132920"/>
            <a:chOff x="6684120" y="1590840"/>
            <a:chExt cx="193680" cy="1132920"/>
          </a:xfrm>
        </p:grpSpPr>
        <p:sp>
          <p:nvSpPr>
            <p:cNvPr id="611" name=""/>
            <p:cNvSpPr/>
            <p:nvPr/>
          </p:nvSpPr>
          <p:spPr>
            <a:xfrm>
              <a:off x="6765120" y="2586240"/>
              <a:ext cx="648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0</a:t>
              </a:r>
              <a:endParaRPr b="0" lang="en-US" sz="900" spc="-1" strike="noStrike">
                <a:solidFill>
                  <a:srgbClr val="000000"/>
                </a:solidFill>
                <a:latin typeface="Arial"/>
              </a:endParaRPr>
            </a:p>
          </p:txBody>
        </p:sp>
        <p:sp>
          <p:nvSpPr>
            <p:cNvPr id="612" name=""/>
            <p:cNvSpPr/>
            <p:nvPr/>
          </p:nvSpPr>
          <p:spPr>
            <a:xfrm>
              <a:off x="6685200" y="225936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0</a:t>
              </a:r>
              <a:endParaRPr b="0" lang="en-US" sz="900" spc="-1" strike="noStrike">
                <a:solidFill>
                  <a:srgbClr val="000000"/>
                </a:solidFill>
                <a:latin typeface="Arial"/>
              </a:endParaRPr>
            </a:p>
          </p:txBody>
        </p:sp>
        <p:sp>
          <p:nvSpPr>
            <p:cNvPr id="613" name=""/>
            <p:cNvSpPr/>
            <p:nvPr/>
          </p:nvSpPr>
          <p:spPr>
            <a:xfrm>
              <a:off x="6685200" y="192420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200</a:t>
              </a:r>
              <a:endParaRPr b="0" lang="en-US" sz="900" spc="-1" strike="noStrike">
                <a:solidFill>
                  <a:srgbClr val="000000"/>
                </a:solidFill>
                <a:latin typeface="Arial"/>
              </a:endParaRPr>
            </a:p>
          </p:txBody>
        </p:sp>
        <p:sp>
          <p:nvSpPr>
            <p:cNvPr id="614" name=""/>
            <p:cNvSpPr/>
            <p:nvPr/>
          </p:nvSpPr>
          <p:spPr>
            <a:xfrm>
              <a:off x="6684120" y="1590840"/>
              <a:ext cx="1926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300</a:t>
              </a:r>
              <a:endParaRPr b="0" lang="en-US" sz="900" spc="-1" strike="noStrike">
                <a:solidFill>
                  <a:srgbClr val="000000"/>
                </a:solidFill>
                <a:latin typeface="Arial"/>
              </a:endParaRPr>
            </a:p>
          </p:txBody>
        </p:sp>
      </p:grpSp>
      <p:grpSp>
        <p:nvGrpSpPr>
          <p:cNvPr id="615" name=""/>
          <p:cNvGrpSpPr/>
          <p:nvPr/>
        </p:nvGrpSpPr>
        <p:grpSpPr>
          <a:xfrm>
            <a:off x="6824160" y="1447920"/>
            <a:ext cx="33480" cy="1166400"/>
            <a:chOff x="6824160" y="1447920"/>
            <a:chExt cx="33480" cy="1166400"/>
          </a:xfrm>
        </p:grpSpPr>
        <p:sp>
          <p:nvSpPr>
            <p:cNvPr id="616" name=""/>
            <p:cNvSpPr/>
            <p:nvPr/>
          </p:nvSpPr>
          <p:spPr>
            <a:xfrm flipH="1">
              <a:off x="6824160" y="2613960"/>
              <a:ext cx="3348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617" name=""/>
            <p:cNvSpPr/>
            <p:nvPr/>
          </p:nvSpPr>
          <p:spPr>
            <a:xfrm flipH="1">
              <a:off x="6846480" y="253404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618" name=""/>
            <p:cNvSpPr/>
            <p:nvPr/>
          </p:nvSpPr>
          <p:spPr>
            <a:xfrm flipH="1">
              <a:off x="6846480" y="244944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619" name=""/>
            <p:cNvSpPr/>
            <p:nvPr/>
          </p:nvSpPr>
          <p:spPr>
            <a:xfrm flipH="1">
              <a:off x="6846480" y="236484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620" name=""/>
            <p:cNvSpPr/>
            <p:nvPr/>
          </p:nvSpPr>
          <p:spPr>
            <a:xfrm flipH="1">
              <a:off x="6824160" y="2284920"/>
              <a:ext cx="3348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621" name=""/>
            <p:cNvSpPr/>
            <p:nvPr/>
          </p:nvSpPr>
          <p:spPr>
            <a:xfrm flipH="1">
              <a:off x="6846480" y="220032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622" name=""/>
            <p:cNvSpPr/>
            <p:nvPr/>
          </p:nvSpPr>
          <p:spPr>
            <a:xfrm flipH="1">
              <a:off x="6846480" y="211572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623" name=""/>
            <p:cNvSpPr/>
            <p:nvPr/>
          </p:nvSpPr>
          <p:spPr>
            <a:xfrm flipH="1">
              <a:off x="6846480" y="203112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624" name=""/>
            <p:cNvSpPr/>
            <p:nvPr/>
          </p:nvSpPr>
          <p:spPr>
            <a:xfrm flipH="1">
              <a:off x="6824160" y="1950840"/>
              <a:ext cx="3348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625" name=""/>
            <p:cNvSpPr/>
            <p:nvPr/>
          </p:nvSpPr>
          <p:spPr>
            <a:xfrm flipH="1">
              <a:off x="6846480" y="186624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626" name=""/>
            <p:cNvSpPr/>
            <p:nvPr/>
          </p:nvSpPr>
          <p:spPr>
            <a:xfrm flipH="1">
              <a:off x="6846480" y="178164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627" name=""/>
            <p:cNvSpPr/>
            <p:nvPr/>
          </p:nvSpPr>
          <p:spPr>
            <a:xfrm flipH="1">
              <a:off x="6846480" y="170172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628" name=""/>
            <p:cNvSpPr/>
            <p:nvPr/>
          </p:nvSpPr>
          <p:spPr>
            <a:xfrm flipH="1">
              <a:off x="6824160" y="1617120"/>
              <a:ext cx="3348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629" name=""/>
            <p:cNvSpPr/>
            <p:nvPr/>
          </p:nvSpPr>
          <p:spPr>
            <a:xfrm flipH="1">
              <a:off x="6846480" y="153252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sp>
          <p:nvSpPr>
            <p:cNvPr id="630" name=""/>
            <p:cNvSpPr/>
            <p:nvPr/>
          </p:nvSpPr>
          <p:spPr>
            <a:xfrm flipH="1">
              <a:off x="6846480" y="1447920"/>
              <a:ext cx="11160" cy="360"/>
            </a:xfrm>
            <a:prstGeom prst="line">
              <a:avLst/>
            </a:prstGeom>
            <a:ln w="12600">
              <a:solidFill>
                <a:srgbClr val="000000"/>
              </a:solidFill>
              <a:miter/>
            </a:ln>
          </p:spPr>
          <p:style>
            <a:lnRef idx="0"/>
            <a:fillRef idx="0"/>
            <a:effectRef idx="0"/>
            <a:fontRef idx="minor"/>
          </p:style>
          <p:txBody>
            <a:bodyPr lIns="90000" rIns="90000" tIns="-46440" bIns="-46440" anchor="t">
              <a:noAutofit/>
            </a:bodyPr>
            <a:p>
              <a:endParaRPr b="0" lang="en-US" sz="2400" spc="-1" strike="noStrike">
                <a:solidFill>
                  <a:srgbClr val="000000"/>
                </a:solidFill>
                <a:latin typeface="Arial"/>
              </a:endParaRPr>
            </a:p>
          </p:txBody>
        </p:sp>
      </p:grpSp>
      <p:sp>
        <p:nvSpPr>
          <p:cNvPr id="631" name=""/>
          <p:cNvSpPr/>
          <p:nvPr/>
        </p:nvSpPr>
        <p:spPr>
          <a:xfrm rot="16200000">
            <a:off x="6397920" y="2042640"/>
            <a:ext cx="35280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 Cells</a:t>
            </a:r>
            <a:endParaRPr b="0" lang="en-US" sz="900" spc="-1" strike="noStrike">
              <a:solidFill>
                <a:srgbClr val="000000"/>
              </a:solidFill>
              <a:latin typeface="Arial"/>
            </a:endParaRPr>
          </a:p>
        </p:txBody>
      </p:sp>
      <p:sp>
        <p:nvSpPr>
          <p:cNvPr id="632" name=""/>
          <p:cNvSpPr/>
          <p:nvPr/>
        </p:nvSpPr>
        <p:spPr>
          <a:xfrm>
            <a:off x="6869160" y="1467000"/>
            <a:ext cx="1430280" cy="1141200"/>
          </a:xfrm>
          <a:custGeom>
            <a:avLst/>
            <a:gdLst/>
            <a:ahLst/>
            <a:rect l="l" t="t" r="r" b="b"/>
            <a:pathLst>
              <a:path w="2032" h="1944">
                <a:moveTo>
                  <a:pt x="0" y="1944"/>
                </a:moveTo>
                <a:lnTo>
                  <a:pt x="0" y="1600"/>
                </a:lnTo>
                <a:lnTo>
                  <a:pt x="0" y="1896"/>
                </a:lnTo>
                <a:lnTo>
                  <a:pt x="8" y="1896"/>
                </a:lnTo>
                <a:lnTo>
                  <a:pt x="16" y="1896"/>
                </a:lnTo>
                <a:lnTo>
                  <a:pt x="24" y="1848"/>
                </a:lnTo>
                <a:lnTo>
                  <a:pt x="32" y="1856"/>
                </a:lnTo>
                <a:lnTo>
                  <a:pt x="40" y="1816"/>
                </a:lnTo>
                <a:lnTo>
                  <a:pt x="48" y="1824"/>
                </a:lnTo>
                <a:lnTo>
                  <a:pt x="56" y="1808"/>
                </a:lnTo>
                <a:lnTo>
                  <a:pt x="64" y="1792"/>
                </a:lnTo>
                <a:lnTo>
                  <a:pt x="72" y="1776"/>
                </a:lnTo>
                <a:lnTo>
                  <a:pt x="80" y="1720"/>
                </a:lnTo>
                <a:lnTo>
                  <a:pt x="88" y="1728"/>
                </a:lnTo>
                <a:lnTo>
                  <a:pt x="96" y="1704"/>
                </a:lnTo>
                <a:lnTo>
                  <a:pt x="104" y="1664"/>
                </a:lnTo>
                <a:lnTo>
                  <a:pt x="112" y="1672"/>
                </a:lnTo>
                <a:lnTo>
                  <a:pt x="120" y="1504"/>
                </a:lnTo>
                <a:lnTo>
                  <a:pt x="128" y="1520"/>
                </a:lnTo>
                <a:lnTo>
                  <a:pt x="136" y="1416"/>
                </a:lnTo>
                <a:lnTo>
                  <a:pt x="144" y="1464"/>
                </a:lnTo>
                <a:lnTo>
                  <a:pt x="152" y="1288"/>
                </a:lnTo>
                <a:lnTo>
                  <a:pt x="160" y="1208"/>
                </a:lnTo>
                <a:lnTo>
                  <a:pt x="168" y="1168"/>
                </a:lnTo>
                <a:lnTo>
                  <a:pt x="176" y="1192"/>
                </a:lnTo>
                <a:lnTo>
                  <a:pt x="184" y="1096"/>
                </a:lnTo>
                <a:lnTo>
                  <a:pt x="192" y="960"/>
                </a:lnTo>
                <a:lnTo>
                  <a:pt x="200" y="736"/>
                </a:lnTo>
                <a:lnTo>
                  <a:pt x="208" y="800"/>
                </a:lnTo>
                <a:lnTo>
                  <a:pt x="216" y="816"/>
                </a:lnTo>
                <a:lnTo>
                  <a:pt x="224" y="616"/>
                </a:lnTo>
                <a:lnTo>
                  <a:pt x="232" y="616"/>
                </a:lnTo>
                <a:lnTo>
                  <a:pt x="240" y="496"/>
                </a:lnTo>
                <a:lnTo>
                  <a:pt x="248" y="472"/>
                </a:lnTo>
                <a:lnTo>
                  <a:pt x="256" y="296"/>
                </a:lnTo>
                <a:lnTo>
                  <a:pt x="264" y="368"/>
                </a:lnTo>
                <a:lnTo>
                  <a:pt x="272" y="272"/>
                </a:lnTo>
                <a:lnTo>
                  <a:pt x="280" y="240"/>
                </a:lnTo>
                <a:lnTo>
                  <a:pt x="288" y="280"/>
                </a:lnTo>
                <a:lnTo>
                  <a:pt x="296" y="352"/>
                </a:lnTo>
                <a:lnTo>
                  <a:pt x="304" y="344"/>
                </a:lnTo>
                <a:lnTo>
                  <a:pt x="312" y="224"/>
                </a:lnTo>
                <a:lnTo>
                  <a:pt x="320" y="48"/>
                </a:lnTo>
                <a:lnTo>
                  <a:pt x="328" y="152"/>
                </a:lnTo>
                <a:lnTo>
                  <a:pt x="336" y="136"/>
                </a:lnTo>
                <a:lnTo>
                  <a:pt x="344" y="208"/>
                </a:lnTo>
                <a:lnTo>
                  <a:pt x="352" y="120"/>
                </a:lnTo>
                <a:lnTo>
                  <a:pt x="360" y="0"/>
                </a:lnTo>
                <a:lnTo>
                  <a:pt x="368" y="168"/>
                </a:lnTo>
                <a:lnTo>
                  <a:pt x="376" y="240"/>
                </a:lnTo>
                <a:lnTo>
                  <a:pt x="384" y="184"/>
                </a:lnTo>
                <a:lnTo>
                  <a:pt x="392" y="240"/>
                </a:lnTo>
                <a:lnTo>
                  <a:pt x="400" y="208"/>
                </a:lnTo>
                <a:lnTo>
                  <a:pt x="408" y="408"/>
                </a:lnTo>
                <a:lnTo>
                  <a:pt x="416" y="384"/>
                </a:lnTo>
                <a:lnTo>
                  <a:pt x="424" y="488"/>
                </a:lnTo>
                <a:lnTo>
                  <a:pt x="432" y="432"/>
                </a:lnTo>
                <a:lnTo>
                  <a:pt x="440" y="440"/>
                </a:lnTo>
                <a:lnTo>
                  <a:pt x="448" y="560"/>
                </a:lnTo>
                <a:lnTo>
                  <a:pt x="456" y="800"/>
                </a:lnTo>
                <a:lnTo>
                  <a:pt x="464" y="784"/>
                </a:lnTo>
                <a:lnTo>
                  <a:pt x="472" y="904"/>
                </a:lnTo>
                <a:lnTo>
                  <a:pt x="480" y="896"/>
                </a:lnTo>
                <a:lnTo>
                  <a:pt x="488" y="1232"/>
                </a:lnTo>
                <a:lnTo>
                  <a:pt x="496" y="1184"/>
                </a:lnTo>
                <a:lnTo>
                  <a:pt x="504" y="1128"/>
                </a:lnTo>
                <a:lnTo>
                  <a:pt x="512" y="1248"/>
                </a:lnTo>
                <a:lnTo>
                  <a:pt x="520" y="1328"/>
                </a:lnTo>
                <a:lnTo>
                  <a:pt x="528" y="1576"/>
                </a:lnTo>
                <a:lnTo>
                  <a:pt x="536" y="1544"/>
                </a:lnTo>
                <a:lnTo>
                  <a:pt x="544" y="1600"/>
                </a:lnTo>
                <a:lnTo>
                  <a:pt x="552" y="1632"/>
                </a:lnTo>
                <a:lnTo>
                  <a:pt x="560" y="1696"/>
                </a:lnTo>
                <a:lnTo>
                  <a:pt x="568" y="1648"/>
                </a:lnTo>
                <a:lnTo>
                  <a:pt x="576" y="1736"/>
                </a:lnTo>
                <a:lnTo>
                  <a:pt x="584" y="1720"/>
                </a:lnTo>
                <a:lnTo>
                  <a:pt x="592" y="1808"/>
                </a:lnTo>
                <a:lnTo>
                  <a:pt x="600" y="1816"/>
                </a:lnTo>
                <a:lnTo>
                  <a:pt x="608" y="1824"/>
                </a:lnTo>
                <a:lnTo>
                  <a:pt x="616" y="1856"/>
                </a:lnTo>
                <a:lnTo>
                  <a:pt x="624" y="1856"/>
                </a:lnTo>
                <a:lnTo>
                  <a:pt x="632" y="1856"/>
                </a:lnTo>
                <a:lnTo>
                  <a:pt x="640" y="1872"/>
                </a:lnTo>
                <a:lnTo>
                  <a:pt x="648" y="1864"/>
                </a:lnTo>
                <a:lnTo>
                  <a:pt x="656" y="1904"/>
                </a:lnTo>
                <a:lnTo>
                  <a:pt x="664" y="1928"/>
                </a:lnTo>
                <a:lnTo>
                  <a:pt x="672" y="1912"/>
                </a:lnTo>
                <a:lnTo>
                  <a:pt x="680" y="1928"/>
                </a:lnTo>
                <a:lnTo>
                  <a:pt x="688" y="1904"/>
                </a:lnTo>
                <a:lnTo>
                  <a:pt x="696" y="1928"/>
                </a:lnTo>
                <a:lnTo>
                  <a:pt x="704" y="1912"/>
                </a:lnTo>
                <a:lnTo>
                  <a:pt x="712" y="1928"/>
                </a:lnTo>
                <a:lnTo>
                  <a:pt x="720" y="1944"/>
                </a:lnTo>
                <a:lnTo>
                  <a:pt x="728" y="1936"/>
                </a:lnTo>
                <a:lnTo>
                  <a:pt x="736" y="1928"/>
                </a:lnTo>
                <a:lnTo>
                  <a:pt x="744" y="1936"/>
                </a:lnTo>
                <a:lnTo>
                  <a:pt x="752" y="1944"/>
                </a:lnTo>
                <a:lnTo>
                  <a:pt x="760" y="1936"/>
                </a:lnTo>
                <a:lnTo>
                  <a:pt x="768" y="1928"/>
                </a:lnTo>
                <a:lnTo>
                  <a:pt x="776" y="1936"/>
                </a:lnTo>
                <a:lnTo>
                  <a:pt x="784" y="1944"/>
                </a:lnTo>
                <a:lnTo>
                  <a:pt x="792" y="1944"/>
                </a:lnTo>
                <a:lnTo>
                  <a:pt x="800" y="1936"/>
                </a:lnTo>
                <a:lnTo>
                  <a:pt x="808" y="1936"/>
                </a:lnTo>
                <a:lnTo>
                  <a:pt x="816" y="1944"/>
                </a:lnTo>
                <a:lnTo>
                  <a:pt x="824" y="1936"/>
                </a:lnTo>
                <a:lnTo>
                  <a:pt x="832" y="1944"/>
                </a:lnTo>
                <a:lnTo>
                  <a:pt x="840" y="1944"/>
                </a:lnTo>
                <a:lnTo>
                  <a:pt x="848" y="1936"/>
                </a:lnTo>
                <a:lnTo>
                  <a:pt x="856" y="1944"/>
                </a:lnTo>
                <a:lnTo>
                  <a:pt x="864" y="1944"/>
                </a:lnTo>
                <a:lnTo>
                  <a:pt x="872" y="1944"/>
                </a:lnTo>
                <a:lnTo>
                  <a:pt x="880" y="1944"/>
                </a:lnTo>
                <a:lnTo>
                  <a:pt x="888" y="1944"/>
                </a:lnTo>
                <a:lnTo>
                  <a:pt x="896" y="1944"/>
                </a:lnTo>
                <a:lnTo>
                  <a:pt x="904" y="1944"/>
                </a:lnTo>
                <a:lnTo>
                  <a:pt x="912" y="1944"/>
                </a:lnTo>
                <a:lnTo>
                  <a:pt x="920" y="1944"/>
                </a:lnTo>
                <a:lnTo>
                  <a:pt x="928" y="1936"/>
                </a:lnTo>
                <a:lnTo>
                  <a:pt x="936" y="1944"/>
                </a:lnTo>
                <a:lnTo>
                  <a:pt x="944" y="1944"/>
                </a:lnTo>
                <a:lnTo>
                  <a:pt x="952" y="1944"/>
                </a:lnTo>
                <a:lnTo>
                  <a:pt x="960" y="1944"/>
                </a:lnTo>
                <a:lnTo>
                  <a:pt x="968" y="1944"/>
                </a:lnTo>
                <a:lnTo>
                  <a:pt x="976" y="1944"/>
                </a:lnTo>
                <a:lnTo>
                  <a:pt x="984" y="1944"/>
                </a:lnTo>
                <a:lnTo>
                  <a:pt x="992" y="1944"/>
                </a:lnTo>
                <a:lnTo>
                  <a:pt x="1000" y="1944"/>
                </a:lnTo>
                <a:lnTo>
                  <a:pt x="1008" y="1944"/>
                </a:lnTo>
                <a:lnTo>
                  <a:pt x="1016" y="1944"/>
                </a:lnTo>
                <a:lnTo>
                  <a:pt x="1024" y="1944"/>
                </a:lnTo>
                <a:lnTo>
                  <a:pt x="1032" y="1944"/>
                </a:lnTo>
                <a:lnTo>
                  <a:pt x="1040" y="1944"/>
                </a:lnTo>
                <a:lnTo>
                  <a:pt x="1048" y="1944"/>
                </a:lnTo>
                <a:lnTo>
                  <a:pt x="1056" y="1944"/>
                </a:lnTo>
                <a:lnTo>
                  <a:pt x="1064" y="1944"/>
                </a:lnTo>
                <a:lnTo>
                  <a:pt x="1072" y="1944"/>
                </a:lnTo>
                <a:lnTo>
                  <a:pt x="1080" y="1944"/>
                </a:lnTo>
                <a:lnTo>
                  <a:pt x="1088" y="1944"/>
                </a:lnTo>
                <a:lnTo>
                  <a:pt x="1096" y="1944"/>
                </a:lnTo>
                <a:lnTo>
                  <a:pt x="1104" y="1944"/>
                </a:lnTo>
                <a:lnTo>
                  <a:pt x="1112" y="1944"/>
                </a:lnTo>
                <a:lnTo>
                  <a:pt x="1120" y="1944"/>
                </a:lnTo>
                <a:lnTo>
                  <a:pt x="1128" y="1944"/>
                </a:lnTo>
                <a:lnTo>
                  <a:pt x="1136" y="1944"/>
                </a:lnTo>
                <a:lnTo>
                  <a:pt x="1144" y="1944"/>
                </a:lnTo>
                <a:lnTo>
                  <a:pt x="1152" y="1944"/>
                </a:lnTo>
                <a:lnTo>
                  <a:pt x="1160" y="1944"/>
                </a:lnTo>
                <a:lnTo>
                  <a:pt x="1168" y="1944"/>
                </a:lnTo>
                <a:lnTo>
                  <a:pt x="1176" y="1944"/>
                </a:lnTo>
                <a:lnTo>
                  <a:pt x="1184" y="1944"/>
                </a:lnTo>
                <a:lnTo>
                  <a:pt x="1192" y="1944"/>
                </a:lnTo>
                <a:lnTo>
                  <a:pt x="1200" y="1944"/>
                </a:lnTo>
                <a:lnTo>
                  <a:pt x="1208" y="1944"/>
                </a:lnTo>
                <a:lnTo>
                  <a:pt x="1216" y="1944"/>
                </a:lnTo>
                <a:lnTo>
                  <a:pt x="1224" y="1944"/>
                </a:lnTo>
                <a:lnTo>
                  <a:pt x="1232" y="1944"/>
                </a:lnTo>
                <a:lnTo>
                  <a:pt x="1240" y="1944"/>
                </a:lnTo>
                <a:lnTo>
                  <a:pt x="1248" y="1944"/>
                </a:lnTo>
                <a:lnTo>
                  <a:pt x="1256" y="1944"/>
                </a:lnTo>
                <a:lnTo>
                  <a:pt x="1264" y="1944"/>
                </a:lnTo>
                <a:lnTo>
                  <a:pt x="1272" y="1944"/>
                </a:lnTo>
                <a:lnTo>
                  <a:pt x="1280" y="1944"/>
                </a:lnTo>
                <a:lnTo>
                  <a:pt x="1288" y="1944"/>
                </a:lnTo>
                <a:lnTo>
                  <a:pt x="1296" y="1944"/>
                </a:lnTo>
                <a:lnTo>
                  <a:pt x="1304" y="1944"/>
                </a:lnTo>
                <a:lnTo>
                  <a:pt x="1312" y="1944"/>
                </a:lnTo>
                <a:lnTo>
                  <a:pt x="1320" y="1944"/>
                </a:lnTo>
                <a:lnTo>
                  <a:pt x="1328" y="1944"/>
                </a:lnTo>
                <a:lnTo>
                  <a:pt x="1336" y="1944"/>
                </a:lnTo>
                <a:lnTo>
                  <a:pt x="1344" y="1944"/>
                </a:lnTo>
                <a:lnTo>
                  <a:pt x="1352" y="1944"/>
                </a:lnTo>
                <a:lnTo>
                  <a:pt x="1360" y="1944"/>
                </a:lnTo>
                <a:lnTo>
                  <a:pt x="1368" y="1944"/>
                </a:lnTo>
                <a:lnTo>
                  <a:pt x="1376" y="1944"/>
                </a:lnTo>
                <a:lnTo>
                  <a:pt x="1384" y="1944"/>
                </a:lnTo>
                <a:lnTo>
                  <a:pt x="1392" y="1944"/>
                </a:lnTo>
                <a:lnTo>
                  <a:pt x="1400" y="1944"/>
                </a:lnTo>
                <a:lnTo>
                  <a:pt x="1408" y="1944"/>
                </a:lnTo>
                <a:lnTo>
                  <a:pt x="1416" y="1944"/>
                </a:lnTo>
                <a:lnTo>
                  <a:pt x="1424" y="1944"/>
                </a:lnTo>
                <a:lnTo>
                  <a:pt x="1432" y="1944"/>
                </a:lnTo>
                <a:lnTo>
                  <a:pt x="1440" y="1944"/>
                </a:lnTo>
                <a:lnTo>
                  <a:pt x="1448" y="1944"/>
                </a:lnTo>
                <a:lnTo>
                  <a:pt x="1456" y="1944"/>
                </a:lnTo>
                <a:lnTo>
                  <a:pt x="1464" y="1944"/>
                </a:lnTo>
                <a:lnTo>
                  <a:pt x="1472" y="1944"/>
                </a:lnTo>
                <a:lnTo>
                  <a:pt x="1480" y="1944"/>
                </a:lnTo>
                <a:lnTo>
                  <a:pt x="1488" y="1944"/>
                </a:lnTo>
                <a:lnTo>
                  <a:pt x="1496" y="1944"/>
                </a:lnTo>
                <a:lnTo>
                  <a:pt x="1504" y="1944"/>
                </a:lnTo>
                <a:lnTo>
                  <a:pt x="1512" y="1944"/>
                </a:lnTo>
                <a:lnTo>
                  <a:pt x="1520" y="1944"/>
                </a:lnTo>
                <a:lnTo>
                  <a:pt x="1528" y="1944"/>
                </a:lnTo>
                <a:lnTo>
                  <a:pt x="1536" y="1944"/>
                </a:lnTo>
                <a:lnTo>
                  <a:pt x="1544" y="1944"/>
                </a:lnTo>
                <a:lnTo>
                  <a:pt x="1552" y="1944"/>
                </a:lnTo>
                <a:lnTo>
                  <a:pt x="1560" y="1944"/>
                </a:lnTo>
                <a:lnTo>
                  <a:pt x="1568" y="1944"/>
                </a:lnTo>
                <a:lnTo>
                  <a:pt x="1576" y="1944"/>
                </a:lnTo>
                <a:lnTo>
                  <a:pt x="1584" y="1944"/>
                </a:lnTo>
                <a:lnTo>
                  <a:pt x="1592" y="1944"/>
                </a:lnTo>
                <a:lnTo>
                  <a:pt x="1600" y="1944"/>
                </a:lnTo>
                <a:lnTo>
                  <a:pt x="1608" y="1944"/>
                </a:lnTo>
                <a:lnTo>
                  <a:pt x="1616" y="1944"/>
                </a:lnTo>
                <a:lnTo>
                  <a:pt x="1624" y="1944"/>
                </a:lnTo>
                <a:lnTo>
                  <a:pt x="1632" y="1944"/>
                </a:lnTo>
                <a:lnTo>
                  <a:pt x="1640" y="1944"/>
                </a:lnTo>
                <a:lnTo>
                  <a:pt x="1648" y="1944"/>
                </a:lnTo>
                <a:lnTo>
                  <a:pt x="1656" y="1944"/>
                </a:lnTo>
                <a:lnTo>
                  <a:pt x="1664" y="1944"/>
                </a:lnTo>
                <a:lnTo>
                  <a:pt x="1672" y="1944"/>
                </a:lnTo>
                <a:lnTo>
                  <a:pt x="1680" y="1944"/>
                </a:lnTo>
                <a:lnTo>
                  <a:pt x="1688" y="1944"/>
                </a:lnTo>
                <a:lnTo>
                  <a:pt x="1696" y="1944"/>
                </a:lnTo>
                <a:lnTo>
                  <a:pt x="1704" y="1944"/>
                </a:lnTo>
                <a:lnTo>
                  <a:pt x="1712" y="1944"/>
                </a:lnTo>
                <a:lnTo>
                  <a:pt x="1720" y="1944"/>
                </a:lnTo>
                <a:lnTo>
                  <a:pt x="1728" y="1944"/>
                </a:lnTo>
                <a:lnTo>
                  <a:pt x="1736" y="1944"/>
                </a:lnTo>
                <a:lnTo>
                  <a:pt x="1744" y="1944"/>
                </a:lnTo>
                <a:lnTo>
                  <a:pt x="1752" y="1944"/>
                </a:lnTo>
                <a:lnTo>
                  <a:pt x="1760" y="1944"/>
                </a:lnTo>
                <a:lnTo>
                  <a:pt x="1768" y="1944"/>
                </a:lnTo>
                <a:lnTo>
                  <a:pt x="1776" y="1944"/>
                </a:lnTo>
                <a:lnTo>
                  <a:pt x="1784" y="1944"/>
                </a:lnTo>
                <a:lnTo>
                  <a:pt x="1792" y="1944"/>
                </a:lnTo>
                <a:lnTo>
                  <a:pt x="1800" y="1944"/>
                </a:lnTo>
                <a:lnTo>
                  <a:pt x="1808" y="1944"/>
                </a:lnTo>
                <a:lnTo>
                  <a:pt x="1816" y="1944"/>
                </a:lnTo>
                <a:lnTo>
                  <a:pt x="1824" y="1944"/>
                </a:lnTo>
                <a:lnTo>
                  <a:pt x="1832" y="1944"/>
                </a:lnTo>
                <a:lnTo>
                  <a:pt x="1840" y="1944"/>
                </a:lnTo>
                <a:lnTo>
                  <a:pt x="1848" y="1944"/>
                </a:lnTo>
                <a:lnTo>
                  <a:pt x="1856" y="1944"/>
                </a:lnTo>
                <a:lnTo>
                  <a:pt x="1864" y="1944"/>
                </a:lnTo>
                <a:lnTo>
                  <a:pt x="1872" y="1944"/>
                </a:lnTo>
                <a:lnTo>
                  <a:pt x="1880" y="1944"/>
                </a:lnTo>
                <a:lnTo>
                  <a:pt x="1888" y="1944"/>
                </a:lnTo>
                <a:lnTo>
                  <a:pt x="1896" y="1944"/>
                </a:lnTo>
                <a:lnTo>
                  <a:pt x="1904" y="1944"/>
                </a:lnTo>
                <a:lnTo>
                  <a:pt x="1912" y="1944"/>
                </a:lnTo>
                <a:lnTo>
                  <a:pt x="1920" y="1944"/>
                </a:lnTo>
                <a:lnTo>
                  <a:pt x="1928" y="1944"/>
                </a:lnTo>
                <a:lnTo>
                  <a:pt x="1936" y="1944"/>
                </a:lnTo>
                <a:lnTo>
                  <a:pt x="1944" y="1944"/>
                </a:lnTo>
                <a:lnTo>
                  <a:pt x="1952" y="1944"/>
                </a:lnTo>
                <a:lnTo>
                  <a:pt x="1960" y="1944"/>
                </a:lnTo>
                <a:lnTo>
                  <a:pt x="1968" y="1944"/>
                </a:lnTo>
                <a:lnTo>
                  <a:pt x="1976" y="1944"/>
                </a:lnTo>
                <a:lnTo>
                  <a:pt x="1984" y="1944"/>
                </a:lnTo>
                <a:lnTo>
                  <a:pt x="1992" y="1944"/>
                </a:lnTo>
                <a:lnTo>
                  <a:pt x="2000" y="1944"/>
                </a:lnTo>
                <a:lnTo>
                  <a:pt x="2008" y="1944"/>
                </a:lnTo>
                <a:lnTo>
                  <a:pt x="2016" y="1944"/>
                </a:lnTo>
                <a:lnTo>
                  <a:pt x="2024" y="1944"/>
                </a:lnTo>
                <a:lnTo>
                  <a:pt x="2032" y="1944"/>
                </a:lnTo>
              </a:path>
            </a:pathLst>
          </a:custGeom>
          <a:noFill/>
          <a:ln w="12600">
            <a:solidFill>
              <a:srgbClr val="000000"/>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633" name=""/>
          <p:cNvSpPr/>
          <p:nvPr/>
        </p:nvSpPr>
        <p:spPr>
          <a:xfrm>
            <a:off x="6869160" y="1409760"/>
            <a:ext cx="1430280" cy="1198440"/>
          </a:xfrm>
          <a:custGeom>
            <a:avLst/>
            <a:gdLst/>
            <a:ahLst/>
            <a:rect l="l" t="t" r="r" b="b"/>
            <a:pathLst>
              <a:path w="2032" h="2040">
                <a:moveTo>
                  <a:pt x="0" y="2040"/>
                </a:moveTo>
                <a:lnTo>
                  <a:pt x="0" y="0"/>
                </a:lnTo>
                <a:lnTo>
                  <a:pt x="0" y="1552"/>
                </a:lnTo>
                <a:lnTo>
                  <a:pt x="8" y="1472"/>
                </a:lnTo>
                <a:lnTo>
                  <a:pt x="16" y="1464"/>
                </a:lnTo>
                <a:lnTo>
                  <a:pt x="24" y="1488"/>
                </a:lnTo>
                <a:lnTo>
                  <a:pt x="32" y="1376"/>
                </a:lnTo>
                <a:lnTo>
                  <a:pt x="40" y="1136"/>
                </a:lnTo>
                <a:lnTo>
                  <a:pt x="48" y="1048"/>
                </a:lnTo>
                <a:lnTo>
                  <a:pt x="56" y="1064"/>
                </a:lnTo>
                <a:lnTo>
                  <a:pt x="64" y="1160"/>
                </a:lnTo>
                <a:lnTo>
                  <a:pt x="72" y="912"/>
                </a:lnTo>
                <a:lnTo>
                  <a:pt x="80" y="696"/>
                </a:lnTo>
                <a:lnTo>
                  <a:pt x="88" y="784"/>
                </a:lnTo>
                <a:lnTo>
                  <a:pt x="96" y="792"/>
                </a:lnTo>
                <a:lnTo>
                  <a:pt x="104" y="768"/>
                </a:lnTo>
                <a:lnTo>
                  <a:pt x="112" y="360"/>
                </a:lnTo>
                <a:lnTo>
                  <a:pt x="120" y="488"/>
                </a:lnTo>
                <a:lnTo>
                  <a:pt x="128" y="560"/>
                </a:lnTo>
                <a:lnTo>
                  <a:pt x="136" y="432"/>
                </a:lnTo>
                <a:lnTo>
                  <a:pt x="144" y="488"/>
                </a:lnTo>
                <a:lnTo>
                  <a:pt x="152" y="552"/>
                </a:lnTo>
                <a:lnTo>
                  <a:pt x="160" y="424"/>
                </a:lnTo>
                <a:lnTo>
                  <a:pt x="168" y="424"/>
                </a:lnTo>
                <a:lnTo>
                  <a:pt x="176" y="496"/>
                </a:lnTo>
                <a:lnTo>
                  <a:pt x="184" y="104"/>
                </a:lnTo>
                <a:lnTo>
                  <a:pt x="192" y="544"/>
                </a:lnTo>
                <a:lnTo>
                  <a:pt x="200" y="272"/>
                </a:lnTo>
                <a:lnTo>
                  <a:pt x="208" y="432"/>
                </a:lnTo>
                <a:lnTo>
                  <a:pt x="216" y="432"/>
                </a:lnTo>
                <a:lnTo>
                  <a:pt x="224" y="280"/>
                </a:lnTo>
                <a:lnTo>
                  <a:pt x="232" y="416"/>
                </a:lnTo>
                <a:lnTo>
                  <a:pt x="240" y="304"/>
                </a:lnTo>
                <a:lnTo>
                  <a:pt x="248" y="360"/>
                </a:lnTo>
                <a:lnTo>
                  <a:pt x="256" y="352"/>
                </a:lnTo>
                <a:lnTo>
                  <a:pt x="264" y="424"/>
                </a:lnTo>
                <a:lnTo>
                  <a:pt x="272" y="320"/>
                </a:lnTo>
                <a:lnTo>
                  <a:pt x="280" y="336"/>
                </a:lnTo>
                <a:lnTo>
                  <a:pt x="288" y="336"/>
                </a:lnTo>
                <a:lnTo>
                  <a:pt x="296" y="272"/>
                </a:lnTo>
                <a:lnTo>
                  <a:pt x="304" y="272"/>
                </a:lnTo>
                <a:lnTo>
                  <a:pt x="312" y="328"/>
                </a:lnTo>
                <a:lnTo>
                  <a:pt x="320" y="352"/>
                </a:lnTo>
                <a:lnTo>
                  <a:pt x="328" y="320"/>
                </a:lnTo>
                <a:lnTo>
                  <a:pt x="336" y="384"/>
                </a:lnTo>
                <a:lnTo>
                  <a:pt x="344" y="360"/>
                </a:lnTo>
                <a:lnTo>
                  <a:pt x="352" y="456"/>
                </a:lnTo>
                <a:lnTo>
                  <a:pt x="360" y="280"/>
                </a:lnTo>
                <a:lnTo>
                  <a:pt x="368" y="104"/>
                </a:lnTo>
                <a:lnTo>
                  <a:pt x="376" y="256"/>
                </a:lnTo>
                <a:lnTo>
                  <a:pt x="384" y="168"/>
                </a:lnTo>
                <a:lnTo>
                  <a:pt x="392" y="488"/>
                </a:lnTo>
                <a:lnTo>
                  <a:pt x="400" y="304"/>
                </a:lnTo>
                <a:lnTo>
                  <a:pt x="408" y="528"/>
                </a:lnTo>
                <a:lnTo>
                  <a:pt x="416" y="120"/>
                </a:lnTo>
                <a:lnTo>
                  <a:pt x="424" y="448"/>
                </a:lnTo>
                <a:lnTo>
                  <a:pt x="432" y="416"/>
                </a:lnTo>
                <a:lnTo>
                  <a:pt x="440" y="624"/>
                </a:lnTo>
                <a:lnTo>
                  <a:pt x="448" y="408"/>
                </a:lnTo>
                <a:lnTo>
                  <a:pt x="456" y="472"/>
                </a:lnTo>
                <a:lnTo>
                  <a:pt x="464" y="1104"/>
                </a:lnTo>
                <a:lnTo>
                  <a:pt x="472" y="672"/>
                </a:lnTo>
                <a:lnTo>
                  <a:pt x="480" y="936"/>
                </a:lnTo>
                <a:lnTo>
                  <a:pt x="488" y="928"/>
                </a:lnTo>
                <a:lnTo>
                  <a:pt x="496" y="808"/>
                </a:lnTo>
                <a:lnTo>
                  <a:pt x="504" y="968"/>
                </a:lnTo>
                <a:lnTo>
                  <a:pt x="512" y="1256"/>
                </a:lnTo>
                <a:lnTo>
                  <a:pt x="520" y="1192"/>
                </a:lnTo>
                <a:lnTo>
                  <a:pt x="528" y="1288"/>
                </a:lnTo>
                <a:lnTo>
                  <a:pt x="536" y="1360"/>
                </a:lnTo>
                <a:lnTo>
                  <a:pt x="544" y="1400"/>
                </a:lnTo>
                <a:lnTo>
                  <a:pt x="552" y="1424"/>
                </a:lnTo>
                <a:lnTo>
                  <a:pt x="560" y="1408"/>
                </a:lnTo>
                <a:lnTo>
                  <a:pt x="568" y="1608"/>
                </a:lnTo>
                <a:lnTo>
                  <a:pt x="576" y="1560"/>
                </a:lnTo>
                <a:lnTo>
                  <a:pt x="584" y="1704"/>
                </a:lnTo>
                <a:lnTo>
                  <a:pt x="592" y="1776"/>
                </a:lnTo>
                <a:lnTo>
                  <a:pt x="600" y="1752"/>
                </a:lnTo>
                <a:lnTo>
                  <a:pt x="608" y="1800"/>
                </a:lnTo>
                <a:lnTo>
                  <a:pt x="616" y="1752"/>
                </a:lnTo>
                <a:lnTo>
                  <a:pt x="624" y="1864"/>
                </a:lnTo>
                <a:lnTo>
                  <a:pt x="632" y="1832"/>
                </a:lnTo>
                <a:lnTo>
                  <a:pt x="640" y="1896"/>
                </a:lnTo>
                <a:lnTo>
                  <a:pt x="648" y="1960"/>
                </a:lnTo>
                <a:lnTo>
                  <a:pt x="656" y="1896"/>
                </a:lnTo>
                <a:lnTo>
                  <a:pt x="664" y="1880"/>
                </a:lnTo>
                <a:lnTo>
                  <a:pt x="672" y="1960"/>
                </a:lnTo>
                <a:lnTo>
                  <a:pt x="680" y="1968"/>
                </a:lnTo>
                <a:lnTo>
                  <a:pt x="688" y="1960"/>
                </a:lnTo>
                <a:lnTo>
                  <a:pt x="696" y="1960"/>
                </a:lnTo>
                <a:lnTo>
                  <a:pt x="704" y="1992"/>
                </a:lnTo>
                <a:lnTo>
                  <a:pt x="712" y="1944"/>
                </a:lnTo>
                <a:lnTo>
                  <a:pt x="720" y="2008"/>
                </a:lnTo>
                <a:lnTo>
                  <a:pt x="728" y="2016"/>
                </a:lnTo>
                <a:lnTo>
                  <a:pt x="736" y="2032"/>
                </a:lnTo>
                <a:lnTo>
                  <a:pt x="744" y="2016"/>
                </a:lnTo>
                <a:lnTo>
                  <a:pt x="752" y="2032"/>
                </a:lnTo>
                <a:lnTo>
                  <a:pt x="760" y="2016"/>
                </a:lnTo>
                <a:lnTo>
                  <a:pt x="768" y="2024"/>
                </a:lnTo>
                <a:lnTo>
                  <a:pt x="776" y="2032"/>
                </a:lnTo>
                <a:lnTo>
                  <a:pt x="784" y="2040"/>
                </a:lnTo>
                <a:lnTo>
                  <a:pt x="792" y="2040"/>
                </a:lnTo>
                <a:lnTo>
                  <a:pt x="800" y="2040"/>
                </a:lnTo>
                <a:lnTo>
                  <a:pt x="808" y="2040"/>
                </a:lnTo>
                <a:lnTo>
                  <a:pt x="816" y="2040"/>
                </a:lnTo>
                <a:lnTo>
                  <a:pt x="824" y="2040"/>
                </a:lnTo>
                <a:lnTo>
                  <a:pt x="832" y="2040"/>
                </a:lnTo>
                <a:lnTo>
                  <a:pt x="840" y="2040"/>
                </a:lnTo>
                <a:lnTo>
                  <a:pt x="848" y="2040"/>
                </a:lnTo>
                <a:lnTo>
                  <a:pt x="856" y="2040"/>
                </a:lnTo>
                <a:lnTo>
                  <a:pt x="864" y="2040"/>
                </a:lnTo>
                <a:lnTo>
                  <a:pt x="872" y="2040"/>
                </a:lnTo>
                <a:lnTo>
                  <a:pt x="880" y="2040"/>
                </a:lnTo>
                <a:lnTo>
                  <a:pt x="888" y="2040"/>
                </a:lnTo>
                <a:lnTo>
                  <a:pt x="896" y="2040"/>
                </a:lnTo>
                <a:lnTo>
                  <a:pt x="904" y="2040"/>
                </a:lnTo>
                <a:lnTo>
                  <a:pt x="912" y="2040"/>
                </a:lnTo>
                <a:lnTo>
                  <a:pt x="920" y="2040"/>
                </a:lnTo>
                <a:lnTo>
                  <a:pt x="928" y="2040"/>
                </a:lnTo>
                <a:lnTo>
                  <a:pt x="936" y="2040"/>
                </a:lnTo>
                <a:lnTo>
                  <a:pt x="944" y="2040"/>
                </a:lnTo>
                <a:lnTo>
                  <a:pt x="952" y="2040"/>
                </a:lnTo>
                <a:lnTo>
                  <a:pt x="960" y="2040"/>
                </a:lnTo>
                <a:lnTo>
                  <a:pt x="968" y="2040"/>
                </a:lnTo>
                <a:lnTo>
                  <a:pt x="976" y="2040"/>
                </a:lnTo>
                <a:lnTo>
                  <a:pt x="984" y="2040"/>
                </a:lnTo>
                <a:lnTo>
                  <a:pt x="992" y="2040"/>
                </a:lnTo>
                <a:lnTo>
                  <a:pt x="1000" y="2040"/>
                </a:lnTo>
                <a:lnTo>
                  <a:pt x="1008" y="2040"/>
                </a:lnTo>
                <a:lnTo>
                  <a:pt x="1016" y="2040"/>
                </a:lnTo>
                <a:lnTo>
                  <a:pt x="1024" y="2040"/>
                </a:lnTo>
                <a:lnTo>
                  <a:pt x="1032" y="2040"/>
                </a:lnTo>
                <a:lnTo>
                  <a:pt x="1040" y="2040"/>
                </a:lnTo>
                <a:lnTo>
                  <a:pt x="1048" y="2040"/>
                </a:lnTo>
                <a:lnTo>
                  <a:pt x="1056" y="2040"/>
                </a:lnTo>
                <a:lnTo>
                  <a:pt x="1064" y="2040"/>
                </a:lnTo>
                <a:lnTo>
                  <a:pt x="1072" y="2040"/>
                </a:lnTo>
                <a:lnTo>
                  <a:pt x="1080" y="2040"/>
                </a:lnTo>
                <a:lnTo>
                  <a:pt x="1088" y="2040"/>
                </a:lnTo>
                <a:lnTo>
                  <a:pt x="1096" y="2040"/>
                </a:lnTo>
                <a:lnTo>
                  <a:pt x="1104" y="2040"/>
                </a:lnTo>
                <a:lnTo>
                  <a:pt x="1112" y="2040"/>
                </a:lnTo>
                <a:lnTo>
                  <a:pt x="1120" y="2040"/>
                </a:lnTo>
                <a:lnTo>
                  <a:pt x="1128" y="2040"/>
                </a:lnTo>
                <a:lnTo>
                  <a:pt x="1136" y="2040"/>
                </a:lnTo>
                <a:lnTo>
                  <a:pt x="1144" y="2040"/>
                </a:lnTo>
                <a:lnTo>
                  <a:pt x="1152" y="2040"/>
                </a:lnTo>
                <a:lnTo>
                  <a:pt x="1160" y="2040"/>
                </a:lnTo>
                <a:lnTo>
                  <a:pt x="1168" y="2040"/>
                </a:lnTo>
                <a:lnTo>
                  <a:pt x="1176" y="2040"/>
                </a:lnTo>
                <a:lnTo>
                  <a:pt x="1184" y="2040"/>
                </a:lnTo>
                <a:lnTo>
                  <a:pt x="1192" y="2040"/>
                </a:lnTo>
                <a:lnTo>
                  <a:pt x="1200" y="2040"/>
                </a:lnTo>
                <a:lnTo>
                  <a:pt x="1208" y="2040"/>
                </a:lnTo>
                <a:lnTo>
                  <a:pt x="1216" y="2040"/>
                </a:lnTo>
                <a:lnTo>
                  <a:pt x="1224" y="2040"/>
                </a:lnTo>
                <a:lnTo>
                  <a:pt x="1232" y="2040"/>
                </a:lnTo>
                <a:lnTo>
                  <a:pt x="1240" y="2040"/>
                </a:lnTo>
                <a:lnTo>
                  <a:pt x="1248" y="2040"/>
                </a:lnTo>
                <a:lnTo>
                  <a:pt x="1256" y="2040"/>
                </a:lnTo>
                <a:lnTo>
                  <a:pt x="1264" y="2040"/>
                </a:lnTo>
                <a:lnTo>
                  <a:pt x="1272" y="2040"/>
                </a:lnTo>
                <a:lnTo>
                  <a:pt x="1280" y="2040"/>
                </a:lnTo>
                <a:lnTo>
                  <a:pt x="1288" y="2040"/>
                </a:lnTo>
                <a:lnTo>
                  <a:pt x="1296" y="2040"/>
                </a:lnTo>
                <a:lnTo>
                  <a:pt x="1304" y="2040"/>
                </a:lnTo>
                <a:lnTo>
                  <a:pt x="1312" y="2040"/>
                </a:lnTo>
                <a:lnTo>
                  <a:pt x="1320" y="2040"/>
                </a:lnTo>
                <a:lnTo>
                  <a:pt x="1328" y="2040"/>
                </a:lnTo>
                <a:lnTo>
                  <a:pt x="1336" y="2040"/>
                </a:lnTo>
                <a:lnTo>
                  <a:pt x="1344" y="2040"/>
                </a:lnTo>
                <a:lnTo>
                  <a:pt x="1352" y="2040"/>
                </a:lnTo>
                <a:lnTo>
                  <a:pt x="1360" y="2040"/>
                </a:lnTo>
                <a:lnTo>
                  <a:pt x="1368" y="2040"/>
                </a:lnTo>
                <a:lnTo>
                  <a:pt x="1376" y="2040"/>
                </a:lnTo>
                <a:lnTo>
                  <a:pt x="1384" y="2040"/>
                </a:lnTo>
                <a:lnTo>
                  <a:pt x="1392" y="2040"/>
                </a:lnTo>
                <a:lnTo>
                  <a:pt x="1400" y="2040"/>
                </a:lnTo>
                <a:lnTo>
                  <a:pt x="1408" y="2040"/>
                </a:lnTo>
                <a:lnTo>
                  <a:pt x="1416" y="2040"/>
                </a:lnTo>
                <a:lnTo>
                  <a:pt x="1424" y="2040"/>
                </a:lnTo>
                <a:lnTo>
                  <a:pt x="1432" y="2040"/>
                </a:lnTo>
                <a:lnTo>
                  <a:pt x="1440" y="2040"/>
                </a:lnTo>
                <a:lnTo>
                  <a:pt x="1448" y="2040"/>
                </a:lnTo>
                <a:lnTo>
                  <a:pt x="1456" y="2040"/>
                </a:lnTo>
                <a:lnTo>
                  <a:pt x="1464" y="2040"/>
                </a:lnTo>
                <a:lnTo>
                  <a:pt x="1472" y="2040"/>
                </a:lnTo>
                <a:lnTo>
                  <a:pt x="1480" y="2040"/>
                </a:lnTo>
                <a:lnTo>
                  <a:pt x="1488" y="2040"/>
                </a:lnTo>
                <a:lnTo>
                  <a:pt x="1496" y="2040"/>
                </a:lnTo>
                <a:lnTo>
                  <a:pt x="1504" y="2040"/>
                </a:lnTo>
                <a:lnTo>
                  <a:pt x="1512" y="2040"/>
                </a:lnTo>
                <a:lnTo>
                  <a:pt x="1520" y="2040"/>
                </a:lnTo>
                <a:lnTo>
                  <a:pt x="1528" y="2040"/>
                </a:lnTo>
                <a:lnTo>
                  <a:pt x="1536" y="2040"/>
                </a:lnTo>
                <a:lnTo>
                  <a:pt x="1544" y="2040"/>
                </a:lnTo>
                <a:lnTo>
                  <a:pt x="1552" y="2040"/>
                </a:lnTo>
                <a:lnTo>
                  <a:pt x="1560" y="2040"/>
                </a:lnTo>
                <a:lnTo>
                  <a:pt x="1568" y="2040"/>
                </a:lnTo>
                <a:lnTo>
                  <a:pt x="1576" y="2040"/>
                </a:lnTo>
                <a:lnTo>
                  <a:pt x="1584" y="2040"/>
                </a:lnTo>
                <a:lnTo>
                  <a:pt x="1592" y="2040"/>
                </a:lnTo>
                <a:lnTo>
                  <a:pt x="1600" y="2040"/>
                </a:lnTo>
                <a:lnTo>
                  <a:pt x="1608" y="2040"/>
                </a:lnTo>
                <a:lnTo>
                  <a:pt x="1616" y="2040"/>
                </a:lnTo>
                <a:lnTo>
                  <a:pt x="1624" y="2040"/>
                </a:lnTo>
                <a:lnTo>
                  <a:pt x="1632" y="2040"/>
                </a:lnTo>
                <a:lnTo>
                  <a:pt x="1640" y="2040"/>
                </a:lnTo>
                <a:lnTo>
                  <a:pt x="1648" y="2040"/>
                </a:lnTo>
                <a:lnTo>
                  <a:pt x="1656" y="2040"/>
                </a:lnTo>
                <a:lnTo>
                  <a:pt x="1664" y="2040"/>
                </a:lnTo>
                <a:lnTo>
                  <a:pt x="1672" y="2040"/>
                </a:lnTo>
                <a:lnTo>
                  <a:pt x="1680" y="2040"/>
                </a:lnTo>
                <a:lnTo>
                  <a:pt x="1688" y="2040"/>
                </a:lnTo>
                <a:lnTo>
                  <a:pt x="1696" y="2040"/>
                </a:lnTo>
                <a:lnTo>
                  <a:pt x="1704" y="2040"/>
                </a:lnTo>
                <a:lnTo>
                  <a:pt x="1712" y="2040"/>
                </a:lnTo>
                <a:lnTo>
                  <a:pt x="1720" y="2040"/>
                </a:lnTo>
                <a:lnTo>
                  <a:pt x="1728" y="2040"/>
                </a:lnTo>
                <a:lnTo>
                  <a:pt x="1736" y="2040"/>
                </a:lnTo>
                <a:lnTo>
                  <a:pt x="1744" y="2040"/>
                </a:lnTo>
                <a:lnTo>
                  <a:pt x="1752" y="2040"/>
                </a:lnTo>
                <a:lnTo>
                  <a:pt x="1760" y="2040"/>
                </a:lnTo>
                <a:lnTo>
                  <a:pt x="1768" y="2040"/>
                </a:lnTo>
                <a:lnTo>
                  <a:pt x="1776" y="2040"/>
                </a:lnTo>
                <a:lnTo>
                  <a:pt x="1784" y="2040"/>
                </a:lnTo>
                <a:lnTo>
                  <a:pt x="1792" y="2040"/>
                </a:lnTo>
                <a:lnTo>
                  <a:pt x="1800" y="2040"/>
                </a:lnTo>
                <a:lnTo>
                  <a:pt x="1808" y="2040"/>
                </a:lnTo>
                <a:lnTo>
                  <a:pt x="1816" y="2040"/>
                </a:lnTo>
                <a:lnTo>
                  <a:pt x="1824" y="2040"/>
                </a:lnTo>
                <a:lnTo>
                  <a:pt x="1832" y="2040"/>
                </a:lnTo>
                <a:lnTo>
                  <a:pt x="1840" y="2040"/>
                </a:lnTo>
                <a:lnTo>
                  <a:pt x="1848" y="2040"/>
                </a:lnTo>
                <a:lnTo>
                  <a:pt x="1856" y="2040"/>
                </a:lnTo>
                <a:lnTo>
                  <a:pt x="1864" y="2040"/>
                </a:lnTo>
                <a:lnTo>
                  <a:pt x="1872" y="2040"/>
                </a:lnTo>
                <a:lnTo>
                  <a:pt x="1880" y="2040"/>
                </a:lnTo>
                <a:lnTo>
                  <a:pt x="1888" y="2040"/>
                </a:lnTo>
                <a:lnTo>
                  <a:pt x="1896" y="2040"/>
                </a:lnTo>
                <a:lnTo>
                  <a:pt x="1904" y="2040"/>
                </a:lnTo>
                <a:lnTo>
                  <a:pt x="1912" y="2040"/>
                </a:lnTo>
                <a:lnTo>
                  <a:pt x="1920" y="2040"/>
                </a:lnTo>
                <a:lnTo>
                  <a:pt x="1928" y="2040"/>
                </a:lnTo>
                <a:lnTo>
                  <a:pt x="1936" y="2040"/>
                </a:lnTo>
                <a:lnTo>
                  <a:pt x="1944" y="2040"/>
                </a:lnTo>
                <a:lnTo>
                  <a:pt x="1952" y="2040"/>
                </a:lnTo>
                <a:lnTo>
                  <a:pt x="1960" y="2040"/>
                </a:lnTo>
                <a:lnTo>
                  <a:pt x="1968" y="2040"/>
                </a:lnTo>
                <a:lnTo>
                  <a:pt x="1976" y="2040"/>
                </a:lnTo>
                <a:lnTo>
                  <a:pt x="1984" y="2040"/>
                </a:lnTo>
                <a:lnTo>
                  <a:pt x="1992" y="2040"/>
                </a:lnTo>
                <a:lnTo>
                  <a:pt x="2000" y="2040"/>
                </a:lnTo>
                <a:lnTo>
                  <a:pt x="2008" y="2040"/>
                </a:lnTo>
                <a:lnTo>
                  <a:pt x="2016" y="2040"/>
                </a:lnTo>
                <a:lnTo>
                  <a:pt x="2024" y="2040"/>
                </a:lnTo>
                <a:lnTo>
                  <a:pt x="2032" y="2040"/>
                </a:lnTo>
              </a:path>
            </a:pathLst>
          </a:custGeom>
          <a:noFill/>
          <a:ln w="12600">
            <a:solidFill>
              <a:srgbClr val="0000ff"/>
            </a:solidFill>
            <a:round/>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nvGrpSpPr>
          <p:cNvPr id="634" name=""/>
          <p:cNvGrpSpPr/>
          <p:nvPr/>
        </p:nvGrpSpPr>
        <p:grpSpPr>
          <a:xfrm>
            <a:off x="4974480" y="2638440"/>
            <a:ext cx="1607400" cy="188280"/>
            <a:chOff x="4974480" y="2638440"/>
            <a:chExt cx="1607400" cy="188280"/>
          </a:xfrm>
        </p:grpSpPr>
        <p:sp>
          <p:nvSpPr>
            <p:cNvPr id="635" name=""/>
            <p:cNvSpPr/>
            <p:nvPr/>
          </p:nvSpPr>
          <p:spPr>
            <a:xfrm>
              <a:off x="4974480" y="26892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636" name=""/>
            <p:cNvSpPr/>
            <p:nvPr/>
          </p:nvSpPr>
          <p:spPr>
            <a:xfrm>
              <a:off x="5097600" y="263844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a:t>
              </a:r>
              <a:endParaRPr b="0" lang="en-US" sz="800" spc="-1" strike="noStrike">
                <a:solidFill>
                  <a:srgbClr val="000000"/>
                </a:solidFill>
                <a:latin typeface="Arial"/>
              </a:endParaRPr>
            </a:p>
          </p:txBody>
        </p:sp>
        <p:sp>
          <p:nvSpPr>
            <p:cNvPr id="637" name=""/>
            <p:cNvSpPr/>
            <p:nvPr/>
          </p:nvSpPr>
          <p:spPr>
            <a:xfrm>
              <a:off x="5328360" y="26892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638" name=""/>
            <p:cNvSpPr/>
            <p:nvPr/>
          </p:nvSpPr>
          <p:spPr>
            <a:xfrm>
              <a:off x="5445000" y="265104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a:t>
              </a:r>
              <a:endParaRPr b="0" lang="en-US" sz="800" spc="-1" strike="noStrike">
                <a:solidFill>
                  <a:srgbClr val="000000"/>
                </a:solidFill>
                <a:latin typeface="Arial"/>
              </a:endParaRPr>
            </a:p>
          </p:txBody>
        </p:sp>
        <p:sp>
          <p:nvSpPr>
            <p:cNvPr id="639" name=""/>
            <p:cNvSpPr/>
            <p:nvPr/>
          </p:nvSpPr>
          <p:spPr>
            <a:xfrm>
              <a:off x="5685840" y="26892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640" name=""/>
            <p:cNvSpPr/>
            <p:nvPr/>
          </p:nvSpPr>
          <p:spPr>
            <a:xfrm>
              <a:off x="5823000" y="266076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a:t>
              </a:r>
              <a:endParaRPr b="0" lang="en-US" sz="800" spc="-1" strike="noStrike">
                <a:solidFill>
                  <a:srgbClr val="000000"/>
                </a:solidFill>
                <a:latin typeface="Arial"/>
              </a:endParaRPr>
            </a:p>
          </p:txBody>
        </p:sp>
        <p:sp>
          <p:nvSpPr>
            <p:cNvPr id="641" name=""/>
            <p:cNvSpPr/>
            <p:nvPr/>
          </p:nvSpPr>
          <p:spPr>
            <a:xfrm>
              <a:off x="6047640" y="26892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642" name=""/>
            <p:cNvSpPr/>
            <p:nvPr/>
          </p:nvSpPr>
          <p:spPr>
            <a:xfrm>
              <a:off x="6174000" y="266076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3</a:t>
              </a:r>
              <a:endParaRPr b="0" lang="en-US" sz="800" spc="-1" strike="noStrike">
                <a:solidFill>
                  <a:srgbClr val="000000"/>
                </a:solidFill>
                <a:latin typeface="Arial"/>
              </a:endParaRPr>
            </a:p>
          </p:txBody>
        </p:sp>
        <p:sp>
          <p:nvSpPr>
            <p:cNvPr id="643" name=""/>
            <p:cNvSpPr/>
            <p:nvPr/>
          </p:nvSpPr>
          <p:spPr>
            <a:xfrm>
              <a:off x="6400080" y="268920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644" name=""/>
            <p:cNvSpPr/>
            <p:nvPr/>
          </p:nvSpPr>
          <p:spPr>
            <a:xfrm>
              <a:off x="6524640" y="265752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4</a:t>
              </a:r>
              <a:endParaRPr b="0" lang="en-US" sz="800" spc="-1" strike="noStrike">
                <a:solidFill>
                  <a:srgbClr val="000000"/>
                </a:solidFill>
                <a:latin typeface="Arial"/>
              </a:endParaRPr>
            </a:p>
          </p:txBody>
        </p:sp>
      </p:grpSp>
      <p:grpSp>
        <p:nvGrpSpPr>
          <p:cNvPr id="645" name=""/>
          <p:cNvGrpSpPr/>
          <p:nvPr/>
        </p:nvGrpSpPr>
        <p:grpSpPr>
          <a:xfrm>
            <a:off x="6780960" y="2647800"/>
            <a:ext cx="1607400" cy="188280"/>
            <a:chOff x="6780960" y="2647800"/>
            <a:chExt cx="1607400" cy="188280"/>
          </a:xfrm>
        </p:grpSpPr>
        <p:sp>
          <p:nvSpPr>
            <p:cNvPr id="646" name=""/>
            <p:cNvSpPr/>
            <p:nvPr/>
          </p:nvSpPr>
          <p:spPr>
            <a:xfrm>
              <a:off x="6780960" y="26985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647" name=""/>
            <p:cNvSpPr/>
            <p:nvPr/>
          </p:nvSpPr>
          <p:spPr>
            <a:xfrm>
              <a:off x="6904080" y="264780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a:t>
              </a:r>
              <a:endParaRPr b="0" lang="en-US" sz="800" spc="-1" strike="noStrike">
                <a:solidFill>
                  <a:srgbClr val="000000"/>
                </a:solidFill>
                <a:latin typeface="Arial"/>
              </a:endParaRPr>
            </a:p>
          </p:txBody>
        </p:sp>
        <p:sp>
          <p:nvSpPr>
            <p:cNvPr id="648" name=""/>
            <p:cNvSpPr/>
            <p:nvPr/>
          </p:nvSpPr>
          <p:spPr>
            <a:xfrm>
              <a:off x="7134840" y="26985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649" name=""/>
            <p:cNvSpPr/>
            <p:nvPr/>
          </p:nvSpPr>
          <p:spPr>
            <a:xfrm>
              <a:off x="7251480" y="266040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a:t>
              </a:r>
              <a:endParaRPr b="0" lang="en-US" sz="800" spc="-1" strike="noStrike">
                <a:solidFill>
                  <a:srgbClr val="000000"/>
                </a:solidFill>
                <a:latin typeface="Arial"/>
              </a:endParaRPr>
            </a:p>
          </p:txBody>
        </p:sp>
        <p:sp>
          <p:nvSpPr>
            <p:cNvPr id="650" name=""/>
            <p:cNvSpPr/>
            <p:nvPr/>
          </p:nvSpPr>
          <p:spPr>
            <a:xfrm>
              <a:off x="7492320" y="26985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651" name=""/>
            <p:cNvSpPr/>
            <p:nvPr/>
          </p:nvSpPr>
          <p:spPr>
            <a:xfrm>
              <a:off x="7629480" y="267012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a:t>
              </a:r>
              <a:endParaRPr b="0" lang="en-US" sz="800" spc="-1" strike="noStrike">
                <a:solidFill>
                  <a:srgbClr val="000000"/>
                </a:solidFill>
                <a:latin typeface="Arial"/>
              </a:endParaRPr>
            </a:p>
          </p:txBody>
        </p:sp>
        <p:sp>
          <p:nvSpPr>
            <p:cNvPr id="652" name=""/>
            <p:cNvSpPr/>
            <p:nvPr/>
          </p:nvSpPr>
          <p:spPr>
            <a:xfrm>
              <a:off x="7854120" y="26985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653" name=""/>
            <p:cNvSpPr/>
            <p:nvPr/>
          </p:nvSpPr>
          <p:spPr>
            <a:xfrm>
              <a:off x="7980480" y="267012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3</a:t>
              </a:r>
              <a:endParaRPr b="0" lang="en-US" sz="800" spc="-1" strike="noStrike">
                <a:solidFill>
                  <a:srgbClr val="000000"/>
                </a:solidFill>
                <a:latin typeface="Arial"/>
              </a:endParaRPr>
            </a:p>
          </p:txBody>
        </p:sp>
        <p:sp>
          <p:nvSpPr>
            <p:cNvPr id="654" name=""/>
            <p:cNvSpPr/>
            <p:nvPr/>
          </p:nvSpPr>
          <p:spPr>
            <a:xfrm>
              <a:off x="8206560" y="269856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655" name=""/>
            <p:cNvSpPr/>
            <p:nvPr/>
          </p:nvSpPr>
          <p:spPr>
            <a:xfrm>
              <a:off x="8331120" y="266688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4</a:t>
              </a:r>
              <a:endParaRPr b="0" lang="en-US" sz="800" spc="-1" strike="noStrike">
                <a:solidFill>
                  <a:srgbClr val="000000"/>
                </a:solidFill>
                <a:latin typeface="Arial"/>
              </a:endParaRPr>
            </a:p>
          </p:txBody>
        </p:sp>
      </p:grpSp>
      <p:grpSp>
        <p:nvGrpSpPr>
          <p:cNvPr id="656" name=""/>
          <p:cNvGrpSpPr/>
          <p:nvPr/>
        </p:nvGrpSpPr>
        <p:grpSpPr>
          <a:xfrm>
            <a:off x="4952160" y="4191120"/>
            <a:ext cx="1607400" cy="188280"/>
            <a:chOff x="4952160" y="4191120"/>
            <a:chExt cx="1607400" cy="188280"/>
          </a:xfrm>
        </p:grpSpPr>
        <p:sp>
          <p:nvSpPr>
            <p:cNvPr id="657" name=""/>
            <p:cNvSpPr/>
            <p:nvPr/>
          </p:nvSpPr>
          <p:spPr>
            <a:xfrm>
              <a:off x="4952160" y="424188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658" name=""/>
            <p:cNvSpPr/>
            <p:nvPr/>
          </p:nvSpPr>
          <p:spPr>
            <a:xfrm>
              <a:off x="5075280" y="419112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a:t>
              </a:r>
              <a:endParaRPr b="0" lang="en-US" sz="800" spc="-1" strike="noStrike">
                <a:solidFill>
                  <a:srgbClr val="000000"/>
                </a:solidFill>
                <a:latin typeface="Arial"/>
              </a:endParaRPr>
            </a:p>
          </p:txBody>
        </p:sp>
        <p:sp>
          <p:nvSpPr>
            <p:cNvPr id="659" name=""/>
            <p:cNvSpPr/>
            <p:nvPr/>
          </p:nvSpPr>
          <p:spPr>
            <a:xfrm>
              <a:off x="5306040" y="424188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660" name=""/>
            <p:cNvSpPr/>
            <p:nvPr/>
          </p:nvSpPr>
          <p:spPr>
            <a:xfrm>
              <a:off x="5422680" y="420372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a:t>
              </a:r>
              <a:endParaRPr b="0" lang="en-US" sz="800" spc="-1" strike="noStrike">
                <a:solidFill>
                  <a:srgbClr val="000000"/>
                </a:solidFill>
                <a:latin typeface="Arial"/>
              </a:endParaRPr>
            </a:p>
          </p:txBody>
        </p:sp>
        <p:sp>
          <p:nvSpPr>
            <p:cNvPr id="661" name=""/>
            <p:cNvSpPr/>
            <p:nvPr/>
          </p:nvSpPr>
          <p:spPr>
            <a:xfrm>
              <a:off x="5663520" y="424188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662" name=""/>
            <p:cNvSpPr/>
            <p:nvPr/>
          </p:nvSpPr>
          <p:spPr>
            <a:xfrm>
              <a:off x="5800680" y="421344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a:t>
              </a:r>
              <a:endParaRPr b="0" lang="en-US" sz="800" spc="-1" strike="noStrike">
                <a:solidFill>
                  <a:srgbClr val="000000"/>
                </a:solidFill>
                <a:latin typeface="Arial"/>
              </a:endParaRPr>
            </a:p>
          </p:txBody>
        </p:sp>
        <p:sp>
          <p:nvSpPr>
            <p:cNvPr id="663" name=""/>
            <p:cNvSpPr/>
            <p:nvPr/>
          </p:nvSpPr>
          <p:spPr>
            <a:xfrm>
              <a:off x="6025320" y="424188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664" name=""/>
            <p:cNvSpPr/>
            <p:nvPr/>
          </p:nvSpPr>
          <p:spPr>
            <a:xfrm>
              <a:off x="6151680" y="421344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3</a:t>
              </a:r>
              <a:endParaRPr b="0" lang="en-US" sz="800" spc="-1" strike="noStrike">
                <a:solidFill>
                  <a:srgbClr val="000000"/>
                </a:solidFill>
                <a:latin typeface="Arial"/>
              </a:endParaRPr>
            </a:p>
          </p:txBody>
        </p:sp>
        <p:sp>
          <p:nvSpPr>
            <p:cNvPr id="665" name=""/>
            <p:cNvSpPr/>
            <p:nvPr/>
          </p:nvSpPr>
          <p:spPr>
            <a:xfrm>
              <a:off x="6377760" y="424188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666" name=""/>
            <p:cNvSpPr/>
            <p:nvPr/>
          </p:nvSpPr>
          <p:spPr>
            <a:xfrm>
              <a:off x="6502320" y="421020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4</a:t>
              </a:r>
              <a:endParaRPr b="0" lang="en-US" sz="800" spc="-1" strike="noStrike">
                <a:solidFill>
                  <a:srgbClr val="000000"/>
                </a:solidFill>
                <a:latin typeface="Arial"/>
              </a:endParaRPr>
            </a:p>
          </p:txBody>
        </p:sp>
      </p:grpSp>
      <p:grpSp>
        <p:nvGrpSpPr>
          <p:cNvPr id="667" name=""/>
          <p:cNvGrpSpPr/>
          <p:nvPr/>
        </p:nvGrpSpPr>
        <p:grpSpPr>
          <a:xfrm>
            <a:off x="6803280" y="4191120"/>
            <a:ext cx="1607400" cy="188280"/>
            <a:chOff x="6803280" y="4191120"/>
            <a:chExt cx="1607400" cy="188280"/>
          </a:xfrm>
        </p:grpSpPr>
        <p:sp>
          <p:nvSpPr>
            <p:cNvPr id="668" name=""/>
            <p:cNvSpPr/>
            <p:nvPr/>
          </p:nvSpPr>
          <p:spPr>
            <a:xfrm>
              <a:off x="6803280" y="424188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669" name=""/>
            <p:cNvSpPr/>
            <p:nvPr/>
          </p:nvSpPr>
          <p:spPr>
            <a:xfrm>
              <a:off x="6926400" y="419112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0</a:t>
              </a:r>
              <a:endParaRPr b="0" lang="en-US" sz="800" spc="-1" strike="noStrike">
                <a:solidFill>
                  <a:srgbClr val="000000"/>
                </a:solidFill>
                <a:latin typeface="Arial"/>
              </a:endParaRPr>
            </a:p>
          </p:txBody>
        </p:sp>
        <p:sp>
          <p:nvSpPr>
            <p:cNvPr id="670" name=""/>
            <p:cNvSpPr/>
            <p:nvPr/>
          </p:nvSpPr>
          <p:spPr>
            <a:xfrm>
              <a:off x="7157160" y="424188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671" name=""/>
            <p:cNvSpPr/>
            <p:nvPr/>
          </p:nvSpPr>
          <p:spPr>
            <a:xfrm>
              <a:off x="7273800" y="420372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a:t>
              </a:r>
              <a:endParaRPr b="0" lang="en-US" sz="800" spc="-1" strike="noStrike">
                <a:solidFill>
                  <a:srgbClr val="000000"/>
                </a:solidFill>
                <a:latin typeface="Arial"/>
              </a:endParaRPr>
            </a:p>
          </p:txBody>
        </p:sp>
        <p:sp>
          <p:nvSpPr>
            <p:cNvPr id="672" name=""/>
            <p:cNvSpPr/>
            <p:nvPr/>
          </p:nvSpPr>
          <p:spPr>
            <a:xfrm>
              <a:off x="7514640" y="424188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673" name=""/>
            <p:cNvSpPr/>
            <p:nvPr/>
          </p:nvSpPr>
          <p:spPr>
            <a:xfrm>
              <a:off x="7651800" y="421344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a:t>
              </a:r>
              <a:endParaRPr b="0" lang="en-US" sz="800" spc="-1" strike="noStrike">
                <a:solidFill>
                  <a:srgbClr val="000000"/>
                </a:solidFill>
                <a:latin typeface="Arial"/>
              </a:endParaRPr>
            </a:p>
          </p:txBody>
        </p:sp>
        <p:sp>
          <p:nvSpPr>
            <p:cNvPr id="674" name=""/>
            <p:cNvSpPr/>
            <p:nvPr/>
          </p:nvSpPr>
          <p:spPr>
            <a:xfrm>
              <a:off x="7876440" y="424188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675" name=""/>
            <p:cNvSpPr/>
            <p:nvPr/>
          </p:nvSpPr>
          <p:spPr>
            <a:xfrm>
              <a:off x="8002800" y="421344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3</a:t>
              </a:r>
              <a:endParaRPr b="0" lang="en-US" sz="800" spc="-1" strike="noStrike">
                <a:solidFill>
                  <a:srgbClr val="000000"/>
                </a:solidFill>
                <a:latin typeface="Arial"/>
              </a:endParaRPr>
            </a:p>
          </p:txBody>
        </p:sp>
        <p:sp>
          <p:nvSpPr>
            <p:cNvPr id="676" name=""/>
            <p:cNvSpPr/>
            <p:nvPr/>
          </p:nvSpPr>
          <p:spPr>
            <a:xfrm>
              <a:off x="8228880" y="4241880"/>
              <a:ext cx="128880" cy="13752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0</a:t>
              </a:r>
              <a:endParaRPr b="0" lang="en-US" sz="900" spc="-1" strike="noStrike">
                <a:solidFill>
                  <a:srgbClr val="000000"/>
                </a:solidFill>
                <a:latin typeface="Arial"/>
              </a:endParaRPr>
            </a:p>
          </p:txBody>
        </p:sp>
        <p:sp>
          <p:nvSpPr>
            <p:cNvPr id="677" name=""/>
            <p:cNvSpPr/>
            <p:nvPr/>
          </p:nvSpPr>
          <p:spPr>
            <a:xfrm>
              <a:off x="8353440" y="421020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4</a:t>
              </a:r>
              <a:endParaRPr b="0" lang="en-US" sz="800" spc="-1" strike="noStrike">
                <a:solidFill>
                  <a:srgbClr val="000000"/>
                </a:solidFill>
                <a:latin typeface="Arial"/>
              </a:endParaRPr>
            </a:p>
          </p:txBody>
        </p:sp>
      </p:grpSp>
      <p:sp>
        <p:nvSpPr>
          <p:cNvPr id="678" name=""/>
          <p:cNvSpPr/>
          <p:nvPr/>
        </p:nvSpPr>
        <p:spPr>
          <a:xfrm>
            <a:off x="2196720" y="957240"/>
            <a:ext cx="7628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CD80</a:t>
            </a:r>
            <a:endParaRPr b="0" lang="en-US" sz="1800" spc="-1" strike="noStrike">
              <a:solidFill>
                <a:srgbClr val="000000"/>
              </a:solidFill>
              <a:latin typeface="Arial"/>
            </a:endParaRPr>
          </a:p>
        </p:txBody>
      </p:sp>
      <p:sp>
        <p:nvSpPr>
          <p:cNvPr id="679" name=""/>
          <p:cNvSpPr/>
          <p:nvPr/>
        </p:nvSpPr>
        <p:spPr>
          <a:xfrm>
            <a:off x="6117480" y="914400"/>
            <a:ext cx="10296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HLA-DR</a:t>
            </a:r>
            <a:endParaRPr b="0" lang="en-US" sz="1800" spc="-1" strike="noStrike">
              <a:solidFill>
                <a:srgbClr val="000000"/>
              </a:solidFill>
              <a:latin typeface="Arial"/>
            </a:endParaRPr>
          </a:p>
        </p:txBody>
      </p:sp>
      <p:sp>
        <p:nvSpPr>
          <p:cNvPr id="680" name=""/>
          <p:cNvSpPr/>
          <p:nvPr/>
        </p:nvSpPr>
        <p:spPr>
          <a:xfrm>
            <a:off x="1523880" y="1371600"/>
            <a:ext cx="1014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 paracasei</a:t>
            </a:r>
            <a:endParaRPr b="0" lang="en-US" sz="1200" spc="-1" strike="noStrike">
              <a:solidFill>
                <a:srgbClr val="000000"/>
              </a:solidFill>
              <a:latin typeface="Arial"/>
            </a:endParaRPr>
          </a:p>
        </p:txBody>
      </p:sp>
      <p:sp>
        <p:nvSpPr>
          <p:cNvPr id="681" name=""/>
          <p:cNvSpPr/>
          <p:nvPr/>
        </p:nvSpPr>
        <p:spPr>
          <a:xfrm>
            <a:off x="5486400" y="1371600"/>
            <a:ext cx="1014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 paracasei</a:t>
            </a:r>
            <a:endParaRPr b="0" lang="en-US" sz="1200" spc="-1" strike="noStrike">
              <a:solidFill>
                <a:srgbClr val="000000"/>
              </a:solidFill>
              <a:latin typeface="Arial"/>
            </a:endParaRPr>
          </a:p>
        </p:txBody>
      </p:sp>
      <p:sp>
        <p:nvSpPr>
          <p:cNvPr id="682" name=""/>
          <p:cNvSpPr/>
          <p:nvPr/>
        </p:nvSpPr>
        <p:spPr>
          <a:xfrm>
            <a:off x="3811320" y="1371600"/>
            <a:ext cx="5036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GG</a:t>
            </a:r>
            <a:endParaRPr b="0" lang="en-US" sz="1200" spc="-1" strike="noStrike">
              <a:solidFill>
                <a:srgbClr val="000000"/>
              </a:solidFill>
              <a:latin typeface="Arial"/>
            </a:endParaRPr>
          </a:p>
        </p:txBody>
      </p:sp>
      <p:sp>
        <p:nvSpPr>
          <p:cNvPr id="683" name=""/>
          <p:cNvSpPr/>
          <p:nvPr/>
        </p:nvSpPr>
        <p:spPr>
          <a:xfrm>
            <a:off x="7803720" y="1411200"/>
            <a:ext cx="5036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GG</a:t>
            </a:r>
            <a:endParaRPr b="0" lang="en-US" sz="1200" spc="-1" strike="noStrike">
              <a:solidFill>
                <a:srgbClr val="000000"/>
              </a:solidFill>
              <a:latin typeface="Arial"/>
            </a:endParaRPr>
          </a:p>
        </p:txBody>
      </p:sp>
      <p:sp>
        <p:nvSpPr>
          <p:cNvPr id="684" name=""/>
          <p:cNvSpPr/>
          <p:nvPr/>
        </p:nvSpPr>
        <p:spPr>
          <a:xfrm>
            <a:off x="1543320" y="2886120"/>
            <a:ext cx="1031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 plantarum</a:t>
            </a:r>
            <a:endParaRPr b="0" lang="en-US" sz="1200" spc="-1" strike="noStrike">
              <a:solidFill>
                <a:srgbClr val="000000"/>
              </a:solidFill>
              <a:latin typeface="Arial"/>
            </a:endParaRPr>
          </a:p>
        </p:txBody>
      </p:sp>
      <p:sp>
        <p:nvSpPr>
          <p:cNvPr id="685" name=""/>
          <p:cNvSpPr/>
          <p:nvPr/>
        </p:nvSpPr>
        <p:spPr>
          <a:xfrm>
            <a:off x="5486760" y="2895480"/>
            <a:ext cx="1031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 plantarum</a:t>
            </a:r>
            <a:endParaRPr b="0" lang="en-US" sz="1200" spc="-1" strike="noStrike">
              <a:solidFill>
                <a:srgbClr val="000000"/>
              </a:solidFill>
              <a:latin typeface="Arial"/>
            </a:endParaRPr>
          </a:p>
        </p:txBody>
      </p:sp>
      <p:sp>
        <p:nvSpPr>
          <p:cNvPr id="686" name=""/>
          <p:cNvSpPr/>
          <p:nvPr/>
        </p:nvSpPr>
        <p:spPr>
          <a:xfrm>
            <a:off x="3735000" y="2895480"/>
            <a:ext cx="5709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alm.</a:t>
            </a:r>
            <a:endParaRPr b="0" lang="en-US" sz="1200" spc="-1" strike="noStrike">
              <a:solidFill>
                <a:srgbClr val="000000"/>
              </a:solidFill>
              <a:latin typeface="Arial"/>
            </a:endParaRPr>
          </a:p>
        </p:txBody>
      </p:sp>
      <p:sp>
        <p:nvSpPr>
          <p:cNvPr id="687" name=""/>
          <p:cNvSpPr/>
          <p:nvPr/>
        </p:nvSpPr>
        <p:spPr>
          <a:xfrm>
            <a:off x="7782840" y="2914560"/>
            <a:ext cx="5709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alm.</a:t>
            </a:r>
            <a:endParaRPr b="0" lang="en-US" sz="1200" spc="-1" strike="noStrike">
              <a:solidFill>
                <a:srgbClr val="000000"/>
              </a:solidFill>
              <a:latin typeface="Arial"/>
            </a:endParaRPr>
          </a:p>
        </p:txBody>
      </p:sp>
      <p:sp>
        <p:nvSpPr>
          <p:cNvPr id="688" name=""/>
          <p:cNvSpPr/>
          <p:nvPr/>
        </p:nvSpPr>
        <p:spPr>
          <a:xfrm>
            <a:off x="6160680" y="6553080"/>
            <a:ext cx="18586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Mileti et al. Figure S1</a:t>
            </a:r>
            <a:endParaRPr b="0" lang="en-US" sz="1400" spc="-1" strike="noStrike">
              <a:solidFill>
                <a:srgbClr val="000000"/>
              </a:solidFill>
              <a:latin typeface="Arial"/>
            </a:endParaRPr>
          </a:p>
        </p:txBody>
      </p:sp>
      <p:sp>
        <p:nvSpPr>
          <p:cNvPr id="689" name=""/>
          <p:cNvSpPr/>
          <p:nvPr/>
        </p:nvSpPr>
        <p:spPr>
          <a:xfrm>
            <a:off x="990720" y="5181480"/>
            <a:ext cx="7391160" cy="1189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Figure S1. Probiotics induce a similar activation of surface markers on DCs.</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Cs were incubated or not with the reported live bacterial strains for 1h in medium without antibiotics, washed and incubated for 23h in medium with antibiotics. Cells were stained for HLA-DR and CD80 expression and analyzed by FACS. Histograms show surface expression of CD80 (left) or HLA-DR (right)  in response to the different bacteria (black histograms). Blue histograms show marker expression in unstimulated cells.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08-17T11:40:00Z</dcterms:created>
  <dc:creator>Comp.Dept. IFOM</dc:creator>
  <dc:description/>
  <dc:language>en-US</dc:language>
  <cp:lastModifiedBy>Comp.Dept. IFOM</cp:lastModifiedBy>
  <dcterms:modified xsi:type="dcterms:W3CDTF">2009-08-17T16:04:21Z</dcterms:modified>
  <cp:revision>2</cp:revision>
  <dc:subject/>
  <dc:title>PowerPoint Presentation</dc:title>
</cp:coreProperties>
</file>